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502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F7F7"/>
    <a:srgbClr val="F2F2F2"/>
    <a:srgbClr val="009999"/>
    <a:srgbClr val="CFE283"/>
    <a:srgbClr val="616161"/>
    <a:srgbClr val="339966"/>
    <a:srgbClr val="00CC99"/>
    <a:srgbClr val="B7D995"/>
    <a:srgbClr val="1F7F88"/>
    <a:srgbClr val="1F7E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5033" autoAdjust="0"/>
  </p:normalViewPr>
  <p:slideViewPr>
    <p:cSldViewPr>
      <p:cViewPr>
        <p:scale>
          <a:sx n="125" d="100"/>
          <a:sy n="125" d="100"/>
        </p:scale>
        <p:origin x="1330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182880" cy="18288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23066"/>
            <a:ext cx="5829300" cy="1750907"/>
          </a:xfrm>
        </p:spPr>
        <p:txBody>
          <a:bodyPr anchor="b"/>
          <a:lstStyle>
            <a:lvl1pPr algn="ctr"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2641495"/>
            <a:ext cx="5143500" cy="1214225"/>
          </a:xfrm>
        </p:spPr>
        <p:txBody>
          <a:bodyPr/>
          <a:lstStyle>
            <a:lvl1pPr marL="0" indent="0" algn="ctr">
              <a:buNone/>
              <a:defRPr sz="1760"/>
            </a:lvl1pPr>
            <a:lvl2pPr marL="335265" indent="0" algn="ctr">
              <a:buNone/>
              <a:defRPr sz="1467"/>
            </a:lvl2pPr>
            <a:lvl3pPr marL="670530" indent="0" algn="ctr">
              <a:buNone/>
              <a:defRPr sz="1320"/>
            </a:lvl3pPr>
            <a:lvl4pPr marL="1005794" indent="0" algn="ctr">
              <a:buNone/>
              <a:defRPr sz="1173"/>
            </a:lvl4pPr>
            <a:lvl5pPr marL="1341059" indent="0" algn="ctr">
              <a:buNone/>
              <a:defRPr sz="1173"/>
            </a:lvl5pPr>
            <a:lvl6pPr marL="1676324" indent="0" algn="ctr">
              <a:buNone/>
              <a:defRPr sz="1173"/>
            </a:lvl6pPr>
            <a:lvl7pPr marL="2011589" indent="0" algn="ctr">
              <a:buNone/>
              <a:defRPr sz="1173"/>
            </a:lvl7pPr>
            <a:lvl8pPr marL="2346853" indent="0" algn="ctr">
              <a:buNone/>
              <a:defRPr sz="1173"/>
            </a:lvl8pPr>
            <a:lvl9pPr marL="2682118" indent="0" algn="ctr">
              <a:buNone/>
              <a:defRPr sz="117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074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147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267758"/>
            <a:ext cx="1478756" cy="42620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267758"/>
            <a:ext cx="4350544" cy="42620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296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707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253809"/>
            <a:ext cx="5915025" cy="2092007"/>
          </a:xfrm>
        </p:spPr>
        <p:txBody>
          <a:bodyPr anchor="b"/>
          <a:lstStyle>
            <a:lvl1pPr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3365607"/>
            <a:ext cx="5915025" cy="1100137"/>
          </a:xfrm>
        </p:spPr>
        <p:txBody>
          <a:bodyPr/>
          <a:lstStyle>
            <a:lvl1pPr marL="0" indent="0">
              <a:buNone/>
              <a:defRPr sz="1760">
                <a:solidFill>
                  <a:schemeClr val="tx1"/>
                </a:solidFill>
              </a:defRPr>
            </a:lvl1pPr>
            <a:lvl2pPr marL="335265" indent="0">
              <a:buNone/>
              <a:defRPr sz="1467">
                <a:solidFill>
                  <a:schemeClr val="tx1">
                    <a:tint val="75000"/>
                  </a:schemeClr>
                </a:solidFill>
              </a:defRPr>
            </a:lvl2pPr>
            <a:lvl3pPr marL="6705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3pPr>
            <a:lvl4pPr marL="100579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4pPr>
            <a:lvl5pPr marL="134105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5pPr>
            <a:lvl6pPr marL="1676324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6pPr>
            <a:lvl7pPr marL="2011589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7pPr>
            <a:lvl8pPr marL="2346853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8pPr>
            <a:lvl9pPr marL="2682118" indent="0">
              <a:buNone/>
              <a:defRPr sz="117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293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338792"/>
            <a:ext cx="291465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338792"/>
            <a:ext cx="2914650" cy="31909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891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267759"/>
            <a:ext cx="5915025" cy="97208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232853"/>
            <a:ext cx="2901255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1837055"/>
            <a:ext cx="2901255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232853"/>
            <a:ext cx="2915543" cy="604202"/>
          </a:xfrm>
        </p:spPr>
        <p:txBody>
          <a:bodyPr anchor="b"/>
          <a:lstStyle>
            <a:lvl1pPr marL="0" indent="0">
              <a:buNone/>
              <a:defRPr sz="1760" b="1"/>
            </a:lvl1pPr>
            <a:lvl2pPr marL="335265" indent="0">
              <a:buNone/>
              <a:defRPr sz="1467" b="1"/>
            </a:lvl2pPr>
            <a:lvl3pPr marL="670530" indent="0">
              <a:buNone/>
              <a:defRPr sz="1320" b="1"/>
            </a:lvl3pPr>
            <a:lvl4pPr marL="1005794" indent="0">
              <a:buNone/>
              <a:defRPr sz="1173" b="1"/>
            </a:lvl4pPr>
            <a:lvl5pPr marL="1341059" indent="0">
              <a:buNone/>
              <a:defRPr sz="1173" b="1"/>
            </a:lvl5pPr>
            <a:lvl6pPr marL="1676324" indent="0">
              <a:buNone/>
              <a:defRPr sz="1173" b="1"/>
            </a:lvl6pPr>
            <a:lvl7pPr marL="2011589" indent="0">
              <a:buNone/>
              <a:defRPr sz="1173" b="1"/>
            </a:lvl7pPr>
            <a:lvl8pPr marL="2346853" indent="0">
              <a:buNone/>
              <a:defRPr sz="1173" b="1"/>
            </a:lvl8pPr>
            <a:lvl9pPr marL="2682118" indent="0">
              <a:buNone/>
              <a:defRPr sz="117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1837055"/>
            <a:ext cx="2915543" cy="270203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369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41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885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5280"/>
            <a:ext cx="2211884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724113"/>
            <a:ext cx="3471863" cy="3573992"/>
          </a:xfrm>
        </p:spPr>
        <p:txBody>
          <a:bodyPr/>
          <a:lstStyle>
            <a:lvl1pPr>
              <a:defRPr sz="2347"/>
            </a:lvl1pPr>
            <a:lvl2pPr>
              <a:defRPr sz="2053"/>
            </a:lvl2pPr>
            <a:lvl3pPr>
              <a:defRPr sz="1760"/>
            </a:lvl3pPr>
            <a:lvl4pPr>
              <a:defRPr sz="1467"/>
            </a:lvl4pPr>
            <a:lvl5pPr>
              <a:defRPr sz="1467"/>
            </a:lvl5pPr>
            <a:lvl6pPr>
              <a:defRPr sz="1467"/>
            </a:lvl6pPr>
            <a:lvl7pPr>
              <a:defRPr sz="1467"/>
            </a:lvl7pPr>
            <a:lvl8pPr>
              <a:defRPr sz="1467"/>
            </a:lvl8pPr>
            <a:lvl9pPr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08760"/>
            <a:ext cx="2211884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57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5280"/>
            <a:ext cx="2211884" cy="1173480"/>
          </a:xfrm>
        </p:spPr>
        <p:txBody>
          <a:bodyPr anchor="b"/>
          <a:lstStyle>
            <a:lvl1pPr>
              <a:defRPr sz="23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724113"/>
            <a:ext cx="3471863" cy="3573992"/>
          </a:xfrm>
        </p:spPr>
        <p:txBody>
          <a:bodyPr anchor="t"/>
          <a:lstStyle>
            <a:lvl1pPr marL="0" indent="0">
              <a:buNone/>
              <a:defRPr sz="2347"/>
            </a:lvl1pPr>
            <a:lvl2pPr marL="335265" indent="0">
              <a:buNone/>
              <a:defRPr sz="2053"/>
            </a:lvl2pPr>
            <a:lvl3pPr marL="670530" indent="0">
              <a:buNone/>
              <a:defRPr sz="1760"/>
            </a:lvl3pPr>
            <a:lvl4pPr marL="1005794" indent="0">
              <a:buNone/>
              <a:defRPr sz="1467"/>
            </a:lvl4pPr>
            <a:lvl5pPr marL="1341059" indent="0">
              <a:buNone/>
              <a:defRPr sz="1467"/>
            </a:lvl5pPr>
            <a:lvl6pPr marL="1676324" indent="0">
              <a:buNone/>
              <a:defRPr sz="1467"/>
            </a:lvl6pPr>
            <a:lvl7pPr marL="2011589" indent="0">
              <a:buNone/>
              <a:defRPr sz="1467"/>
            </a:lvl7pPr>
            <a:lvl8pPr marL="2346853" indent="0">
              <a:buNone/>
              <a:defRPr sz="1467"/>
            </a:lvl8pPr>
            <a:lvl9pPr marL="2682118" indent="0">
              <a:buNone/>
              <a:defRPr sz="14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508760"/>
            <a:ext cx="2211884" cy="2795165"/>
          </a:xfrm>
        </p:spPr>
        <p:txBody>
          <a:bodyPr/>
          <a:lstStyle>
            <a:lvl1pPr marL="0" indent="0">
              <a:buNone/>
              <a:defRPr sz="1173"/>
            </a:lvl1pPr>
            <a:lvl2pPr marL="335265" indent="0">
              <a:buNone/>
              <a:defRPr sz="1027"/>
            </a:lvl2pPr>
            <a:lvl3pPr marL="670530" indent="0">
              <a:buNone/>
              <a:defRPr sz="880"/>
            </a:lvl3pPr>
            <a:lvl4pPr marL="1005794" indent="0">
              <a:buNone/>
              <a:defRPr sz="733"/>
            </a:lvl4pPr>
            <a:lvl5pPr marL="1341059" indent="0">
              <a:buNone/>
              <a:defRPr sz="733"/>
            </a:lvl5pPr>
            <a:lvl6pPr marL="1676324" indent="0">
              <a:buNone/>
              <a:defRPr sz="733"/>
            </a:lvl6pPr>
            <a:lvl7pPr marL="2011589" indent="0">
              <a:buNone/>
              <a:defRPr sz="733"/>
            </a:lvl7pPr>
            <a:lvl8pPr marL="2346853" indent="0">
              <a:buNone/>
              <a:defRPr sz="733"/>
            </a:lvl8pPr>
            <a:lvl9pPr marL="2682118" indent="0">
              <a:buNone/>
              <a:defRPr sz="7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3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267759"/>
            <a:ext cx="5915025" cy="9720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338792"/>
            <a:ext cx="5915025" cy="31909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4661325"/>
            <a:ext cx="154305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20C4E-20A0-4905-BEE1-2567EC6A3A00}" type="datetimeFigureOut">
              <a:rPr lang="en-US" smtClean="0"/>
              <a:t>4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4661325"/>
            <a:ext cx="2314575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4661325"/>
            <a:ext cx="1543050" cy="2677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EA168-72C3-4EA7-B3C8-3F523C545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077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70530" rtl="0" eaLnBrk="1" latinLnBrk="0" hangingPunct="1">
        <a:lnSpc>
          <a:spcPct val="90000"/>
        </a:lnSpc>
        <a:spcBef>
          <a:spcPct val="0"/>
        </a:spcBef>
        <a:buNone/>
        <a:defRPr sz="32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7632" indent="-167632" algn="l" defTabSz="67053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053" kern="1200">
          <a:solidFill>
            <a:schemeClr val="tx1"/>
          </a:solidFill>
          <a:latin typeface="+mn-lt"/>
          <a:ea typeface="+mn-ea"/>
          <a:cs typeface="+mn-cs"/>
        </a:defRPr>
      </a:lvl1pPr>
      <a:lvl2pPr marL="50289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760" kern="1200">
          <a:solidFill>
            <a:schemeClr val="tx1"/>
          </a:solidFill>
          <a:latin typeface="+mn-lt"/>
          <a:ea typeface="+mn-ea"/>
          <a:cs typeface="+mn-cs"/>
        </a:defRPr>
      </a:lvl2pPr>
      <a:lvl3pPr marL="838162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467" kern="1200">
          <a:solidFill>
            <a:schemeClr val="tx1"/>
          </a:solidFill>
          <a:latin typeface="+mn-lt"/>
          <a:ea typeface="+mn-ea"/>
          <a:cs typeface="+mn-cs"/>
        </a:defRPr>
      </a:lvl3pPr>
      <a:lvl4pPr marL="1173427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50869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84395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179221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514486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849750" indent="-167632" algn="l" defTabSz="670530" rtl="0" eaLnBrk="1" latinLnBrk="0" hangingPunct="1">
        <a:lnSpc>
          <a:spcPct val="90000"/>
        </a:lnSpc>
        <a:spcBef>
          <a:spcPts val="367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1pPr>
      <a:lvl2pPr marL="335265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70530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3pPr>
      <a:lvl4pPr marL="100579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34105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676324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2011589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346853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682118" algn="l" defTabSz="670530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2" name="Curved Left Arrow 119">
            <a:extLst>
              <a:ext uri="{FF2B5EF4-FFF2-40B4-BE49-F238E27FC236}">
                <a16:creationId xmlns:a16="http://schemas.microsoft.com/office/drawing/2014/main" id="{3934C427-5391-4B15-3817-45126A8C926B}"/>
              </a:ext>
            </a:extLst>
          </p:cNvPr>
          <p:cNvSpPr/>
          <p:nvPr/>
        </p:nvSpPr>
        <p:spPr>
          <a:xfrm rot="4682016">
            <a:off x="4703114" y="3507560"/>
            <a:ext cx="1410507" cy="1309353"/>
          </a:xfrm>
          <a:prstGeom prst="curvedLeftArrow">
            <a:avLst>
              <a:gd name="adj1" fmla="val 1224"/>
              <a:gd name="adj2" fmla="val 3593"/>
              <a:gd name="adj3" fmla="val 2199"/>
            </a:avLst>
          </a:prstGeom>
          <a:gradFill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8100000" scaled="1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93" name="Rectangle: Rounded Corners 3892">
            <a:extLst>
              <a:ext uri="{FF2B5EF4-FFF2-40B4-BE49-F238E27FC236}">
                <a16:creationId xmlns:a16="http://schemas.microsoft.com/office/drawing/2014/main" id="{6891EE9A-3C60-5F7C-BB0D-09CFAEEF2B7B}"/>
              </a:ext>
            </a:extLst>
          </p:cNvPr>
          <p:cNvSpPr/>
          <p:nvPr/>
        </p:nvSpPr>
        <p:spPr>
          <a:xfrm>
            <a:off x="5532797" y="3192096"/>
            <a:ext cx="1266428" cy="1730769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Curved Left Arrow 120">
            <a:extLst>
              <a:ext uri="{FF2B5EF4-FFF2-40B4-BE49-F238E27FC236}">
                <a16:creationId xmlns:a16="http://schemas.microsoft.com/office/drawing/2014/main" id="{4E23900D-9249-C5AA-C24C-3414F3039553}"/>
              </a:ext>
            </a:extLst>
          </p:cNvPr>
          <p:cNvSpPr/>
          <p:nvPr/>
        </p:nvSpPr>
        <p:spPr>
          <a:xfrm rot="8856522" flipH="1">
            <a:off x="1909687" y="2858294"/>
            <a:ext cx="959975" cy="1721776"/>
          </a:xfrm>
          <a:prstGeom prst="curvedLeftArrow">
            <a:avLst>
              <a:gd name="adj1" fmla="val 1837"/>
              <a:gd name="adj2" fmla="val 5104"/>
              <a:gd name="adj3" fmla="val 4052"/>
            </a:avLst>
          </a:prstGeom>
          <a:gradFill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8100000" scaled="1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67" name="Rectangle 3866">
            <a:extLst>
              <a:ext uri="{FF2B5EF4-FFF2-40B4-BE49-F238E27FC236}">
                <a16:creationId xmlns:a16="http://schemas.microsoft.com/office/drawing/2014/main" id="{54A9EAC8-B6AD-2F6B-8EDB-D42C4C7D6DA8}"/>
              </a:ext>
            </a:extLst>
          </p:cNvPr>
          <p:cNvSpPr/>
          <p:nvPr/>
        </p:nvSpPr>
        <p:spPr>
          <a:xfrm>
            <a:off x="1965960" y="3472053"/>
            <a:ext cx="1425317" cy="14799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Curved Left Arrow 119">
            <a:extLst>
              <a:ext uri="{FF2B5EF4-FFF2-40B4-BE49-F238E27FC236}">
                <a16:creationId xmlns:a16="http://schemas.microsoft.com/office/drawing/2014/main" id="{E4838B0A-0470-AA85-0F41-289F3D1ACBFB}"/>
              </a:ext>
            </a:extLst>
          </p:cNvPr>
          <p:cNvSpPr/>
          <p:nvPr/>
        </p:nvSpPr>
        <p:spPr>
          <a:xfrm rot="21153604" flipH="1">
            <a:off x="5017939" y="2787099"/>
            <a:ext cx="466672" cy="1107023"/>
          </a:xfrm>
          <a:prstGeom prst="curvedLeftArrow">
            <a:avLst>
              <a:gd name="adj1" fmla="val 4713"/>
              <a:gd name="adj2" fmla="val 10687"/>
              <a:gd name="adj3" fmla="val 8790"/>
            </a:avLst>
          </a:prstGeom>
          <a:gradFill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8100000" scaled="1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502" name="Rectangle 501">
            <a:extLst>
              <a:ext uri="{FF2B5EF4-FFF2-40B4-BE49-F238E27FC236}">
                <a16:creationId xmlns:a16="http://schemas.microsoft.com/office/drawing/2014/main" id="{E358714F-DF1E-ABF4-4EFD-FB8F3AD29869}"/>
              </a:ext>
            </a:extLst>
          </p:cNvPr>
          <p:cNvSpPr/>
          <p:nvPr/>
        </p:nvSpPr>
        <p:spPr>
          <a:xfrm>
            <a:off x="4774699" y="3210884"/>
            <a:ext cx="1260848" cy="30224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ython Prescription</a:t>
            </a:r>
          </a:p>
          <a:p>
            <a:pPr algn="ctr"/>
            <a:r>
              <a:rPr lang="en-US" sz="4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Virtual Screening Tool</a:t>
            </a:r>
          </a:p>
        </p:txBody>
      </p:sp>
      <p:sp>
        <p:nvSpPr>
          <p:cNvPr id="3866" name="Rectangle 3865">
            <a:extLst>
              <a:ext uri="{FF2B5EF4-FFF2-40B4-BE49-F238E27FC236}">
                <a16:creationId xmlns:a16="http://schemas.microsoft.com/office/drawing/2014/main" id="{B39634E4-AC54-63CA-6EE9-DAFB5328BCBB}"/>
              </a:ext>
            </a:extLst>
          </p:cNvPr>
          <p:cNvSpPr/>
          <p:nvPr/>
        </p:nvSpPr>
        <p:spPr>
          <a:xfrm>
            <a:off x="5026224" y="2709519"/>
            <a:ext cx="488373" cy="3416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Curved Down Arrow 62">
            <a:extLst>
              <a:ext uri="{FF2B5EF4-FFF2-40B4-BE49-F238E27FC236}">
                <a16:creationId xmlns:a16="http://schemas.microsoft.com/office/drawing/2014/main" id="{91D9CADB-702B-010A-CC73-E19B16AB0621}"/>
              </a:ext>
            </a:extLst>
          </p:cNvPr>
          <p:cNvSpPr/>
          <p:nvPr/>
        </p:nvSpPr>
        <p:spPr>
          <a:xfrm rot="4818919" flipV="1">
            <a:off x="2313552" y="1266435"/>
            <a:ext cx="855916" cy="463129"/>
          </a:xfrm>
          <a:prstGeom prst="curvedDownArrow">
            <a:avLst>
              <a:gd name="adj1" fmla="val 3061"/>
              <a:gd name="adj2" fmla="val 9590"/>
              <a:gd name="adj3" fmla="val 7475"/>
            </a:avLst>
          </a:prstGeom>
          <a:gradFill flip="none" rotWithShape="1">
            <a:gsLst>
              <a:gs pos="0">
                <a:schemeClr val="accent4">
                  <a:lumMod val="67000"/>
                </a:schemeClr>
              </a:gs>
              <a:gs pos="48000">
                <a:schemeClr val="accent4">
                  <a:lumMod val="97000"/>
                  <a:lumOff val="3000"/>
                </a:schemeClr>
              </a:gs>
              <a:gs pos="100000">
                <a:schemeClr val="accent4">
                  <a:lumMod val="60000"/>
                  <a:lumOff val="40000"/>
                </a:schemeClr>
              </a:gs>
            </a:gsLst>
            <a:lin ang="16200000" scaled="1"/>
            <a:tileRect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1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65" name="Rectangle 3864">
            <a:extLst>
              <a:ext uri="{FF2B5EF4-FFF2-40B4-BE49-F238E27FC236}">
                <a16:creationId xmlns:a16="http://schemas.microsoft.com/office/drawing/2014/main" id="{4E30EAE1-C8A1-839C-02F3-11375FD233AF}"/>
              </a:ext>
            </a:extLst>
          </p:cNvPr>
          <p:cNvSpPr/>
          <p:nvPr/>
        </p:nvSpPr>
        <p:spPr>
          <a:xfrm>
            <a:off x="2148840" y="922835"/>
            <a:ext cx="837270" cy="7286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Curved Left Arrow 88">
            <a:extLst>
              <a:ext uri="{FF2B5EF4-FFF2-40B4-BE49-F238E27FC236}">
                <a16:creationId xmlns:a16="http://schemas.microsoft.com/office/drawing/2014/main" id="{AF56FF21-6405-7D3F-AB63-F29B3324C1AE}"/>
              </a:ext>
            </a:extLst>
          </p:cNvPr>
          <p:cNvSpPr/>
          <p:nvPr/>
        </p:nvSpPr>
        <p:spPr>
          <a:xfrm rot="16200000" flipH="1" flipV="1">
            <a:off x="3327745" y="4086791"/>
            <a:ext cx="446836" cy="1325818"/>
          </a:xfrm>
          <a:prstGeom prst="curvedLeftArrow">
            <a:avLst>
              <a:gd name="adj1" fmla="val 4482"/>
              <a:gd name="adj2" fmla="val 11925"/>
              <a:gd name="adj3" fmla="val 8515"/>
            </a:avLst>
          </a:prstGeom>
          <a:gradFill flip="none" rotWithShape="1"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10800000" scaled="1"/>
            <a:tileRect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1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63" name="Rectangle 3862">
            <a:extLst>
              <a:ext uri="{FF2B5EF4-FFF2-40B4-BE49-F238E27FC236}">
                <a16:creationId xmlns:a16="http://schemas.microsoft.com/office/drawing/2014/main" id="{4F5D01DA-1B2E-FE08-97C3-08FD2ABFB863}"/>
              </a:ext>
            </a:extLst>
          </p:cNvPr>
          <p:cNvSpPr/>
          <p:nvPr/>
        </p:nvSpPr>
        <p:spPr>
          <a:xfrm>
            <a:off x="3875631" y="4160520"/>
            <a:ext cx="421156" cy="6312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Curved Down Arrow 62">
            <a:extLst>
              <a:ext uri="{FF2B5EF4-FFF2-40B4-BE49-F238E27FC236}">
                <a16:creationId xmlns:a16="http://schemas.microsoft.com/office/drawing/2014/main" id="{3EDC8292-BF83-81D5-510A-50296D6AAE46}"/>
              </a:ext>
            </a:extLst>
          </p:cNvPr>
          <p:cNvSpPr/>
          <p:nvPr/>
        </p:nvSpPr>
        <p:spPr>
          <a:xfrm rot="14574949">
            <a:off x="-241902" y="3319211"/>
            <a:ext cx="1561547" cy="742155"/>
          </a:xfrm>
          <a:prstGeom prst="curvedDownArrow">
            <a:avLst>
              <a:gd name="adj1" fmla="val 2714"/>
              <a:gd name="adj2" fmla="val 6930"/>
              <a:gd name="adj3" fmla="val 5284"/>
            </a:avLst>
          </a:prstGeom>
          <a:gradFill flip="none" rotWithShape="1">
            <a:gsLst>
              <a:gs pos="0">
                <a:schemeClr val="accent4">
                  <a:lumMod val="67000"/>
                </a:schemeClr>
              </a:gs>
              <a:gs pos="48000">
                <a:schemeClr val="accent4">
                  <a:lumMod val="97000"/>
                  <a:lumOff val="3000"/>
                </a:schemeClr>
              </a:gs>
              <a:gs pos="100000">
                <a:schemeClr val="accent4">
                  <a:lumMod val="60000"/>
                  <a:lumOff val="40000"/>
                </a:schemeClr>
              </a:gs>
            </a:gsLst>
            <a:lin ang="16200000" scaled="1"/>
            <a:tileRect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1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58" name="Rectangle 3857">
            <a:extLst>
              <a:ext uri="{FF2B5EF4-FFF2-40B4-BE49-F238E27FC236}">
                <a16:creationId xmlns:a16="http://schemas.microsoft.com/office/drawing/2014/main" id="{5D352A30-6FE4-5BA8-89B3-23E56BCE118C}"/>
              </a:ext>
            </a:extLst>
          </p:cNvPr>
          <p:cNvSpPr/>
          <p:nvPr/>
        </p:nvSpPr>
        <p:spPr>
          <a:xfrm>
            <a:off x="84186" y="3870095"/>
            <a:ext cx="1551913" cy="10886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Curved Down Arrow 62">
            <a:extLst>
              <a:ext uri="{FF2B5EF4-FFF2-40B4-BE49-F238E27FC236}">
                <a16:creationId xmlns:a16="http://schemas.microsoft.com/office/drawing/2014/main" id="{7EF58AD0-F828-D60C-0C97-C4BD866F5F25}"/>
              </a:ext>
            </a:extLst>
          </p:cNvPr>
          <p:cNvSpPr/>
          <p:nvPr/>
        </p:nvSpPr>
        <p:spPr>
          <a:xfrm flipV="1">
            <a:off x="1051560" y="1914404"/>
            <a:ext cx="910374" cy="587146"/>
          </a:xfrm>
          <a:prstGeom prst="curvedDownArrow">
            <a:avLst>
              <a:gd name="adj1" fmla="val 3037"/>
              <a:gd name="adj2" fmla="val 7967"/>
              <a:gd name="adj3" fmla="val 5853"/>
            </a:avLst>
          </a:prstGeom>
          <a:gradFill flip="none" rotWithShape="1">
            <a:gsLst>
              <a:gs pos="0">
                <a:schemeClr val="accent4">
                  <a:lumMod val="67000"/>
                </a:schemeClr>
              </a:gs>
              <a:gs pos="48000">
                <a:schemeClr val="accent4">
                  <a:lumMod val="97000"/>
                  <a:lumOff val="3000"/>
                </a:schemeClr>
              </a:gs>
              <a:gs pos="100000">
                <a:schemeClr val="accent4">
                  <a:lumMod val="60000"/>
                  <a:lumOff val="40000"/>
                </a:schemeClr>
              </a:gs>
            </a:gsLst>
            <a:lin ang="16200000" scaled="1"/>
            <a:tileRect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1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857" name="Rectangle 3856">
            <a:extLst>
              <a:ext uri="{FF2B5EF4-FFF2-40B4-BE49-F238E27FC236}">
                <a16:creationId xmlns:a16="http://schemas.microsoft.com/office/drawing/2014/main" id="{82CDCA97-5432-85A4-3A3E-12BB1643EF57}"/>
              </a:ext>
            </a:extLst>
          </p:cNvPr>
          <p:cNvSpPr/>
          <p:nvPr/>
        </p:nvSpPr>
        <p:spPr>
          <a:xfrm>
            <a:off x="797225" y="1791628"/>
            <a:ext cx="731520" cy="9362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AutoShape 4" descr="-এর ছবি">
            <a:extLst>
              <a:ext uri="{FF2B5EF4-FFF2-40B4-BE49-F238E27FC236}">
                <a16:creationId xmlns:a16="http://schemas.microsoft.com/office/drawing/2014/main" id="{623C2CE7-7E50-B244-A5C7-D216C5ACB52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04477" y="819654"/>
            <a:ext cx="160208" cy="1602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41148" tIns="20574" rIns="41148" bIns="20574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4" name="Curved Left Arrow 105">
            <a:extLst>
              <a:ext uri="{FF2B5EF4-FFF2-40B4-BE49-F238E27FC236}">
                <a16:creationId xmlns:a16="http://schemas.microsoft.com/office/drawing/2014/main" id="{2D6A10F5-7E05-A369-2A0C-8117B2B5AF79}"/>
              </a:ext>
            </a:extLst>
          </p:cNvPr>
          <p:cNvSpPr/>
          <p:nvPr/>
        </p:nvSpPr>
        <p:spPr>
          <a:xfrm rot="311914">
            <a:off x="6041109" y="2156929"/>
            <a:ext cx="401965" cy="838116"/>
          </a:xfrm>
          <a:prstGeom prst="curvedLeftArrow">
            <a:avLst>
              <a:gd name="adj1" fmla="val 5359"/>
              <a:gd name="adj2" fmla="val 11971"/>
              <a:gd name="adj3" fmla="val 9279"/>
            </a:avLst>
          </a:prstGeom>
          <a:gradFill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8100000" scaled="1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D88A16C7-40AA-EEC3-854C-AC8ABBDB7A7F}"/>
              </a:ext>
            </a:extLst>
          </p:cNvPr>
          <p:cNvSpPr/>
          <p:nvPr/>
        </p:nvSpPr>
        <p:spPr>
          <a:xfrm>
            <a:off x="3062994" y="772869"/>
            <a:ext cx="366006" cy="101481"/>
          </a:xfrm>
          <a:prstGeom prst="ellipse">
            <a:avLst/>
          </a:prstGeom>
          <a:noFill/>
          <a:ln w="3175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grpSp>
        <p:nvGrpSpPr>
          <p:cNvPr id="499" name="Group 498">
            <a:extLst>
              <a:ext uri="{FF2B5EF4-FFF2-40B4-BE49-F238E27FC236}">
                <a16:creationId xmlns:a16="http://schemas.microsoft.com/office/drawing/2014/main" id="{1BD078B9-BEBF-ACE7-B02E-8AD5F390C5FC}"/>
              </a:ext>
            </a:extLst>
          </p:cNvPr>
          <p:cNvGrpSpPr/>
          <p:nvPr/>
        </p:nvGrpSpPr>
        <p:grpSpPr>
          <a:xfrm>
            <a:off x="2445393" y="2180434"/>
            <a:ext cx="806845" cy="532867"/>
            <a:chOff x="2286176" y="2031940"/>
            <a:chExt cx="806845" cy="532867"/>
          </a:xfrm>
        </p:grpSpPr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F2791C4F-66A7-46BA-429E-02C102E75FEF}"/>
                </a:ext>
              </a:extLst>
            </p:cNvPr>
            <p:cNvSpPr/>
            <p:nvPr/>
          </p:nvSpPr>
          <p:spPr>
            <a:xfrm>
              <a:off x="2548046" y="2177134"/>
              <a:ext cx="438064" cy="8966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solidFill>
                    <a:srgbClr val="517D33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hain A</a:t>
              </a: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6819483D-173D-2CBD-C9CA-CD3F12F768FD}"/>
                </a:ext>
              </a:extLst>
            </p:cNvPr>
            <p:cNvSpPr/>
            <p:nvPr/>
          </p:nvSpPr>
          <p:spPr>
            <a:xfrm>
              <a:off x="2550582" y="2341005"/>
              <a:ext cx="423316" cy="9851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solidFill>
                    <a:srgbClr val="95590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hain C</a:t>
              </a: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FEF2C9A1-70FF-D479-896C-794FEFE1B1CB}"/>
                </a:ext>
              </a:extLst>
            </p:cNvPr>
            <p:cNvSpPr/>
            <p:nvPr/>
          </p:nvSpPr>
          <p:spPr>
            <a:xfrm>
              <a:off x="2550583" y="2258950"/>
              <a:ext cx="424979" cy="8572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solidFill>
                    <a:srgbClr val="255D8F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hain B</a:t>
              </a:r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E0D522C6-9656-C1AB-670B-E709D978AA2E}"/>
                </a:ext>
              </a:extLst>
            </p:cNvPr>
            <p:cNvSpPr/>
            <p:nvPr/>
          </p:nvSpPr>
          <p:spPr>
            <a:xfrm>
              <a:off x="2475241" y="2475653"/>
              <a:ext cx="617780" cy="8915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dirty="0">
                  <a:solidFill>
                    <a:srgbClr val="700000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Heteroatoms &amp; Water Molecules</a:t>
              </a:r>
            </a:p>
          </p:txBody>
        </p:sp>
        <p:sp>
          <p:nvSpPr>
            <p:cNvPr id="133" name="Rounded Rectangle 43">
              <a:extLst>
                <a:ext uri="{FF2B5EF4-FFF2-40B4-BE49-F238E27FC236}">
                  <a16:creationId xmlns:a16="http://schemas.microsoft.com/office/drawing/2014/main" id="{249EF20A-1239-8EE9-B118-31FC7AC9D557}"/>
                </a:ext>
              </a:extLst>
            </p:cNvPr>
            <p:cNvSpPr/>
            <p:nvPr/>
          </p:nvSpPr>
          <p:spPr>
            <a:xfrm>
              <a:off x="2626338" y="2166935"/>
              <a:ext cx="277746" cy="278582"/>
            </a:xfrm>
            <a:prstGeom prst="round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00" b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Straight Arrow Connector 133">
              <a:extLst>
                <a:ext uri="{FF2B5EF4-FFF2-40B4-BE49-F238E27FC236}">
                  <a16:creationId xmlns:a16="http://schemas.microsoft.com/office/drawing/2014/main" id="{2DC55DF0-BE71-C3E6-9ECA-7BD3C0DBE92F}"/>
                </a:ext>
              </a:extLst>
            </p:cNvPr>
            <p:cNvCxnSpPr/>
            <p:nvPr/>
          </p:nvCxnSpPr>
          <p:spPr>
            <a:xfrm flipV="1">
              <a:off x="2386180" y="2512628"/>
              <a:ext cx="188138" cy="127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CAC97C3D-0A04-DFDC-AA4C-86804EEAA6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0525" y="2287589"/>
              <a:ext cx="759" cy="22846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2E26AF7C-A455-9913-40AF-7A213092E75E}"/>
                </a:ext>
              </a:extLst>
            </p:cNvPr>
            <p:cNvCxnSpPr/>
            <p:nvPr/>
          </p:nvCxnSpPr>
          <p:spPr>
            <a:xfrm>
              <a:off x="2386180" y="2291044"/>
              <a:ext cx="235296" cy="141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199150A2-EC57-7C51-A923-852113DA0CB2}"/>
                </a:ext>
              </a:extLst>
            </p:cNvPr>
            <p:cNvSpPr/>
            <p:nvPr/>
          </p:nvSpPr>
          <p:spPr>
            <a:xfrm>
              <a:off x="2286176" y="2198481"/>
              <a:ext cx="402782" cy="8841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omplex</a:t>
              </a: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FEE0216B-5339-A44D-B89D-4654A3B8AB71}"/>
                </a:ext>
              </a:extLst>
            </p:cNvPr>
            <p:cNvSpPr/>
            <p:nvPr/>
          </p:nvSpPr>
          <p:spPr>
            <a:xfrm>
              <a:off x="2457460" y="2031940"/>
              <a:ext cx="628245" cy="124302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5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Sigma1 Trimer</a:t>
              </a:r>
            </a:p>
          </p:txBody>
        </p:sp>
      </p:grpSp>
      <p:grpSp>
        <p:nvGrpSpPr>
          <p:cNvPr id="3856" name="Group 3855">
            <a:extLst>
              <a:ext uri="{FF2B5EF4-FFF2-40B4-BE49-F238E27FC236}">
                <a16:creationId xmlns:a16="http://schemas.microsoft.com/office/drawing/2014/main" id="{2BE3812F-0860-70C8-B252-2F067EC756AA}"/>
              </a:ext>
            </a:extLst>
          </p:cNvPr>
          <p:cNvGrpSpPr/>
          <p:nvPr/>
        </p:nvGrpSpPr>
        <p:grpSpPr>
          <a:xfrm>
            <a:off x="3621813" y="1848706"/>
            <a:ext cx="882498" cy="386920"/>
            <a:chOff x="3540534" y="1835106"/>
            <a:chExt cx="882498" cy="386920"/>
          </a:xfrm>
        </p:grpSpPr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1DB247A5-6825-D07B-5AF6-AC0538BC3577}"/>
                </a:ext>
              </a:extLst>
            </p:cNvPr>
            <p:cNvSpPr/>
            <p:nvPr/>
          </p:nvSpPr>
          <p:spPr>
            <a:xfrm>
              <a:off x="3540534" y="1835106"/>
              <a:ext cx="882498" cy="1525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rotein optimization</a:t>
              </a:r>
            </a:p>
          </p:txBody>
        </p: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673F8216-22FA-26F3-25A4-0DDC0A8CD078}"/>
                </a:ext>
              </a:extLst>
            </p:cNvPr>
            <p:cNvCxnSpPr>
              <a:cxnSpLocks/>
            </p:cNvCxnSpPr>
            <p:nvPr/>
          </p:nvCxnSpPr>
          <p:spPr>
            <a:xfrm>
              <a:off x="3627345" y="1981288"/>
              <a:ext cx="716055" cy="0"/>
            </a:xfrm>
            <a:prstGeom prst="straightConnector1">
              <a:avLst/>
            </a:prstGeom>
            <a:ln w="9525">
              <a:gradFill flip="none" rotWithShape="1">
                <a:gsLst>
                  <a:gs pos="0">
                    <a:schemeClr val="accent4">
                      <a:lumMod val="40000"/>
                      <a:lumOff val="60000"/>
                    </a:schemeClr>
                  </a:gs>
                  <a:gs pos="46000">
                    <a:schemeClr val="accent4">
                      <a:lumMod val="95000"/>
                      <a:lumOff val="5000"/>
                    </a:schemeClr>
                  </a:gs>
                  <a:gs pos="100000">
                    <a:schemeClr val="accent4">
                      <a:lumMod val="60000"/>
                    </a:schemeClr>
                  </a:gs>
                </a:gsLst>
                <a:path path="circle">
                  <a:fillToRect l="50000" t="130000" r="50000" b="-30000"/>
                </a:path>
                <a:tileRect/>
              </a:gra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B4D17414-C6BE-EB10-E7EE-41A3BBC8FB46}"/>
                </a:ext>
              </a:extLst>
            </p:cNvPr>
            <p:cNvSpPr/>
            <p:nvPr/>
          </p:nvSpPr>
          <p:spPr>
            <a:xfrm>
              <a:off x="3581232" y="1975805"/>
              <a:ext cx="76216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GROMOS 43B1</a:t>
              </a:r>
            </a:p>
            <a:p>
              <a:pPr algn="ctr"/>
              <a:r>
                <a:rPr lang="en-US" sz="5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 force field </a:t>
              </a:r>
            </a:p>
          </p:txBody>
        </p:sp>
      </p:grp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C892703F-DD86-1607-175A-B1D1E55DFDA9}"/>
              </a:ext>
            </a:extLst>
          </p:cNvPr>
          <p:cNvCxnSpPr>
            <a:cxnSpLocks/>
            <a:stCxn id="125" idx="2"/>
            <a:endCxn id="168" idx="0"/>
          </p:cNvCxnSpPr>
          <p:nvPr/>
        </p:nvCxnSpPr>
        <p:spPr>
          <a:xfrm flipH="1">
            <a:off x="2503291" y="823610"/>
            <a:ext cx="559703" cy="662775"/>
          </a:xfrm>
          <a:prstGeom prst="straightConnector1">
            <a:avLst/>
          </a:prstGeom>
          <a:ln w="3175">
            <a:gradFill flip="none" rotWithShape="1">
              <a:gsLst>
                <a:gs pos="0">
                  <a:schemeClr val="accent4">
                    <a:lumMod val="89000"/>
                  </a:schemeClr>
                </a:gs>
                <a:gs pos="23000">
                  <a:schemeClr val="accent4">
                    <a:lumMod val="89000"/>
                  </a:schemeClr>
                </a:gs>
                <a:gs pos="69000">
                  <a:schemeClr val="accent4">
                    <a:lumMod val="75000"/>
                  </a:schemeClr>
                </a:gs>
                <a:gs pos="97000">
                  <a:schemeClr val="accent4">
                    <a:lumMod val="7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Rectangle 145">
            <a:extLst>
              <a:ext uri="{FF2B5EF4-FFF2-40B4-BE49-F238E27FC236}">
                <a16:creationId xmlns:a16="http://schemas.microsoft.com/office/drawing/2014/main" id="{F50B5A22-994C-3F07-0372-A1289319B9FB}"/>
              </a:ext>
            </a:extLst>
          </p:cNvPr>
          <p:cNvSpPr/>
          <p:nvPr/>
        </p:nvSpPr>
        <p:spPr>
          <a:xfrm>
            <a:off x="3209661" y="46919"/>
            <a:ext cx="1730535" cy="1437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Genomic architecture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9285D34E-B3D3-AC63-EF25-CC7CA2352A5F}"/>
              </a:ext>
            </a:extLst>
          </p:cNvPr>
          <p:cNvSpPr/>
          <p:nvPr/>
        </p:nvSpPr>
        <p:spPr>
          <a:xfrm>
            <a:off x="5503802" y="1134615"/>
            <a:ext cx="1284573" cy="234147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creen for phytochemicals exhibiting antiviral properties</a:t>
            </a:r>
            <a:endParaRPr lang="en-US" sz="300" b="1" dirty="0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48" name="Curved Left Arrow 87">
            <a:extLst>
              <a:ext uri="{FF2B5EF4-FFF2-40B4-BE49-F238E27FC236}">
                <a16:creationId xmlns:a16="http://schemas.microsoft.com/office/drawing/2014/main" id="{330E445A-A0C2-319A-F531-0189FF41EE0A}"/>
              </a:ext>
            </a:extLst>
          </p:cNvPr>
          <p:cNvSpPr/>
          <p:nvPr/>
        </p:nvSpPr>
        <p:spPr>
          <a:xfrm rot="174567" flipH="1">
            <a:off x="5155480" y="1604928"/>
            <a:ext cx="407525" cy="506162"/>
          </a:xfrm>
          <a:prstGeom prst="curvedLeftArrow">
            <a:avLst>
              <a:gd name="adj1" fmla="val 4662"/>
              <a:gd name="adj2" fmla="val 12936"/>
              <a:gd name="adj3" fmla="val 9120"/>
            </a:avLst>
          </a:prstGeom>
          <a:gradFill>
            <a:gsLst>
              <a:gs pos="100000">
                <a:schemeClr val="accent4">
                  <a:lumMod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8100000" scaled="1"/>
          </a:gra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0" name="Rounded Rectangle 93">
            <a:extLst>
              <a:ext uri="{FF2B5EF4-FFF2-40B4-BE49-F238E27FC236}">
                <a16:creationId xmlns:a16="http://schemas.microsoft.com/office/drawing/2014/main" id="{1F449D3B-583C-8EC3-471A-DFE931BDBCA1}"/>
              </a:ext>
            </a:extLst>
          </p:cNvPr>
          <p:cNvSpPr/>
          <p:nvPr/>
        </p:nvSpPr>
        <p:spPr>
          <a:xfrm>
            <a:off x="5571915" y="1475129"/>
            <a:ext cx="1201900" cy="31489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A dataset of 373 phytochemicals with antiviral potential</a:t>
            </a:r>
          </a:p>
        </p:txBody>
      </p:sp>
      <p:sp>
        <p:nvSpPr>
          <p:cNvPr id="151" name="Rounded Rectangle 96">
            <a:extLst>
              <a:ext uri="{FF2B5EF4-FFF2-40B4-BE49-F238E27FC236}">
                <a16:creationId xmlns:a16="http://schemas.microsoft.com/office/drawing/2014/main" id="{67C0D46F-DD45-1979-04A6-70EFF16DBA7C}"/>
              </a:ext>
            </a:extLst>
          </p:cNvPr>
          <p:cNvSpPr/>
          <p:nvPr/>
        </p:nvSpPr>
        <p:spPr>
          <a:xfrm>
            <a:off x="5571915" y="1920084"/>
            <a:ext cx="1201901" cy="326476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Retrieve the listed phytochemicals from the </a:t>
            </a:r>
            <a:r>
              <a:rPr lang="en-US" sz="600" b="1" dirty="0" err="1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PubChem</a:t>
            </a:r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database</a:t>
            </a:r>
            <a:endParaRPr lang="en-US" sz="400" b="1" dirty="0">
              <a:solidFill>
                <a:schemeClr val="tx1"/>
              </a:solidFill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2" name="Rounded Rectangle 100">
            <a:extLst>
              <a:ext uri="{FF2B5EF4-FFF2-40B4-BE49-F238E27FC236}">
                <a16:creationId xmlns:a16="http://schemas.microsoft.com/office/drawing/2014/main" id="{5A030BCA-C603-5337-E9D5-12EC791858E7}"/>
              </a:ext>
            </a:extLst>
          </p:cNvPr>
          <p:cNvSpPr/>
          <p:nvPr/>
        </p:nvSpPr>
        <p:spPr>
          <a:xfrm>
            <a:off x="4157504" y="2848597"/>
            <a:ext cx="904995" cy="211173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Optimized Protein Structure</a:t>
            </a:r>
          </a:p>
        </p:txBody>
      </p:sp>
      <p:sp>
        <p:nvSpPr>
          <p:cNvPr id="153" name="Rounded Rectangle 101">
            <a:extLst>
              <a:ext uri="{FF2B5EF4-FFF2-40B4-BE49-F238E27FC236}">
                <a16:creationId xmlns:a16="http://schemas.microsoft.com/office/drawing/2014/main" id="{2DA5E2D3-C579-28B0-1C7B-F57A806CF9A5}"/>
              </a:ext>
            </a:extLst>
          </p:cNvPr>
          <p:cNvSpPr/>
          <p:nvPr/>
        </p:nvSpPr>
        <p:spPr>
          <a:xfrm>
            <a:off x="2990175" y="2840028"/>
            <a:ext cx="904995" cy="211173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Native Protein Structure</a:t>
            </a:r>
          </a:p>
        </p:txBody>
      </p:sp>
      <p:sp>
        <p:nvSpPr>
          <p:cNvPr id="154" name="Rounded Rectangle 103">
            <a:extLst>
              <a:ext uri="{FF2B5EF4-FFF2-40B4-BE49-F238E27FC236}">
                <a16:creationId xmlns:a16="http://schemas.microsoft.com/office/drawing/2014/main" id="{7F6FE471-FB70-CD90-D158-8490626DFE0B}"/>
              </a:ext>
            </a:extLst>
          </p:cNvPr>
          <p:cNvSpPr/>
          <p:nvPr/>
        </p:nvSpPr>
        <p:spPr>
          <a:xfrm>
            <a:off x="5062499" y="2849116"/>
            <a:ext cx="904995" cy="211173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Optimized Ligand structures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663A513B-FC13-0E02-34B2-DD89BA88C3F9}"/>
              </a:ext>
            </a:extLst>
          </p:cNvPr>
          <p:cNvSpPr/>
          <p:nvPr/>
        </p:nvSpPr>
        <p:spPr>
          <a:xfrm>
            <a:off x="5571915" y="2506158"/>
            <a:ext cx="877574" cy="109728"/>
          </a:xfrm>
          <a:prstGeom prst="rect">
            <a:avLst/>
          </a:prstGeom>
          <a:noFill/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Ligand optimization by mmff94 force field</a:t>
            </a:r>
          </a:p>
        </p:txBody>
      </p:sp>
      <p:sp>
        <p:nvSpPr>
          <p:cNvPr id="156" name="Rounded Rectangle 124">
            <a:extLst>
              <a:ext uri="{FF2B5EF4-FFF2-40B4-BE49-F238E27FC236}">
                <a16:creationId xmlns:a16="http://schemas.microsoft.com/office/drawing/2014/main" id="{F666E383-AD7C-F55D-41D4-C41F388A7B43}"/>
              </a:ext>
            </a:extLst>
          </p:cNvPr>
          <p:cNvSpPr/>
          <p:nvPr/>
        </p:nvSpPr>
        <p:spPr>
          <a:xfrm>
            <a:off x="5622866" y="4731107"/>
            <a:ext cx="1150255" cy="211173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Molecular docking of 373 protein ligand complexes</a:t>
            </a: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13ECC34B-05D1-00ED-D4A5-622A6F1AA2F4}"/>
              </a:ext>
            </a:extLst>
          </p:cNvPr>
          <p:cNvSpPr/>
          <p:nvPr/>
        </p:nvSpPr>
        <p:spPr>
          <a:xfrm>
            <a:off x="4022378" y="3561353"/>
            <a:ext cx="527054" cy="1737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ProTox-3.0</a:t>
            </a:r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D08DE95A-4F1D-F540-2E6A-25BD5EC7E80E}"/>
              </a:ext>
            </a:extLst>
          </p:cNvPr>
          <p:cNvSpPr/>
          <p:nvPr/>
        </p:nvSpPr>
        <p:spPr>
          <a:xfrm>
            <a:off x="2148840" y="4274687"/>
            <a:ext cx="1591671" cy="185813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Catechin gallate (CID: 6419835)</a:t>
            </a:r>
          </a:p>
          <a:p>
            <a:pPr algn="ctr"/>
            <a:r>
              <a:rPr lang="en-US" sz="600" b="1" dirty="0" err="1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Bilobetin</a:t>
            </a:r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(CID: 5315459)</a:t>
            </a:r>
          </a:p>
        </p:txBody>
      </p:sp>
      <p:sp>
        <p:nvSpPr>
          <p:cNvPr id="165" name="Rounded Rectangle 92">
            <a:extLst>
              <a:ext uri="{FF2B5EF4-FFF2-40B4-BE49-F238E27FC236}">
                <a16:creationId xmlns:a16="http://schemas.microsoft.com/office/drawing/2014/main" id="{8BF06C60-C70F-D963-800D-F1E3CEAC0B15}"/>
              </a:ext>
            </a:extLst>
          </p:cNvPr>
          <p:cNvSpPr/>
          <p:nvPr/>
        </p:nvSpPr>
        <p:spPr>
          <a:xfrm>
            <a:off x="203309" y="2726282"/>
            <a:ext cx="1877591" cy="225251"/>
          </a:xfrm>
          <a:prstGeom prst="round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4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Novel Therapeutic drug</a:t>
            </a:r>
          </a:p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(Catechin gallate)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A8872BBA-06D0-C683-35D7-2CE7B08C33C2}"/>
              </a:ext>
            </a:extLst>
          </p:cNvPr>
          <p:cNvSpPr/>
          <p:nvPr/>
        </p:nvSpPr>
        <p:spPr>
          <a:xfrm>
            <a:off x="3072238" y="4791791"/>
            <a:ext cx="908343" cy="10149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33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op hit compounds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72CCE5D4-E123-0D7E-57D8-6E9845239EC0}"/>
              </a:ext>
            </a:extLst>
          </p:cNvPr>
          <p:cNvSpPr/>
          <p:nvPr/>
        </p:nvSpPr>
        <p:spPr>
          <a:xfrm>
            <a:off x="1238741" y="-4976"/>
            <a:ext cx="1456862" cy="2578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Mammalian orthoreovirus</a:t>
            </a:r>
          </a:p>
        </p:txBody>
      </p:sp>
      <p:grpSp>
        <p:nvGrpSpPr>
          <p:cNvPr id="2930" name="Group 2929">
            <a:extLst>
              <a:ext uri="{FF2B5EF4-FFF2-40B4-BE49-F238E27FC236}">
                <a16:creationId xmlns:a16="http://schemas.microsoft.com/office/drawing/2014/main" id="{27503AA7-E4B7-1FBC-0FB8-6A09B414EBB0}"/>
              </a:ext>
            </a:extLst>
          </p:cNvPr>
          <p:cNvGrpSpPr/>
          <p:nvPr/>
        </p:nvGrpSpPr>
        <p:grpSpPr>
          <a:xfrm>
            <a:off x="4653520" y="2170597"/>
            <a:ext cx="723299" cy="251148"/>
            <a:chOff x="4419597" y="2035665"/>
            <a:chExt cx="723299" cy="251148"/>
          </a:xfrm>
        </p:grpSpPr>
        <p:sp>
          <p:nvSpPr>
            <p:cNvPr id="140" name="Rounded Rectangle 50">
              <a:extLst>
                <a:ext uri="{FF2B5EF4-FFF2-40B4-BE49-F238E27FC236}">
                  <a16:creationId xmlns:a16="http://schemas.microsoft.com/office/drawing/2014/main" id="{E64E8C48-5CA0-2977-8876-D9555489B445}"/>
                </a:ext>
              </a:extLst>
            </p:cNvPr>
            <p:cNvSpPr/>
            <p:nvPr/>
          </p:nvSpPr>
          <p:spPr>
            <a:xfrm>
              <a:off x="4632384" y="2173813"/>
              <a:ext cx="276578" cy="112511"/>
            </a:xfrm>
            <a:prstGeom prst="round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grpSp>
          <p:nvGrpSpPr>
            <p:cNvPr id="2929" name="Group 2928">
              <a:extLst>
                <a:ext uri="{FF2B5EF4-FFF2-40B4-BE49-F238E27FC236}">
                  <a16:creationId xmlns:a16="http://schemas.microsoft.com/office/drawing/2014/main" id="{FCF0EDEE-8724-28F7-6B46-20F00B4AB34A}"/>
                </a:ext>
              </a:extLst>
            </p:cNvPr>
            <p:cNvGrpSpPr/>
            <p:nvPr/>
          </p:nvGrpSpPr>
          <p:grpSpPr>
            <a:xfrm>
              <a:off x="4419597" y="2035665"/>
              <a:ext cx="723299" cy="251148"/>
              <a:chOff x="4423271" y="2030603"/>
              <a:chExt cx="723299" cy="251148"/>
            </a:xfrm>
          </p:grpSpPr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574E8BF9-1628-169F-2803-55E07B1C8CF3}"/>
                  </a:ext>
                </a:extLst>
              </p:cNvPr>
              <p:cNvSpPr/>
              <p:nvPr/>
            </p:nvSpPr>
            <p:spPr>
              <a:xfrm>
                <a:off x="4487297" y="2165149"/>
                <a:ext cx="574100" cy="1166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Chain A</a:t>
                </a:r>
              </a:p>
            </p:txBody>
          </p:sp>
          <p:sp>
            <p:nvSpPr>
              <p:cNvPr id="139" name="Rectangle 138">
                <a:extLst>
                  <a:ext uri="{FF2B5EF4-FFF2-40B4-BE49-F238E27FC236}">
                    <a16:creationId xmlns:a16="http://schemas.microsoft.com/office/drawing/2014/main" id="{07B4E906-4C8A-C6C2-1B19-AD2F40963BC4}"/>
                  </a:ext>
                </a:extLst>
              </p:cNvPr>
              <p:cNvSpPr/>
              <p:nvPr/>
            </p:nvSpPr>
            <p:spPr>
              <a:xfrm>
                <a:off x="4423271" y="2030603"/>
                <a:ext cx="723299" cy="124302"/>
              </a:xfrm>
              <a:prstGeom prst="rect">
                <a:avLst/>
              </a:prstGeom>
              <a:noFill/>
              <a:ln w="952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5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Sigma1 Monomer</a:t>
                </a:r>
              </a:p>
            </p:txBody>
          </p:sp>
        </p:grpSp>
      </p:grp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AB899C91-C664-F4F7-7F00-8ADDFF509BBD}"/>
              </a:ext>
            </a:extLst>
          </p:cNvPr>
          <p:cNvGrpSpPr/>
          <p:nvPr/>
        </p:nvGrpSpPr>
        <p:grpSpPr>
          <a:xfrm>
            <a:off x="2859730" y="237409"/>
            <a:ext cx="2426132" cy="627365"/>
            <a:chOff x="7771751" y="380403"/>
            <a:chExt cx="4354730" cy="1126076"/>
          </a:xfrm>
          <a:effectLst/>
        </p:grpSpPr>
        <p:sp>
          <p:nvSpPr>
            <p:cNvPr id="175" name="Rounded Rectangle 4"/>
            <p:cNvSpPr/>
            <p:nvPr/>
          </p:nvSpPr>
          <p:spPr>
            <a:xfrm>
              <a:off x="8167640" y="408341"/>
              <a:ext cx="1177744" cy="121921"/>
            </a:xfrm>
            <a:prstGeom prst="roundRect">
              <a:avLst/>
            </a:prstGeom>
            <a:gradFill flip="none" rotWithShape="1">
              <a:gsLst>
                <a:gs pos="0">
                  <a:schemeClr val="accent6">
                    <a:shade val="30000"/>
                    <a:satMod val="115000"/>
                  </a:schemeClr>
                </a:gs>
                <a:gs pos="50000">
                  <a:schemeClr val="accent6">
                    <a:shade val="67500"/>
                    <a:satMod val="115000"/>
                  </a:schemeClr>
                </a:gs>
                <a:gs pos="100000">
                  <a:schemeClr val="accent6"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  <p:sp>
          <p:nvSpPr>
            <p:cNvPr id="176" name="Rounded Rectangle 8"/>
            <p:cNvSpPr/>
            <p:nvPr/>
          </p:nvSpPr>
          <p:spPr>
            <a:xfrm>
              <a:off x="8443259" y="789203"/>
              <a:ext cx="982103" cy="134937"/>
            </a:xfrm>
            <a:prstGeom prst="roundRect">
              <a:avLst/>
            </a:prstGeom>
            <a:gradFill flip="none" rotWithShape="1">
              <a:gsLst>
                <a:gs pos="0">
                  <a:srgbClr val="0070C0">
                    <a:shade val="30000"/>
                    <a:satMod val="115000"/>
                  </a:srgbClr>
                </a:gs>
                <a:gs pos="50000">
                  <a:srgbClr val="0070C0">
                    <a:shade val="67500"/>
                    <a:satMod val="115000"/>
                  </a:srgbClr>
                </a:gs>
                <a:gs pos="100000">
                  <a:srgbClr val="0070C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</p:txBody>
        </p:sp>
        <p:sp>
          <p:nvSpPr>
            <p:cNvPr id="177" name="Rounded Rectangle 13"/>
            <p:cNvSpPr/>
            <p:nvPr/>
          </p:nvSpPr>
          <p:spPr>
            <a:xfrm>
              <a:off x="8537419" y="1173154"/>
              <a:ext cx="675241" cy="144781"/>
            </a:xfrm>
            <a:prstGeom prst="roundRect">
              <a:avLst/>
            </a:prstGeom>
            <a:gradFill flip="none" rotWithShape="1">
              <a:gsLst>
                <a:gs pos="0">
                  <a:schemeClr val="accent2">
                    <a:lumMod val="75000"/>
                    <a:shade val="30000"/>
                    <a:satMod val="115000"/>
                  </a:schemeClr>
                </a:gs>
                <a:gs pos="50000">
                  <a:schemeClr val="accent2">
                    <a:lumMod val="75000"/>
                    <a:shade val="67500"/>
                    <a:satMod val="115000"/>
                  </a:schemeClr>
                </a:gs>
                <a:gs pos="100000">
                  <a:schemeClr val="accent2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</a:p>
          </p:txBody>
        </p:sp>
        <p:sp>
          <p:nvSpPr>
            <p:cNvPr id="178" name="Rounded Rectangle 14"/>
            <p:cNvSpPr/>
            <p:nvPr/>
          </p:nvSpPr>
          <p:spPr>
            <a:xfrm>
              <a:off x="9380313" y="408341"/>
              <a:ext cx="1177744" cy="121921"/>
            </a:xfrm>
            <a:prstGeom prst="roundRect">
              <a:avLst/>
            </a:prstGeom>
            <a:gradFill flip="none" rotWithShape="1">
              <a:gsLst>
                <a:gs pos="0">
                  <a:schemeClr val="accent6">
                    <a:shade val="30000"/>
                    <a:satMod val="115000"/>
                  </a:schemeClr>
                </a:gs>
                <a:gs pos="50000">
                  <a:schemeClr val="accent6">
                    <a:shade val="67500"/>
                    <a:satMod val="115000"/>
                  </a:schemeClr>
                </a:gs>
                <a:gs pos="100000">
                  <a:schemeClr val="accent6"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  <p:sp>
          <p:nvSpPr>
            <p:cNvPr id="179" name="Rounded Rectangle 15"/>
            <p:cNvSpPr/>
            <p:nvPr/>
          </p:nvSpPr>
          <p:spPr>
            <a:xfrm>
              <a:off x="10592181" y="408341"/>
              <a:ext cx="1177745" cy="121920"/>
            </a:xfrm>
            <a:prstGeom prst="roundRect">
              <a:avLst/>
            </a:prstGeom>
            <a:gradFill flip="none" rotWithShape="1">
              <a:gsLst>
                <a:gs pos="0">
                  <a:schemeClr val="accent6">
                    <a:shade val="30000"/>
                    <a:satMod val="115000"/>
                  </a:schemeClr>
                </a:gs>
                <a:gs pos="50000">
                  <a:schemeClr val="accent6">
                    <a:shade val="67500"/>
                    <a:satMod val="115000"/>
                  </a:schemeClr>
                </a:gs>
                <a:gs pos="100000">
                  <a:schemeClr val="accent6"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L3</a:t>
              </a:r>
            </a:p>
          </p:txBody>
        </p:sp>
        <p:sp>
          <p:nvSpPr>
            <p:cNvPr id="180" name="Rounded Rectangle 16"/>
            <p:cNvSpPr/>
            <p:nvPr/>
          </p:nvSpPr>
          <p:spPr>
            <a:xfrm>
              <a:off x="10490261" y="789203"/>
              <a:ext cx="982103" cy="134937"/>
            </a:xfrm>
            <a:prstGeom prst="roundRect">
              <a:avLst/>
            </a:prstGeom>
            <a:gradFill flip="none" rotWithShape="1">
              <a:gsLst>
                <a:gs pos="0">
                  <a:srgbClr val="0070C0">
                    <a:shade val="30000"/>
                    <a:satMod val="115000"/>
                  </a:srgbClr>
                </a:gs>
                <a:gs pos="50000">
                  <a:srgbClr val="0070C0">
                    <a:shade val="67500"/>
                    <a:satMod val="115000"/>
                  </a:srgbClr>
                </a:gs>
                <a:gs pos="100000">
                  <a:srgbClr val="0070C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3</a:t>
              </a:r>
            </a:p>
          </p:txBody>
        </p:sp>
        <p:sp>
          <p:nvSpPr>
            <p:cNvPr id="181" name="Rounded Rectangle 17"/>
            <p:cNvSpPr/>
            <p:nvPr/>
          </p:nvSpPr>
          <p:spPr>
            <a:xfrm>
              <a:off x="9466760" y="789203"/>
              <a:ext cx="982103" cy="134937"/>
            </a:xfrm>
            <a:prstGeom prst="roundRect">
              <a:avLst/>
            </a:prstGeom>
            <a:gradFill flip="none" rotWithShape="1">
              <a:gsLst>
                <a:gs pos="0">
                  <a:srgbClr val="0070C0">
                    <a:shade val="30000"/>
                    <a:satMod val="115000"/>
                  </a:srgbClr>
                </a:gs>
                <a:gs pos="50000">
                  <a:srgbClr val="0070C0">
                    <a:shade val="67500"/>
                    <a:satMod val="115000"/>
                  </a:srgbClr>
                </a:gs>
                <a:gs pos="100000">
                  <a:srgbClr val="0070C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2</a:t>
              </a:r>
            </a:p>
          </p:txBody>
        </p:sp>
        <p:sp>
          <p:nvSpPr>
            <p:cNvPr id="182" name="Rounded Rectangle 21"/>
            <p:cNvSpPr/>
            <p:nvPr/>
          </p:nvSpPr>
          <p:spPr>
            <a:xfrm>
              <a:off x="9264850" y="1173154"/>
              <a:ext cx="675241" cy="144781"/>
            </a:xfrm>
            <a:prstGeom prst="roundRect">
              <a:avLst/>
            </a:prstGeom>
            <a:gradFill flip="none" rotWithShape="1">
              <a:gsLst>
                <a:gs pos="0">
                  <a:schemeClr val="accent2">
                    <a:lumMod val="75000"/>
                    <a:shade val="30000"/>
                    <a:satMod val="115000"/>
                  </a:schemeClr>
                </a:gs>
                <a:gs pos="50000">
                  <a:schemeClr val="accent2">
                    <a:lumMod val="75000"/>
                    <a:shade val="67500"/>
                    <a:satMod val="115000"/>
                  </a:schemeClr>
                </a:gs>
                <a:gs pos="100000">
                  <a:schemeClr val="accent2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2</a:t>
              </a:r>
            </a:p>
          </p:txBody>
        </p:sp>
        <p:sp>
          <p:nvSpPr>
            <p:cNvPr id="183" name="Rounded Rectangle 22"/>
            <p:cNvSpPr/>
            <p:nvPr/>
          </p:nvSpPr>
          <p:spPr>
            <a:xfrm>
              <a:off x="9973796" y="1173154"/>
              <a:ext cx="675241" cy="144781"/>
            </a:xfrm>
            <a:prstGeom prst="roundRect">
              <a:avLst/>
            </a:prstGeom>
            <a:gradFill flip="none" rotWithShape="1">
              <a:gsLst>
                <a:gs pos="0">
                  <a:schemeClr val="accent2">
                    <a:lumMod val="75000"/>
                    <a:shade val="30000"/>
                    <a:satMod val="115000"/>
                  </a:schemeClr>
                </a:gs>
                <a:gs pos="50000">
                  <a:schemeClr val="accent2">
                    <a:lumMod val="75000"/>
                    <a:shade val="67500"/>
                    <a:satMod val="115000"/>
                  </a:schemeClr>
                </a:gs>
                <a:gs pos="100000">
                  <a:schemeClr val="accent2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3</a:t>
              </a:r>
            </a:p>
          </p:txBody>
        </p:sp>
        <p:sp>
          <p:nvSpPr>
            <p:cNvPr id="184" name="Rounded Rectangle 23"/>
            <p:cNvSpPr/>
            <p:nvPr/>
          </p:nvSpPr>
          <p:spPr>
            <a:xfrm>
              <a:off x="10682744" y="1173154"/>
              <a:ext cx="675241" cy="144781"/>
            </a:xfrm>
            <a:prstGeom prst="roundRect">
              <a:avLst/>
            </a:prstGeom>
            <a:gradFill flip="none" rotWithShape="1">
              <a:gsLst>
                <a:gs pos="0">
                  <a:schemeClr val="accent2">
                    <a:lumMod val="75000"/>
                    <a:shade val="30000"/>
                    <a:satMod val="115000"/>
                  </a:schemeClr>
                </a:gs>
                <a:gs pos="50000">
                  <a:schemeClr val="accent2">
                    <a:lumMod val="75000"/>
                    <a:shade val="67500"/>
                    <a:satMod val="115000"/>
                  </a:schemeClr>
                </a:gs>
                <a:gs pos="100000">
                  <a:schemeClr val="accent2">
                    <a:lumMod val="7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9525"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4</a:t>
              </a:r>
            </a:p>
          </p:txBody>
        </p:sp>
        <p:sp>
          <p:nvSpPr>
            <p:cNvPr id="185" name="Rounded Rectangle 27"/>
            <p:cNvSpPr/>
            <p:nvPr/>
          </p:nvSpPr>
          <p:spPr>
            <a:xfrm>
              <a:off x="10641508" y="556238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λ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86" name="Rounded Rectangle 28"/>
            <p:cNvSpPr/>
            <p:nvPr/>
          </p:nvSpPr>
          <p:spPr>
            <a:xfrm>
              <a:off x="9423895" y="556238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λ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87" name="Rounded Rectangle 29"/>
            <p:cNvSpPr/>
            <p:nvPr/>
          </p:nvSpPr>
          <p:spPr>
            <a:xfrm>
              <a:off x="8206282" y="558200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λ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8" name="Rounded Rectangle 30"/>
            <p:cNvSpPr/>
            <p:nvPr/>
          </p:nvSpPr>
          <p:spPr>
            <a:xfrm>
              <a:off x="9382405" y="934537"/>
              <a:ext cx="711434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µ1</a:t>
              </a:r>
            </a:p>
          </p:txBody>
        </p:sp>
        <p:sp>
          <p:nvSpPr>
            <p:cNvPr id="189" name="Rounded Rectangle 31"/>
            <p:cNvSpPr/>
            <p:nvPr/>
          </p:nvSpPr>
          <p:spPr>
            <a:xfrm>
              <a:off x="8359938" y="939494"/>
              <a:ext cx="711434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µ2</a:t>
              </a:r>
            </a:p>
          </p:txBody>
        </p:sp>
        <p:sp>
          <p:nvSpPr>
            <p:cNvPr id="190" name="Rounded Rectangle 32"/>
            <p:cNvSpPr/>
            <p:nvPr/>
          </p:nvSpPr>
          <p:spPr>
            <a:xfrm>
              <a:off x="10100076" y="943739"/>
              <a:ext cx="939495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µNS+µNSC</a:t>
              </a:r>
            </a:p>
          </p:txBody>
        </p:sp>
        <p:sp>
          <p:nvSpPr>
            <p:cNvPr id="191" name="Rounded Rectangle 33"/>
            <p:cNvSpPr/>
            <p:nvPr/>
          </p:nvSpPr>
          <p:spPr>
            <a:xfrm>
              <a:off x="8095129" y="1331940"/>
              <a:ext cx="786120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σ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+</a:t>
              </a:r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 σ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s</a:t>
              </a:r>
            </a:p>
          </p:txBody>
        </p:sp>
        <p:sp>
          <p:nvSpPr>
            <p:cNvPr id="192" name="Rounded Rectangle 34"/>
            <p:cNvSpPr/>
            <p:nvPr/>
          </p:nvSpPr>
          <p:spPr>
            <a:xfrm>
              <a:off x="9050186" y="1331939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σ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93" name="Rounded Rectangle 35"/>
            <p:cNvSpPr/>
            <p:nvPr/>
          </p:nvSpPr>
          <p:spPr>
            <a:xfrm>
              <a:off x="9716937" y="1333125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σ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94" name="Rounded Rectangle 36"/>
            <p:cNvSpPr/>
            <p:nvPr/>
          </p:nvSpPr>
          <p:spPr>
            <a:xfrm>
              <a:off x="10469076" y="1331939"/>
              <a:ext cx="666751" cy="17335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σ</a:t>
              </a:r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95" name="Rounded Rectangle 50"/>
            <p:cNvSpPr/>
            <p:nvPr/>
          </p:nvSpPr>
          <p:spPr>
            <a:xfrm>
              <a:off x="7771751" y="380403"/>
              <a:ext cx="573039" cy="17081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5'</a:t>
              </a:r>
            </a:p>
          </p:txBody>
        </p:sp>
        <p:sp>
          <p:nvSpPr>
            <p:cNvPr id="196" name="Rounded Rectangle 51"/>
            <p:cNvSpPr/>
            <p:nvPr/>
          </p:nvSpPr>
          <p:spPr>
            <a:xfrm>
              <a:off x="11620789" y="380403"/>
              <a:ext cx="505692" cy="170814"/>
            </a:xfrm>
            <a:prstGeom prst="roundRect">
              <a:avLst/>
            </a:prstGeom>
            <a:noFill/>
            <a:ln>
              <a:noFill/>
            </a:ln>
            <a:effectLst>
              <a:innerShdw blurRad="1079500">
                <a:prstClr val="black">
                  <a:alpha val="13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3'</a:t>
              </a:r>
            </a:p>
          </p:txBody>
        </p:sp>
        <p:sp>
          <p:nvSpPr>
            <p:cNvPr id="197" name="Arrow: Bent 196">
              <a:extLst>
                <a:ext uri="{FF2B5EF4-FFF2-40B4-BE49-F238E27FC236}">
                  <a16:creationId xmlns:a16="http://schemas.microsoft.com/office/drawing/2014/main" id="{C1EBC0D2-1214-B083-CDC3-00BA0315E803}"/>
                </a:ext>
              </a:extLst>
            </p:cNvPr>
            <p:cNvSpPr/>
            <p:nvPr/>
          </p:nvSpPr>
          <p:spPr>
            <a:xfrm rot="10800000">
              <a:off x="8631555" y="530262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Arrow: Bent 197">
              <a:extLst>
                <a:ext uri="{FF2B5EF4-FFF2-40B4-BE49-F238E27FC236}">
                  <a16:creationId xmlns:a16="http://schemas.microsoft.com/office/drawing/2014/main" id="{CA9581C5-4DE0-18FA-3949-3FAADA21D741}"/>
                </a:ext>
              </a:extLst>
            </p:cNvPr>
            <p:cNvSpPr/>
            <p:nvPr/>
          </p:nvSpPr>
          <p:spPr>
            <a:xfrm rot="10800000">
              <a:off x="9855921" y="536038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Arrow: Bent 198">
              <a:extLst>
                <a:ext uri="{FF2B5EF4-FFF2-40B4-BE49-F238E27FC236}">
                  <a16:creationId xmlns:a16="http://schemas.microsoft.com/office/drawing/2014/main" id="{CBEC14F0-6741-E6D4-BF3C-C8E4E9CA5C18}"/>
                </a:ext>
              </a:extLst>
            </p:cNvPr>
            <p:cNvSpPr/>
            <p:nvPr/>
          </p:nvSpPr>
          <p:spPr>
            <a:xfrm rot="10800000">
              <a:off x="11062341" y="529176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4" name="Arrow: Bent 1023">
              <a:extLst>
                <a:ext uri="{FF2B5EF4-FFF2-40B4-BE49-F238E27FC236}">
                  <a16:creationId xmlns:a16="http://schemas.microsoft.com/office/drawing/2014/main" id="{9CE5F88F-F0C5-7A4E-B946-B6EBB10D2017}"/>
                </a:ext>
              </a:extLst>
            </p:cNvPr>
            <p:cNvSpPr/>
            <p:nvPr/>
          </p:nvSpPr>
          <p:spPr>
            <a:xfrm rot="10800000">
              <a:off x="8808271" y="923241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5" name="Arrow: Bent 1024">
              <a:extLst>
                <a:ext uri="{FF2B5EF4-FFF2-40B4-BE49-F238E27FC236}">
                  <a16:creationId xmlns:a16="http://schemas.microsoft.com/office/drawing/2014/main" id="{97A1A6F8-1A63-8D60-643D-E2F2142DA407}"/>
                </a:ext>
              </a:extLst>
            </p:cNvPr>
            <p:cNvSpPr/>
            <p:nvPr/>
          </p:nvSpPr>
          <p:spPr>
            <a:xfrm rot="10800000">
              <a:off x="9836773" y="918461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4" name="Arrow: Bent 1033">
              <a:extLst>
                <a:ext uri="{FF2B5EF4-FFF2-40B4-BE49-F238E27FC236}">
                  <a16:creationId xmlns:a16="http://schemas.microsoft.com/office/drawing/2014/main" id="{5E609768-9C2D-657F-4111-7DF5B259D77F}"/>
                </a:ext>
              </a:extLst>
            </p:cNvPr>
            <p:cNvSpPr/>
            <p:nvPr/>
          </p:nvSpPr>
          <p:spPr>
            <a:xfrm rot="10800000">
              <a:off x="10862358" y="924088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5" name="Arrow: Bent 1034">
              <a:extLst>
                <a:ext uri="{FF2B5EF4-FFF2-40B4-BE49-F238E27FC236}">
                  <a16:creationId xmlns:a16="http://schemas.microsoft.com/office/drawing/2014/main" id="{5B37995F-68BE-C3D9-15A4-C0B91A9C2B48}"/>
                </a:ext>
              </a:extLst>
            </p:cNvPr>
            <p:cNvSpPr/>
            <p:nvPr/>
          </p:nvSpPr>
          <p:spPr>
            <a:xfrm rot="10800000">
              <a:off x="8791367" y="1317693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0" name="Arrow: Bent 1039">
              <a:extLst>
                <a:ext uri="{FF2B5EF4-FFF2-40B4-BE49-F238E27FC236}">
                  <a16:creationId xmlns:a16="http://schemas.microsoft.com/office/drawing/2014/main" id="{0D8F32AD-E76F-BC26-7B52-D8F73532533A}"/>
                </a:ext>
              </a:extLst>
            </p:cNvPr>
            <p:cNvSpPr/>
            <p:nvPr/>
          </p:nvSpPr>
          <p:spPr>
            <a:xfrm rot="10800000">
              <a:off x="10191779" y="1316607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1" name="Arrow: Bent 1040">
              <a:extLst>
                <a:ext uri="{FF2B5EF4-FFF2-40B4-BE49-F238E27FC236}">
                  <a16:creationId xmlns:a16="http://schemas.microsoft.com/office/drawing/2014/main" id="{6AAAC465-83E1-6B9F-8E05-095246886397}"/>
                </a:ext>
              </a:extLst>
            </p:cNvPr>
            <p:cNvSpPr/>
            <p:nvPr/>
          </p:nvSpPr>
          <p:spPr>
            <a:xfrm rot="10800000">
              <a:off x="10900725" y="1311922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2" name="Arrow: Bent 1041">
              <a:extLst>
                <a:ext uri="{FF2B5EF4-FFF2-40B4-BE49-F238E27FC236}">
                  <a16:creationId xmlns:a16="http://schemas.microsoft.com/office/drawing/2014/main" id="{8F52431B-102D-7A80-0456-C9C5EBF9C37A}"/>
                </a:ext>
              </a:extLst>
            </p:cNvPr>
            <p:cNvSpPr/>
            <p:nvPr/>
          </p:nvSpPr>
          <p:spPr>
            <a:xfrm rot="10800000">
              <a:off x="9481092" y="1317036"/>
              <a:ext cx="137570" cy="140144"/>
            </a:xfrm>
            <a:prstGeom prst="bentArrow">
              <a:avLst>
                <a:gd name="adj1" fmla="val 9239"/>
                <a:gd name="adj2" fmla="val 15270"/>
                <a:gd name="adj3" fmla="val 25752"/>
                <a:gd name="adj4" fmla="val 53443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64" name="Rectangle 1163">
            <a:extLst>
              <a:ext uri="{FF2B5EF4-FFF2-40B4-BE49-F238E27FC236}">
                <a16:creationId xmlns:a16="http://schemas.microsoft.com/office/drawing/2014/main" id="{2C3FF715-8200-E135-F9D0-9C621529803F}"/>
              </a:ext>
            </a:extLst>
          </p:cNvPr>
          <p:cNvSpPr/>
          <p:nvPr/>
        </p:nvSpPr>
        <p:spPr>
          <a:xfrm>
            <a:off x="5028824" y="1737865"/>
            <a:ext cx="755230" cy="21433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ubChem</a:t>
            </a:r>
          </a:p>
        </p:txBody>
      </p:sp>
      <p:grpSp>
        <p:nvGrpSpPr>
          <p:cNvPr id="1165" name="Group 1164">
            <a:extLst>
              <a:ext uri="{FF2B5EF4-FFF2-40B4-BE49-F238E27FC236}">
                <a16:creationId xmlns:a16="http://schemas.microsoft.com/office/drawing/2014/main" id="{398A982C-6003-8283-4159-944A383D6EC4}"/>
              </a:ext>
            </a:extLst>
          </p:cNvPr>
          <p:cNvGrpSpPr/>
          <p:nvPr/>
        </p:nvGrpSpPr>
        <p:grpSpPr>
          <a:xfrm>
            <a:off x="5623560" y="137950"/>
            <a:ext cx="942539" cy="1007519"/>
            <a:chOff x="1865371" y="3899971"/>
            <a:chExt cx="999719" cy="1068641"/>
          </a:xfrm>
        </p:grpSpPr>
        <p:grpSp>
          <p:nvGrpSpPr>
            <p:cNvPr id="1166" name="Group 1165">
              <a:extLst>
                <a:ext uri="{FF2B5EF4-FFF2-40B4-BE49-F238E27FC236}">
                  <a16:creationId xmlns:a16="http://schemas.microsoft.com/office/drawing/2014/main" id="{6737C999-A609-C63F-1DB6-D43782F85C66}"/>
                </a:ext>
              </a:extLst>
            </p:cNvPr>
            <p:cNvGrpSpPr/>
            <p:nvPr/>
          </p:nvGrpSpPr>
          <p:grpSpPr>
            <a:xfrm>
              <a:off x="1865371" y="3899971"/>
              <a:ext cx="999719" cy="814101"/>
              <a:chOff x="1865371" y="3766882"/>
              <a:chExt cx="1125647" cy="916648"/>
            </a:xfrm>
          </p:grpSpPr>
          <p:grpSp>
            <p:nvGrpSpPr>
              <p:cNvPr id="1174" name="Group 1173">
                <a:extLst>
                  <a:ext uri="{FF2B5EF4-FFF2-40B4-BE49-F238E27FC236}">
                    <a16:creationId xmlns:a16="http://schemas.microsoft.com/office/drawing/2014/main" id="{A35408C9-4628-EEC6-C254-80BA6C24D978}"/>
                  </a:ext>
                </a:extLst>
              </p:cNvPr>
              <p:cNvGrpSpPr/>
              <p:nvPr/>
            </p:nvGrpSpPr>
            <p:grpSpPr>
              <a:xfrm>
                <a:off x="1865371" y="3766882"/>
                <a:ext cx="1125647" cy="916648"/>
                <a:chOff x="270188" y="360288"/>
                <a:chExt cx="2455110" cy="1999270"/>
              </a:xfrm>
            </p:grpSpPr>
            <p:grpSp>
              <p:nvGrpSpPr>
                <p:cNvPr id="1176" name="Group 1175">
                  <a:extLst>
                    <a:ext uri="{FF2B5EF4-FFF2-40B4-BE49-F238E27FC236}">
                      <a16:creationId xmlns:a16="http://schemas.microsoft.com/office/drawing/2014/main" id="{C0F5D3B4-FF49-1016-0A48-5B848BDBF5E4}"/>
                    </a:ext>
                  </a:extLst>
                </p:cNvPr>
                <p:cNvGrpSpPr/>
                <p:nvPr/>
              </p:nvGrpSpPr>
              <p:grpSpPr>
                <a:xfrm>
                  <a:off x="567816" y="360288"/>
                  <a:ext cx="2063293" cy="1999270"/>
                  <a:chOff x="5115598" y="1806827"/>
                  <a:chExt cx="2669954" cy="2587105"/>
                </a:xfrm>
              </p:grpSpPr>
              <p:sp>
                <p:nvSpPr>
                  <p:cNvPr id="1197" name="Rectangle 1196">
                    <a:extLst>
                      <a:ext uri="{FF2B5EF4-FFF2-40B4-BE49-F238E27FC236}">
                        <a16:creationId xmlns:a16="http://schemas.microsoft.com/office/drawing/2014/main" id="{64769543-111B-66F0-673D-8DEEE31D7C2B}"/>
                      </a:ext>
                    </a:extLst>
                  </p:cNvPr>
                  <p:cNvSpPr/>
                  <p:nvPr/>
                </p:nvSpPr>
                <p:spPr>
                  <a:xfrm rot="1169447">
                    <a:off x="5770910" y="2006795"/>
                    <a:ext cx="1960802" cy="2387137"/>
                  </a:xfrm>
                  <a:prstGeom prst="rect">
                    <a:avLst/>
                  </a:prstGeom>
                  <a:solidFill>
                    <a:schemeClr val="bg2">
                      <a:lumMod val="9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98" name="Rectangle 1197">
                    <a:extLst>
                      <a:ext uri="{FF2B5EF4-FFF2-40B4-BE49-F238E27FC236}">
                        <a16:creationId xmlns:a16="http://schemas.microsoft.com/office/drawing/2014/main" id="{9E803D45-21A6-9000-395C-2C05C0AF019E}"/>
                      </a:ext>
                    </a:extLst>
                  </p:cNvPr>
                  <p:cNvSpPr/>
                  <p:nvPr/>
                </p:nvSpPr>
                <p:spPr>
                  <a:xfrm rot="20226519">
                    <a:off x="5115598" y="1881082"/>
                    <a:ext cx="1960802" cy="2387137"/>
                  </a:xfrm>
                  <a:prstGeom prst="rect">
                    <a:avLst/>
                  </a:prstGeom>
                  <a:solidFill>
                    <a:schemeClr val="bg2">
                      <a:lumMod val="9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199" name="Group 1198">
                    <a:extLst>
                      <a:ext uri="{FF2B5EF4-FFF2-40B4-BE49-F238E27FC236}">
                        <a16:creationId xmlns:a16="http://schemas.microsoft.com/office/drawing/2014/main" id="{AB12B607-89B3-6359-8BB9-4D33E177DE19}"/>
                      </a:ext>
                    </a:extLst>
                  </p:cNvPr>
                  <p:cNvGrpSpPr/>
                  <p:nvPr/>
                </p:nvGrpSpPr>
                <p:grpSpPr>
                  <a:xfrm>
                    <a:off x="5387327" y="1806827"/>
                    <a:ext cx="2398225" cy="2544159"/>
                    <a:chOff x="5387327" y="1806827"/>
                    <a:chExt cx="2398225" cy="2544159"/>
                  </a:xfrm>
                </p:grpSpPr>
                <p:sp>
                  <p:nvSpPr>
                    <p:cNvPr id="1200" name="Rectangle 1199">
                      <a:extLst>
                        <a:ext uri="{FF2B5EF4-FFF2-40B4-BE49-F238E27FC236}">
                          <a16:creationId xmlns:a16="http://schemas.microsoft.com/office/drawing/2014/main" id="{ED397C64-CFBA-9C08-BC29-2ECA1B105CA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387327" y="1806827"/>
                      <a:ext cx="2094172" cy="2544159"/>
                    </a:xfrm>
                    <a:prstGeom prst="rect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201" name="Group 1200">
                      <a:extLst>
                        <a:ext uri="{FF2B5EF4-FFF2-40B4-BE49-F238E27FC236}">
                          <a16:creationId xmlns:a16="http://schemas.microsoft.com/office/drawing/2014/main" id="{4BC6B7A4-694A-CDF7-67BA-895998699A8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575498" y="2733522"/>
                      <a:ext cx="1210054" cy="1541446"/>
                      <a:chOff x="6659084" y="2736490"/>
                      <a:chExt cx="1210054" cy="1541446"/>
                    </a:xfrm>
                  </p:grpSpPr>
                  <p:sp>
                    <p:nvSpPr>
                      <p:cNvPr id="1241" name="Rectangle 1240">
                        <a:extLst>
                          <a:ext uri="{FF2B5EF4-FFF2-40B4-BE49-F238E27FC236}">
                            <a16:creationId xmlns:a16="http://schemas.microsoft.com/office/drawing/2014/main" id="{E7021FF3-AD78-D1C5-8037-9B4E8147E88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659084" y="3550454"/>
                        <a:ext cx="734910" cy="72748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2" name="Rectangle 1241">
                        <a:extLst>
                          <a:ext uri="{FF2B5EF4-FFF2-40B4-BE49-F238E27FC236}">
                            <a16:creationId xmlns:a16="http://schemas.microsoft.com/office/drawing/2014/main" id="{1CCD559E-5ED6-5B71-F336-3481F433210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720268" y="3698111"/>
                        <a:ext cx="93233" cy="571197"/>
                      </a:xfrm>
                      <a:prstGeom prst="rect">
                        <a:avLst/>
                      </a:prstGeom>
                      <a:solidFill>
                        <a:schemeClr val="accent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3" name="Rectangle 1242">
                        <a:extLst>
                          <a:ext uri="{FF2B5EF4-FFF2-40B4-BE49-F238E27FC236}">
                            <a16:creationId xmlns:a16="http://schemas.microsoft.com/office/drawing/2014/main" id="{A9FC0524-16F8-0239-8A92-2B58513A02B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903507" y="3845486"/>
                        <a:ext cx="97536" cy="423822"/>
                      </a:xfrm>
                      <a:prstGeom prst="rect">
                        <a:avLst/>
                      </a:prstGeom>
                      <a:solidFill>
                        <a:schemeClr val="accent2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4" name="Rectangle 1243">
                        <a:extLst>
                          <a:ext uri="{FF2B5EF4-FFF2-40B4-BE49-F238E27FC236}">
                            <a16:creationId xmlns:a16="http://schemas.microsoft.com/office/drawing/2014/main" id="{CB1A3AFC-E462-648B-BE26-B4822E56073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068653" y="3749484"/>
                        <a:ext cx="93233" cy="519824"/>
                      </a:xfrm>
                      <a:prstGeom prst="rect">
                        <a:avLst/>
                      </a:prstGeom>
                      <a:solidFill>
                        <a:srgbClr val="7030A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5" name="Rectangle 1244">
                        <a:extLst>
                          <a:ext uri="{FF2B5EF4-FFF2-40B4-BE49-F238E27FC236}">
                            <a16:creationId xmlns:a16="http://schemas.microsoft.com/office/drawing/2014/main" id="{CB59D4AE-0459-3F3B-F0DE-CB151FC7F8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229496" y="3903600"/>
                        <a:ext cx="93233" cy="365707"/>
                      </a:xfrm>
                      <a:prstGeom prst="rect">
                        <a:avLst/>
                      </a:prstGeom>
                      <a:solidFill>
                        <a:schemeClr val="accent6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6" name="Rectangle 1245">
                        <a:extLst>
                          <a:ext uri="{FF2B5EF4-FFF2-40B4-BE49-F238E27FC236}">
                            <a16:creationId xmlns:a16="http://schemas.microsoft.com/office/drawing/2014/main" id="{CD83B153-0D27-E68A-8A30-13D0FD7F21ED}"/>
                          </a:ext>
                        </a:extLst>
                      </p:cNvPr>
                      <p:cNvSpPr/>
                      <p:nvPr/>
                    </p:nvSpPr>
                    <p:spPr>
                      <a:xfrm rot="1236668">
                        <a:off x="7654975" y="2736490"/>
                        <a:ext cx="214163" cy="347681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7" name="Rectangle 1246">
                        <a:extLst>
                          <a:ext uri="{FF2B5EF4-FFF2-40B4-BE49-F238E27FC236}">
                            <a16:creationId xmlns:a16="http://schemas.microsoft.com/office/drawing/2014/main" id="{89648A5C-DDFA-8BD4-60C5-5244F5C38E22}"/>
                          </a:ext>
                        </a:extLst>
                      </p:cNvPr>
                      <p:cNvSpPr/>
                      <p:nvPr/>
                    </p:nvSpPr>
                    <p:spPr>
                      <a:xfrm rot="1215602">
                        <a:off x="7701999" y="2757251"/>
                        <a:ext cx="93233" cy="290690"/>
                      </a:xfrm>
                      <a:prstGeom prst="rect">
                        <a:avLst/>
                      </a:prstGeom>
                      <a:solidFill>
                        <a:srgbClr val="7030A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202" name="Straight Connector 1201">
                      <a:extLst>
                        <a:ext uri="{FF2B5EF4-FFF2-40B4-BE49-F238E27FC236}">
                          <a16:creationId xmlns:a16="http://schemas.microsoft.com/office/drawing/2014/main" id="{DB2A50EC-A89F-86C7-5781-953D903736F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617858" y="2088623"/>
                      <a:ext cx="1783956" cy="0"/>
                    </a:xfrm>
                    <a:prstGeom prst="line">
                      <a:avLst/>
                    </a:prstGeom>
                    <a:ln w="12700">
                      <a:solidFill>
                        <a:schemeClr val="accent2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203" name="Group 1202">
                      <a:extLst>
                        <a:ext uri="{FF2B5EF4-FFF2-40B4-BE49-F238E27FC236}">
                          <a16:creationId xmlns:a16="http://schemas.microsoft.com/office/drawing/2014/main" id="{81089DCF-246B-DC4E-71E3-F2A6F1BA26E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613899" y="2842224"/>
                      <a:ext cx="603150" cy="632148"/>
                      <a:chOff x="9393937" y="2631413"/>
                      <a:chExt cx="1225296" cy="1225296"/>
                    </a:xfrm>
                  </p:grpSpPr>
                  <p:sp>
                    <p:nvSpPr>
                      <p:cNvPr id="1233" name="Freeform: Shape 1232">
                        <a:extLst>
                          <a:ext uri="{FF2B5EF4-FFF2-40B4-BE49-F238E27FC236}">
                            <a16:creationId xmlns:a16="http://schemas.microsoft.com/office/drawing/2014/main" id="{966E7B2F-F287-8984-1DEA-334BF37CF9B2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9721609" y="2860561"/>
                        <a:ext cx="569948" cy="111652"/>
                      </a:xfrm>
                      <a:custGeom>
                        <a:avLst/>
                        <a:gdLst>
                          <a:gd name="csX0" fmla="*/ 0 w 569948"/>
                          <a:gd name="csY0" fmla="*/ 55826 h 111652"/>
                          <a:gd name="csX1" fmla="*/ 5628 w 569948"/>
                          <a:gd name="csY1" fmla="*/ 0 h 111652"/>
                          <a:gd name="csX2" fmla="*/ 569948 w 569948"/>
                          <a:gd name="csY2" fmla="*/ 0 h 111652"/>
                          <a:gd name="csX3" fmla="*/ 569948 w 569948"/>
                          <a:gd name="csY3" fmla="*/ 111652 h 111652"/>
                          <a:gd name="csX4" fmla="*/ 5628 w 569948"/>
                          <a:gd name="csY4" fmla="*/ 111652 h 111652"/>
                          <a:gd name="csX5" fmla="*/ 0 w 569948"/>
                          <a:gd name="csY5" fmla="*/ 55826 h 11165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569948" h="111652">
                            <a:moveTo>
                              <a:pt x="0" y="55826"/>
                            </a:moveTo>
                            <a:lnTo>
                              <a:pt x="5628" y="0"/>
                            </a:lnTo>
                            <a:lnTo>
                              <a:pt x="569948" y="0"/>
                            </a:lnTo>
                            <a:lnTo>
                              <a:pt x="569948" y="111652"/>
                            </a:lnTo>
                            <a:lnTo>
                              <a:pt x="5628" y="111652"/>
                            </a:lnTo>
                            <a:lnTo>
                              <a:pt x="0" y="55826"/>
                            </a:lnTo>
                            <a:close/>
                          </a:path>
                        </a:pathLst>
                      </a:custGeom>
                      <a:solidFill>
                        <a:schemeClr val="accent2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4" name="Freeform: Shape 1233">
                        <a:extLst>
                          <a:ext uri="{FF2B5EF4-FFF2-40B4-BE49-F238E27FC236}">
                            <a16:creationId xmlns:a16="http://schemas.microsoft.com/office/drawing/2014/main" id="{25947AA1-7BF2-E119-9087-FB23B9C708F8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9616521" y="2978777"/>
                        <a:ext cx="111653" cy="556822"/>
                      </a:xfrm>
                      <a:custGeom>
                        <a:avLst/>
                        <a:gdLst>
                          <a:gd name="csX0" fmla="*/ 0 w 111653"/>
                          <a:gd name="csY0" fmla="*/ 552517 h 556822"/>
                          <a:gd name="csX1" fmla="*/ 0 w 111653"/>
                          <a:gd name="csY1" fmla="*/ 0 h 556822"/>
                          <a:gd name="csX2" fmla="*/ 111653 w 111653"/>
                          <a:gd name="csY2" fmla="*/ 0 h 556822"/>
                          <a:gd name="csX3" fmla="*/ 111653 w 111653"/>
                          <a:gd name="csY3" fmla="*/ 549871 h 556822"/>
                          <a:gd name="csX4" fmla="*/ 42700 w 111653"/>
                          <a:gd name="csY4" fmla="*/ 556822 h 556822"/>
                          <a:gd name="csX5" fmla="*/ 0 w 111653"/>
                          <a:gd name="csY5" fmla="*/ 552517 h 55682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111653" h="556822">
                            <a:moveTo>
                              <a:pt x="0" y="552517"/>
                            </a:moveTo>
                            <a:lnTo>
                              <a:pt x="0" y="0"/>
                            </a:lnTo>
                            <a:lnTo>
                              <a:pt x="111653" y="0"/>
                            </a:lnTo>
                            <a:lnTo>
                              <a:pt x="111653" y="549871"/>
                            </a:lnTo>
                            <a:lnTo>
                              <a:pt x="42700" y="556822"/>
                            </a:lnTo>
                            <a:lnTo>
                              <a:pt x="0" y="552517"/>
                            </a:lnTo>
                            <a:close/>
                          </a:path>
                        </a:pathLst>
                      </a:custGeom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5" name="Freeform: Shape 1234">
                        <a:extLst>
                          <a:ext uri="{FF2B5EF4-FFF2-40B4-BE49-F238E27FC236}">
                            <a16:creationId xmlns:a16="http://schemas.microsoft.com/office/drawing/2014/main" id="{824F173D-6833-2DE4-FB15-425B9AACC631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10284995" y="2978777"/>
                        <a:ext cx="111653" cy="556823"/>
                      </a:xfrm>
                      <a:custGeom>
                        <a:avLst/>
                        <a:gdLst>
                          <a:gd name="csX0" fmla="*/ 0 w 111653"/>
                          <a:gd name="csY0" fmla="*/ 556823 h 556823"/>
                          <a:gd name="csX1" fmla="*/ 0 w 111653"/>
                          <a:gd name="csY1" fmla="*/ 4305 h 556823"/>
                          <a:gd name="csX2" fmla="*/ 42700 w 111653"/>
                          <a:gd name="csY2" fmla="*/ 0 h 556823"/>
                          <a:gd name="csX3" fmla="*/ 111653 w 111653"/>
                          <a:gd name="csY3" fmla="*/ 6951 h 556823"/>
                          <a:gd name="csX4" fmla="*/ 111653 w 111653"/>
                          <a:gd name="csY4" fmla="*/ 556823 h 556823"/>
                          <a:gd name="csX5" fmla="*/ 0 w 111653"/>
                          <a:gd name="csY5" fmla="*/ 556823 h 556823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111653" h="556823">
                            <a:moveTo>
                              <a:pt x="0" y="556823"/>
                            </a:moveTo>
                            <a:lnTo>
                              <a:pt x="0" y="4305"/>
                            </a:lnTo>
                            <a:lnTo>
                              <a:pt x="42700" y="0"/>
                            </a:lnTo>
                            <a:lnTo>
                              <a:pt x="111653" y="6951"/>
                            </a:lnTo>
                            <a:lnTo>
                              <a:pt x="111653" y="556823"/>
                            </a:lnTo>
                            <a:lnTo>
                              <a:pt x="0" y="556823"/>
                            </a:lnTo>
                            <a:close/>
                          </a:path>
                        </a:pathLst>
                      </a:custGeom>
                      <a:solidFill>
                        <a:schemeClr val="accent6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6" name="Freeform: Shape 1235">
                        <a:extLst>
                          <a:ext uri="{FF2B5EF4-FFF2-40B4-BE49-F238E27FC236}">
                            <a16:creationId xmlns:a16="http://schemas.microsoft.com/office/drawing/2014/main" id="{863DA53E-5D1E-9828-7844-499DFEDD6911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9734736" y="3529036"/>
                        <a:ext cx="543695" cy="111652"/>
                      </a:xfrm>
                      <a:custGeom>
                        <a:avLst/>
                        <a:gdLst>
                          <a:gd name="csX0" fmla="*/ 0 w 543695"/>
                          <a:gd name="csY0" fmla="*/ 111652 h 111652"/>
                          <a:gd name="csX1" fmla="*/ 0 w 543695"/>
                          <a:gd name="csY1" fmla="*/ 0 h 111652"/>
                          <a:gd name="csX2" fmla="*/ 538068 w 543695"/>
                          <a:gd name="csY2" fmla="*/ 0 h 111652"/>
                          <a:gd name="csX3" fmla="*/ 543695 w 543695"/>
                          <a:gd name="csY3" fmla="*/ 55826 h 111652"/>
                          <a:gd name="csX4" fmla="*/ 538068 w 543695"/>
                          <a:gd name="csY4" fmla="*/ 111652 h 111652"/>
                          <a:gd name="csX5" fmla="*/ 0 w 543695"/>
                          <a:gd name="csY5" fmla="*/ 111652 h 11165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543695" h="111652">
                            <a:moveTo>
                              <a:pt x="0" y="111652"/>
                            </a:moveTo>
                            <a:lnTo>
                              <a:pt x="0" y="0"/>
                            </a:lnTo>
                            <a:lnTo>
                              <a:pt x="538068" y="0"/>
                            </a:lnTo>
                            <a:lnTo>
                              <a:pt x="543695" y="55826"/>
                            </a:lnTo>
                            <a:lnTo>
                              <a:pt x="538068" y="111652"/>
                            </a:lnTo>
                            <a:lnTo>
                              <a:pt x="0" y="111652"/>
                            </a:lnTo>
                            <a:close/>
                          </a:path>
                        </a:pathLst>
                      </a:custGeom>
                      <a:solidFill>
                        <a:schemeClr val="accent6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7" name="Freeform: Shape 1236">
                        <a:extLst>
                          <a:ext uri="{FF2B5EF4-FFF2-40B4-BE49-F238E27FC236}">
                            <a16:creationId xmlns:a16="http://schemas.microsoft.com/office/drawing/2014/main" id="{81EF059A-839B-9E64-40C5-2EABDB0D8207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10056509" y="2642942"/>
                        <a:ext cx="564320" cy="552518"/>
                      </a:xfrm>
                      <a:custGeom>
                        <a:avLst/>
                        <a:gdLst>
                          <a:gd name="csX0" fmla="*/ 0 w 564320"/>
                          <a:gd name="csY0" fmla="*/ 552518 h 552518"/>
                          <a:gd name="csX1" fmla="*/ 6819 w 564320"/>
                          <a:gd name="csY1" fmla="*/ 484873 h 552518"/>
                          <a:gd name="csX2" fmla="*/ 483550 w 564320"/>
                          <a:gd name="csY2" fmla="*/ 8142 h 552518"/>
                          <a:gd name="csX3" fmla="*/ 564320 w 564320"/>
                          <a:gd name="csY3" fmla="*/ 0 h 552518"/>
                          <a:gd name="csX4" fmla="*/ 564320 w 564320"/>
                          <a:gd name="csY4" fmla="*/ 552518 h 552518"/>
                          <a:gd name="csX5" fmla="*/ 0 w 564320"/>
                          <a:gd name="csY5" fmla="*/ 552518 h 552518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564320" h="552518">
                            <a:moveTo>
                              <a:pt x="0" y="552518"/>
                            </a:moveTo>
                            <a:lnTo>
                              <a:pt x="6819" y="484873"/>
                            </a:lnTo>
                            <a:cubicBezTo>
                              <a:pt x="55785" y="245582"/>
                              <a:pt x="244259" y="57108"/>
                              <a:pt x="483550" y="8142"/>
                            </a:cubicBezTo>
                            <a:lnTo>
                              <a:pt x="564320" y="0"/>
                            </a:lnTo>
                            <a:lnTo>
                              <a:pt x="564320" y="552518"/>
                            </a:lnTo>
                            <a:lnTo>
                              <a:pt x="0" y="552518"/>
                            </a:lnTo>
                            <a:close/>
                          </a:path>
                        </a:pathLst>
                      </a:custGeom>
                      <a:solidFill>
                        <a:schemeClr val="accent2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8" name="Freeform: Shape 1237">
                        <a:extLst>
                          <a:ext uri="{FF2B5EF4-FFF2-40B4-BE49-F238E27FC236}">
                            <a16:creationId xmlns:a16="http://schemas.microsoft.com/office/drawing/2014/main" id="{57A13219-CF09-7AD5-8350-4DFD385320FB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9950757" y="3201362"/>
                        <a:ext cx="111653" cy="111652"/>
                      </a:xfrm>
                      <a:custGeom>
                        <a:avLst/>
                        <a:gdLst>
                          <a:gd name="csX0" fmla="*/ 0 w 111653"/>
                          <a:gd name="csY0" fmla="*/ 111652 h 111652"/>
                          <a:gd name="csX1" fmla="*/ 0 w 111653"/>
                          <a:gd name="csY1" fmla="*/ 0 h 111652"/>
                          <a:gd name="csX2" fmla="*/ 111653 w 111653"/>
                          <a:gd name="csY2" fmla="*/ 0 h 111652"/>
                          <a:gd name="csX3" fmla="*/ 111653 w 111653"/>
                          <a:gd name="csY3" fmla="*/ 111652 h 111652"/>
                          <a:gd name="csX4" fmla="*/ 0 w 111653"/>
                          <a:gd name="csY4" fmla="*/ 111652 h 11165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</a:cxnLst>
                        <a:rect l="l" t="t" r="r" b="b"/>
                        <a:pathLst>
                          <a:path w="111653" h="111652">
                            <a:moveTo>
                              <a:pt x="0" y="111652"/>
                            </a:moveTo>
                            <a:lnTo>
                              <a:pt x="0" y="0"/>
                            </a:lnTo>
                            <a:lnTo>
                              <a:pt x="111653" y="0"/>
                            </a:lnTo>
                            <a:lnTo>
                              <a:pt x="111653" y="111652"/>
                            </a:lnTo>
                            <a:lnTo>
                              <a:pt x="0" y="111652"/>
                            </a:lnTo>
                            <a:close/>
                          </a:path>
                        </a:pathLst>
                      </a:cu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9" name="Freeform: Shape 1238">
                        <a:extLst>
                          <a:ext uri="{FF2B5EF4-FFF2-40B4-BE49-F238E27FC236}">
                            <a16:creationId xmlns:a16="http://schemas.microsoft.com/office/drawing/2014/main" id="{A4B1D4F6-8EE4-BF88-6040-70215CDE6B46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9406788" y="3307113"/>
                        <a:ext cx="538068" cy="549871"/>
                      </a:xfrm>
                      <a:custGeom>
                        <a:avLst/>
                        <a:gdLst>
                          <a:gd name="csX0" fmla="*/ 0 w 538068"/>
                          <a:gd name="csY0" fmla="*/ 549871 h 549871"/>
                          <a:gd name="csX1" fmla="*/ 0 w 538068"/>
                          <a:gd name="csY1" fmla="*/ 0 h 549871"/>
                          <a:gd name="csX2" fmla="*/ 538068 w 538068"/>
                          <a:gd name="csY2" fmla="*/ 0 h 549871"/>
                          <a:gd name="csX3" fmla="*/ 531248 w 538068"/>
                          <a:gd name="csY3" fmla="*/ 67644 h 549871"/>
                          <a:gd name="csX4" fmla="*/ 54517 w 538068"/>
                          <a:gd name="csY4" fmla="*/ 544375 h 549871"/>
                          <a:gd name="csX5" fmla="*/ 0 w 538068"/>
                          <a:gd name="csY5" fmla="*/ 549871 h 549871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538068" h="549871">
                            <a:moveTo>
                              <a:pt x="0" y="549871"/>
                            </a:moveTo>
                            <a:lnTo>
                              <a:pt x="0" y="0"/>
                            </a:lnTo>
                            <a:lnTo>
                              <a:pt x="538068" y="0"/>
                            </a:lnTo>
                            <a:lnTo>
                              <a:pt x="531248" y="67644"/>
                            </a:lnTo>
                            <a:cubicBezTo>
                              <a:pt x="482282" y="306935"/>
                              <a:pt x="293809" y="495409"/>
                              <a:pt x="54517" y="544375"/>
                            </a:cubicBezTo>
                            <a:lnTo>
                              <a:pt x="0" y="549871"/>
                            </a:lnTo>
                            <a:close/>
                          </a:path>
                        </a:pathLst>
                      </a:custGeom>
                      <a:solidFill>
                        <a:schemeClr val="accent1">
                          <a:lumMod val="60000"/>
                          <a:lumOff val="4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40" name="Freeform: Shape 1239">
                        <a:extLst>
                          <a:ext uri="{FF2B5EF4-FFF2-40B4-BE49-F238E27FC236}">
                            <a16:creationId xmlns:a16="http://schemas.microsoft.com/office/drawing/2014/main" id="{36E725AF-7DD0-AFBB-5048-6D68F0D7F05C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10068312" y="3307112"/>
                        <a:ext cx="538068" cy="549872"/>
                      </a:xfrm>
                      <a:custGeom>
                        <a:avLst/>
                        <a:gdLst>
                          <a:gd name="csX0" fmla="*/ 0 w 538068"/>
                          <a:gd name="csY0" fmla="*/ 549872 h 549872"/>
                          <a:gd name="csX1" fmla="*/ 0 w 538068"/>
                          <a:gd name="csY1" fmla="*/ 0 h 549872"/>
                          <a:gd name="csX2" fmla="*/ 54517 w 538068"/>
                          <a:gd name="csY2" fmla="*/ 5496 h 549872"/>
                          <a:gd name="csX3" fmla="*/ 531248 w 538068"/>
                          <a:gd name="csY3" fmla="*/ 482227 h 549872"/>
                          <a:gd name="csX4" fmla="*/ 538068 w 538068"/>
                          <a:gd name="csY4" fmla="*/ 549872 h 549872"/>
                          <a:gd name="csX5" fmla="*/ 0 w 538068"/>
                          <a:gd name="csY5" fmla="*/ 549872 h 54987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</a:cxnLst>
                        <a:rect l="l" t="t" r="r" b="b"/>
                        <a:pathLst>
                          <a:path w="538068" h="549872">
                            <a:moveTo>
                              <a:pt x="0" y="549872"/>
                            </a:moveTo>
                            <a:lnTo>
                              <a:pt x="0" y="0"/>
                            </a:lnTo>
                            <a:lnTo>
                              <a:pt x="54517" y="5496"/>
                            </a:lnTo>
                            <a:cubicBezTo>
                              <a:pt x="293809" y="54462"/>
                              <a:pt x="482282" y="242936"/>
                              <a:pt x="531248" y="482227"/>
                            </a:cubicBezTo>
                            <a:lnTo>
                              <a:pt x="538068" y="549872"/>
                            </a:lnTo>
                            <a:lnTo>
                              <a:pt x="0" y="549872"/>
                            </a:lnTo>
                            <a:close/>
                          </a:path>
                        </a:pathLst>
                      </a:custGeom>
                      <a:solidFill>
                        <a:schemeClr val="accent6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204" name="Group 1203">
                      <a:extLst>
                        <a:ext uri="{FF2B5EF4-FFF2-40B4-BE49-F238E27FC236}">
                          <a16:creationId xmlns:a16="http://schemas.microsoft.com/office/drawing/2014/main" id="{09F0F840-E250-FA22-3DF5-85B8C9F1663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74271" y="2396889"/>
                      <a:ext cx="904240" cy="325070"/>
                      <a:chOff x="9702800" y="1883423"/>
                      <a:chExt cx="904240" cy="300772"/>
                    </a:xfrm>
                    <a:solidFill>
                      <a:schemeClr val="accent5">
                        <a:lumMod val="60000"/>
                        <a:lumOff val="40000"/>
                      </a:schemeClr>
                    </a:solidFill>
                  </p:grpSpPr>
                  <p:sp>
                    <p:nvSpPr>
                      <p:cNvPr id="1228" name="Rectangle 1227">
                        <a:extLst>
                          <a:ext uri="{FF2B5EF4-FFF2-40B4-BE49-F238E27FC236}">
                            <a16:creationId xmlns:a16="http://schemas.microsoft.com/office/drawing/2014/main" id="{EF105785-256F-F1EB-F3BF-6714AB9727C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88342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9" name="Rectangle 1228">
                        <a:extLst>
                          <a:ext uri="{FF2B5EF4-FFF2-40B4-BE49-F238E27FC236}">
                            <a16:creationId xmlns:a16="http://schemas.microsoft.com/office/drawing/2014/main" id="{4789920A-9EE5-3049-32BB-A3EB35465CA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942507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0" name="Rectangle 1229">
                        <a:extLst>
                          <a:ext uri="{FF2B5EF4-FFF2-40B4-BE49-F238E27FC236}">
                            <a16:creationId xmlns:a16="http://schemas.microsoft.com/office/drawing/2014/main" id="{C6FE3F8A-60E1-360B-9EAB-81E236C6097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06740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1" name="Rectangle 1230">
                        <a:extLst>
                          <a:ext uri="{FF2B5EF4-FFF2-40B4-BE49-F238E27FC236}">
                            <a16:creationId xmlns:a16="http://schemas.microsoft.com/office/drawing/2014/main" id="{C78E1FB0-6D8A-67F9-A61F-6E86DD47A62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7097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32" name="Rectangle 1231">
                        <a:extLst>
                          <a:ext uri="{FF2B5EF4-FFF2-40B4-BE49-F238E27FC236}">
                            <a16:creationId xmlns:a16="http://schemas.microsoft.com/office/drawing/2014/main" id="{6B8DF0ED-A9C9-347A-747A-E9FDC1EEA7B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138476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205" name="Group 1204">
                      <a:extLst>
                        <a:ext uri="{FF2B5EF4-FFF2-40B4-BE49-F238E27FC236}">
                          <a16:creationId xmlns:a16="http://schemas.microsoft.com/office/drawing/2014/main" id="{C9980FD6-1F07-7CA6-4992-26EA4041704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608045" y="2158002"/>
                      <a:ext cx="1783956" cy="147364"/>
                      <a:chOff x="8544377" y="1364959"/>
                      <a:chExt cx="904240" cy="169036"/>
                    </a:xfrm>
                    <a:solidFill>
                      <a:schemeClr val="bg2">
                        <a:lumMod val="50000"/>
                      </a:schemeClr>
                    </a:solidFill>
                  </p:grpSpPr>
                  <p:sp>
                    <p:nvSpPr>
                      <p:cNvPr id="1225" name="Rectangle 1224">
                        <a:extLst>
                          <a:ext uri="{FF2B5EF4-FFF2-40B4-BE49-F238E27FC236}">
                            <a16:creationId xmlns:a16="http://schemas.microsoft.com/office/drawing/2014/main" id="{BCF6495D-FB40-5ECB-E904-5573486A84C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544377" y="1364959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6" name="Rectangle 1225">
                        <a:extLst>
                          <a:ext uri="{FF2B5EF4-FFF2-40B4-BE49-F238E27FC236}">
                            <a16:creationId xmlns:a16="http://schemas.microsoft.com/office/drawing/2014/main" id="{33A4FCF8-064D-8D5C-257A-00C0AB68681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544377" y="142404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7" name="Rectangle 1226">
                        <a:extLst>
                          <a:ext uri="{FF2B5EF4-FFF2-40B4-BE49-F238E27FC236}">
                            <a16:creationId xmlns:a16="http://schemas.microsoft.com/office/drawing/2014/main" id="{5D958402-D83D-CB58-1559-EC8A7A069F2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544377" y="1488276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206" name="Group 1205">
                      <a:extLst>
                        <a:ext uri="{FF2B5EF4-FFF2-40B4-BE49-F238E27FC236}">
                          <a16:creationId xmlns:a16="http://schemas.microsoft.com/office/drawing/2014/main" id="{7F3302A4-1DD9-3ED8-D205-2454871511B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586593" y="2889793"/>
                      <a:ext cx="904240" cy="300772"/>
                      <a:chOff x="9702800" y="1883423"/>
                      <a:chExt cx="904240" cy="300772"/>
                    </a:xfrm>
                    <a:solidFill>
                      <a:schemeClr val="bg2">
                        <a:lumMod val="75000"/>
                      </a:schemeClr>
                    </a:solidFill>
                  </p:grpSpPr>
                  <p:sp>
                    <p:nvSpPr>
                      <p:cNvPr id="1220" name="Rectangle 1219">
                        <a:extLst>
                          <a:ext uri="{FF2B5EF4-FFF2-40B4-BE49-F238E27FC236}">
                            <a16:creationId xmlns:a16="http://schemas.microsoft.com/office/drawing/2014/main" id="{EED080D3-2486-0081-F6A3-E3FCC99F6B7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88342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1" name="Rectangle 1220">
                        <a:extLst>
                          <a:ext uri="{FF2B5EF4-FFF2-40B4-BE49-F238E27FC236}">
                            <a16:creationId xmlns:a16="http://schemas.microsoft.com/office/drawing/2014/main" id="{599BFB55-797F-77C2-5705-F2516628EA8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942507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2" name="Rectangle 1221">
                        <a:extLst>
                          <a:ext uri="{FF2B5EF4-FFF2-40B4-BE49-F238E27FC236}">
                            <a16:creationId xmlns:a16="http://schemas.microsoft.com/office/drawing/2014/main" id="{3AB4753C-7755-FEEF-4169-5575F0B5AC0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06740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3" name="Rectangle 1222">
                        <a:extLst>
                          <a:ext uri="{FF2B5EF4-FFF2-40B4-BE49-F238E27FC236}">
                            <a16:creationId xmlns:a16="http://schemas.microsoft.com/office/drawing/2014/main" id="{589A44AB-0B16-732B-1993-F5985CD9C47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7097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24" name="Rectangle 1223">
                        <a:extLst>
                          <a:ext uri="{FF2B5EF4-FFF2-40B4-BE49-F238E27FC236}">
                            <a16:creationId xmlns:a16="http://schemas.microsoft.com/office/drawing/2014/main" id="{D9D8D9DE-59B3-98A6-A7DA-D3A0DC8ADAA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138476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207" name="Rectangle 1206">
                      <a:extLst>
                        <a:ext uri="{FF2B5EF4-FFF2-40B4-BE49-F238E27FC236}">
                          <a16:creationId xmlns:a16="http://schemas.microsoft.com/office/drawing/2014/main" id="{AFF265BC-40CE-FFA6-16E2-85CD3609282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617858" y="2390026"/>
                      <a:ext cx="767701" cy="343644"/>
                    </a:xfrm>
                    <a:prstGeom prst="rect">
                      <a:avLst/>
                    </a:prstGeom>
                    <a:gradFill flip="none" rotWithShape="1">
                      <a:gsLst>
                        <a:gs pos="0">
                          <a:schemeClr val="accent6">
                            <a:lumMod val="60000"/>
                            <a:lumOff val="40000"/>
                            <a:shade val="30000"/>
                            <a:satMod val="115000"/>
                          </a:schemeClr>
                        </a:gs>
                        <a:gs pos="50000">
                          <a:schemeClr val="accent6">
                            <a:lumMod val="60000"/>
                            <a:lumOff val="40000"/>
                            <a:shade val="67500"/>
                            <a:satMod val="115000"/>
                          </a:schemeClr>
                        </a:gs>
                        <a:gs pos="100000">
                          <a:schemeClr val="accent6">
                            <a:lumMod val="60000"/>
                            <a:lumOff val="40000"/>
                            <a:shade val="100000"/>
                            <a:satMod val="115000"/>
                          </a:schemeClr>
                        </a:gs>
                      </a:gsLst>
                      <a:lin ang="0" scaled="1"/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208" name="Straight Connector 1207">
                      <a:extLst>
                        <a:ext uri="{FF2B5EF4-FFF2-40B4-BE49-F238E27FC236}">
                          <a16:creationId xmlns:a16="http://schemas.microsoft.com/office/drawing/2014/main" id="{8C81C450-57C9-5782-50C0-B88AE2FC424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604374" y="2804903"/>
                      <a:ext cx="1783956" cy="0"/>
                    </a:xfrm>
                    <a:prstGeom prst="line">
                      <a:avLst/>
                    </a:prstGeom>
                    <a:ln w="12700">
                      <a:solidFill>
                        <a:srgbClr val="0070C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209" name="Group 1208">
                      <a:extLst>
                        <a:ext uri="{FF2B5EF4-FFF2-40B4-BE49-F238E27FC236}">
                          <a16:creationId xmlns:a16="http://schemas.microsoft.com/office/drawing/2014/main" id="{DCBD4F61-0E1A-433D-C20D-51EC30AD84C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577307" y="3933099"/>
                      <a:ext cx="904240" cy="300772"/>
                      <a:chOff x="9702800" y="1883423"/>
                      <a:chExt cx="904240" cy="300772"/>
                    </a:xfrm>
                    <a:solidFill>
                      <a:schemeClr val="tx2">
                        <a:lumMod val="60000"/>
                        <a:lumOff val="40000"/>
                      </a:schemeClr>
                    </a:solidFill>
                  </p:grpSpPr>
                  <p:sp>
                    <p:nvSpPr>
                      <p:cNvPr id="1215" name="Rectangle 1214">
                        <a:extLst>
                          <a:ext uri="{FF2B5EF4-FFF2-40B4-BE49-F238E27FC236}">
                            <a16:creationId xmlns:a16="http://schemas.microsoft.com/office/drawing/2014/main" id="{55205431-EE4C-5FC1-5A6A-11F64DB3E56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88342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6" name="Rectangle 1215">
                        <a:extLst>
                          <a:ext uri="{FF2B5EF4-FFF2-40B4-BE49-F238E27FC236}">
                            <a16:creationId xmlns:a16="http://schemas.microsoft.com/office/drawing/2014/main" id="{F7BB1A75-F254-7233-C0B7-3485E17870B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1942507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7" name="Rectangle 1216">
                        <a:extLst>
                          <a:ext uri="{FF2B5EF4-FFF2-40B4-BE49-F238E27FC236}">
                            <a16:creationId xmlns:a16="http://schemas.microsoft.com/office/drawing/2014/main" id="{DBE0DD5B-EAE1-4FC7-D9BF-1217DFA45B6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06740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8" name="Rectangle 1217">
                        <a:extLst>
                          <a:ext uri="{FF2B5EF4-FFF2-40B4-BE49-F238E27FC236}">
                            <a16:creationId xmlns:a16="http://schemas.microsoft.com/office/drawing/2014/main" id="{95C6ED20-FB29-078A-1F6B-D3510BE6BA0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070973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9" name="Rectangle 1218">
                        <a:extLst>
                          <a:ext uri="{FF2B5EF4-FFF2-40B4-BE49-F238E27FC236}">
                            <a16:creationId xmlns:a16="http://schemas.microsoft.com/office/drawing/2014/main" id="{4D32228D-FFE2-01AB-1EF1-1865F27FF45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9702800" y="2138476"/>
                        <a:ext cx="904240" cy="45719"/>
                      </a:xfrm>
                      <a:prstGeom prst="rect">
                        <a:avLst/>
                      </a:prstGeom>
                      <a:grpFill/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210" name="Group 1209">
                      <a:extLst>
                        <a:ext uri="{FF2B5EF4-FFF2-40B4-BE49-F238E27FC236}">
                          <a16:creationId xmlns:a16="http://schemas.microsoft.com/office/drawing/2014/main" id="{51E8507C-B096-9906-8F13-B32B693D049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731129" y="3285179"/>
                      <a:ext cx="602548" cy="557337"/>
                      <a:chOff x="5556557" y="5101170"/>
                      <a:chExt cx="1240288" cy="1255296"/>
                    </a:xfrm>
                  </p:grpSpPr>
                  <p:sp>
                    <p:nvSpPr>
                      <p:cNvPr id="1211" name="Freeform: Shape 1210">
                        <a:extLst>
                          <a:ext uri="{FF2B5EF4-FFF2-40B4-BE49-F238E27FC236}">
                            <a16:creationId xmlns:a16="http://schemas.microsoft.com/office/drawing/2014/main" id="{66EEB4E0-9C9E-4218-EA6A-24B19B28176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58642" y="5101170"/>
                        <a:ext cx="518276" cy="494733"/>
                      </a:xfrm>
                      <a:custGeom>
                        <a:avLst/>
                        <a:gdLst>
                          <a:gd name="csX0" fmla="*/ 518276 w 518276"/>
                          <a:gd name="csY0" fmla="*/ 0 h 494733"/>
                          <a:gd name="csX1" fmla="*/ 518276 w 518276"/>
                          <a:gd name="csY1" fmla="*/ 63503 h 494733"/>
                          <a:gd name="csX2" fmla="*/ 461608 w 518276"/>
                          <a:gd name="csY2" fmla="*/ 69215 h 494733"/>
                          <a:gd name="csX3" fmla="*/ 69406 w 518276"/>
                          <a:gd name="csY3" fmla="*/ 461417 h 494733"/>
                          <a:gd name="csX4" fmla="*/ 66048 w 518276"/>
                          <a:gd name="csY4" fmla="*/ 494733 h 494733"/>
                          <a:gd name="csX5" fmla="*/ 0 w 518276"/>
                          <a:gd name="csY5" fmla="*/ 494733 h 494733"/>
                          <a:gd name="csX6" fmla="*/ 4334 w 518276"/>
                          <a:gd name="csY6" fmla="*/ 451741 h 494733"/>
                          <a:gd name="csX7" fmla="*/ 449102 w 518276"/>
                          <a:gd name="csY7" fmla="*/ 6973 h 494733"/>
                          <a:gd name="csX8" fmla="*/ 518276 w 518276"/>
                          <a:gd name="csY8" fmla="*/ 0 h 494733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  <a:cxn ang="0">
                            <a:pos x="csX6" y="csY6"/>
                          </a:cxn>
                          <a:cxn ang="0">
                            <a:pos x="csX7" y="csY7"/>
                          </a:cxn>
                          <a:cxn ang="0">
                            <a:pos x="csX8" y="csY8"/>
                          </a:cxn>
                        </a:cxnLst>
                        <a:rect l="l" t="t" r="r" b="b"/>
                        <a:pathLst>
                          <a:path w="518276" h="494733">
                            <a:moveTo>
                              <a:pt x="518276" y="0"/>
                            </a:moveTo>
                            <a:lnTo>
                              <a:pt x="518276" y="63503"/>
                            </a:lnTo>
                            <a:lnTo>
                              <a:pt x="461608" y="69215"/>
                            </a:lnTo>
                            <a:cubicBezTo>
                              <a:pt x="264745" y="109499"/>
                              <a:pt x="109690" y="264554"/>
                              <a:pt x="69406" y="461417"/>
                            </a:cubicBezTo>
                            <a:lnTo>
                              <a:pt x="66048" y="494733"/>
                            </a:lnTo>
                            <a:lnTo>
                              <a:pt x="0" y="494733"/>
                            </a:lnTo>
                            <a:lnTo>
                              <a:pt x="4334" y="451741"/>
                            </a:lnTo>
                            <a:cubicBezTo>
                              <a:pt x="50018" y="228494"/>
                              <a:pt x="225855" y="52657"/>
                              <a:pt x="449102" y="6973"/>
                            </a:cubicBezTo>
                            <a:lnTo>
                              <a:pt x="518276" y="0"/>
                            </a:lnTo>
                            <a:close/>
                          </a:path>
                        </a:pathLst>
                      </a:custGeom>
                      <a:solidFill>
                        <a:schemeClr val="bg1"/>
                      </a:solidFill>
                      <a:ln w="28575">
                        <a:solidFill>
                          <a:schemeClr val="accent5"/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2" name="Freeform: Shape 1211">
                        <a:extLst>
                          <a:ext uri="{FF2B5EF4-FFF2-40B4-BE49-F238E27FC236}">
                            <a16:creationId xmlns:a16="http://schemas.microsoft.com/office/drawing/2014/main" id="{DEBBA072-1A45-588A-2414-8DC33237DC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979288" y="5484793"/>
                        <a:ext cx="412978" cy="424038"/>
                      </a:xfrm>
                      <a:custGeom>
                        <a:avLst/>
                        <a:gdLst>
                          <a:gd name="csX0" fmla="*/ 0 w 507311"/>
                          <a:gd name="csY0" fmla="*/ 0 h 493628"/>
                          <a:gd name="csX1" fmla="*/ 58209 w 507311"/>
                          <a:gd name="csY1" fmla="*/ 5868 h 493628"/>
                          <a:gd name="csX2" fmla="*/ 502977 w 507311"/>
                          <a:gd name="csY2" fmla="*/ 450636 h 493628"/>
                          <a:gd name="csX3" fmla="*/ 507311 w 507311"/>
                          <a:gd name="csY3" fmla="*/ 493628 h 493628"/>
                          <a:gd name="csX4" fmla="*/ 439046 w 507311"/>
                          <a:gd name="csY4" fmla="*/ 493628 h 493628"/>
                          <a:gd name="csX5" fmla="*/ 435687 w 507311"/>
                          <a:gd name="csY5" fmla="*/ 460312 h 493628"/>
                          <a:gd name="csX6" fmla="*/ 43485 w 507311"/>
                          <a:gd name="csY6" fmla="*/ 68110 h 493628"/>
                          <a:gd name="csX7" fmla="*/ 0 w 507311"/>
                          <a:gd name="csY7" fmla="*/ 63727 h 493628"/>
                          <a:gd name="csX8" fmla="*/ 0 w 507311"/>
                          <a:gd name="csY8" fmla="*/ 0 h 493628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  <a:cxn ang="0">
                            <a:pos x="csX6" y="csY6"/>
                          </a:cxn>
                          <a:cxn ang="0">
                            <a:pos x="csX7" y="csY7"/>
                          </a:cxn>
                          <a:cxn ang="0">
                            <a:pos x="csX8" y="csY8"/>
                          </a:cxn>
                        </a:cxnLst>
                        <a:rect l="l" t="t" r="r" b="b"/>
                        <a:pathLst>
                          <a:path w="507311" h="493628">
                            <a:moveTo>
                              <a:pt x="0" y="0"/>
                            </a:moveTo>
                            <a:lnTo>
                              <a:pt x="58209" y="5868"/>
                            </a:lnTo>
                            <a:cubicBezTo>
                              <a:pt x="281456" y="51552"/>
                              <a:pt x="457294" y="227389"/>
                              <a:pt x="502977" y="450636"/>
                            </a:cubicBezTo>
                            <a:lnTo>
                              <a:pt x="507311" y="493628"/>
                            </a:lnTo>
                            <a:lnTo>
                              <a:pt x="439046" y="493628"/>
                            </a:lnTo>
                            <a:lnTo>
                              <a:pt x="435687" y="460312"/>
                            </a:lnTo>
                            <a:cubicBezTo>
                              <a:pt x="395403" y="263449"/>
                              <a:pt x="240348" y="108394"/>
                              <a:pt x="43485" y="68110"/>
                            </a:cubicBezTo>
                            <a:lnTo>
                              <a:pt x="0" y="63727"/>
                            </a:lnTo>
                            <a:lnTo>
                              <a:pt x="0" y="0"/>
                            </a:lnTo>
                            <a:close/>
                          </a:path>
                        </a:pathLst>
                      </a:custGeom>
                      <a:solidFill>
                        <a:schemeClr val="bg1"/>
                      </a:solidFill>
                      <a:ln w="28575">
                        <a:solidFill>
                          <a:schemeClr val="accent2"/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3" name="Freeform: Shape 1212">
                        <a:extLst>
                          <a:ext uri="{FF2B5EF4-FFF2-40B4-BE49-F238E27FC236}">
                            <a16:creationId xmlns:a16="http://schemas.microsoft.com/office/drawing/2014/main" id="{4A6AB124-F766-7BD8-6822-81088171A9D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285360" y="5821439"/>
                        <a:ext cx="511485" cy="535027"/>
                      </a:xfrm>
                      <a:custGeom>
                        <a:avLst/>
                        <a:gdLst>
                          <a:gd name="csX0" fmla="*/ 442425 w 511484"/>
                          <a:gd name="csY0" fmla="*/ 0 h 535027"/>
                          <a:gd name="csX1" fmla="*/ 511484 w 511484"/>
                          <a:gd name="csY1" fmla="*/ 0 h 535027"/>
                          <a:gd name="csX2" fmla="*/ 502977 w 511484"/>
                          <a:gd name="csY2" fmla="*/ 84391 h 535027"/>
                          <a:gd name="csX3" fmla="*/ 58209 w 511484"/>
                          <a:gd name="csY3" fmla="*/ 529159 h 535027"/>
                          <a:gd name="csX4" fmla="*/ 0 w 511484"/>
                          <a:gd name="csY4" fmla="*/ 535027 h 535027"/>
                          <a:gd name="csX5" fmla="*/ 0 w 511484"/>
                          <a:gd name="csY5" fmla="*/ 463423 h 535027"/>
                          <a:gd name="csX6" fmla="*/ 43485 w 511484"/>
                          <a:gd name="csY6" fmla="*/ 459039 h 535027"/>
                          <a:gd name="csX7" fmla="*/ 435687 w 511484"/>
                          <a:gd name="csY7" fmla="*/ 66837 h 535027"/>
                          <a:gd name="csX8" fmla="*/ 442425 w 511484"/>
                          <a:gd name="csY8" fmla="*/ 0 h 535027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  <a:cxn ang="0">
                            <a:pos x="csX6" y="csY6"/>
                          </a:cxn>
                          <a:cxn ang="0">
                            <a:pos x="csX7" y="csY7"/>
                          </a:cxn>
                          <a:cxn ang="0">
                            <a:pos x="csX8" y="csY8"/>
                          </a:cxn>
                        </a:cxnLst>
                        <a:rect l="l" t="t" r="r" b="b"/>
                        <a:pathLst>
                          <a:path w="511484" h="535027">
                            <a:moveTo>
                              <a:pt x="442425" y="0"/>
                            </a:moveTo>
                            <a:lnTo>
                              <a:pt x="511484" y="0"/>
                            </a:lnTo>
                            <a:lnTo>
                              <a:pt x="502977" y="84391"/>
                            </a:lnTo>
                            <a:cubicBezTo>
                              <a:pt x="457294" y="307638"/>
                              <a:pt x="281456" y="483476"/>
                              <a:pt x="58209" y="529159"/>
                            </a:cubicBezTo>
                            <a:lnTo>
                              <a:pt x="0" y="535027"/>
                            </a:lnTo>
                            <a:lnTo>
                              <a:pt x="0" y="463423"/>
                            </a:lnTo>
                            <a:lnTo>
                              <a:pt x="43485" y="459039"/>
                            </a:lnTo>
                            <a:cubicBezTo>
                              <a:pt x="240348" y="418755"/>
                              <a:pt x="395403" y="263700"/>
                              <a:pt x="435687" y="66837"/>
                            </a:cubicBezTo>
                            <a:lnTo>
                              <a:pt x="442425" y="0"/>
                            </a:lnTo>
                            <a:close/>
                          </a:path>
                        </a:pathLst>
                      </a:custGeom>
                      <a:solidFill>
                        <a:schemeClr val="bg1"/>
                      </a:solidFill>
                      <a:ln w="28575">
                        <a:solidFill>
                          <a:schemeClr val="tx2"/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14" name="Freeform: Shape 1213">
                        <a:extLst>
                          <a:ext uri="{FF2B5EF4-FFF2-40B4-BE49-F238E27FC236}">
                            <a16:creationId xmlns:a16="http://schemas.microsoft.com/office/drawing/2014/main" id="{719F4F3D-F332-CBCA-1D8C-A876638A4A4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56557" y="5818378"/>
                        <a:ext cx="522450" cy="536133"/>
                      </a:xfrm>
                      <a:custGeom>
                        <a:avLst/>
                        <a:gdLst>
                          <a:gd name="csX0" fmla="*/ 0 w 522449"/>
                          <a:gd name="csY0" fmla="*/ 0 h 536132"/>
                          <a:gd name="csX1" fmla="*/ 66841 w 522449"/>
                          <a:gd name="csY1" fmla="*/ 0 h 536132"/>
                          <a:gd name="csX2" fmla="*/ 73579 w 522449"/>
                          <a:gd name="csY2" fmla="*/ 66837 h 536132"/>
                          <a:gd name="csX3" fmla="*/ 465781 w 522449"/>
                          <a:gd name="csY3" fmla="*/ 459039 h 536132"/>
                          <a:gd name="csX4" fmla="*/ 522449 w 522449"/>
                          <a:gd name="csY4" fmla="*/ 464752 h 536132"/>
                          <a:gd name="csX5" fmla="*/ 522449 w 522449"/>
                          <a:gd name="csY5" fmla="*/ 536132 h 536132"/>
                          <a:gd name="csX6" fmla="*/ 453275 w 522449"/>
                          <a:gd name="csY6" fmla="*/ 529159 h 536132"/>
                          <a:gd name="csX7" fmla="*/ 8507 w 522449"/>
                          <a:gd name="csY7" fmla="*/ 84391 h 536132"/>
                          <a:gd name="csX8" fmla="*/ 0 w 522449"/>
                          <a:gd name="csY8" fmla="*/ 0 h 536132"/>
                        </a:gdLst>
                        <a:ahLst/>
                        <a:cxnLst>
                          <a:cxn ang="0">
                            <a:pos x="csX0" y="csY0"/>
                          </a:cxn>
                          <a:cxn ang="0">
                            <a:pos x="csX1" y="csY1"/>
                          </a:cxn>
                          <a:cxn ang="0">
                            <a:pos x="csX2" y="csY2"/>
                          </a:cxn>
                          <a:cxn ang="0">
                            <a:pos x="csX3" y="csY3"/>
                          </a:cxn>
                          <a:cxn ang="0">
                            <a:pos x="csX4" y="csY4"/>
                          </a:cxn>
                          <a:cxn ang="0">
                            <a:pos x="csX5" y="csY5"/>
                          </a:cxn>
                          <a:cxn ang="0">
                            <a:pos x="csX6" y="csY6"/>
                          </a:cxn>
                          <a:cxn ang="0">
                            <a:pos x="csX7" y="csY7"/>
                          </a:cxn>
                          <a:cxn ang="0">
                            <a:pos x="csX8" y="csY8"/>
                          </a:cxn>
                        </a:cxnLst>
                        <a:rect l="l" t="t" r="r" b="b"/>
                        <a:pathLst>
                          <a:path w="522449" h="536132">
                            <a:moveTo>
                              <a:pt x="0" y="0"/>
                            </a:moveTo>
                            <a:lnTo>
                              <a:pt x="66841" y="0"/>
                            </a:lnTo>
                            <a:lnTo>
                              <a:pt x="73579" y="66837"/>
                            </a:lnTo>
                            <a:cubicBezTo>
                              <a:pt x="113863" y="263700"/>
                              <a:pt x="268918" y="418755"/>
                              <a:pt x="465781" y="459039"/>
                            </a:cubicBezTo>
                            <a:lnTo>
                              <a:pt x="522449" y="464752"/>
                            </a:lnTo>
                            <a:lnTo>
                              <a:pt x="522449" y="536132"/>
                            </a:lnTo>
                            <a:lnTo>
                              <a:pt x="453275" y="529159"/>
                            </a:lnTo>
                            <a:cubicBezTo>
                              <a:pt x="230028" y="483476"/>
                              <a:pt x="54191" y="307638"/>
                              <a:pt x="8507" y="84391"/>
                            </a:cubicBezTo>
                            <a:lnTo>
                              <a:pt x="0" y="0"/>
                            </a:lnTo>
                            <a:close/>
                          </a:path>
                        </a:pathLst>
                      </a:custGeom>
                      <a:solidFill>
                        <a:schemeClr val="accent2"/>
                      </a:solidFill>
                      <a:ln w="28575">
                        <a:solidFill>
                          <a:schemeClr val="accent6"/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 anchor="ctr">
                        <a:noAutofit/>
                      </a:bodyPr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1177" name="Group 1176">
                  <a:extLst>
                    <a:ext uri="{FF2B5EF4-FFF2-40B4-BE49-F238E27FC236}">
                      <a16:creationId xmlns:a16="http://schemas.microsoft.com/office/drawing/2014/main" id="{BF2F3DE4-7E12-37E8-AFDF-497AB6EAF718}"/>
                    </a:ext>
                  </a:extLst>
                </p:cNvPr>
                <p:cNvGrpSpPr/>
                <p:nvPr/>
              </p:nvGrpSpPr>
              <p:grpSpPr>
                <a:xfrm rot="20196860">
                  <a:off x="604618" y="1263554"/>
                  <a:ext cx="216969" cy="152991"/>
                  <a:chOff x="4104640" y="897950"/>
                  <a:chExt cx="513080" cy="152991"/>
                </a:xfrm>
              </p:grpSpPr>
              <p:cxnSp>
                <p:nvCxnSpPr>
                  <p:cNvPr id="1192" name="Straight Connector 1191">
                    <a:extLst>
                      <a:ext uri="{FF2B5EF4-FFF2-40B4-BE49-F238E27FC236}">
                        <a16:creationId xmlns:a16="http://schemas.microsoft.com/office/drawing/2014/main" id="{73D7DF51-7054-E0D7-9690-81233C7F7904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897950"/>
                    <a:ext cx="513080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9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3" name="Straight Connector 1192">
                    <a:extLst>
                      <a:ext uri="{FF2B5EF4-FFF2-40B4-BE49-F238E27FC236}">
                        <a16:creationId xmlns:a16="http://schemas.microsoft.com/office/drawing/2014/main" id="{B7E0B041-C004-681C-141F-B46774C60568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37156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4" name="Straight Connector 1193">
                    <a:extLst>
                      <a:ext uri="{FF2B5EF4-FFF2-40B4-BE49-F238E27FC236}">
                        <a16:creationId xmlns:a16="http://schemas.microsoft.com/office/drawing/2014/main" id="{51CE208B-6F48-4C55-E190-98FAE97B1C42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77427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5" name="Straight Connector 1194">
                    <a:extLst>
                      <a:ext uri="{FF2B5EF4-FFF2-40B4-BE49-F238E27FC236}">
                        <a16:creationId xmlns:a16="http://schemas.microsoft.com/office/drawing/2014/main" id="{149101A0-8181-6F3B-B7D2-7921B298F268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15612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6" name="Straight Connector 1195">
                    <a:extLst>
                      <a:ext uri="{FF2B5EF4-FFF2-40B4-BE49-F238E27FC236}">
                        <a16:creationId xmlns:a16="http://schemas.microsoft.com/office/drawing/2014/main" id="{B0356281-C523-FCF8-908A-F436EA26258D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50941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78" name="Group 1177">
                  <a:extLst>
                    <a:ext uri="{FF2B5EF4-FFF2-40B4-BE49-F238E27FC236}">
                      <a16:creationId xmlns:a16="http://schemas.microsoft.com/office/drawing/2014/main" id="{1A373887-D00A-3F9C-48D8-0CF394FFF80B}"/>
                    </a:ext>
                  </a:extLst>
                </p:cNvPr>
                <p:cNvGrpSpPr/>
                <p:nvPr/>
              </p:nvGrpSpPr>
              <p:grpSpPr>
                <a:xfrm rot="20196860">
                  <a:off x="406312" y="767708"/>
                  <a:ext cx="513080" cy="152992"/>
                  <a:chOff x="4104640" y="897950"/>
                  <a:chExt cx="513080" cy="152992"/>
                </a:xfrm>
              </p:grpSpPr>
              <p:cxnSp>
                <p:nvCxnSpPr>
                  <p:cNvPr id="1187" name="Straight Connector 1186">
                    <a:extLst>
                      <a:ext uri="{FF2B5EF4-FFF2-40B4-BE49-F238E27FC236}">
                        <a16:creationId xmlns:a16="http://schemas.microsoft.com/office/drawing/2014/main" id="{B147C78E-908B-9C81-5818-E08D384F58D6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897950"/>
                    <a:ext cx="513080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9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8" name="Straight Connector 1187">
                    <a:extLst>
                      <a:ext uri="{FF2B5EF4-FFF2-40B4-BE49-F238E27FC236}">
                        <a16:creationId xmlns:a16="http://schemas.microsoft.com/office/drawing/2014/main" id="{4EEC814F-DE23-EFD6-DD0E-E4C3B42CE4B8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37156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9" name="Straight Connector 1188">
                    <a:extLst>
                      <a:ext uri="{FF2B5EF4-FFF2-40B4-BE49-F238E27FC236}">
                        <a16:creationId xmlns:a16="http://schemas.microsoft.com/office/drawing/2014/main" id="{D03CB58B-0F33-761E-DEEC-5E5DBFCF32E5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77427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0" name="Straight Connector 1189">
                    <a:extLst>
                      <a:ext uri="{FF2B5EF4-FFF2-40B4-BE49-F238E27FC236}">
                        <a16:creationId xmlns:a16="http://schemas.microsoft.com/office/drawing/2014/main" id="{7D7BE984-CEAF-78EC-5480-3FF97DA2143F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15612"/>
                    <a:ext cx="513080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9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1" name="Straight Connector 1190">
                    <a:extLst>
                      <a:ext uri="{FF2B5EF4-FFF2-40B4-BE49-F238E27FC236}">
                        <a16:creationId xmlns:a16="http://schemas.microsoft.com/office/drawing/2014/main" id="{8C16BC89-80C9-A161-F2ED-6B71A50F149D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50942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79" name="Rectangle 1178">
                  <a:extLst>
                    <a:ext uri="{FF2B5EF4-FFF2-40B4-BE49-F238E27FC236}">
                      <a16:creationId xmlns:a16="http://schemas.microsoft.com/office/drawing/2014/main" id="{DFF63881-BC09-1F94-3F9C-3403DB01E563}"/>
                    </a:ext>
                  </a:extLst>
                </p:cNvPr>
                <p:cNvSpPr/>
                <p:nvPr/>
              </p:nvSpPr>
              <p:spPr>
                <a:xfrm rot="20270168">
                  <a:off x="529272" y="1025896"/>
                  <a:ext cx="201930" cy="174895"/>
                </a:xfrm>
                <a:prstGeom prst="rect">
                  <a:avLst/>
                </a:prstGeom>
                <a:solidFill>
                  <a:schemeClr val="accent6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0" name="Rectangle 1179">
                  <a:extLst>
                    <a:ext uri="{FF2B5EF4-FFF2-40B4-BE49-F238E27FC236}">
                      <a16:creationId xmlns:a16="http://schemas.microsoft.com/office/drawing/2014/main" id="{5810F4C6-6B30-5BB5-FB0F-53D682BF414A}"/>
                    </a:ext>
                  </a:extLst>
                </p:cNvPr>
                <p:cNvSpPr/>
                <p:nvPr/>
              </p:nvSpPr>
              <p:spPr>
                <a:xfrm rot="20270168" flipV="1">
                  <a:off x="270188" y="716988"/>
                  <a:ext cx="501611" cy="45719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181" name="Group 1180">
                  <a:extLst>
                    <a:ext uri="{FF2B5EF4-FFF2-40B4-BE49-F238E27FC236}">
                      <a16:creationId xmlns:a16="http://schemas.microsoft.com/office/drawing/2014/main" id="{18DDCE14-3F76-1942-D41E-F28CA93EA722}"/>
                    </a:ext>
                  </a:extLst>
                </p:cNvPr>
                <p:cNvGrpSpPr/>
                <p:nvPr/>
              </p:nvGrpSpPr>
              <p:grpSpPr>
                <a:xfrm rot="1196717">
                  <a:off x="2417220" y="861870"/>
                  <a:ext cx="308078" cy="152991"/>
                  <a:chOff x="4104640" y="897950"/>
                  <a:chExt cx="513080" cy="152991"/>
                </a:xfrm>
              </p:grpSpPr>
              <p:cxnSp>
                <p:nvCxnSpPr>
                  <p:cNvPr id="1182" name="Straight Connector 1181">
                    <a:extLst>
                      <a:ext uri="{FF2B5EF4-FFF2-40B4-BE49-F238E27FC236}">
                        <a16:creationId xmlns:a16="http://schemas.microsoft.com/office/drawing/2014/main" id="{33B55BE3-DF9E-47BF-2569-DCAC30FB5766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897950"/>
                    <a:ext cx="513080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9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3" name="Straight Connector 1182">
                    <a:extLst>
                      <a:ext uri="{FF2B5EF4-FFF2-40B4-BE49-F238E27FC236}">
                        <a16:creationId xmlns:a16="http://schemas.microsoft.com/office/drawing/2014/main" id="{91A0B8D0-A208-61FA-EC21-F68251A82E19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37156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4" name="Straight Connector 1183">
                    <a:extLst>
                      <a:ext uri="{FF2B5EF4-FFF2-40B4-BE49-F238E27FC236}">
                        <a16:creationId xmlns:a16="http://schemas.microsoft.com/office/drawing/2014/main" id="{612EDF4F-BC4E-702B-A327-46D10B1D27B0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977427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5" name="Straight Connector 1184">
                    <a:extLst>
                      <a:ext uri="{FF2B5EF4-FFF2-40B4-BE49-F238E27FC236}">
                        <a16:creationId xmlns:a16="http://schemas.microsoft.com/office/drawing/2014/main" id="{048F7E7F-314E-8DC5-33F2-B549A63F9EC0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15612"/>
                    <a:ext cx="513080" cy="0"/>
                  </a:xfrm>
                  <a:prstGeom prst="line">
                    <a:avLst/>
                  </a:prstGeom>
                  <a:ln w="19050">
                    <a:solidFill>
                      <a:schemeClr val="bg1">
                        <a:lumMod val="9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6" name="Straight Connector 1185">
                    <a:extLst>
                      <a:ext uri="{FF2B5EF4-FFF2-40B4-BE49-F238E27FC236}">
                        <a16:creationId xmlns:a16="http://schemas.microsoft.com/office/drawing/2014/main" id="{36734B40-0F8D-4545-2575-AE96B0A56DFD}"/>
                      </a:ext>
                    </a:extLst>
                  </p:cNvPr>
                  <p:cNvCxnSpPr/>
                  <p:nvPr/>
                </p:nvCxnSpPr>
                <p:spPr>
                  <a:xfrm>
                    <a:off x="4104640" y="1050941"/>
                    <a:ext cx="513080" cy="0"/>
                  </a:xfrm>
                  <a:prstGeom prst="line">
                    <a:avLst/>
                  </a:prstGeom>
                  <a:ln w="19050"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175" name="Oval 1174">
                <a:extLst>
                  <a:ext uri="{FF2B5EF4-FFF2-40B4-BE49-F238E27FC236}">
                    <a16:creationId xmlns:a16="http://schemas.microsoft.com/office/drawing/2014/main" id="{A43F5E5D-B34B-4476-4FA2-D1DFB389B6BB}"/>
                  </a:ext>
                </a:extLst>
              </p:cNvPr>
              <p:cNvSpPr/>
              <p:nvPr/>
            </p:nvSpPr>
            <p:spPr>
              <a:xfrm>
                <a:off x="2218980" y="3859491"/>
                <a:ext cx="584850" cy="655225"/>
              </a:xfrm>
              <a:prstGeom prst="ellipse">
                <a:avLst/>
              </a:prstGeom>
              <a:solidFill>
                <a:schemeClr val="bg1">
                  <a:alpha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67" name="Rectangle 1166">
              <a:extLst>
                <a:ext uri="{FF2B5EF4-FFF2-40B4-BE49-F238E27FC236}">
                  <a16:creationId xmlns:a16="http://schemas.microsoft.com/office/drawing/2014/main" id="{9E0CF87F-58A8-3001-579A-47D30FD2EB53}"/>
                </a:ext>
              </a:extLst>
            </p:cNvPr>
            <p:cNvSpPr/>
            <p:nvPr/>
          </p:nvSpPr>
          <p:spPr>
            <a:xfrm rot="19223402">
              <a:off x="2623052" y="4520435"/>
              <a:ext cx="61976" cy="102439"/>
            </a:xfrm>
            <a:prstGeom prst="rect">
              <a:avLst/>
            </a:prstGeom>
            <a:gradFill flip="none" rotWithShape="1">
              <a:gsLst>
                <a:gs pos="0">
                  <a:schemeClr val="bg2">
                    <a:lumMod val="50000"/>
                    <a:shade val="30000"/>
                    <a:satMod val="115000"/>
                  </a:schemeClr>
                </a:gs>
                <a:gs pos="50000">
                  <a:schemeClr val="bg2">
                    <a:lumMod val="50000"/>
                    <a:shade val="67500"/>
                    <a:satMod val="115000"/>
                  </a:schemeClr>
                </a:gs>
                <a:gs pos="100000">
                  <a:schemeClr val="bg2">
                    <a:lumMod val="50000"/>
                    <a:shade val="100000"/>
                    <a:satMod val="115000"/>
                  </a:schemeClr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8" name="Flowchart: Connector 1167">
              <a:extLst>
                <a:ext uri="{FF2B5EF4-FFF2-40B4-BE49-F238E27FC236}">
                  <a16:creationId xmlns:a16="http://schemas.microsoft.com/office/drawing/2014/main" id="{512AF7FD-1DD7-5953-21B8-9FFF339D81FE}"/>
                </a:ext>
              </a:extLst>
            </p:cNvPr>
            <p:cNvSpPr/>
            <p:nvPr/>
          </p:nvSpPr>
          <p:spPr>
            <a:xfrm>
              <a:off x="2172048" y="4016080"/>
              <a:ext cx="551904" cy="546662"/>
            </a:xfrm>
            <a:prstGeom prst="flowChartConnector">
              <a:avLst/>
            </a:prstGeom>
            <a:noFill/>
            <a:ln w="3810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9" name="Flowchart: Connector 1168">
              <a:extLst>
                <a:ext uri="{FF2B5EF4-FFF2-40B4-BE49-F238E27FC236}">
                  <a16:creationId xmlns:a16="http://schemas.microsoft.com/office/drawing/2014/main" id="{F945D137-F22D-47C9-F36D-015DD9AD67C3}"/>
                </a:ext>
              </a:extLst>
            </p:cNvPr>
            <p:cNvSpPr/>
            <p:nvPr/>
          </p:nvSpPr>
          <p:spPr>
            <a:xfrm>
              <a:off x="2138977" y="3982805"/>
              <a:ext cx="615856" cy="610007"/>
            </a:xfrm>
            <a:prstGeom prst="flowChartConnector">
              <a:avLst/>
            </a:prstGeom>
            <a:noFill/>
            <a:ln w="38100">
              <a:solidFill>
                <a:schemeClr val="accent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0" name="Rectangle: Rounded Corners 1169">
              <a:extLst>
                <a:ext uri="{FF2B5EF4-FFF2-40B4-BE49-F238E27FC236}">
                  <a16:creationId xmlns:a16="http://schemas.microsoft.com/office/drawing/2014/main" id="{63F9CE43-06BC-AA81-1353-238D377BAC82}"/>
                </a:ext>
              </a:extLst>
            </p:cNvPr>
            <p:cNvSpPr/>
            <p:nvPr/>
          </p:nvSpPr>
          <p:spPr>
            <a:xfrm rot="19248708">
              <a:off x="2741721" y="4538346"/>
              <a:ext cx="118137" cy="422021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1" name="Rectangle 1170">
              <a:extLst>
                <a:ext uri="{FF2B5EF4-FFF2-40B4-BE49-F238E27FC236}">
                  <a16:creationId xmlns:a16="http://schemas.microsoft.com/office/drawing/2014/main" id="{FF8F66C6-E56B-A455-3DAB-9A4828E906D0}"/>
                </a:ext>
              </a:extLst>
            </p:cNvPr>
            <p:cNvSpPr/>
            <p:nvPr/>
          </p:nvSpPr>
          <p:spPr>
            <a:xfrm rot="19258261">
              <a:off x="2764158" y="4574429"/>
              <a:ext cx="17430" cy="394183"/>
            </a:xfrm>
            <a:prstGeom prst="rect">
              <a:avLst/>
            </a:prstGeom>
            <a:solidFill>
              <a:schemeClr val="bg1"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2" name="Moon 1171">
              <a:extLst>
                <a:ext uri="{FF2B5EF4-FFF2-40B4-BE49-F238E27FC236}">
                  <a16:creationId xmlns:a16="http://schemas.microsoft.com/office/drawing/2014/main" id="{CB383E9E-5482-22A0-211B-9262190E1CD9}"/>
                </a:ext>
              </a:extLst>
            </p:cNvPr>
            <p:cNvSpPr/>
            <p:nvPr/>
          </p:nvSpPr>
          <p:spPr>
            <a:xfrm>
              <a:off x="2232608" y="4076295"/>
              <a:ext cx="214297" cy="430392"/>
            </a:xfrm>
            <a:prstGeom prst="moon">
              <a:avLst>
                <a:gd name="adj" fmla="val 22414"/>
              </a:avLst>
            </a:prstGeom>
            <a:solidFill>
              <a:schemeClr val="bg1">
                <a:alpha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3" name="Rectangle 1172">
              <a:extLst>
                <a:ext uri="{FF2B5EF4-FFF2-40B4-BE49-F238E27FC236}">
                  <a16:creationId xmlns:a16="http://schemas.microsoft.com/office/drawing/2014/main" id="{EBCB6D55-3EB2-D38E-5052-28F751310AEA}"/>
                </a:ext>
              </a:extLst>
            </p:cNvPr>
            <p:cNvSpPr/>
            <p:nvPr/>
          </p:nvSpPr>
          <p:spPr>
            <a:xfrm>
              <a:off x="2059346" y="4196585"/>
              <a:ext cx="775898" cy="19691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Literature</a:t>
              </a:r>
            </a:p>
            <a:p>
              <a:pPr algn="ctr"/>
              <a:r>
                <a:rPr lang="en-US" sz="7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Review</a:t>
              </a:r>
            </a:p>
          </p:txBody>
        </p:sp>
      </p:grpSp>
      <p:grpSp>
        <p:nvGrpSpPr>
          <p:cNvPr id="1248" name="Group 1247">
            <a:extLst>
              <a:ext uri="{FF2B5EF4-FFF2-40B4-BE49-F238E27FC236}">
                <a16:creationId xmlns:a16="http://schemas.microsoft.com/office/drawing/2014/main" id="{9D726FFE-FCD7-7A4E-3AEE-A9DDE7C288D3}"/>
              </a:ext>
            </a:extLst>
          </p:cNvPr>
          <p:cNvGrpSpPr/>
          <p:nvPr/>
        </p:nvGrpSpPr>
        <p:grpSpPr>
          <a:xfrm>
            <a:off x="3538407" y="3750750"/>
            <a:ext cx="1037633" cy="1064734"/>
            <a:chOff x="5486152" y="1339565"/>
            <a:chExt cx="2865368" cy="2940208"/>
          </a:xfrm>
        </p:grpSpPr>
        <p:sp>
          <p:nvSpPr>
            <p:cNvPr id="1249" name="Freeform: Shape 1248">
              <a:extLst>
                <a:ext uri="{FF2B5EF4-FFF2-40B4-BE49-F238E27FC236}">
                  <a16:creationId xmlns:a16="http://schemas.microsoft.com/office/drawing/2014/main" id="{22FE437D-5547-96A7-08FC-C2F14559804A}"/>
                </a:ext>
              </a:extLst>
            </p:cNvPr>
            <p:cNvSpPr/>
            <p:nvPr/>
          </p:nvSpPr>
          <p:spPr>
            <a:xfrm rot="16200000">
              <a:off x="6618864" y="1437064"/>
              <a:ext cx="582131" cy="2099882"/>
            </a:xfrm>
            <a:custGeom>
              <a:avLst/>
              <a:gdLst>
                <a:gd name="csX0" fmla="*/ 661947 w 661947"/>
                <a:gd name="csY0" fmla="*/ 0 h 2099882"/>
                <a:gd name="csX1" fmla="*/ 639723 w 661947"/>
                <a:gd name="csY1" fmla="*/ 68707 h 2099882"/>
                <a:gd name="csX2" fmla="*/ 518677 w 661947"/>
                <a:gd name="csY2" fmla="*/ 1062777 h 2099882"/>
                <a:gd name="csX3" fmla="*/ 639722 w 661947"/>
                <a:gd name="csY3" fmla="*/ 2056847 h 2099882"/>
                <a:gd name="csX4" fmla="*/ 653643 w 661947"/>
                <a:gd name="csY4" fmla="*/ 2099882 h 2099882"/>
                <a:gd name="csX5" fmla="*/ 338543 w 661947"/>
                <a:gd name="csY5" fmla="*/ 1963969 h 2099882"/>
                <a:gd name="csX6" fmla="*/ 75746 w 661947"/>
                <a:gd name="csY6" fmla="*/ 1872283 h 2099882"/>
                <a:gd name="csX7" fmla="*/ 70577 w 661947"/>
                <a:gd name="csY7" fmla="*/ 1848772 h 2099882"/>
                <a:gd name="csX8" fmla="*/ 0 w 661947"/>
                <a:gd name="csY8" fmla="*/ 1062777 h 2099882"/>
                <a:gd name="csX9" fmla="*/ 70578 w 661947"/>
                <a:gd name="csY9" fmla="*/ 276783 h 2099882"/>
                <a:gd name="csX10" fmla="*/ 79407 w 661947"/>
                <a:gd name="csY10" fmla="*/ 236617 h 2099882"/>
                <a:gd name="csX11" fmla="*/ 303997 w 661947"/>
                <a:gd name="csY11" fmla="*/ 155707 h 2099882"/>
                <a:gd name="csX12" fmla="*/ 638197 w 661947"/>
                <a:gd name="csY12" fmla="*/ 11796 h 2099882"/>
                <a:gd name="csX13" fmla="*/ 661947 w 661947"/>
                <a:gd name="csY13" fmla="*/ 0 h 2099882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  <a:cxn ang="0">
                  <a:pos x="csX5" y="csY5"/>
                </a:cxn>
                <a:cxn ang="0">
                  <a:pos x="csX6" y="csY6"/>
                </a:cxn>
                <a:cxn ang="0">
                  <a:pos x="csX7" y="csY7"/>
                </a:cxn>
                <a:cxn ang="0">
                  <a:pos x="csX8" y="csY8"/>
                </a:cxn>
                <a:cxn ang="0">
                  <a:pos x="csX9" y="csY9"/>
                </a:cxn>
                <a:cxn ang="0">
                  <a:pos x="csX10" y="csY10"/>
                </a:cxn>
                <a:cxn ang="0">
                  <a:pos x="csX11" y="csY11"/>
                </a:cxn>
                <a:cxn ang="0">
                  <a:pos x="csX12" y="csY12"/>
                </a:cxn>
                <a:cxn ang="0">
                  <a:pos x="csX13" y="csY13"/>
                </a:cxn>
              </a:cxnLst>
              <a:rect l="l" t="t" r="r" b="b"/>
              <a:pathLst>
                <a:path w="661947" h="2099882">
                  <a:moveTo>
                    <a:pt x="661947" y="0"/>
                  </a:moveTo>
                  <a:lnTo>
                    <a:pt x="639723" y="68707"/>
                  </a:lnTo>
                  <a:cubicBezTo>
                    <a:pt x="564926" y="323138"/>
                    <a:pt x="518677" y="674610"/>
                    <a:pt x="518677" y="1062777"/>
                  </a:cubicBezTo>
                  <a:cubicBezTo>
                    <a:pt x="518677" y="1450943"/>
                    <a:pt x="564926" y="1802416"/>
                    <a:pt x="639722" y="2056847"/>
                  </a:cubicBezTo>
                  <a:lnTo>
                    <a:pt x="653643" y="2099882"/>
                  </a:lnTo>
                  <a:lnTo>
                    <a:pt x="338543" y="1963969"/>
                  </a:lnTo>
                  <a:lnTo>
                    <a:pt x="75746" y="1872283"/>
                  </a:lnTo>
                  <a:lnTo>
                    <a:pt x="70577" y="1848772"/>
                  </a:lnTo>
                  <a:cubicBezTo>
                    <a:pt x="26015" y="1624386"/>
                    <a:pt x="0" y="1353902"/>
                    <a:pt x="0" y="1062777"/>
                  </a:cubicBezTo>
                  <a:cubicBezTo>
                    <a:pt x="0" y="771652"/>
                    <a:pt x="26015" y="501167"/>
                    <a:pt x="70578" y="276783"/>
                  </a:cubicBezTo>
                  <a:lnTo>
                    <a:pt x="79407" y="236617"/>
                  </a:lnTo>
                  <a:lnTo>
                    <a:pt x="303997" y="155707"/>
                  </a:lnTo>
                  <a:cubicBezTo>
                    <a:pt x="415239" y="111642"/>
                    <a:pt x="526610" y="63612"/>
                    <a:pt x="638197" y="11796"/>
                  </a:cubicBezTo>
                  <a:lnTo>
                    <a:pt x="661947" y="0"/>
                  </a:lnTo>
                  <a:close/>
                </a:path>
              </a:pathLst>
            </a:custGeom>
            <a:gradFill flip="none" rotWithShape="1">
              <a:gsLst>
                <a:gs pos="0">
                  <a:srgbClr val="D73B03">
                    <a:shade val="30000"/>
                    <a:satMod val="115000"/>
                  </a:srgbClr>
                </a:gs>
                <a:gs pos="50000">
                  <a:srgbClr val="D73B03">
                    <a:shade val="67500"/>
                    <a:satMod val="115000"/>
                  </a:srgbClr>
                </a:gs>
                <a:gs pos="100000">
                  <a:srgbClr val="D73B03">
                    <a:shade val="100000"/>
                    <a:satMod val="115000"/>
                  </a:srgb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0" name="Freeform: Shape 1249">
              <a:extLst>
                <a:ext uri="{FF2B5EF4-FFF2-40B4-BE49-F238E27FC236}">
                  <a16:creationId xmlns:a16="http://schemas.microsoft.com/office/drawing/2014/main" id="{069C1150-4F38-A21D-46F2-209948B89EF3}"/>
                </a:ext>
              </a:extLst>
            </p:cNvPr>
            <p:cNvSpPr/>
            <p:nvPr/>
          </p:nvSpPr>
          <p:spPr>
            <a:xfrm rot="16200000">
              <a:off x="6697361" y="2835081"/>
              <a:ext cx="447455" cy="1352195"/>
            </a:xfrm>
            <a:custGeom>
              <a:avLst/>
              <a:gdLst>
                <a:gd name="csX0" fmla="*/ 532064 w 532064"/>
                <a:gd name="csY0" fmla="*/ 0 h 1352195"/>
                <a:gd name="csX1" fmla="*/ 530691 w 532064"/>
                <a:gd name="csY1" fmla="*/ 7693 h 1352195"/>
                <a:gd name="csX2" fmla="*/ 480814 w 532064"/>
                <a:gd name="csY2" fmla="*/ 677771 h 1352195"/>
                <a:gd name="csX3" fmla="*/ 530690 w 532064"/>
                <a:gd name="csY3" fmla="*/ 1347849 h 1352195"/>
                <a:gd name="csX4" fmla="*/ 531467 w 532064"/>
                <a:gd name="csY4" fmla="*/ 1352195 h 1352195"/>
                <a:gd name="csX5" fmla="*/ 286763 w 532064"/>
                <a:gd name="csY5" fmla="*/ 1304431 h 1352195"/>
                <a:gd name="csX6" fmla="*/ 39420 w 532064"/>
                <a:gd name="csY6" fmla="*/ 1274008 h 1352195"/>
                <a:gd name="csX7" fmla="*/ 32474 w 532064"/>
                <a:gd name="csY7" fmla="*/ 1224961 h 1352195"/>
                <a:gd name="csX8" fmla="*/ 0 w 532064"/>
                <a:gd name="csY8" fmla="*/ 677775 h 1352195"/>
                <a:gd name="csX9" fmla="*/ 32474 w 532064"/>
                <a:gd name="csY9" fmla="*/ 130589 h 1352195"/>
                <a:gd name="csX10" fmla="*/ 39060 w 532064"/>
                <a:gd name="csY10" fmla="*/ 84084 h 1352195"/>
                <a:gd name="csX11" fmla="*/ 265504 w 532064"/>
                <a:gd name="csY11" fmla="*/ 55416 h 1352195"/>
                <a:gd name="csX12" fmla="*/ 532064 w 532064"/>
                <a:gd name="csY12" fmla="*/ 0 h 1352195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  <a:cxn ang="0">
                  <a:pos x="csX5" y="csY5"/>
                </a:cxn>
                <a:cxn ang="0">
                  <a:pos x="csX6" y="csY6"/>
                </a:cxn>
                <a:cxn ang="0">
                  <a:pos x="csX7" y="csY7"/>
                </a:cxn>
                <a:cxn ang="0">
                  <a:pos x="csX8" y="csY8"/>
                </a:cxn>
                <a:cxn ang="0">
                  <a:pos x="csX9" y="csY9"/>
                </a:cxn>
                <a:cxn ang="0">
                  <a:pos x="csX10" y="csY10"/>
                </a:cxn>
                <a:cxn ang="0">
                  <a:pos x="csX11" y="csY11"/>
                </a:cxn>
                <a:cxn ang="0">
                  <a:pos x="csX12" y="csY12"/>
                </a:cxn>
              </a:cxnLst>
              <a:rect l="l" t="t" r="r" b="b"/>
              <a:pathLst>
                <a:path w="532064" h="1352195">
                  <a:moveTo>
                    <a:pt x="532064" y="0"/>
                  </a:moveTo>
                  <a:lnTo>
                    <a:pt x="530691" y="7693"/>
                  </a:lnTo>
                  <a:cubicBezTo>
                    <a:pt x="498880" y="206896"/>
                    <a:pt x="480814" y="435167"/>
                    <a:pt x="480814" y="677771"/>
                  </a:cubicBezTo>
                  <a:cubicBezTo>
                    <a:pt x="480814" y="920375"/>
                    <a:pt x="498880" y="1148645"/>
                    <a:pt x="530690" y="1347849"/>
                  </a:cubicBezTo>
                  <a:lnTo>
                    <a:pt x="531467" y="1352195"/>
                  </a:lnTo>
                  <a:lnTo>
                    <a:pt x="286763" y="1304431"/>
                  </a:lnTo>
                  <a:lnTo>
                    <a:pt x="39420" y="1274008"/>
                  </a:lnTo>
                  <a:lnTo>
                    <a:pt x="32474" y="1224961"/>
                  </a:lnTo>
                  <a:cubicBezTo>
                    <a:pt x="11562" y="1056768"/>
                    <a:pt x="0" y="871858"/>
                    <a:pt x="0" y="677775"/>
                  </a:cubicBezTo>
                  <a:cubicBezTo>
                    <a:pt x="0" y="483692"/>
                    <a:pt x="11562" y="298782"/>
                    <a:pt x="32474" y="130589"/>
                  </a:cubicBezTo>
                  <a:lnTo>
                    <a:pt x="39060" y="84084"/>
                  </a:lnTo>
                  <a:lnTo>
                    <a:pt x="265504" y="55416"/>
                  </a:lnTo>
                  <a:lnTo>
                    <a:pt x="532064" y="0"/>
                  </a:lnTo>
                  <a:close/>
                </a:path>
              </a:pathLst>
            </a:custGeom>
            <a:gradFill flip="none" rotWithShape="1">
              <a:gsLst>
                <a:gs pos="0">
                  <a:srgbClr val="00B0F0">
                    <a:shade val="30000"/>
                    <a:satMod val="115000"/>
                  </a:srgbClr>
                </a:gs>
                <a:gs pos="50000">
                  <a:srgbClr val="00B0F0">
                    <a:shade val="67500"/>
                    <a:satMod val="115000"/>
                  </a:srgbClr>
                </a:gs>
                <a:gs pos="100000">
                  <a:srgbClr val="00B0F0">
                    <a:shade val="100000"/>
                    <a:satMod val="115000"/>
                  </a:srgb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1" name="Freeform: Shape 1250">
              <a:extLst>
                <a:ext uri="{FF2B5EF4-FFF2-40B4-BE49-F238E27FC236}">
                  <a16:creationId xmlns:a16="http://schemas.microsoft.com/office/drawing/2014/main" id="{850108D7-758A-0431-BD1D-2C175DB93BF6}"/>
                </a:ext>
              </a:extLst>
            </p:cNvPr>
            <p:cNvSpPr/>
            <p:nvPr/>
          </p:nvSpPr>
          <p:spPr>
            <a:xfrm rot="16200000">
              <a:off x="6583951" y="479791"/>
              <a:ext cx="677641" cy="2811781"/>
            </a:xfrm>
            <a:custGeom>
              <a:avLst/>
              <a:gdLst>
                <a:gd name="csX0" fmla="*/ 792350 w 792350"/>
                <a:gd name="csY0" fmla="*/ 0 h 2811780"/>
                <a:gd name="csX1" fmla="*/ 792349 w 792350"/>
                <a:gd name="csY1" fmla="*/ 2811780 h 2811780"/>
                <a:gd name="csX2" fmla="*/ 149283 w 792350"/>
                <a:gd name="csY2" fmla="*/ 2449163 h 2811780"/>
                <a:gd name="csX3" fmla="*/ 134966 w 792350"/>
                <a:gd name="csY3" fmla="*/ 2442987 h 2811780"/>
                <a:gd name="csX4" fmla="*/ 121045 w 792350"/>
                <a:gd name="csY4" fmla="*/ 2399952 h 2811780"/>
                <a:gd name="csX5" fmla="*/ 0 w 792350"/>
                <a:gd name="csY5" fmla="*/ 1405882 h 2811780"/>
                <a:gd name="csX6" fmla="*/ 121046 w 792350"/>
                <a:gd name="csY6" fmla="*/ 411812 h 2811780"/>
                <a:gd name="csX7" fmla="*/ 143270 w 792350"/>
                <a:gd name="csY7" fmla="*/ 343105 h 2811780"/>
                <a:gd name="csX8" fmla="*/ 455020 w 792350"/>
                <a:gd name="csY8" fmla="*/ 188273 h 2811780"/>
                <a:gd name="csX9" fmla="*/ 792350 w 792350"/>
                <a:gd name="csY9" fmla="*/ 0 h 2811780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  <a:cxn ang="0">
                  <a:pos x="csX5" y="csY5"/>
                </a:cxn>
                <a:cxn ang="0">
                  <a:pos x="csX6" y="csY6"/>
                </a:cxn>
                <a:cxn ang="0">
                  <a:pos x="csX7" y="csY7"/>
                </a:cxn>
                <a:cxn ang="0">
                  <a:pos x="csX8" y="csY8"/>
                </a:cxn>
                <a:cxn ang="0">
                  <a:pos x="csX9" y="csY9"/>
                </a:cxn>
              </a:cxnLst>
              <a:rect l="l" t="t" r="r" b="b"/>
              <a:pathLst>
                <a:path w="792350" h="2811780">
                  <a:moveTo>
                    <a:pt x="792350" y="0"/>
                  </a:moveTo>
                  <a:cubicBezTo>
                    <a:pt x="575659" y="918972"/>
                    <a:pt x="535343" y="1868424"/>
                    <a:pt x="792349" y="2811780"/>
                  </a:cubicBezTo>
                  <a:cubicBezTo>
                    <a:pt x="581852" y="2673191"/>
                    <a:pt x="367261" y="2552509"/>
                    <a:pt x="149283" y="2449163"/>
                  </a:cubicBezTo>
                  <a:lnTo>
                    <a:pt x="134966" y="2442987"/>
                  </a:lnTo>
                  <a:lnTo>
                    <a:pt x="121045" y="2399952"/>
                  </a:lnTo>
                  <a:cubicBezTo>
                    <a:pt x="46249" y="2145521"/>
                    <a:pt x="0" y="1794048"/>
                    <a:pt x="0" y="1405882"/>
                  </a:cubicBezTo>
                  <a:cubicBezTo>
                    <a:pt x="0" y="1017715"/>
                    <a:pt x="46249" y="666243"/>
                    <a:pt x="121046" y="411812"/>
                  </a:cubicBezTo>
                  <a:lnTo>
                    <a:pt x="143270" y="343105"/>
                  </a:lnTo>
                  <a:lnTo>
                    <a:pt x="455020" y="188273"/>
                  </a:lnTo>
                  <a:cubicBezTo>
                    <a:pt x="567128" y="129063"/>
                    <a:pt x="679542" y="66246"/>
                    <a:pt x="792350" y="0"/>
                  </a:cubicBezTo>
                  <a:close/>
                </a:path>
              </a:pathLst>
            </a:custGeom>
            <a:gradFill flip="none" rotWithShape="1">
              <a:gsLst>
                <a:gs pos="0">
                  <a:srgbClr val="C00000">
                    <a:shade val="30000"/>
                    <a:satMod val="115000"/>
                  </a:srgbClr>
                </a:gs>
                <a:gs pos="50000">
                  <a:srgbClr val="C00000">
                    <a:shade val="67500"/>
                    <a:satMod val="115000"/>
                  </a:srgbClr>
                </a:gs>
                <a:gs pos="100000">
                  <a:srgbClr val="C00000">
                    <a:shade val="100000"/>
                    <a:satMod val="115000"/>
                  </a:srgbClr>
                </a:gs>
              </a:gsLst>
              <a:lin ang="27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2" name="Freeform: Shape 1251">
              <a:extLst>
                <a:ext uri="{FF2B5EF4-FFF2-40B4-BE49-F238E27FC236}">
                  <a16:creationId xmlns:a16="http://schemas.microsoft.com/office/drawing/2014/main" id="{237F66ED-7FA8-7EA5-9E2F-C54E1D08DECB}"/>
                </a:ext>
              </a:extLst>
            </p:cNvPr>
            <p:cNvSpPr/>
            <p:nvPr/>
          </p:nvSpPr>
          <p:spPr>
            <a:xfrm rot="16200000">
              <a:off x="6677406" y="2196666"/>
              <a:ext cx="472855" cy="1635666"/>
            </a:xfrm>
            <a:custGeom>
              <a:avLst/>
              <a:gdLst>
                <a:gd name="csX0" fmla="*/ 560221 w 560221"/>
                <a:gd name="csY0" fmla="*/ 0 h 1635666"/>
                <a:gd name="csX1" fmla="*/ 551392 w 560221"/>
                <a:gd name="csY1" fmla="*/ 40166 h 1635666"/>
                <a:gd name="csX2" fmla="*/ 480814 w 560221"/>
                <a:gd name="csY2" fmla="*/ 826160 h 1635666"/>
                <a:gd name="csX3" fmla="*/ 551391 w 560221"/>
                <a:gd name="csY3" fmla="*/ 1612155 h 1635666"/>
                <a:gd name="csX4" fmla="*/ 556560 w 560221"/>
                <a:gd name="csY4" fmla="*/ 1635666 h 1635666"/>
                <a:gd name="csX5" fmla="*/ 485393 w 560221"/>
                <a:gd name="csY5" fmla="*/ 1610838 h 1635666"/>
                <a:gd name="csX6" fmla="*/ 147413 w 560221"/>
                <a:gd name="csY6" fmla="*/ 1519470 h 1635666"/>
                <a:gd name="csX7" fmla="*/ 50653 w 560221"/>
                <a:gd name="csY7" fmla="*/ 1500583 h 1635666"/>
                <a:gd name="csX8" fmla="*/ 49876 w 560221"/>
                <a:gd name="csY8" fmla="*/ 1496237 h 1635666"/>
                <a:gd name="csX9" fmla="*/ 0 w 560221"/>
                <a:gd name="csY9" fmla="*/ 826159 h 1635666"/>
                <a:gd name="csX10" fmla="*/ 49877 w 560221"/>
                <a:gd name="csY10" fmla="*/ 156081 h 1635666"/>
                <a:gd name="csX11" fmla="*/ 51250 w 560221"/>
                <a:gd name="csY11" fmla="*/ 148388 h 1635666"/>
                <a:gd name="csX12" fmla="*/ 118182 w 560221"/>
                <a:gd name="csY12" fmla="*/ 134474 h 1635666"/>
                <a:gd name="csX13" fmla="*/ 451378 w 560221"/>
                <a:gd name="csY13" fmla="*/ 39212 h 1635666"/>
                <a:gd name="csX14" fmla="*/ 560221 w 560221"/>
                <a:gd name="csY14" fmla="*/ 0 h 1635666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  <a:cxn ang="0">
                  <a:pos x="csX5" y="csY5"/>
                </a:cxn>
                <a:cxn ang="0">
                  <a:pos x="csX6" y="csY6"/>
                </a:cxn>
                <a:cxn ang="0">
                  <a:pos x="csX7" y="csY7"/>
                </a:cxn>
                <a:cxn ang="0">
                  <a:pos x="csX8" y="csY8"/>
                </a:cxn>
                <a:cxn ang="0">
                  <a:pos x="csX9" y="csY9"/>
                </a:cxn>
                <a:cxn ang="0">
                  <a:pos x="csX10" y="csY10"/>
                </a:cxn>
                <a:cxn ang="0">
                  <a:pos x="csX11" y="csY11"/>
                </a:cxn>
                <a:cxn ang="0">
                  <a:pos x="csX12" y="csY12"/>
                </a:cxn>
                <a:cxn ang="0">
                  <a:pos x="csX13" y="csY13"/>
                </a:cxn>
                <a:cxn ang="0">
                  <a:pos x="csX14" y="csY14"/>
                </a:cxn>
              </a:cxnLst>
              <a:rect l="l" t="t" r="r" b="b"/>
              <a:pathLst>
                <a:path w="560221" h="1635666">
                  <a:moveTo>
                    <a:pt x="560221" y="0"/>
                  </a:moveTo>
                  <a:lnTo>
                    <a:pt x="551392" y="40166"/>
                  </a:lnTo>
                  <a:cubicBezTo>
                    <a:pt x="506829" y="264550"/>
                    <a:pt x="480814" y="535035"/>
                    <a:pt x="480814" y="826160"/>
                  </a:cubicBezTo>
                  <a:cubicBezTo>
                    <a:pt x="480814" y="1117285"/>
                    <a:pt x="506829" y="1387769"/>
                    <a:pt x="551391" y="1612155"/>
                  </a:cubicBezTo>
                  <a:lnTo>
                    <a:pt x="556560" y="1635666"/>
                  </a:lnTo>
                  <a:lnTo>
                    <a:pt x="485393" y="1610838"/>
                  </a:lnTo>
                  <a:cubicBezTo>
                    <a:pt x="373373" y="1576214"/>
                    <a:pt x="260684" y="1545782"/>
                    <a:pt x="147413" y="1519470"/>
                  </a:cubicBezTo>
                  <a:lnTo>
                    <a:pt x="50653" y="1500583"/>
                  </a:lnTo>
                  <a:lnTo>
                    <a:pt x="49876" y="1496237"/>
                  </a:lnTo>
                  <a:cubicBezTo>
                    <a:pt x="18066" y="1297033"/>
                    <a:pt x="0" y="1068763"/>
                    <a:pt x="0" y="826159"/>
                  </a:cubicBezTo>
                  <a:cubicBezTo>
                    <a:pt x="0" y="583555"/>
                    <a:pt x="18066" y="355284"/>
                    <a:pt x="49877" y="156081"/>
                  </a:cubicBezTo>
                  <a:lnTo>
                    <a:pt x="51250" y="148388"/>
                  </a:lnTo>
                  <a:lnTo>
                    <a:pt x="118182" y="134474"/>
                  </a:lnTo>
                  <a:cubicBezTo>
                    <a:pt x="229267" y="106982"/>
                    <a:pt x="340303" y="75169"/>
                    <a:pt x="451378" y="39212"/>
                  </a:cubicBezTo>
                  <a:lnTo>
                    <a:pt x="560221" y="0"/>
                  </a:lnTo>
                  <a:close/>
                </a:path>
              </a:pathLst>
            </a:custGeom>
            <a:gradFill flip="none" rotWithShape="1">
              <a:gsLst>
                <a:gs pos="0">
                  <a:schemeClr val="accent2">
                    <a:shade val="30000"/>
                    <a:satMod val="115000"/>
                  </a:schemeClr>
                </a:gs>
                <a:gs pos="50000">
                  <a:schemeClr val="accent2">
                    <a:shade val="67500"/>
                    <a:satMod val="115000"/>
                  </a:schemeClr>
                </a:gs>
                <a:gs pos="100000">
                  <a:schemeClr val="accent2">
                    <a:shade val="100000"/>
                    <a:satMod val="115000"/>
                  </a:scheme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3" name="Freeform: Shape 1252">
              <a:extLst>
                <a:ext uri="{FF2B5EF4-FFF2-40B4-BE49-F238E27FC236}">
                  <a16:creationId xmlns:a16="http://schemas.microsoft.com/office/drawing/2014/main" id="{188BC2AB-2351-024C-A435-2D91FE6AE165}"/>
                </a:ext>
              </a:extLst>
            </p:cNvPr>
            <p:cNvSpPr/>
            <p:nvPr/>
          </p:nvSpPr>
          <p:spPr>
            <a:xfrm rot="16200000">
              <a:off x="6711139" y="3398032"/>
              <a:ext cx="425799" cy="1189924"/>
            </a:xfrm>
            <a:custGeom>
              <a:avLst/>
              <a:gdLst>
                <a:gd name="csX0" fmla="*/ 523682 w 523682"/>
                <a:gd name="csY0" fmla="*/ 1189924 h 1189924"/>
                <a:gd name="csX1" fmla="*/ 426608 w 523682"/>
                <a:gd name="csY1" fmla="*/ 1177984 h 1189924"/>
                <a:gd name="csX2" fmla="*/ 79771 w 523682"/>
                <a:gd name="csY2" fmla="*/ 1159482 h 1189924"/>
                <a:gd name="csX3" fmla="*/ 79771 w 523682"/>
                <a:gd name="csY3" fmla="*/ 27910 h 1189924"/>
                <a:gd name="csX4" fmla="*/ 415447 w 523682"/>
                <a:gd name="csY4" fmla="*/ 13658 h 1189924"/>
                <a:gd name="csX5" fmla="*/ 523322 w 523682"/>
                <a:gd name="csY5" fmla="*/ 0 h 1189924"/>
                <a:gd name="csX6" fmla="*/ 516736 w 523682"/>
                <a:gd name="csY6" fmla="*/ 46505 h 1189924"/>
                <a:gd name="csX7" fmla="*/ 484262 w 523682"/>
                <a:gd name="csY7" fmla="*/ 593691 h 1189924"/>
                <a:gd name="csX8" fmla="*/ 516736 w 523682"/>
                <a:gd name="csY8" fmla="*/ 1140877 h 1189924"/>
                <a:gd name="csX9" fmla="*/ 523682 w 523682"/>
                <a:gd name="csY9" fmla="*/ 1189924 h 1189924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  <a:cxn ang="0">
                  <a:pos x="csX5" y="csY5"/>
                </a:cxn>
                <a:cxn ang="0">
                  <a:pos x="csX6" y="csY6"/>
                </a:cxn>
                <a:cxn ang="0">
                  <a:pos x="csX7" y="csY7"/>
                </a:cxn>
                <a:cxn ang="0">
                  <a:pos x="csX8" y="csY8"/>
                </a:cxn>
                <a:cxn ang="0">
                  <a:pos x="csX9" y="csY9"/>
                </a:cxn>
              </a:cxnLst>
              <a:rect l="l" t="t" r="r" b="b"/>
              <a:pathLst>
                <a:path w="523682" h="1189924">
                  <a:moveTo>
                    <a:pt x="523682" y="1189924"/>
                  </a:moveTo>
                  <a:lnTo>
                    <a:pt x="426608" y="1177984"/>
                  </a:lnTo>
                  <a:cubicBezTo>
                    <a:pt x="311370" y="1167864"/>
                    <a:pt x="195728" y="1161720"/>
                    <a:pt x="79771" y="1159482"/>
                  </a:cubicBezTo>
                  <a:cubicBezTo>
                    <a:pt x="-41173" y="751811"/>
                    <a:pt x="-10937" y="374621"/>
                    <a:pt x="79771" y="27910"/>
                  </a:cubicBezTo>
                  <a:cubicBezTo>
                    <a:pt x="191948" y="27957"/>
                    <a:pt x="303811" y="23147"/>
                    <a:pt x="415447" y="13658"/>
                  </a:cubicBezTo>
                  <a:lnTo>
                    <a:pt x="523322" y="0"/>
                  </a:lnTo>
                  <a:lnTo>
                    <a:pt x="516736" y="46505"/>
                  </a:lnTo>
                  <a:cubicBezTo>
                    <a:pt x="495824" y="214698"/>
                    <a:pt x="484262" y="399608"/>
                    <a:pt x="484262" y="593691"/>
                  </a:cubicBezTo>
                  <a:cubicBezTo>
                    <a:pt x="484262" y="787774"/>
                    <a:pt x="495824" y="972684"/>
                    <a:pt x="516736" y="1140877"/>
                  </a:cubicBezTo>
                  <a:lnTo>
                    <a:pt x="523682" y="1189924"/>
                  </a:lnTo>
                  <a:close/>
                </a:path>
              </a:pathLst>
            </a:custGeom>
            <a:gradFill flip="none" rotWithShape="1">
              <a:gsLst>
                <a:gs pos="0">
                  <a:srgbClr val="0070C0">
                    <a:shade val="30000"/>
                    <a:satMod val="115000"/>
                  </a:srgbClr>
                </a:gs>
                <a:gs pos="50000">
                  <a:srgbClr val="0070C0">
                    <a:shade val="67500"/>
                    <a:satMod val="115000"/>
                  </a:srgbClr>
                </a:gs>
                <a:gs pos="100000">
                  <a:srgbClr val="0070C0">
                    <a:shade val="100000"/>
                    <a:satMod val="115000"/>
                  </a:srgb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4" name="Oval 1253">
              <a:extLst>
                <a:ext uri="{FF2B5EF4-FFF2-40B4-BE49-F238E27FC236}">
                  <a16:creationId xmlns:a16="http://schemas.microsoft.com/office/drawing/2014/main" id="{26BE9258-9EB2-8434-8FAE-A3A25E894076}"/>
                </a:ext>
              </a:extLst>
            </p:cNvPr>
            <p:cNvSpPr/>
            <p:nvPr/>
          </p:nvSpPr>
          <p:spPr>
            <a:xfrm>
              <a:off x="5486152" y="1339565"/>
              <a:ext cx="2865368" cy="414588"/>
            </a:xfrm>
            <a:prstGeom prst="ellipse">
              <a:avLst/>
            </a:prstGeom>
            <a:gradFill flip="none" rotWithShape="1">
              <a:gsLst>
                <a:gs pos="0">
                  <a:schemeClr val="bg1">
                    <a:lumMod val="95000"/>
                    <a:shade val="30000"/>
                    <a:satMod val="115000"/>
                  </a:schemeClr>
                </a:gs>
                <a:gs pos="50000">
                  <a:schemeClr val="bg1">
                    <a:lumMod val="95000"/>
                    <a:shade val="67500"/>
                    <a:satMod val="115000"/>
                  </a:schemeClr>
                </a:gs>
                <a:gs pos="100000">
                  <a:schemeClr val="bg1">
                    <a:lumMod val="9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bg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>
                    <a:lumMod val="8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5" name="Oval 1254">
              <a:extLst>
                <a:ext uri="{FF2B5EF4-FFF2-40B4-BE49-F238E27FC236}">
                  <a16:creationId xmlns:a16="http://schemas.microsoft.com/office/drawing/2014/main" id="{FFF9129F-756C-9439-81CC-E0C014C790D5}"/>
                </a:ext>
              </a:extLst>
            </p:cNvPr>
            <p:cNvSpPr/>
            <p:nvPr/>
          </p:nvSpPr>
          <p:spPr>
            <a:xfrm>
              <a:off x="5610593" y="1382465"/>
              <a:ext cx="2598668" cy="329213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50000"/>
                    <a:shade val="30000"/>
                    <a:satMod val="115000"/>
                  </a:schemeClr>
                </a:gs>
                <a:gs pos="50000">
                  <a:schemeClr val="bg2">
                    <a:lumMod val="50000"/>
                    <a:shade val="67500"/>
                    <a:satMod val="115000"/>
                  </a:schemeClr>
                </a:gs>
                <a:gs pos="100000">
                  <a:schemeClr val="bg2">
                    <a:lumMod val="50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bg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256" name="Oval 1255">
              <a:extLst>
                <a:ext uri="{FF2B5EF4-FFF2-40B4-BE49-F238E27FC236}">
                  <a16:creationId xmlns:a16="http://schemas.microsoft.com/office/drawing/2014/main" id="{8B9727F7-BF37-3927-59B5-D3CC2A021707}"/>
                </a:ext>
              </a:extLst>
            </p:cNvPr>
            <p:cNvSpPr/>
            <p:nvPr/>
          </p:nvSpPr>
          <p:spPr>
            <a:xfrm>
              <a:off x="5859986" y="1546859"/>
              <a:ext cx="2068624" cy="164818"/>
            </a:xfrm>
            <a:prstGeom prst="ellipse">
              <a:avLst/>
            </a:prstGeom>
            <a:gradFill flip="none" rotWithShape="1">
              <a:gsLst>
                <a:gs pos="0">
                  <a:schemeClr val="bg1">
                    <a:lumMod val="85000"/>
                    <a:shade val="30000"/>
                    <a:satMod val="115000"/>
                  </a:schemeClr>
                </a:gs>
                <a:gs pos="50000">
                  <a:schemeClr val="bg1">
                    <a:lumMod val="85000"/>
                    <a:shade val="67500"/>
                    <a:satMod val="115000"/>
                  </a:schemeClr>
                </a:gs>
                <a:gs pos="100000">
                  <a:schemeClr val="bg1">
                    <a:lumMod val="85000"/>
                    <a:shade val="100000"/>
                    <a:satMod val="115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257" name="Rectangle 36">
              <a:extLst>
                <a:ext uri="{FF2B5EF4-FFF2-40B4-BE49-F238E27FC236}">
                  <a16:creationId xmlns:a16="http://schemas.microsoft.com/office/drawing/2014/main" id="{B0B340BC-FEEE-0C2A-192F-181E99FA288B}"/>
                </a:ext>
              </a:extLst>
            </p:cNvPr>
            <p:cNvSpPr/>
            <p:nvPr/>
          </p:nvSpPr>
          <p:spPr>
            <a:xfrm>
              <a:off x="7189470" y="1695098"/>
              <a:ext cx="744855" cy="2584675"/>
            </a:xfrm>
            <a:custGeom>
              <a:avLst/>
              <a:gdLst>
                <a:gd name="csX0" fmla="*/ 0 w 114300"/>
                <a:gd name="csY0" fmla="*/ 0 h 2504665"/>
                <a:gd name="csX1" fmla="*/ 114300 w 114300"/>
                <a:gd name="csY1" fmla="*/ 0 h 2504665"/>
                <a:gd name="csX2" fmla="*/ 114300 w 114300"/>
                <a:gd name="csY2" fmla="*/ 2504665 h 2504665"/>
                <a:gd name="csX3" fmla="*/ 0 w 114300"/>
                <a:gd name="csY3" fmla="*/ 2504665 h 2504665"/>
                <a:gd name="csX4" fmla="*/ 0 w 114300"/>
                <a:gd name="csY4" fmla="*/ 0 h 2504665"/>
                <a:gd name="csX0" fmla="*/ 3810 w 118110"/>
                <a:gd name="csY0" fmla="*/ 0 h 2525620"/>
                <a:gd name="csX1" fmla="*/ 118110 w 118110"/>
                <a:gd name="csY1" fmla="*/ 0 h 2525620"/>
                <a:gd name="csX2" fmla="*/ 118110 w 118110"/>
                <a:gd name="csY2" fmla="*/ 2504665 h 2525620"/>
                <a:gd name="csX3" fmla="*/ 0 w 118110"/>
                <a:gd name="csY3" fmla="*/ 2525620 h 2525620"/>
                <a:gd name="csX4" fmla="*/ 3810 w 118110"/>
                <a:gd name="csY4" fmla="*/ 0 h 2525620"/>
                <a:gd name="csX0" fmla="*/ 3810 w 118110"/>
                <a:gd name="csY0" fmla="*/ 0 h 2525620"/>
                <a:gd name="csX1" fmla="*/ 118110 w 118110"/>
                <a:gd name="csY1" fmla="*/ 0 h 2525620"/>
                <a:gd name="csX2" fmla="*/ 118110 w 118110"/>
                <a:gd name="csY2" fmla="*/ 2504665 h 2525620"/>
                <a:gd name="csX3" fmla="*/ 0 w 118110"/>
                <a:gd name="csY3" fmla="*/ 2525620 h 2525620"/>
                <a:gd name="csX4" fmla="*/ 3810 w 118110"/>
                <a:gd name="csY4" fmla="*/ 0 h 2525620"/>
                <a:gd name="csX0" fmla="*/ 3810 w 695325"/>
                <a:gd name="csY0" fmla="*/ 4953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10 w 695325"/>
                <a:gd name="csY4" fmla="*/ 49530 h 2575150"/>
                <a:gd name="csX0" fmla="*/ 3810 w 695325"/>
                <a:gd name="csY0" fmla="*/ 4953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10 w 695325"/>
                <a:gd name="csY4" fmla="*/ 49530 h 2575150"/>
                <a:gd name="csX0" fmla="*/ 3810 w 695325"/>
                <a:gd name="csY0" fmla="*/ 4953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10 w 695325"/>
                <a:gd name="csY4" fmla="*/ 49530 h 2575150"/>
                <a:gd name="csX0" fmla="*/ 3810 w 695325"/>
                <a:gd name="csY0" fmla="*/ 4953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10 w 695325"/>
                <a:gd name="csY4" fmla="*/ 49530 h 2575150"/>
                <a:gd name="csX0" fmla="*/ 386715 w 695325"/>
                <a:gd name="csY0" fmla="*/ 3048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6715 w 695325"/>
                <a:gd name="csY4" fmla="*/ 30480 h 2575150"/>
                <a:gd name="csX0" fmla="*/ 386715 w 695325"/>
                <a:gd name="csY0" fmla="*/ 3048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6715 w 695325"/>
                <a:gd name="csY4" fmla="*/ 30480 h 2575150"/>
                <a:gd name="csX0" fmla="*/ 386715 w 695325"/>
                <a:gd name="csY0" fmla="*/ 3048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6715 w 695325"/>
                <a:gd name="csY4" fmla="*/ 30480 h 2575150"/>
                <a:gd name="csX0" fmla="*/ 386715 w 695325"/>
                <a:gd name="csY0" fmla="*/ 30480 h 2575150"/>
                <a:gd name="csX1" fmla="*/ 695325 w 695325"/>
                <a:gd name="csY1" fmla="*/ 0 h 2575150"/>
                <a:gd name="csX2" fmla="*/ 118110 w 695325"/>
                <a:gd name="csY2" fmla="*/ 2554195 h 2575150"/>
                <a:gd name="csX3" fmla="*/ 0 w 695325"/>
                <a:gd name="csY3" fmla="*/ 2575150 h 2575150"/>
                <a:gd name="csX4" fmla="*/ 386715 w 695325"/>
                <a:gd name="csY4" fmla="*/ 30480 h 2575150"/>
                <a:gd name="csX0" fmla="*/ 386715 w 744855"/>
                <a:gd name="csY0" fmla="*/ 40005 h 2584675"/>
                <a:gd name="csX1" fmla="*/ 744855 w 744855"/>
                <a:gd name="csY1" fmla="*/ 0 h 2584675"/>
                <a:gd name="csX2" fmla="*/ 118110 w 744855"/>
                <a:gd name="csY2" fmla="*/ 2563720 h 2584675"/>
                <a:gd name="csX3" fmla="*/ 0 w 744855"/>
                <a:gd name="csY3" fmla="*/ 2584675 h 2584675"/>
                <a:gd name="csX4" fmla="*/ 386715 w 744855"/>
                <a:gd name="csY4" fmla="*/ 40005 h 2584675"/>
                <a:gd name="csX0" fmla="*/ 386715 w 744855"/>
                <a:gd name="csY0" fmla="*/ 40005 h 2584675"/>
                <a:gd name="csX1" fmla="*/ 744855 w 744855"/>
                <a:gd name="csY1" fmla="*/ 0 h 2584675"/>
                <a:gd name="csX2" fmla="*/ 118110 w 744855"/>
                <a:gd name="csY2" fmla="*/ 2563720 h 2584675"/>
                <a:gd name="csX3" fmla="*/ 0 w 744855"/>
                <a:gd name="csY3" fmla="*/ 2584675 h 2584675"/>
                <a:gd name="csX4" fmla="*/ 386715 w 744855"/>
                <a:gd name="csY4" fmla="*/ 40005 h 2584675"/>
                <a:gd name="csX0" fmla="*/ 386715 w 744855"/>
                <a:gd name="csY0" fmla="*/ 40005 h 2584675"/>
                <a:gd name="csX1" fmla="*/ 744855 w 744855"/>
                <a:gd name="csY1" fmla="*/ 0 h 2584675"/>
                <a:gd name="csX2" fmla="*/ 118110 w 744855"/>
                <a:gd name="csY2" fmla="*/ 2563720 h 2584675"/>
                <a:gd name="csX3" fmla="*/ 0 w 744855"/>
                <a:gd name="csY3" fmla="*/ 2584675 h 2584675"/>
                <a:gd name="csX4" fmla="*/ 386715 w 744855"/>
                <a:gd name="csY4" fmla="*/ 40005 h 2584675"/>
                <a:gd name="csX0" fmla="*/ 386715 w 744855"/>
                <a:gd name="csY0" fmla="*/ 40005 h 2584675"/>
                <a:gd name="csX1" fmla="*/ 744855 w 744855"/>
                <a:gd name="csY1" fmla="*/ 0 h 2584675"/>
                <a:gd name="csX2" fmla="*/ 118110 w 744855"/>
                <a:gd name="csY2" fmla="*/ 2563720 h 2584675"/>
                <a:gd name="csX3" fmla="*/ 0 w 744855"/>
                <a:gd name="csY3" fmla="*/ 2584675 h 2584675"/>
                <a:gd name="csX4" fmla="*/ 386715 w 744855"/>
                <a:gd name="csY4" fmla="*/ 40005 h 2584675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</a:cxnLst>
              <a:rect l="l" t="t" r="r" b="b"/>
              <a:pathLst>
                <a:path w="744855" h="2584675">
                  <a:moveTo>
                    <a:pt x="386715" y="40005"/>
                  </a:moveTo>
                  <a:cubicBezTo>
                    <a:pt x="556641" y="35941"/>
                    <a:pt x="641985" y="10160"/>
                    <a:pt x="744855" y="0"/>
                  </a:cubicBezTo>
                  <a:cubicBezTo>
                    <a:pt x="314706" y="833110"/>
                    <a:pt x="133731" y="1687938"/>
                    <a:pt x="118110" y="2563720"/>
                  </a:cubicBezTo>
                  <a:cubicBezTo>
                    <a:pt x="78740" y="2580230"/>
                    <a:pt x="39370" y="2577690"/>
                    <a:pt x="0" y="2584675"/>
                  </a:cubicBezTo>
                  <a:cubicBezTo>
                    <a:pt x="889" y="1724260"/>
                    <a:pt x="135890" y="869940"/>
                    <a:pt x="386715" y="40005"/>
                  </a:cubicBezTo>
                  <a:close/>
                </a:path>
              </a:pathLst>
            </a:custGeom>
            <a:solidFill>
              <a:schemeClr val="bg1">
                <a:alpha val="29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8" name="Rectangle 1257">
              <a:extLst>
                <a:ext uri="{FF2B5EF4-FFF2-40B4-BE49-F238E27FC236}">
                  <a16:creationId xmlns:a16="http://schemas.microsoft.com/office/drawing/2014/main" id="{129BA733-4C4A-F48E-07E3-AD749F1571E3}"/>
                </a:ext>
              </a:extLst>
            </p:cNvPr>
            <p:cNvSpPr/>
            <p:nvPr/>
          </p:nvSpPr>
          <p:spPr>
            <a:xfrm>
              <a:off x="5890712" y="1770900"/>
              <a:ext cx="2099882" cy="4471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DSORPTION</a:t>
              </a:r>
            </a:p>
          </p:txBody>
        </p:sp>
        <p:sp>
          <p:nvSpPr>
            <p:cNvPr id="1259" name="Rectangle 1258">
              <a:extLst>
                <a:ext uri="{FF2B5EF4-FFF2-40B4-BE49-F238E27FC236}">
                  <a16:creationId xmlns:a16="http://schemas.microsoft.com/office/drawing/2014/main" id="{A3E53502-5197-A530-BE03-A8D2D54CA843}"/>
                </a:ext>
              </a:extLst>
            </p:cNvPr>
            <p:cNvSpPr/>
            <p:nvPr/>
          </p:nvSpPr>
          <p:spPr>
            <a:xfrm>
              <a:off x="5890712" y="2324638"/>
              <a:ext cx="2099882" cy="44548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DISTRIBUTION</a:t>
              </a:r>
            </a:p>
          </p:txBody>
        </p:sp>
        <p:sp>
          <p:nvSpPr>
            <p:cNvPr id="1260" name="Rectangle 1259">
              <a:extLst>
                <a:ext uri="{FF2B5EF4-FFF2-40B4-BE49-F238E27FC236}">
                  <a16:creationId xmlns:a16="http://schemas.microsoft.com/office/drawing/2014/main" id="{EB9B5A9F-FD7F-CDA3-CDD8-51D4ECE2C7C6}"/>
                </a:ext>
              </a:extLst>
            </p:cNvPr>
            <p:cNvSpPr/>
            <p:nvPr/>
          </p:nvSpPr>
          <p:spPr>
            <a:xfrm>
              <a:off x="5890712" y="2845140"/>
              <a:ext cx="2099882" cy="39897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ETABOLISM</a:t>
              </a:r>
            </a:p>
          </p:txBody>
        </p:sp>
        <p:sp>
          <p:nvSpPr>
            <p:cNvPr id="1261" name="Rectangle 1260">
              <a:extLst>
                <a:ext uri="{FF2B5EF4-FFF2-40B4-BE49-F238E27FC236}">
                  <a16:creationId xmlns:a16="http://schemas.microsoft.com/office/drawing/2014/main" id="{2EEC9D59-612C-EC31-2B4F-FF996A0E62FE}"/>
                </a:ext>
              </a:extLst>
            </p:cNvPr>
            <p:cNvSpPr/>
            <p:nvPr/>
          </p:nvSpPr>
          <p:spPr>
            <a:xfrm>
              <a:off x="5890716" y="3325948"/>
              <a:ext cx="2099882" cy="39897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XCRETION</a:t>
              </a:r>
            </a:p>
          </p:txBody>
        </p:sp>
        <p:sp>
          <p:nvSpPr>
            <p:cNvPr id="1262" name="Rectangle 1261">
              <a:extLst>
                <a:ext uri="{FF2B5EF4-FFF2-40B4-BE49-F238E27FC236}">
                  <a16:creationId xmlns:a16="http://schemas.microsoft.com/office/drawing/2014/main" id="{5ED11933-A9AA-9ACD-5397-BA6A21E36175}"/>
                </a:ext>
              </a:extLst>
            </p:cNvPr>
            <p:cNvSpPr/>
            <p:nvPr/>
          </p:nvSpPr>
          <p:spPr>
            <a:xfrm>
              <a:off x="5868895" y="3816734"/>
              <a:ext cx="2099882" cy="38049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TOXICITY</a:t>
              </a:r>
            </a:p>
          </p:txBody>
        </p:sp>
      </p:grpSp>
      <p:grpSp>
        <p:nvGrpSpPr>
          <p:cNvPr id="1263" name="Group 1262">
            <a:extLst>
              <a:ext uri="{FF2B5EF4-FFF2-40B4-BE49-F238E27FC236}">
                <a16:creationId xmlns:a16="http://schemas.microsoft.com/office/drawing/2014/main" id="{AB8AA037-3694-3C24-0D9C-5197DF4EF6D1}"/>
              </a:ext>
            </a:extLst>
          </p:cNvPr>
          <p:cNvGrpSpPr/>
          <p:nvPr/>
        </p:nvGrpSpPr>
        <p:grpSpPr>
          <a:xfrm>
            <a:off x="220752" y="3109670"/>
            <a:ext cx="1932746" cy="1888684"/>
            <a:chOff x="4047257" y="431441"/>
            <a:chExt cx="3510941" cy="3430899"/>
          </a:xfrm>
        </p:grpSpPr>
        <p:grpSp>
          <p:nvGrpSpPr>
            <p:cNvPr id="1264" name="Group 1263">
              <a:extLst>
                <a:ext uri="{FF2B5EF4-FFF2-40B4-BE49-F238E27FC236}">
                  <a16:creationId xmlns:a16="http://schemas.microsoft.com/office/drawing/2014/main" id="{57E5580C-E841-936A-D757-6FAEDE2DFBE5}"/>
                </a:ext>
              </a:extLst>
            </p:cNvPr>
            <p:cNvGrpSpPr/>
            <p:nvPr/>
          </p:nvGrpSpPr>
          <p:grpSpPr>
            <a:xfrm>
              <a:off x="4057517" y="431441"/>
              <a:ext cx="3486284" cy="3430899"/>
              <a:chOff x="5520556" y="1133145"/>
              <a:chExt cx="3692387" cy="3633728"/>
            </a:xfrm>
          </p:grpSpPr>
          <p:grpSp>
            <p:nvGrpSpPr>
              <p:cNvPr id="1277" name="Group 1276">
                <a:extLst>
                  <a:ext uri="{FF2B5EF4-FFF2-40B4-BE49-F238E27FC236}">
                    <a16:creationId xmlns:a16="http://schemas.microsoft.com/office/drawing/2014/main" id="{B61412F6-7D14-038B-5A8B-541CECFB0CA8}"/>
                  </a:ext>
                </a:extLst>
              </p:cNvPr>
              <p:cNvGrpSpPr/>
              <p:nvPr/>
            </p:nvGrpSpPr>
            <p:grpSpPr>
              <a:xfrm rot="16200000">
                <a:off x="6601559" y="1398920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320" name="Group 1319">
                  <a:extLst>
                    <a:ext uri="{FF2B5EF4-FFF2-40B4-BE49-F238E27FC236}">
                      <a16:creationId xmlns:a16="http://schemas.microsoft.com/office/drawing/2014/main" id="{74DC8C3A-F36E-25EE-3FD2-2A0305600B8C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323" name="Teardrop 1322">
                    <a:extLst>
                      <a:ext uri="{FF2B5EF4-FFF2-40B4-BE49-F238E27FC236}">
                        <a16:creationId xmlns:a16="http://schemas.microsoft.com/office/drawing/2014/main" id="{701DC0BC-AB84-F330-C154-5D648BD76FCD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FD8A3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4" name="Heart 1323">
                    <a:extLst>
                      <a:ext uri="{FF2B5EF4-FFF2-40B4-BE49-F238E27FC236}">
                        <a16:creationId xmlns:a16="http://schemas.microsoft.com/office/drawing/2014/main" id="{D362B120-1B8D-FB8F-33E2-90055826F283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FD8A3A">
                          <a:shade val="30000"/>
                          <a:satMod val="115000"/>
                        </a:srgbClr>
                      </a:gs>
                      <a:gs pos="50000">
                        <a:srgbClr val="FD8A3A">
                          <a:shade val="67500"/>
                          <a:satMod val="115000"/>
                        </a:srgbClr>
                      </a:gs>
                      <a:gs pos="100000">
                        <a:srgbClr val="FD8A3A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5" name="Arrow: Chevron 1324">
                    <a:extLst>
                      <a:ext uri="{FF2B5EF4-FFF2-40B4-BE49-F238E27FC236}">
                        <a16:creationId xmlns:a16="http://schemas.microsoft.com/office/drawing/2014/main" id="{014C93FC-ADB2-E0DB-B440-C455B020FEF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21" name="Moon 1320">
                  <a:extLst>
                    <a:ext uri="{FF2B5EF4-FFF2-40B4-BE49-F238E27FC236}">
                      <a16:creationId xmlns:a16="http://schemas.microsoft.com/office/drawing/2014/main" id="{38509DDD-DBC1-DF3F-9330-3926C0AD55CC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2" name="Oval 1321">
                  <a:extLst>
                    <a:ext uri="{FF2B5EF4-FFF2-40B4-BE49-F238E27FC236}">
                      <a16:creationId xmlns:a16="http://schemas.microsoft.com/office/drawing/2014/main" id="{A395CE96-FD3C-264C-7FF8-DC6D6EDF3B70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78" name="Group 1277">
                <a:extLst>
                  <a:ext uri="{FF2B5EF4-FFF2-40B4-BE49-F238E27FC236}">
                    <a16:creationId xmlns:a16="http://schemas.microsoft.com/office/drawing/2014/main" id="{78D107B9-13A5-AEC8-6F34-077DB311ABE9}"/>
                  </a:ext>
                </a:extLst>
              </p:cNvPr>
              <p:cNvGrpSpPr/>
              <p:nvPr/>
            </p:nvGrpSpPr>
            <p:grpSpPr>
              <a:xfrm rot="735129">
                <a:off x="7710687" y="2749127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314" name="Group 1313">
                  <a:extLst>
                    <a:ext uri="{FF2B5EF4-FFF2-40B4-BE49-F238E27FC236}">
                      <a16:creationId xmlns:a16="http://schemas.microsoft.com/office/drawing/2014/main" id="{B889262E-029B-E222-1052-8B515BCD6342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317" name="Teardrop 1316">
                    <a:extLst>
                      <a:ext uri="{FF2B5EF4-FFF2-40B4-BE49-F238E27FC236}">
                        <a16:creationId xmlns:a16="http://schemas.microsoft.com/office/drawing/2014/main" id="{2F102895-6AF7-D57E-5722-4FA37D27CCDE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FFC13C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8" name="Heart 1317">
                    <a:extLst>
                      <a:ext uri="{FF2B5EF4-FFF2-40B4-BE49-F238E27FC236}">
                        <a16:creationId xmlns:a16="http://schemas.microsoft.com/office/drawing/2014/main" id="{689203AD-2B2F-2BBE-F1C8-924E6041EFD5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FFC13C">
                          <a:shade val="30000"/>
                          <a:satMod val="115000"/>
                        </a:srgbClr>
                      </a:gs>
                      <a:gs pos="50000">
                        <a:srgbClr val="FFC13C">
                          <a:shade val="67500"/>
                          <a:satMod val="115000"/>
                        </a:srgbClr>
                      </a:gs>
                      <a:gs pos="100000">
                        <a:srgbClr val="FFC13C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9" name="Arrow: Chevron 1318">
                    <a:extLst>
                      <a:ext uri="{FF2B5EF4-FFF2-40B4-BE49-F238E27FC236}">
                        <a16:creationId xmlns:a16="http://schemas.microsoft.com/office/drawing/2014/main" id="{4454A7DE-632E-0A5E-964D-C9FA707861B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chemeClr val="accent4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15" name="Moon 1314">
                  <a:extLst>
                    <a:ext uri="{FF2B5EF4-FFF2-40B4-BE49-F238E27FC236}">
                      <a16:creationId xmlns:a16="http://schemas.microsoft.com/office/drawing/2014/main" id="{2070FBF9-D334-FF8F-F4A4-6F83F326F45A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6" name="Oval 1315">
                  <a:extLst>
                    <a:ext uri="{FF2B5EF4-FFF2-40B4-BE49-F238E27FC236}">
                      <a16:creationId xmlns:a16="http://schemas.microsoft.com/office/drawing/2014/main" id="{CFC05B93-81F6-3CC1-F70E-7FFEA6BBC043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79" name="Group 1278">
                <a:extLst>
                  <a:ext uri="{FF2B5EF4-FFF2-40B4-BE49-F238E27FC236}">
                    <a16:creationId xmlns:a16="http://schemas.microsoft.com/office/drawing/2014/main" id="{A893B9E4-092C-F65F-748D-9C7EBB5D8EB4}"/>
                  </a:ext>
                </a:extLst>
              </p:cNvPr>
              <p:cNvGrpSpPr/>
              <p:nvPr/>
            </p:nvGrpSpPr>
            <p:grpSpPr>
              <a:xfrm rot="7058515">
                <a:off x="6112514" y="3521989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308" name="Group 1307">
                  <a:extLst>
                    <a:ext uri="{FF2B5EF4-FFF2-40B4-BE49-F238E27FC236}">
                      <a16:creationId xmlns:a16="http://schemas.microsoft.com/office/drawing/2014/main" id="{432C3D21-5EF2-109F-35F3-3ED9CEE44778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311" name="Teardrop 1310">
                    <a:extLst>
                      <a:ext uri="{FF2B5EF4-FFF2-40B4-BE49-F238E27FC236}">
                        <a16:creationId xmlns:a16="http://schemas.microsoft.com/office/drawing/2014/main" id="{81099DAF-B7C3-A3B6-D948-5369A66CB34E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F55F48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2" name="Heart 1311">
                    <a:extLst>
                      <a:ext uri="{FF2B5EF4-FFF2-40B4-BE49-F238E27FC236}">
                        <a16:creationId xmlns:a16="http://schemas.microsoft.com/office/drawing/2014/main" id="{4063901D-5AC2-2788-1FFA-43F62BF30F78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F55F48">
                          <a:shade val="30000"/>
                          <a:satMod val="115000"/>
                        </a:srgbClr>
                      </a:gs>
                      <a:gs pos="50000">
                        <a:srgbClr val="F55F48">
                          <a:shade val="67500"/>
                          <a:satMod val="115000"/>
                        </a:srgbClr>
                      </a:gs>
                      <a:gs pos="100000">
                        <a:srgbClr val="F55F48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3" name="Arrow: Chevron 1312">
                    <a:extLst>
                      <a:ext uri="{FF2B5EF4-FFF2-40B4-BE49-F238E27FC236}">
                        <a16:creationId xmlns:a16="http://schemas.microsoft.com/office/drawing/2014/main" id="{48FB41CC-A8C8-9E46-E1DA-A91DFEFBBD34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09" name="Moon 1308">
                  <a:extLst>
                    <a:ext uri="{FF2B5EF4-FFF2-40B4-BE49-F238E27FC236}">
                      <a16:creationId xmlns:a16="http://schemas.microsoft.com/office/drawing/2014/main" id="{029F1ADC-F5AD-B1BD-A0AD-82C258BA6F1D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0" name="Oval 1309">
                  <a:extLst>
                    <a:ext uri="{FF2B5EF4-FFF2-40B4-BE49-F238E27FC236}">
                      <a16:creationId xmlns:a16="http://schemas.microsoft.com/office/drawing/2014/main" id="{34A9C400-383C-A15C-3814-A54D2D88324D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80" name="Group 1279">
                <a:extLst>
                  <a:ext uri="{FF2B5EF4-FFF2-40B4-BE49-F238E27FC236}">
                    <a16:creationId xmlns:a16="http://schemas.microsoft.com/office/drawing/2014/main" id="{152420BA-87CD-6D7D-8B58-B0A44C991305}"/>
                  </a:ext>
                </a:extLst>
              </p:cNvPr>
              <p:cNvGrpSpPr/>
              <p:nvPr/>
            </p:nvGrpSpPr>
            <p:grpSpPr>
              <a:xfrm rot="10102073">
                <a:off x="5520556" y="2764737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302" name="Group 1301">
                  <a:extLst>
                    <a:ext uri="{FF2B5EF4-FFF2-40B4-BE49-F238E27FC236}">
                      <a16:creationId xmlns:a16="http://schemas.microsoft.com/office/drawing/2014/main" id="{B37164F6-F878-DCE1-7D3C-40210E995F86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305" name="Teardrop 1304">
                    <a:extLst>
                      <a:ext uri="{FF2B5EF4-FFF2-40B4-BE49-F238E27FC236}">
                        <a16:creationId xmlns:a16="http://schemas.microsoft.com/office/drawing/2014/main" id="{07E85D52-BFF2-B4AD-41AF-C6CEECD39573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CC339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6" name="Heart 1305">
                    <a:extLst>
                      <a:ext uri="{FF2B5EF4-FFF2-40B4-BE49-F238E27FC236}">
                        <a16:creationId xmlns:a16="http://schemas.microsoft.com/office/drawing/2014/main" id="{2B08B93B-7447-BF68-43B6-671A72B050B8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CC3399">
                          <a:shade val="30000"/>
                          <a:satMod val="115000"/>
                        </a:srgbClr>
                      </a:gs>
                      <a:gs pos="50000">
                        <a:srgbClr val="CC3399">
                          <a:shade val="67500"/>
                          <a:satMod val="115000"/>
                        </a:srgbClr>
                      </a:gs>
                      <a:gs pos="100000">
                        <a:srgbClr val="CC3399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7" name="Arrow: Chevron 1306">
                    <a:extLst>
                      <a:ext uri="{FF2B5EF4-FFF2-40B4-BE49-F238E27FC236}">
                        <a16:creationId xmlns:a16="http://schemas.microsoft.com/office/drawing/2014/main" id="{DCB38C97-659A-983C-5D62-73E16E14B535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rgbClr val="7030A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03" name="Moon 1302">
                  <a:extLst>
                    <a:ext uri="{FF2B5EF4-FFF2-40B4-BE49-F238E27FC236}">
                      <a16:creationId xmlns:a16="http://schemas.microsoft.com/office/drawing/2014/main" id="{5DABD3AA-5CF7-1906-1D82-BD9720FB99BF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4" name="Oval 1303">
                  <a:extLst>
                    <a:ext uri="{FF2B5EF4-FFF2-40B4-BE49-F238E27FC236}">
                      <a16:creationId xmlns:a16="http://schemas.microsoft.com/office/drawing/2014/main" id="{27A2DB13-B229-E5CD-3BFC-78A20F059338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81" name="Group 1280">
                <a:extLst>
                  <a:ext uri="{FF2B5EF4-FFF2-40B4-BE49-F238E27FC236}">
                    <a16:creationId xmlns:a16="http://schemas.microsoft.com/office/drawing/2014/main" id="{84E62ACE-7663-4967-9589-1F9D2C3E1E17}"/>
                  </a:ext>
                </a:extLst>
              </p:cNvPr>
              <p:cNvGrpSpPr/>
              <p:nvPr/>
            </p:nvGrpSpPr>
            <p:grpSpPr>
              <a:xfrm rot="13178917">
                <a:off x="5736860" y="1818811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296" name="Group 1295">
                  <a:extLst>
                    <a:ext uri="{FF2B5EF4-FFF2-40B4-BE49-F238E27FC236}">
                      <a16:creationId xmlns:a16="http://schemas.microsoft.com/office/drawing/2014/main" id="{AE947B83-0CD2-0876-FC1B-3B6B6B6A4A76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299" name="Teardrop 1298">
                    <a:extLst>
                      <a:ext uri="{FF2B5EF4-FFF2-40B4-BE49-F238E27FC236}">
                        <a16:creationId xmlns:a16="http://schemas.microsoft.com/office/drawing/2014/main" id="{916BFF1D-2B56-ED72-219A-A903A640319E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2DC9B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0" name="Heart 1299">
                    <a:extLst>
                      <a:ext uri="{FF2B5EF4-FFF2-40B4-BE49-F238E27FC236}">
                        <a16:creationId xmlns:a16="http://schemas.microsoft.com/office/drawing/2014/main" id="{36DDFA42-210F-2765-9C50-FCA5E105A10F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2DC9B6">
                          <a:shade val="30000"/>
                          <a:satMod val="115000"/>
                        </a:srgbClr>
                      </a:gs>
                      <a:gs pos="50000">
                        <a:srgbClr val="2DC9B6">
                          <a:shade val="67500"/>
                          <a:satMod val="115000"/>
                        </a:srgbClr>
                      </a:gs>
                      <a:gs pos="100000">
                        <a:srgbClr val="2DC9B6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1" name="Arrow: Chevron 1300">
                    <a:extLst>
                      <a:ext uri="{FF2B5EF4-FFF2-40B4-BE49-F238E27FC236}">
                        <a16:creationId xmlns:a16="http://schemas.microsoft.com/office/drawing/2014/main" id="{61CE49BF-4C65-B78D-DC9F-C64A88230ADA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rgbClr val="00999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297" name="Moon 1296">
                  <a:extLst>
                    <a:ext uri="{FF2B5EF4-FFF2-40B4-BE49-F238E27FC236}">
                      <a16:creationId xmlns:a16="http://schemas.microsoft.com/office/drawing/2014/main" id="{ECC76BC4-4728-230A-4DEB-BB350395F2CB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8" name="Oval 1297">
                  <a:extLst>
                    <a:ext uri="{FF2B5EF4-FFF2-40B4-BE49-F238E27FC236}">
                      <a16:creationId xmlns:a16="http://schemas.microsoft.com/office/drawing/2014/main" id="{16D07A37-B831-180D-FEE6-3321970FFED3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82" name="Group 1281">
                <a:extLst>
                  <a:ext uri="{FF2B5EF4-FFF2-40B4-BE49-F238E27FC236}">
                    <a16:creationId xmlns:a16="http://schemas.microsoft.com/office/drawing/2014/main" id="{02456B8F-E6E3-FD37-93E8-7CD119017A78}"/>
                  </a:ext>
                </a:extLst>
              </p:cNvPr>
              <p:cNvGrpSpPr/>
              <p:nvPr/>
            </p:nvGrpSpPr>
            <p:grpSpPr>
              <a:xfrm rot="19328869">
                <a:off x="7486225" y="1812699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290" name="Group 1289">
                  <a:extLst>
                    <a:ext uri="{FF2B5EF4-FFF2-40B4-BE49-F238E27FC236}">
                      <a16:creationId xmlns:a16="http://schemas.microsoft.com/office/drawing/2014/main" id="{A6E94165-CDCC-3F5A-B996-96BDFE7B9EFE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293" name="Teardrop 1292">
                    <a:extLst>
                      <a:ext uri="{FF2B5EF4-FFF2-40B4-BE49-F238E27FC236}">
                        <a16:creationId xmlns:a16="http://schemas.microsoft.com/office/drawing/2014/main" id="{9ECF47AF-FB89-8B94-CFB4-A462C63A2B3B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B0D15A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4" name="Heart 1293">
                    <a:extLst>
                      <a:ext uri="{FF2B5EF4-FFF2-40B4-BE49-F238E27FC236}">
                        <a16:creationId xmlns:a16="http://schemas.microsoft.com/office/drawing/2014/main" id="{8083F127-FA47-C436-8899-CD4045846ED1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B0D15A">
                          <a:shade val="30000"/>
                          <a:satMod val="115000"/>
                        </a:srgbClr>
                      </a:gs>
                      <a:gs pos="50000">
                        <a:srgbClr val="B0D15A">
                          <a:shade val="67500"/>
                          <a:satMod val="115000"/>
                        </a:srgbClr>
                      </a:gs>
                      <a:gs pos="100000">
                        <a:srgbClr val="B0D15A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5" name="Arrow: Chevron 1294">
                    <a:extLst>
                      <a:ext uri="{FF2B5EF4-FFF2-40B4-BE49-F238E27FC236}">
                        <a16:creationId xmlns:a16="http://schemas.microsoft.com/office/drawing/2014/main" id="{D7C302EA-8323-DEF4-0FB4-D61C40261A42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chemeClr val="accent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291" name="Moon 1290">
                  <a:extLst>
                    <a:ext uri="{FF2B5EF4-FFF2-40B4-BE49-F238E27FC236}">
                      <a16:creationId xmlns:a16="http://schemas.microsoft.com/office/drawing/2014/main" id="{1CCD99F3-310B-9B4E-9337-872A92A30FC9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2" name="Oval 1291">
                  <a:extLst>
                    <a:ext uri="{FF2B5EF4-FFF2-40B4-BE49-F238E27FC236}">
                      <a16:creationId xmlns:a16="http://schemas.microsoft.com/office/drawing/2014/main" id="{759AC574-D1AA-E461-569A-698520B70A8E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83" name="Group 1282">
                <a:extLst>
                  <a:ext uri="{FF2B5EF4-FFF2-40B4-BE49-F238E27FC236}">
                    <a16:creationId xmlns:a16="http://schemas.microsoft.com/office/drawing/2014/main" id="{1E3F627C-9E2E-DC58-7516-79C20B871235}"/>
                  </a:ext>
                </a:extLst>
              </p:cNvPr>
              <p:cNvGrpSpPr/>
              <p:nvPr/>
            </p:nvGrpSpPr>
            <p:grpSpPr>
              <a:xfrm rot="3929165">
                <a:off x="7095340" y="3530392"/>
                <a:ext cx="1502256" cy="970706"/>
                <a:chOff x="2997926" y="2090887"/>
                <a:chExt cx="1502256" cy="970706"/>
              </a:xfrm>
            </p:grpSpPr>
            <p:grpSp>
              <p:nvGrpSpPr>
                <p:cNvPr id="1284" name="Group 1283">
                  <a:extLst>
                    <a:ext uri="{FF2B5EF4-FFF2-40B4-BE49-F238E27FC236}">
                      <a16:creationId xmlns:a16="http://schemas.microsoft.com/office/drawing/2014/main" id="{9B6381B0-84BB-6C8E-47B0-545D78406B1B}"/>
                    </a:ext>
                  </a:extLst>
                </p:cNvPr>
                <p:cNvGrpSpPr/>
                <p:nvPr/>
              </p:nvGrpSpPr>
              <p:grpSpPr>
                <a:xfrm>
                  <a:off x="2997926" y="2090887"/>
                  <a:ext cx="1502256" cy="970706"/>
                  <a:chOff x="2749006" y="2416007"/>
                  <a:chExt cx="1502256" cy="970706"/>
                </a:xfrm>
                <a:solidFill>
                  <a:schemeClr val="accent2"/>
                </a:solidFill>
              </p:grpSpPr>
              <p:sp>
                <p:nvSpPr>
                  <p:cNvPr id="1287" name="Teardrop 1286">
                    <a:extLst>
                      <a:ext uri="{FF2B5EF4-FFF2-40B4-BE49-F238E27FC236}">
                        <a16:creationId xmlns:a16="http://schemas.microsoft.com/office/drawing/2014/main" id="{C5E18A7F-5C5B-8453-C9DE-B7354C7B2009}"/>
                      </a:ext>
                    </a:extLst>
                  </p:cNvPr>
                  <p:cNvSpPr/>
                  <p:nvPr/>
                </p:nvSpPr>
                <p:spPr>
                  <a:xfrm rot="13383762">
                    <a:off x="3115481" y="2416007"/>
                    <a:ext cx="970706" cy="970706"/>
                  </a:xfrm>
                  <a:prstGeom prst="teardrop">
                    <a:avLst>
                      <a:gd name="adj" fmla="val 98320"/>
                    </a:avLst>
                  </a:prstGeom>
                  <a:solidFill>
                    <a:srgbClr val="36AFE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8" name="Heart 1287">
                    <a:extLst>
                      <a:ext uri="{FF2B5EF4-FFF2-40B4-BE49-F238E27FC236}">
                        <a16:creationId xmlns:a16="http://schemas.microsoft.com/office/drawing/2014/main" id="{76AC8F73-3C6C-08E1-ACFF-8D44750EB860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9100" y="2466298"/>
                    <a:ext cx="954201" cy="870123"/>
                  </a:xfrm>
                  <a:prstGeom prst="heart">
                    <a:avLst/>
                  </a:prstGeom>
                  <a:gradFill flip="none" rotWithShape="1">
                    <a:gsLst>
                      <a:gs pos="0">
                        <a:srgbClr val="36AFE0">
                          <a:shade val="30000"/>
                          <a:satMod val="115000"/>
                        </a:srgbClr>
                      </a:gs>
                      <a:gs pos="50000">
                        <a:srgbClr val="36AFE0">
                          <a:shade val="67500"/>
                          <a:satMod val="115000"/>
                        </a:srgbClr>
                      </a:gs>
                      <a:gs pos="100000">
                        <a:srgbClr val="36AFE0">
                          <a:shade val="100000"/>
                          <a:satMod val="115000"/>
                        </a:srgbClr>
                      </a:gs>
                    </a:gsLst>
                    <a:lin ang="162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9" name="Arrow: Chevron 1288">
                    <a:extLst>
                      <a:ext uri="{FF2B5EF4-FFF2-40B4-BE49-F238E27FC236}">
                        <a16:creationId xmlns:a16="http://schemas.microsoft.com/office/drawing/2014/main" id="{ED72285B-0518-C283-19DF-E48A8EBD645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749006" y="2792775"/>
                    <a:ext cx="247650" cy="243840"/>
                  </a:xfrm>
                  <a:prstGeom prst="chevron">
                    <a:avLst/>
                  </a:prstGeom>
                  <a:solidFill>
                    <a:schemeClr val="accent5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285" name="Moon 1284">
                  <a:extLst>
                    <a:ext uri="{FF2B5EF4-FFF2-40B4-BE49-F238E27FC236}">
                      <a16:creationId xmlns:a16="http://schemas.microsoft.com/office/drawing/2014/main" id="{DA6CA7C0-4A37-C9AF-361B-243F641D7579}"/>
                    </a:ext>
                  </a:extLst>
                </p:cNvPr>
                <p:cNvSpPr/>
                <p:nvPr/>
              </p:nvSpPr>
              <p:spPr>
                <a:xfrm>
                  <a:off x="3345579" y="2179320"/>
                  <a:ext cx="568960" cy="790070"/>
                </a:xfrm>
                <a:prstGeom prst="moon">
                  <a:avLst>
                    <a:gd name="adj" fmla="val 11607"/>
                  </a:avLst>
                </a:prstGeom>
                <a:solidFill>
                  <a:schemeClr val="bg1"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6" name="Oval 1285">
                  <a:extLst>
                    <a:ext uri="{FF2B5EF4-FFF2-40B4-BE49-F238E27FC236}">
                      <a16:creationId xmlns:a16="http://schemas.microsoft.com/office/drawing/2014/main" id="{9B844551-A9A3-1F36-CAEC-945D56F9EF4D}"/>
                    </a:ext>
                  </a:extLst>
                </p:cNvPr>
                <p:cNvSpPr/>
                <p:nvPr/>
              </p:nvSpPr>
              <p:spPr>
                <a:xfrm>
                  <a:off x="4242169" y="2540732"/>
                  <a:ext cx="207582" cy="67245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265" name="Group 1264">
              <a:extLst>
                <a:ext uri="{FF2B5EF4-FFF2-40B4-BE49-F238E27FC236}">
                  <a16:creationId xmlns:a16="http://schemas.microsoft.com/office/drawing/2014/main" id="{C616F84C-0334-BB31-4E45-A4AB1BCCA760}"/>
                </a:ext>
              </a:extLst>
            </p:cNvPr>
            <p:cNvGrpSpPr/>
            <p:nvPr/>
          </p:nvGrpSpPr>
          <p:grpSpPr>
            <a:xfrm>
              <a:off x="5137912" y="1529955"/>
              <a:ext cx="1323876" cy="1323876"/>
              <a:chOff x="7104649" y="3155453"/>
              <a:chExt cx="1417938" cy="1417938"/>
            </a:xfrm>
          </p:grpSpPr>
          <p:sp>
            <p:nvSpPr>
              <p:cNvPr id="1275" name="Flowchart: Connector 1274">
                <a:extLst>
                  <a:ext uri="{FF2B5EF4-FFF2-40B4-BE49-F238E27FC236}">
                    <a16:creationId xmlns:a16="http://schemas.microsoft.com/office/drawing/2014/main" id="{4252B0CF-6697-B720-29D8-1F017860C878}"/>
                  </a:ext>
                </a:extLst>
              </p:cNvPr>
              <p:cNvSpPr/>
              <p:nvPr/>
            </p:nvSpPr>
            <p:spPr>
              <a:xfrm>
                <a:off x="7104649" y="3155453"/>
                <a:ext cx="1417938" cy="1417938"/>
              </a:xfrm>
              <a:prstGeom prst="flowChartConnector">
                <a:avLst/>
              </a:prstGeom>
              <a:noFill/>
              <a:ln w="38100"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6" name="Flowchart: Connector 1275">
                <a:extLst>
                  <a:ext uri="{FF2B5EF4-FFF2-40B4-BE49-F238E27FC236}">
                    <a16:creationId xmlns:a16="http://schemas.microsoft.com/office/drawing/2014/main" id="{7866D3C7-2746-8BD8-91A2-FACF1DBAD0F4}"/>
                  </a:ext>
                </a:extLst>
              </p:cNvPr>
              <p:cNvSpPr/>
              <p:nvPr/>
            </p:nvSpPr>
            <p:spPr>
              <a:xfrm>
                <a:off x="7207766" y="3248922"/>
                <a:ext cx="1225762" cy="1225762"/>
              </a:xfrm>
              <a:prstGeom prst="flowChartConnector">
                <a:avLst/>
              </a:prstGeom>
              <a:noFill/>
              <a:ln w="19050"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66" name="Rectangle: Rounded Corners 1265">
              <a:extLst>
                <a:ext uri="{FF2B5EF4-FFF2-40B4-BE49-F238E27FC236}">
                  <a16:creationId xmlns:a16="http://schemas.microsoft.com/office/drawing/2014/main" id="{B56C72BE-54BC-69E9-D8D8-AB4BA72517B1}"/>
                </a:ext>
              </a:extLst>
            </p:cNvPr>
            <p:cNvSpPr/>
            <p:nvPr/>
          </p:nvSpPr>
          <p:spPr>
            <a:xfrm>
              <a:off x="5124642" y="610126"/>
              <a:ext cx="1295419" cy="794431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RMSD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67" name="Rectangle: Rounded Corners 1266">
              <a:extLst>
                <a:ext uri="{FF2B5EF4-FFF2-40B4-BE49-F238E27FC236}">
                  <a16:creationId xmlns:a16="http://schemas.microsoft.com/office/drawing/2014/main" id="{99AE4319-0622-6CE9-96D2-69B4F8CA1E55}"/>
                </a:ext>
              </a:extLst>
            </p:cNvPr>
            <p:cNvSpPr/>
            <p:nvPr/>
          </p:nvSpPr>
          <p:spPr>
            <a:xfrm>
              <a:off x="6054697" y="1050400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RMSF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68" name="Rectangle: Rounded Corners 1267">
              <a:extLst>
                <a:ext uri="{FF2B5EF4-FFF2-40B4-BE49-F238E27FC236}">
                  <a16:creationId xmlns:a16="http://schemas.microsoft.com/office/drawing/2014/main" id="{46F7D0E9-BAFC-1FA0-36D7-2760B848CB5D}"/>
                </a:ext>
              </a:extLst>
            </p:cNvPr>
            <p:cNvSpPr/>
            <p:nvPr/>
          </p:nvSpPr>
          <p:spPr>
            <a:xfrm>
              <a:off x="6262780" y="2004392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 err="1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Rg</a:t>
              </a:r>
              <a:endParaRPr lang="en-US" sz="6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69" name="Rectangle: Rounded Corners 1268">
              <a:extLst>
                <a:ext uri="{FF2B5EF4-FFF2-40B4-BE49-F238E27FC236}">
                  <a16:creationId xmlns:a16="http://schemas.microsoft.com/office/drawing/2014/main" id="{401EFCD0-31F2-2743-450C-5518C9CAEB7E}"/>
                </a:ext>
              </a:extLst>
            </p:cNvPr>
            <p:cNvSpPr/>
            <p:nvPr/>
          </p:nvSpPr>
          <p:spPr>
            <a:xfrm>
              <a:off x="5666701" y="2819280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ASA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70" name="Rectangle: Rounded Corners 1269">
              <a:extLst>
                <a:ext uri="{FF2B5EF4-FFF2-40B4-BE49-F238E27FC236}">
                  <a16:creationId xmlns:a16="http://schemas.microsoft.com/office/drawing/2014/main" id="{28CC6CBD-7009-28F0-FFCC-C6FC90B37EE4}"/>
                </a:ext>
              </a:extLst>
            </p:cNvPr>
            <p:cNvSpPr/>
            <p:nvPr/>
          </p:nvSpPr>
          <p:spPr>
            <a:xfrm>
              <a:off x="4628418" y="2822532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H-bond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71" name="Rectangle: Rounded Corners 1270">
              <a:extLst>
                <a:ext uri="{FF2B5EF4-FFF2-40B4-BE49-F238E27FC236}">
                  <a16:creationId xmlns:a16="http://schemas.microsoft.com/office/drawing/2014/main" id="{94DF6AAB-8794-7416-FE0F-6F515473F427}"/>
                </a:ext>
              </a:extLst>
            </p:cNvPr>
            <p:cNvSpPr/>
            <p:nvPr/>
          </p:nvSpPr>
          <p:spPr>
            <a:xfrm>
              <a:off x="4047257" y="2002750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CA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72" name="Rectangle: Rounded Corners 1271">
              <a:extLst>
                <a:ext uri="{FF2B5EF4-FFF2-40B4-BE49-F238E27FC236}">
                  <a16:creationId xmlns:a16="http://schemas.microsoft.com/office/drawing/2014/main" id="{9863A42E-40A9-DB22-E826-F56E4FFC5DC9}"/>
                </a:ext>
              </a:extLst>
            </p:cNvPr>
            <p:cNvSpPr/>
            <p:nvPr/>
          </p:nvSpPr>
          <p:spPr>
            <a:xfrm>
              <a:off x="4210209" y="1061613"/>
              <a:ext cx="1295418" cy="79443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M-GBSA</a:t>
              </a:r>
            </a:p>
            <a:p>
              <a:pPr algn="ctr"/>
              <a:r>
                <a:rPr lang="en-US" sz="600" b="1" i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273" name="Flowchart: Connector 1272">
              <a:extLst>
                <a:ext uri="{FF2B5EF4-FFF2-40B4-BE49-F238E27FC236}">
                  <a16:creationId xmlns:a16="http://schemas.microsoft.com/office/drawing/2014/main" id="{94BDD646-187C-A2E3-5CE6-67765D5E0115}"/>
                </a:ext>
              </a:extLst>
            </p:cNvPr>
            <p:cNvSpPr/>
            <p:nvPr/>
          </p:nvSpPr>
          <p:spPr>
            <a:xfrm>
              <a:off x="5329649" y="1729591"/>
              <a:ext cx="942332" cy="942332"/>
            </a:xfrm>
            <a:prstGeom prst="flowChartConnector">
              <a:avLst/>
            </a:prstGeom>
            <a:solidFill>
              <a:schemeClr val="bg1">
                <a:alpha val="9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4" name="Oval 1273">
              <a:extLst>
                <a:ext uri="{FF2B5EF4-FFF2-40B4-BE49-F238E27FC236}">
                  <a16:creationId xmlns:a16="http://schemas.microsoft.com/office/drawing/2014/main" id="{5D5927B6-04F7-C455-8EDB-C7EE3334A789}"/>
                </a:ext>
              </a:extLst>
            </p:cNvPr>
            <p:cNvSpPr/>
            <p:nvPr/>
          </p:nvSpPr>
          <p:spPr>
            <a:xfrm>
              <a:off x="5133999" y="1522331"/>
              <a:ext cx="1356852" cy="1356852"/>
            </a:xfrm>
            <a:prstGeom prst="ellipse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5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olecular</a:t>
              </a:r>
            </a:p>
            <a:p>
              <a:pPr algn="ctr"/>
              <a:r>
                <a:rPr lang="en-US" sz="5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dynamics </a:t>
              </a:r>
            </a:p>
            <a:p>
              <a:pPr algn="ctr"/>
              <a:r>
                <a:rPr lang="en-US" sz="500" b="1" i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Simulation</a:t>
              </a:r>
            </a:p>
          </p:txBody>
        </p:sp>
      </p:grpSp>
      <p:grpSp>
        <p:nvGrpSpPr>
          <p:cNvPr id="1419" name="Group 1418">
            <a:extLst>
              <a:ext uri="{FF2B5EF4-FFF2-40B4-BE49-F238E27FC236}">
                <a16:creationId xmlns:a16="http://schemas.microsoft.com/office/drawing/2014/main" id="{63129740-0FF5-21F7-08C6-D0C09AD36783}"/>
              </a:ext>
            </a:extLst>
          </p:cNvPr>
          <p:cNvGrpSpPr/>
          <p:nvPr/>
        </p:nvGrpSpPr>
        <p:grpSpPr>
          <a:xfrm>
            <a:off x="748723" y="1920084"/>
            <a:ext cx="692139" cy="787886"/>
            <a:chOff x="-102873" y="4140362"/>
            <a:chExt cx="1524343" cy="1735212"/>
          </a:xfrm>
        </p:grpSpPr>
        <p:grpSp>
          <p:nvGrpSpPr>
            <p:cNvPr id="1420" name="Group 1419">
              <a:extLst>
                <a:ext uri="{FF2B5EF4-FFF2-40B4-BE49-F238E27FC236}">
                  <a16:creationId xmlns:a16="http://schemas.microsoft.com/office/drawing/2014/main" id="{95479E81-4877-E801-533B-1B8D9FBCFC14}"/>
                </a:ext>
              </a:extLst>
            </p:cNvPr>
            <p:cNvGrpSpPr/>
            <p:nvPr/>
          </p:nvGrpSpPr>
          <p:grpSpPr>
            <a:xfrm>
              <a:off x="243726" y="4140362"/>
              <a:ext cx="1177744" cy="1735212"/>
              <a:chOff x="6533860" y="373105"/>
              <a:chExt cx="1881789" cy="2772506"/>
            </a:xfrm>
          </p:grpSpPr>
          <p:grpSp>
            <p:nvGrpSpPr>
              <p:cNvPr id="1422" name="Group 1421">
                <a:extLst>
                  <a:ext uri="{FF2B5EF4-FFF2-40B4-BE49-F238E27FC236}">
                    <a16:creationId xmlns:a16="http://schemas.microsoft.com/office/drawing/2014/main" id="{964D9EE4-65A9-8464-78E6-85C5F6185076}"/>
                  </a:ext>
                </a:extLst>
              </p:cNvPr>
              <p:cNvGrpSpPr/>
              <p:nvPr/>
            </p:nvGrpSpPr>
            <p:grpSpPr>
              <a:xfrm>
                <a:off x="6533860" y="373105"/>
                <a:ext cx="1881789" cy="2772506"/>
                <a:chOff x="6579659" y="605965"/>
                <a:chExt cx="1881789" cy="2772506"/>
              </a:xfrm>
            </p:grpSpPr>
            <p:grpSp>
              <p:nvGrpSpPr>
                <p:cNvPr id="1434" name="Group 1433">
                  <a:extLst>
                    <a:ext uri="{FF2B5EF4-FFF2-40B4-BE49-F238E27FC236}">
                      <a16:creationId xmlns:a16="http://schemas.microsoft.com/office/drawing/2014/main" id="{47B4F899-1E1A-DE26-1A57-28538BD68855}"/>
                    </a:ext>
                  </a:extLst>
                </p:cNvPr>
                <p:cNvGrpSpPr/>
                <p:nvPr/>
              </p:nvGrpSpPr>
              <p:grpSpPr>
                <a:xfrm rot="11488929">
                  <a:off x="6758556" y="1906236"/>
                  <a:ext cx="550773" cy="651210"/>
                  <a:chOff x="4861357" y="1438124"/>
                  <a:chExt cx="550773" cy="651210"/>
                </a:xfrm>
              </p:grpSpPr>
              <p:sp>
                <p:nvSpPr>
                  <p:cNvPr id="1499" name="Flowchart: Delay 1498">
                    <a:extLst>
                      <a:ext uri="{FF2B5EF4-FFF2-40B4-BE49-F238E27FC236}">
                        <a16:creationId xmlns:a16="http://schemas.microsoft.com/office/drawing/2014/main" id="{9D05F4AA-B30E-572B-8ED3-61E5E8F3A079}"/>
                      </a:ext>
                    </a:extLst>
                  </p:cNvPr>
                  <p:cNvSpPr/>
                  <p:nvPr/>
                </p:nvSpPr>
                <p:spPr>
                  <a:xfrm rot="18694516">
                    <a:off x="5073812" y="1472552"/>
                    <a:ext cx="372746" cy="303890"/>
                  </a:xfrm>
                  <a:prstGeom prst="flowChartDelay">
                    <a:avLst/>
                  </a:prstGeom>
                  <a:solidFill>
                    <a:schemeClr val="accent5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0" name="Flowchart: Delay 1499">
                    <a:extLst>
                      <a:ext uri="{FF2B5EF4-FFF2-40B4-BE49-F238E27FC236}">
                        <a16:creationId xmlns:a16="http://schemas.microsoft.com/office/drawing/2014/main" id="{BCA8208D-6E11-1A83-464F-6A9A5BE5CCB8}"/>
                      </a:ext>
                    </a:extLst>
                  </p:cNvPr>
                  <p:cNvSpPr/>
                  <p:nvPr/>
                </p:nvSpPr>
                <p:spPr>
                  <a:xfrm rot="7894516">
                    <a:off x="4826929" y="1751017"/>
                    <a:ext cx="372745" cy="303890"/>
                  </a:xfrm>
                  <a:prstGeom prst="flowChartDelay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1" name="Oval 1500">
                    <a:extLst>
                      <a:ext uri="{FF2B5EF4-FFF2-40B4-BE49-F238E27FC236}">
                        <a16:creationId xmlns:a16="http://schemas.microsoft.com/office/drawing/2014/main" id="{943DBBC6-09FD-D219-11DD-1978A14D3403}"/>
                      </a:ext>
                    </a:extLst>
                  </p:cNvPr>
                  <p:cNvSpPr/>
                  <p:nvPr/>
                </p:nvSpPr>
                <p:spPr>
                  <a:xfrm rot="18694516">
                    <a:off x="4976633" y="1802428"/>
                    <a:ext cx="482599" cy="45538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435" name="Group 1434">
                  <a:extLst>
                    <a:ext uri="{FF2B5EF4-FFF2-40B4-BE49-F238E27FC236}">
                      <a16:creationId xmlns:a16="http://schemas.microsoft.com/office/drawing/2014/main" id="{AD5CB10E-9DD0-401C-D2A0-7B259773CBB0}"/>
                    </a:ext>
                  </a:extLst>
                </p:cNvPr>
                <p:cNvGrpSpPr/>
                <p:nvPr/>
              </p:nvGrpSpPr>
              <p:grpSpPr>
                <a:xfrm>
                  <a:off x="6579659" y="605965"/>
                  <a:ext cx="1881789" cy="2772506"/>
                  <a:chOff x="4568190" y="2239831"/>
                  <a:chExt cx="1881789" cy="2772506"/>
                </a:xfrm>
              </p:grpSpPr>
              <p:sp>
                <p:nvSpPr>
                  <p:cNvPr id="1436" name="Oval 1435">
                    <a:extLst>
                      <a:ext uri="{FF2B5EF4-FFF2-40B4-BE49-F238E27FC236}">
                        <a16:creationId xmlns:a16="http://schemas.microsoft.com/office/drawing/2014/main" id="{EDA91257-7C89-BA12-5A71-3FE786BB2183}"/>
                      </a:ext>
                    </a:extLst>
                  </p:cNvPr>
                  <p:cNvSpPr/>
                  <p:nvPr/>
                </p:nvSpPr>
                <p:spPr>
                  <a:xfrm rot="259448">
                    <a:off x="4766922" y="4707008"/>
                    <a:ext cx="494513" cy="116988"/>
                  </a:xfrm>
                  <a:prstGeom prst="ellipse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7" name="Oval 1436">
                    <a:extLst>
                      <a:ext uri="{FF2B5EF4-FFF2-40B4-BE49-F238E27FC236}">
                        <a16:creationId xmlns:a16="http://schemas.microsoft.com/office/drawing/2014/main" id="{FD8098B7-4D97-A407-29ED-5D769287FC15}"/>
                      </a:ext>
                    </a:extLst>
                  </p:cNvPr>
                  <p:cNvSpPr/>
                  <p:nvPr/>
                </p:nvSpPr>
                <p:spPr>
                  <a:xfrm>
                    <a:off x="5794678" y="4643247"/>
                    <a:ext cx="655301" cy="129485"/>
                  </a:xfrm>
                  <a:prstGeom prst="ellips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8" name="Oval 1437">
                    <a:extLst>
                      <a:ext uri="{FF2B5EF4-FFF2-40B4-BE49-F238E27FC236}">
                        <a16:creationId xmlns:a16="http://schemas.microsoft.com/office/drawing/2014/main" id="{EDA6E7A0-271C-CB14-76FE-A4E7368E6A63}"/>
                      </a:ext>
                    </a:extLst>
                  </p:cNvPr>
                  <p:cNvSpPr/>
                  <p:nvPr/>
                </p:nvSpPr>
                <p:spPr>
                  <a:xfrm>
                    <a:off x="5535757" y="4923038"/>
                    <a:ext cx="593697" cy="89299"/>
                  </a:xfrm>
                  <a:prstGeom prst="ellips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439" name="Group 1438">
                    <a:extLst>
                      <a:ext uri="{FF2B5EF4-FFF2-40B4-BE49-F238E27FC236}">
                        <a16:creationId xmlns:a16="http://schemas.microsoft.com/office/drawing/2014/main" id="{225CD8B8-E006-1ED0-E09C-89F27DD4765C}"/>
                      </a:ext>
                    </a:extLst>
                  </p:cNvPr>
                  <p:cNvGrpSpPr/>
                  <p:nvPr/>
                </p:nvGrpSpPr>
                <p:grpSpPr>
                  <a:xfrm>
                    <a:off x="4615106" y="3158585"/>
                    <a:ext cx="1172823" cy="1272581"/>
                    <a:chOff x="4613476" y="3219198"/>
                    <a:chExt cx="1177484" cy="1272581"/>
                  </a:xfrm>
                </p:grpSpPr>
                <p:grpSp>
                  <p:nvGrpSpPr>
                    <p:cNvPr id="1471" name="Group 1470">
                      <a:extLst>
                        <a:ext uri="{FF2B5EF4-FFF2-40B4-BE49-F238E27FC236}">
                          <a16:creationId xmlns:a16="http://schemas.microsoft.com/office/drawing/2014/main" id="{742622B0-1F60-FF50-A738-BC125DC2D4F9}"/>
                        </a:ext>
                      </a:extLst>
                    </p:cNvPr>
                    <p:cNvGrpSpPr/>
                    <p:nvPr/>
                  </p:nvGrpSpPr>
                  <p:grpSpPr>
                    <a:xfrm rot="1937524">
                      <a:off x="4854614" y="3324251"/>
                      <a:ext cx="745492" cy="305098"/>
                      <a:chOff x="5193344" y="1222711"/>
                      <a:chExt cx="745492" cy="305098"/>
                    </a:xfrm>
                  </p:grpSpPr>
                  <p:sp>
                    <p:nvSpPr>
                      <p:cNvPr id="1496" name="Flowchart: Delay 1495">
                        <a:extLst>
                          <a:ext uri="{FF2B5EF4-FFF2-40B4-BE49-F238E27FC236}">
                            <a16:creationId xmlns:a16="http://schemas.microsoft.com/office/drawing/2014/main" id="{63A77BF1-AA7C-386F-C253-A4F80FF8ECB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7" name="Flowchart: Delay 1496">
                        <a:extLst>
                          <a:ext uri="{FF2B5EF4-FFF2-40B4-BE49-F238E27FC236}">
                            <a16:creationId xmlns:a16="http://schemas.microsoft.com/office/drawing/2014/main" id="{C9FF1F27-49B7-9BAF-B453-BF5E87D4D3B5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8" name="Oval 1497">
                        <a:extLst>
                          <a:ext uri="{FF2B5EF4-FFF2-40B4-BE49-F238E27FC236}">
                            <a16:creationId xmlns:a16="http://schemas.microsoft.com/office/drawing/2014/main" id="{93AED764-7F1D-0D2C-59DB-1D137B27707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2" name="Group 1471">
                      <a:extLst>
                        <a:ext uri="{FF2B5EF4-FFF2-40B4-BE49-F238E27FC236}">
                          <a16:creationId xmlns:a16="http://schemas.microsoft.com/office/drawing/2014/main" id="{007B36F1-593B-C222-9830-110155B3D627}"/>
                        </a:ext>
                      </a:extLst>
                    </p:cNvPr>
                    <p:cNvGrpSpPr/>
                    <p:nvPr/>
                  </p:nvGrpSpPr>
                  <p:grpSpPr>
                    <a:xfrm rot="4387965">
                      <a:off x="5219667" y="3640299"/>
                      <a:ext cx="746607" cy="305348"/>
                      <a:chOff x="5193344" y="1222711"/>
                      <a:chExt cx="746607" cy="305348"/>
                    </a:xfrm>
                  </p:grpSpPr>
                  <p:sp>
                    <p:nvSpPr>
                      <p:cNvPr id="1493" name="Flowchart: Delay 1492">
                        <a:extLst>
                          <a:ext uri="{FF2B5EF4-FFF2-40B4-BE49-F238E27FC236}">
                            <a16:creationId xmlns:a16="http://schemas.microsoft.com/office/drawing/2014/main" id="{8787448E-0332-342A-B8ED-38E3BA85281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7205" y="122296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4" name="Flowchart: Delay 1493">
                        <a:extLst>
                          <a:ext uri="{FF2B5EF4-FFF2-40B4-BE49-F238E27FC236}">
                            <a16:creationId xmlns:a16="http://schemas.microsoft.com/office/drawing/2014/main" id="{A2B62AEB-7EDB-BA2F-FDEC-53F64113514E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5" name="Oval 1494">
                        <a:extLst>
                          <a:ext uri="{FF2B5EF4-FFF2-40B4-BE49-F238E27FC236}">
                            <a16:creationId xmlns:a16="http://schemas.microsoft.com/office/drawing/2014/main" id="{FBD17E7A-FCF3-FAA5-9DC8-9FE3F45607A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3" name="Group 1472">
                      <a:extLst>
                        <a:ext uri="{FF2B5EF4-FFF2-40B4-BE49-F238E27FC236}">
                          <a16:creationId xmlns:a16="http://schemas.microsoft.com/office/drawing/2014/main" id="{522AC7A9-FE63-FD65-5E21-135620395425}"/>
                        </a:ext>
                      </a:extLst>
                    </p:cNvPr>
                    <p:cNvGrpSpPr/>
                    <p:nvPr/>
                  </p:nvGrpSpPr>
                  <p:grpSpPr>
                    <a:xfrm rot="15432939">
                      <a:off x="4453718" y="3439395"/>
                      <a:ext cx="745492" cy="305098"/>
                      <a:chOff x="5193344" y="1222711"/>
                      <a:chExt cx="745492" cy="305098"/>
                    </a:xfrm>
                  </p:grpSpPr>
                  <p:sp>
                    <p:nvSpPr>
                      <p:cNvPr id="1490" name="Flowchart: Delay 1489">
                        <a:extLst>
                          <a:ext uri="{FF2B5EF4-FFF2-40B4-BE49-F238E27FC236}">
                            <a16:creationId xmlns:a16="http://schemas.microsoft.com/office/drawing/2014/main" id="{2E9A6BEC-B8A0-AF7E-AE6B-C26CB3B80D3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1" name="Flowchart: Delay 1490">
                        <a:extLst>
                          <a:ext uri="{FF2B5EF4-FFF2-40B4-BE49-F238E27FC236}">
                            <a16:creationId xmlns:a16="http://schemas.microsoft.com/office/drawing/2014/main" id="{FF0F5DC4-DA15-6A07-90BD-3AC460B93AB7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92" name="Oval 1491">
                        <a:extLst>
                          <a:ext uri="{FF2B5EF4-FFF2-40B4-BE49-F238E27FC236}">
                            <a16:creationId xmlns:a16="http://schemas.microsoft.com/office/drawing/2014/main" id="{070E8720-67A8-28E2-2834-47F2BF9148F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4" name="Group 1473">
                      <a:extLst>
                        <a:ext uri="{FF2B5EF4-FFF2-40B4-BE49-F238E27FC236}">
                          <a16:creationId xmlns:a16="http://schemas.microsoft.com/office/drawing/2014/main" id="{577AB831-5653-7F8E-06F0-5837B8FCED8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045468" y="3682782"/>
                      <a:ext cx="745492" cy="305098"/>
                      <a:chOff x="5193344" y="1222711"/>
                      <a:chExt cx="745492" cy="305098"/>
                    </a:xfrm>
                  </p:grpSpPr>
                  <p:sp>
                    <p:nvSpPr>
                      <p:cNvPr id="1487" name="Flowchart: Delay 1486">
                        <a:extLst>
                          <a:ext uri="{FF2B5EF4-FFF2-40B4-BE49-F238E27FC236}">
                            <a16:creationId xmlns:a16="http://schemas.microsoft.com/office/drawing/2014/main" id="{AF58A723-2C83-A5A3-4410-C856052A31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8" name="Flowchart: Delay 1487">
                        <a:extLst>
                          <a:ext uri="{FF2B5EF4-FFF2-40B4-BE49-F238E27FC236}">
                            <a16:creationId xmlns:a16="http://schemas.microsoft.com/office/drawing/2014/main" id="{CBB42409-EEA4-4213-A000-5BA192009214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9" name="Oval 1488">
                        <a:extLst>
                          <a:ext uri="{FF2B5EF4-FFF2-40B4-BE49-F238E27FC236}">
                            <a16:creationId xmlns:a16="http://schemas.microsoft.com/office/drawing/2014/main" id="{8907D8AA-1C7C-C2A3-4937-6B42ABFA6C6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5" name="Group 1474">
                      <a:extLst>
                        <a:ext uri="{FF2B5EF4-FFF2-40B4-BE49-F238E27FC236}">
                          <a16:creationId xmlns:a16="http://schemas.microsoft.com/office/drawing/2014/main" id="{4D136827-94BD-39E0-03DA-2206C032B4FC}"/>
                        </a:ext>
                      </a:extLst>
                    </p:cNvPr>
                    <p:cNvGrpSpPr/>
                    <p:nvPr/>
                  </p:nvGrpSpPr>
                  <p:grpSpPr>
                    <a:xfrm rot="19618397">
                      <a:off x="4613476" y="4030576"/>
                      <a:ext cx="745492" cy="305098"/>
                      <a:chOff x="5193344" y="1222711"/>
                      <a:chExt cx="745492" cy="305098"/>
                    </a:xfrm>
                  </p:grpSpPr>
                  <p:sp>
                    <p:nvSpPr>
                      <p:cNvPr id="1484" name="Flowchart: Delay 1483">
                        <a:extLst>
                          <a:ext uri="{FF2B5EF4-FFF2-40B4-BE49-F238E27FC236}">
                            <a16:creationId xmlns:a16="http://schemas.microsoft.com/office/drawing/2014/main" id="{367ED96F-AF58-CAD9-8023-CF092FE1BB3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5" name="Flowchart: Delay 1484">
                        <a:extLst>
                          <a:ext uri="{FF2B5EF4-FFF2-40B4-BE49-F238E27FC236}">
                            <a16:creationId xmlns:a16="http://schemas.microsoft.com/office/drawing/2014/main" id="{4561C7F0-CF5E-AF8F-3714-B1F2724A809D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6" name="Oval 1485">
                        <a:extLst>
                          <a:ext uri="{FF2B5EF4-FFF2-40B4-BE49-F238E27FC236}">
                            <a16:creationId xmlns:a16="http://schemas.microsoft.com/office/drawing/2014/main" id="{6CDE87E6-D69C-6353-A2B2-223996B3A8F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6" name="Group 1475">
                      <a:extLst>
                        <a:ext uri="{FF2B5EF4-FFF2-40B4-BE49-F238E27FC236}">
                          <a16:creationId xmlns:a16="http://schemas.microsoft.com/office/drawing/2014/main" id="{7F0D0129-3B72-F9FC-86A8-97525BA2584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871085" y="4130989"/>
                      <a:ext cx="745491" cy="305098"/>
                      <a:chOff x="5193345" y="1222711"/>
                      <a:chExt cx="745491" cy="305098"/>
                    </a:xfrm>
                  </p:grpSpPr>
                  <p:sp>
                    <p:nvSpPr>
                      <p:cNvPr id="1481" name="Flowchart: Delay 1480">
                        <a:extLst>
                          <a:ext uri="{FF2B5EF4-FFF2-40B4-BE49-F238E27FC236}">
                            <a16:creationId xmlns:a16="http://schemas.microsoft.com/office/drawing/2014/main" id="{CC8AF018-B6B3-8842-E714-835D35C9317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2" name="Flowchart: Delay 1481">
                        <a:extLst>
                          <a:ext uri="{FF2B5EF4-FFF2-40B4-BE49-F238E27FC236}">
                            <a16:creationId xmlns:a16="http://schemas.microsoft.com/office/drawing/2014/main" id="{3A9ABDC8-5378-6C96-3A79-98CA82C40416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5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3" name="Oval 1482">
                        <a:extLst>
                          <a:ext uri="{FF2B5EF4-FFF2-40B4-BE49-F238E27FC236}">
                            <a16:creationId xmlns:a16="http://schemas.microsoft.com/office/drawing/2014/main" id="{9B12CB58-4AAA-F693-C163-AC375391302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10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77" name="Group 1476">
                      <a:extLst>
                        <a:ext uri="{FF2B5EF4-FFF2-40B4-BE49-F238E27FC236}">
                          <a16:creationId xmlns:a16="http://schemas.microsoft.com/office/drawing/2014/main" id="{033B1381-D43B-B0EB-A46E-9D38CC5FFE8D}"/>
                        </a:ext>
                      </a:extLst>
                    </p:cNvPr>
                    <p:cNvGrpSpPr/>
                    <p:nvPr/>
                  </p:nvGrpSpPr>
                  <p:grpSpPr>
                    <a:xfrm rot="3342165">
                      <a:off x="5126166" y="3966484"/>
                      <a:ext cx="745492" cy="305098"/>
                      <a:chOff x="5193344" y="1222711"/>
                      <a:chExt cx="745492" cy="305098"/>
                    </a:xfrm>
                  </p:grpSpPr>
                  <p:sp>
                    <p:nvSpPr>
                      <p:cNvPr id="1478" name="Flowchart: Delay 1477">
                        <a:extLst>
                          <a:ext uri="{FF2B5EF4-FFF2-40B4-BE49-F238E27FC236}">
                            <a16:creationId xmlns:a16="http://schemas.microsoft.com/office/drawing/2014/main" id="{5BD02EF6-7215-425F-864C-5A28A91A459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566090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accent5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79" name="Flowchart: Delay 1478">
                        <a:extLst>
                          <a:ext uri="{FF2B5EF4-FFF2-40B4-BE49-F238E27FC236}">
                            <a16:creationId xmlns:a16="http://schemas.microsoft.com/office/drawing/2014/main" id="{EAE2902D-8513-339D-DCD9-AB8F24F53C9F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93344" y="1222711"/>
                        <a:ext cx="372746" cy="305098"/>
                      </a:xfrm>
                      <a:prstGeom prst="flowChartDelay">
                        <a:avLst/>
                      </a:prstGeom>
                      <a:solidFill>
                        <a:schemeClr val="bg1">
                          <a:lumMod val="9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80" name="Oval 1479">
                        <a:extLst>
                          <a:ext uri="{FF2B5EF4-FFF2-40B4-BE49-F238E27FC236}">
                            <a16:creationId xmlns:a16="http://schemas.microsoft.com/office/drawing/2014/main" id="{71446D47-6764-8450-9103-CF874F90A57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12409" y="1251922"/>
                        <a:ext cx="482600" cy="45719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sp>
                <p:nvSpPr>
                  <p:cNvPr id="1440" name="Rectangle 1023">
                    <a:extLst>
                      <a:ext uri="{FF2B5EF4-FFF2-40B4-BE49-F238E27FC236}">
                        <a16:creationId xmlns:a16="http://schemas.microsoft.com/office/drawing/2014/main" id="{7AFBBF98-03EF-29CF-8826-4C4050487FC0}"/>
                      </a:ext>
                    </a:extLst>
                  </p:cNvPr>
                  <p:cNvSpPr/>
                  <p:nvPr/>
                </p:nvSpPr>
                <p:spPr>
                  <a:xfrm>
                    <a:off x="4603895" y="4352940"/>
                    <a:ext cx="1235383" cy="196317"/>
                  </a:xfrm>
                  <a:custGeom>
                    <a:avLst/>
                    <a:gdLst>
                      <a:gd name="csX0" fmla="*/ 0 w 1172824"/>
                      <a:gd name="csY0" fmla="*/ 0 h 1408176"/>
                      <a:gd name="csX1" fmla="*/ 1172824 w 1172824"/>
                      <a:gd name="csY1" fmla="*/ 0 h 1408176"/>
                      <a:gd name="csX2" fmla="*/ 1172824 w 1172824"/>
                      <a:gd name="csY2" fmla="*/ 1408176 h 1408176"/>
                      <a:gd name="csX3" fmla="*/ 0 w 1172824"/>
                      <a:gd name="csY3" fmla="*/ 1408176 h 1408176"/>
                      <a:gd name="csX4" fmla="*/ 0 w 1172824"/>
                      <a:gd name="csY4" fmla="*/ 0 h 1408176"/>
                      <a:gd name="csX0" fmla="*/ 0 w 1172824"/>
                      <a:gd name="csY0" fmla="*/ 0 h 1455589"/>
                      <a:gd name="csX1" fmla="*/ 1172824 w 1172824"/>
                      <a:gd name="csY1" fmla="*/ 0 h 1455589"/>
                      <a:gd name="csX2" fmla="*/ 1172824 w 1172824"/>
                      <a:gd name="csY2" fmla="*/ 1408176 h 1455589"/>
                      <a:gd name="csX3" fmla="*/ 0 w 1172824"/>
                      <a:gd name="csY3" fmla="*/ 1408176 h 1455589"/>
                      <a:gd name="csX4" fmla="*/ 0 w 1172824"/>
                      <a:gd name="csY4" fmla="*/ 0 h 1455589"/>
                      <a:gd name="csX0" fmla="*/ 0 w 1172824"/>
                      <a:gd name="csY0" fmla="*/ 0 h 1488186"/>
                      <a:gd name="csX1" fmla="*/ 1172824 w 1172824"/>
                      <a:gd name="csY1" fmla="*/ 0 h 1488186"/>
                      <a:gd name="csX2" fmla="*/ 1172824 w 1172824"/>
                      <a:gd name="csY2" fmla="*/ 1408176 h 1488186"/>
                      <a:gd name="csX3" fmla="*/ 0 w 1172824"/>
                      <a:gd name="csY3" fmla="*/ 1408176 h 1488186"/>
                      <a:gd name="csX4" fmla="*/ 0 w 1172824"/>
                      <a:gd name="csY4" fmla="*/ 0 h 1488186"/>
                      <a:gd name="csX0" fmla="*/ 0 w 1172824"/>
                      <a:gd name="csY0" fmla="*/ 0 h 1868138"/>
                      <a:gd name="csX1" fmla="*/ 1172824 w 1172824"/>
                      <a:gd name="csY1" fmla="*/ 0 h 1868138"/>
                      <a:gd name="csX2" fmla="*/ 1172824 w 1172824"/>
                      <a:gd name="csY2" fmla="*/ 1408176 h 1868138"/>
                      <a:gd name="csX3" fmla="*/ 0 w 1172824"/>
                      <a:gd name="csY3" fmla="*/ 1408176 h 1868138"/>
                      <a:gd name="csX4" fmla="*/ 0 w 1172824"/>
                      <a:gd name="csY4" fmla="*/ 0 h 1868138"/>
                      <a:gd name="csX0" fmla="*/ 0 w 1172824"/>
                      <a:gd name="csY0" fmla="*/ 0 h 2108681"/>
                      <a:gd name="csX1" fmla="*/ 1172824 w 1172824"/>
                      <a:gd name="csY1" fmla="*/ 0 h 2108681"/>
                      <a:gd name="csX2" fmla="*/ 1172824 w 1172824"/>
                      <a:gd name="csY2" fmla="*/ 1408176 h 2108681"/>
                      <a:gd name="csX3" fmla="*/ 0 w 1172824"/>
                      <a:gd name="csY3" fmla="*/ 1408176 h 2108681"/>
                      <a:gd name="csX4" fmla="*/ 0 w 1172824"/>
                      <a:gd name="csY4" fmla="*/ 0 h 2108681"/>
                      <a:gd name="csX0" fmla="*/ 0 w 1172824"/>
                      <a:gd name="csY0" fmla="*/ 0 h 2249212"/>
                      <a:gd name="csX1" fmla="*/ 1172824 w 1172824"/>
                      <a:gd name="csY1" fmla="*/ 0 h 2249212"/>
                      <a:gd name="csX2" fmla="*/ 1172824 w 1172824"/>
                      <a:gd name="csY2" fmla="*/ 1408176 h 2249212"/>
                      <a:gd name="csX3" fmla="*/ 0 w 1172824"/>
                      <a:gd name="csY3" fmla="*/ 1408176 h 2249212"/>
                      <a:gd name="csX4" fmla="*/ 0 w 1172824"/>
                      <a:gd name="csY4" fmla="*/ 0 h 2249212"/>
                      <a:gd name="csX0" fmla="*/ 0 w 1172824"/>
                      <a:gd name="csY0" fmla="*/ 0 h 2366692"/>
                      <a:gd name="csX1" fmla="*/ 1172824 w 1172824"/>
                      <a:gd name="csY1" fmla="*/ 0 h 2366692"/>
                      <a:gd name="csX2" fmla="*/ 1172824 w 1172824"/>
                      <a:gd name="csY2" fmla="*/ 1408176 h 2366692"/>
                      <a:gd name="csX3" fmla="*/ 0 w 1172824"/>
                      <a:gd name="csY3" fmla="*/ 1408176 h 2366692"/>
                      <a:gd name="csX4" fmla="*/ 0 w 1172824"/>
                      <a:gd name="csY4" fmla="*/ 0 h 2366692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1172824" h="2366692">
                        <a:moveTo>
                          <a:pt x="0" y="0"/>
                        </a:moveTo>
                        <a:lnTo>
                          <a:pt x="1172824" y="0"/>
                        </a:lnTo>
                        <a:lnTo>
                          <a:pt x="1172824" y="1408176"/>
                        </a:lnTo>
                        <a:cubicBezTo>
                          <a:pt x="778073" y="2663136"/>
                          <a:pt x="394365" y="2709068"/>
                          <a:pt x="0" y="1408176"/>
                        </a:cubicBezTo>
                        <a:lnTo>
                          <a:pt x="0" y="0"/>
                        </a:ln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accent6">
                          <a:lumMod val="60000"/>
                          <a:lumOff val="40000"/>
                          <a:shade val="30000"/>
                          <a:satMod val="115000"/>
                        </a:schemeClr>
                      </a:gs>
                      <a:gs pos="50000">
                        <a:schemeClr val="accent6">
                          <a:lumMod val="60000"/>
                          <a:lumOff val="40000"/>
                          <a:shade val="67500"/>
                          <a:satMod val="115000"/>
                        </a:schemeClr>
                      </a:gs>
                      <a:gs pos="100000">
                        <a:schemeClr val="accent6">
                          <a:lumMod val="60000"/>
                          <a:lumOff val="40000"/>
                          <a:shade val="100000"/>
                          <a:satMod val="115000"/>
                        </a:schemeClr>
                      </a:gs>
                    </a:gsLst>
                    <a:path path="circle">
                      <a:fillToRect r="100000" b="100000"/>
                    </a:path>
                    <a:tileRect l="-100000" t="-100000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1" name="Rectangle 190">
                    <a:extLst>
                      <a:ext uri="{FF2B5EF4-FFF2-40B4-BE49-F238E27FC236}">
                        <a16:creationId xmlns:a16="http://schemas.microsoft.com/office/drawing/2014/main" id="{2896F051-26C8-045D-0F14-882214987E9A}"/>
                      </a:ext>
                    </a:extLst>
                  </p:cNvPr>
                  <p:cNvSpPr/>
                  <p:nvPr/>
                </p:nvSpPr>
                <p:spPr>
                  <a:xfrm>
                    <a:off x="4568190" y="2650955"/>
                    <a:ext cx="1306830" cy="232453"/>
                  </a:xfrm>
                  <a:custGeom>
                    <a:avLst/>
                    <a:gdLst>
                      <a:gd name="csX0" fmla="*/ 0 w 1420496"/>
                      <a:gd name="csY0" fmla="*/ 0 h 232453"/>
                      <a:gd name="csX1" fmla="*/ 1420496 w 1420496"/>
                      <a:gd name="csY1" fmla="*/ 0 h 232453"/>
                      <a:gd name="csX2" fmla="*/ 1420496 w 1420496"/>
                      <a:gd name="csY2" fmla="*/ 232453 h 232453"/>
                      <a:gd name="csX3" fmla="*/ 0 w 1420496"/>
                      <a:gd name="csY3" fmla="*/ 232453 h 232453"/>
                      <a:gd name="csX4" fmla="*/ 0 w 1420496"/>
                      <a:gd name="csY4" fmla="*/ 0 h 232453"/>
                      <a:gd name="csX0" fmla="*/ 16086 w 1436582"/>
                      <a:gd name="csY0" fmla="*/ 0 h 232453"/>
                      <a:gd name="csX1" fmla="*/ 1436582 w 1436582"/>
                      <a:gd name="csY1" fmla="*/ 0 h 232453"/>
                      <a:gd name="csX2" fmla="*/ 1436582 w 1436582"/>
                      <a:gd name="csY2" fmla="*/ 232453 h 232453"/>
                      <a:gd name="csX3" fmla="*/ 16086 w 1436582"/>
                      <a:gd name="csY3" fmla="*/ 232453 h 232453"/>
                      <a:gd name="csX4" fmla="*/ 16086 w 1436582"/>
                      <a:gd name="csY4" fmla="*/ 0 h 232453"/>
                      <a:gd name="csX0" fmla="*/ 25737 w 1446233"/>
                      <a:gd name="csY0" fmla="*/ 0 h 232453"/>
                      <a:gd name="csX1" fmla="*/ 1446233 w 1446233"/>
                      <a:gd name="csY1" fmla="*/ 0 h 232453"/>
                      <a:gd name="csX2" fmla="*/ 1446233 w 1446233"/>
                      <a:gd name="csY2" fmla="*/ 232453 h 232453"/>
                      <a:gd name="csX3" fmla="*/ 25737 w 1446233"/>
                      <a:gd name="csY3" fmla="*/ 232453 h 232453"/>
                      <a:gd name="csX4" fmla="*/ 25737 w 1446233"/>
                      <a:gd name="csY4" fmla="*/ 0 h 232453"/>
                      <a:gd name="csX0" fmla="*/ 25737 w 1467399"/>
                      <a:gd name="csY0" fmla="*/ 0 h 232453"/>
                      <a:gd name="csX1" fmla="*/ 1446233 w 1467399"/>
                      <a:gd name="csY1" fmla="*/ 0 h 232453"/>
                      <a:gd name="csX2" fmla="*/ 1446233 w 1467399"/>
                      <a:gd name="csY2" fmla="*/ 232453 h 232453"/>
                      <a:gd name="csX3" fmla="*/ 25737 w 1467399"/>
                      <a:gd name="csY3" fmla="*/ 232453 h 232453"/>
                      <a:gd name="csX4" fmla="*/ 25737 w 1467399"/>
                      <a:gd name="csY4" fmla="*/ 0 h 232453"/>
                      <a:gd name="csX0" fmla="*/ 25737 w 1474627"/>
                      <a:gd name="csY0" fmla="*/ 0 h 232453"/>
                      <a:gd name="csX1" fmla="*/ 1446233 w 1474627"/>
                      <a:gd name="csY1" fmla="*/ 0 h 232453"/>
                      <a:gd name="csX2" fmla="*/ 1446233 w 1474627"/>
                      <a:gd name="csY2" fmla="*/ 232453 h 232453"/>
                      <a:gd name="csX3" fmla="*/ 25737 w 1474627"/>
                      <a:gd name="csY3" fmla="*/ 232453 h 232453"/>
                      <a:gd name="csX4" fmla="*/ 25737 w 1474627"/>
                      <a:gd name="csY4" fmla="*/ 0 h 232453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1474627" h="232453">
                        <a:moveTo>
                          <a:pt x="25737" y="0"/>
                        </a:moveTo>
                        <a:lnTo>
                          <a:pt x="1446233" y="0"/>
                        </a:lnTo>
                        <a:cubicBezTo>
                          <a:pt x="1493858" y="73674"/>
                          <a:pt x="1472903" y="158779"/>
                          <a:pt x="1446233" y="232453"/>
                        </a:cubicBezTo>
                        <a:lnTo>
                          <a:pt x="25737" y="232453"/>
                        </a:lnTo>
                        <a:cubicBezTo>
                          <a:pt x="-6648" y="154969"/>
                          <a:pt x="-10458" y="77484"/>
                          <a:pt x="25737" y="0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accent6">
                          <a:lumMod val="40000"/>
                          <a:lumOff val="60000"/>
                          <a:shade val="30000"/>
                          <a:satMod val="115000"/>
                        </a:schemeClr>
                      </a:gs>
                      <a:gs pos="50000">
                        <a:schemeClr val="accent6">
                          <a:lumMod val="40000"/>
                          <a:lumOff val="60000"/>
                          <a:shade val="67500"/>
                          <a:satMod val="115000"/>
                        </a:schemeClr>
                      </a:gs>
                      <a:gs pos="100000">
                        <a:schemeClr val="accent6">
                          <a:lumMod val="40000"/>
                          <a:lumOff val="60000"/>
                          <a:shade val="100000"/>
                          <a:satMod val="115000"/>
                        </a:schemeClr>
                      </a:gs>
                    </a:gsLst>
                    <a:path path="circle">
                      <a:fillToRect l="100000" b="100000"/>
                    </a:path>
                    <a:tileRect t="-100000" r="-100000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2" name="Flowchart: Delay 1441">
                    <a:extLst>
                      <a:ext uri="{FF2B5EF4-FFF2-40B4-BE49-F238E27FC236}">
                        <a16:creationId xmlns:a16="http://schemas.microsoft.com/office/drawing/2014/main" id="{F77E2B54-A450-73C2-C9AB-504EA6048724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192394" y="2064215"/>
                    <a:ext cx="58420" cy="1173480"/>
                  </a:xfrm>
                  <a:prstGeom prst="flowChartDelay">
                    <a:avLst/>
                  </a:prstGeom>
                  <a:solidFill>
                    <a:schemeClr val="bg2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3" name="Flowchart: Delay 1442">
                    <a:extLst>
                      <a:ext uri="{FF2B5EF4-FFF2-40B4-BE49-F238E27FC236}">
                        <a16:creationId xmlns:a16="http://schemas.microsoft.com/office/drawing/2014/main" id="{AEA4CE5E-5FA4-7A1A-EEE2-6B316C5FFD39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192394" y="1682301"/>
                    <a:ext cx="58420" cy="1173480"/>
                  </a:xfrm>
                  <a:prstGeom prst="flowChartDelay">
                    <a:avLst/>
                  </a:prstGeom>
                  <a:gradFill flip="none" rotWithShape="1">
                    <a:gsLst>
                      <a:gs pos="0">
                        <a:schemeClr val="bg2">
                          <a:lumMod val="50000"/>
                          <a:shade val="30000"/>
                          <a:satMod val="115000"/>
                        </a:schemeClr>
                      </a:gs>
                      <a:gs pos="50000">
                        <a:schemeClr val="bg2">
                          <a:lumMod val="50000"/>
                          <a:shade val="67500"/>
                          <a:satMod val="115000"/>
                        </a:schemeClr>
                      </a:gs>
                      <a:gs pos="100000">
                        <a:schemeClr val="bg2">
                          <a:lumMod val="50000"/>
                          <a:shade val="100000"/>
                          <a:satMod val="115000"/>
                        </a:scheme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4" name="Rectangle 1443">
                    <a:extLst>
                      <a:ext uri="{FF2B5EF4-FFF2-40B4-BE49-F238E27FC236}">
                        <a16:creationId xmlns:a16="http://schemas.microsoft.com/office/drawing/2014/main" id="{4C31D0AA-D51A-5DB8-0C67-4DB13CBB7BF1}"/>
                      </a:ext>
                    </a:extLst>
                  </p:cNvPr>
                  <p:cNvSpPr/>
                  <p:nvPr/>
                </p:nvSpPr>
                <p:spPr>
                  <a:xfrm>
                    <a:off x="4634864" y="2275501"/>
                    <a:ext cx="1173480" cy="381000"/>
                  </a:xfrm>
                  <a:prstGeom prst="rect">
                    <a:avLst/>
                  </a:prstGeom>
                  <a:gradFill flip="none" rotWithShape="1">
                    <a:gsLst>
                      <a:gs pos="0">
                        <a:schemeClr val="bg1">
                          <a:lumMod val="85000"/>
                          <a:shade val="30000"/>
                          <a:satMod val="115000"/>
                        </a:schemeClr>
                      </a:gs>
                      <a:gs pos="50000">
                        <a:schemeClr val="bg1">
                          <a:lumMod val="85000"/>
                          <a:shade val="67500"/>
                          <a:satMod val="115000"/>
                        </a:schemeClr>
                      </a:gs>
                      <a:gs pos="100000">
                        <a:schemeClr val="bg1">
                          <a:lumMod val="85000"/>
                          <a:shade val="100000"/>
                          <a:satMod val="115000"/>
                        </a:scheme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5" name="Rectangle 1444">
                    <a:extLst>
                      <a:ext uri="{FF2B5EF4-FFF2-40B4-BE49-F238E27FC236}">
                        <a16:creationId xmlns:a16="http://schemas.microsoft.com/office/drawing/2014/main" id="{5594F049-5029-EFAE-C563-26A433AE029B}"/>
                      </a:ext>
                    </a:extLst>
                  </p:cNvPr>
                  <p:cNvSpPr/>
                  <p:nvPr/>
                </p:nvSpPr>
                <p:spPr>
                  <a:xfrm>
                    <a:off x="4691381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6" name="Rectangle 1445">
                    <a:extLst>
                      <a:ext uri="{FF2B5EF4-FFF2-40B4-BE49-F238E27FC236}">
                        <a16:creationId xmlns:a16="http://schemas.microsoft.com/office/drawing/2014/main" id="{B6A016C1-0880-3B7B-3142-D3EF9FA92B11}"/>
                      </a:ext>
                    </a:extLst>
                  </p:cNvPr>
                  <p:cNvSpPr/>
                  <p:nvPr/>
                </p:nvSpPr>
                <p:spPr>
                  <a:xfrm>
                    <a:off x="4770121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7" name="Rectangle 1446">
                    <a:extLst>
                      <a:ext uri="{FF2B5EF4-FFF2-40B4-BE49-F238E27FC236}">
                        <a16:creationId xmlns:a16="http://schemas.microsoft.com/office/drawing/2014/main" id="{F7ED95CE-2A22-9F87-B00F-CC1891D28A42}"/>
                      </a:ext>
                    </a:extLst>
                  </p:cNvPr>
                  <p:cNvSpPr/>
                  <p:nvPr/>
                </p:nvSpPr>
                <p:spPr>
                  <a:xfrm>
                    <a:off x="4855211" y="2322830"/>
                    <a:ext cx="45719" cy="286343"/>
                  </a:xfrm>
                  <a:prstGeom prst="rect">
                    <a:avLst/>
                  </a:prstGeom>
                  <a:solidFill>
                    <a:schemeClr val="bg2">
                      <a:lumMod val="9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8" name="Rectangle 1447">
                    <a:extLst>
                      <a:ext uri="{FF2B5EF4-FFF2-40B4-BE49-F238E27FC236}">
                        <a16:creationId xmlns:a16="http://schemas.microsoft.com/office/drawing/2014/main" id="{D1E337D2-C2B7-D688-1FE0-91458C76C9DD}"/>
                      </a:ext>
                    </a:extLst>
                  </p:cNvPr>
                  <p:cNvSpPr/>
                  <p:nvPr/>
                </p:nvSpPr>
                <p:spPr>
                  <a:xfrm>
                    <a:off x="4933951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9" name="Rectangle 1448">
                    <a:extLst>
                      <a:ext uri="{FF2B5EF4-FFF2-40B4-BE49-F238E27FC236}">
                        <a16:creationId xmlns:a16="http://schemas.microsoft.com/office/drawing/2014/main" id="{D80C21B7-FEF1-C90F-6903-D2513C3EE3EE}"/>
                      </a:ext>
                    </a:extLst>
                  </p:cNvPr>
                  <p:cNvSpPr/>
                  <p:nvPr/>
                </p:nvSpPr>
                <p:spPr>
                  <a:xfrm>
                    <a:off x="5012691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0" name="Rectangle 1449">
                    <a:extLst>
                      <a:ext uri="{FF2B5EF4-FFF2-40B4-BE49-F238E27FC236}">
                        <a16:creationId xmlns:a16="http://schemas.microsoft.com/office/drawing/2014/main" id="{14CB3D10-E206-36A7-5CEB-656F8CCE54F0}"/>
                      </a:ext>
                    </a:extLst>
                  </p:cNvPr>
                  <p:cNvSpPr/>
                  <p:nvPr/>
                </p:nvSpPr>
                <p:spPr>
                  <a:xfrm>
                    <a:off x="5091431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1" name="Rectangle 1450">
                    <a:extLst>
                      <a:ext uri="{FF2B5EF4-FFF2-40B4-BE49-F238E27FC236}">
                        <a16:creationId xmlns:a16="http://schemas.microsoft.com/office/drawing/2014/main" id="{FB5BF4ED-9BA4-B965-B3DC-7C0EE441A472}"/>
                      </a:ext>
                    </a:extLst>
                  </p:cNvPr>
                  <p:cNvSpPr/>
                  <p:nvPr/>
                </p:nvSpPr>
                <p:spPr>
                  <a:xfrm>
                    <a:off x="5165090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2" name="Rectangle 1451">
                    <a:extLst>
                      <a:ext uri="{FF2B5EF4-FFF2-40B4-BE49-F238E27FC236}">
                        <a16:creationId xmlns:a16="http://schemas.microsoft.com/office/drawing/2014/main" id="{5D5F121A-742D-9324-A511-92EE4D3BD3CD}"/>
                      </a:ext>
                    </a:extLst>
                  </p:cNvPr>
                  <p:cNvSpPr/>
                  <p:nvPr/>
                </p:nvSpPr>
                <p:spPr>
                  <a:xfrm>
                    <a:off x="5243830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3" name="Rectangle 1452">
                    <a:extLst>
                      <a:ext uri="{FF2B5EF4-FFF2-40B4-BE49-F238E27FC236}">
                        <a16:creationId xmlns:a16="http://schemas.microsoft.com/office/drawing/2014/main" id="{3ECA2041-8B20-EF3C-5FBC-80F801DF565B}"/>
                      </a:ext>
                    </a:extLst>
                  </p:cNvPr>
                  <p:cNvSpPr/>
                  <p:nvPr/>
                </p:nvSpPr>
                <p:spPr>
                  <a:xfrm>
                    <a:off x="5318125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4" name="Rectangle 1453">
                    <a:extLst>
                      <a:ext uri="{FF2B5EF4-FFF2-40B4-BE49-F238E27FC236}">
                        <a16:creationId xmlns:a16="http://schemas.microsoft.com/office/drawing/2014/main" id="{B31CD6CE-5132-23E7-0012-F28409F4B958}"/>
                      </a:ext>
                    </a:extLst>
                  </p:cNvPr>
                  <p:cNvSpPr/>
                  <p:nvPr/>
                </p:nvSpPr>
                <p:spPr>
                  <a:xfrm>
                    <a:off x="5396862" y="2322828"/>
                    <a:ext cx="45718" cy="286344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5" name="Rectangle 1454">
                    <a:extLst>
                      <a:ext uri="{FF2B5EF4-FFF2-40B4-BE49-F238E27FC236}">
                        <a16:creationId xmlns:a16="http://schemas.microsoft.com/office/drawing/2014/main" id="{0B1A0693-63A1-25D7-72BC-EBC4BE0E8AC5}"/>
                      </a:ext>
                    </a:extLst>
                  </p:cNvPr>
                  <p:cNvSpPr/>
                  <p:nvPr/>
                </p:nvSpPr>
                <p:spPr>
                  <a:xfrm>
                    <a:off x="5474969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6" name="Rectangle 1455">
                    <a:extLst>
                      <a:ext uri="{FF2B5EF4-FFF2-40B4-BE49-F238E27FC236}">
                        <a16:creationId xmlns:a16="http://schemas.microsoft.com/office/drawing/2014/main" id="{5BEBA6C5-3BD8-BCE1-7EC6-CCD42056ECF8}"/>
                      </a:ext>
                    </a:extLst>
                  </p:cNvPr>
                  <p:cNvSpPr/>
                  <p:nvPr/>
                </p:nvSpPr>
                <p:spPr>
                  <a:xfrm>
                    <a:off x="5553709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7" name="Rectangle 1456">
                    <a:extLst>
                      <a:ext uri="{FF2B5EF4-FFF2-40B4-BE49-F238E27FC236}">
                        <a16:creationId xmlns:a16="http://schemas.microsoft.com/office/drawing/2014/main" id="{BAE1684A-6CAD-22EB-0673-4E484980A451}"/>
                      </a:ext>
                    </a:extLst>
                  </p:cNvPr>
                  <p:cNvSpPr/>
                  <p:nvPr/>
                </p:nvSpPr>
                <p:spPr>
                  <a:xfrm>
                    <a:off x="5628004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8" name="Rectangle 1457">
                    <a:extLst>
                      <a:ext uri="{FF2B5EF4-FFF2-40B4-BE49-F238E27FC236}">
                        <a16:creationId xmlns:a16="http://schemas.microsoft.com/office/drawing/2014/main" id="{DEA2D5C0-3440-B232-966E-85BDED92174F}"/>
                      </a:ext>
                    </a:extLst>
                  </p:cNvPr>
                  <p:cNvSpPr/>
                  <p:nvPr/>
                </p:nvSpPr>
                <p:spPr>
                  <a:xfrm>
                    <a:off x="5706744" y="2322830"/>
                    <a:ext cx="45719" cy="286343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459" name="Group 1458">
                    <a:extLst>
                      <a:ext uri="{FF2B5EF4-FFF2-40B4-BE49-F238E27FC236}">
                        <a16:creationId xmlns:a16="http://schemas.microsoft.com/office/drawing/2014/main" id="{1EDD5849-F63B-37BC-8EAB-02717A32FBF8}"/>
                      </a:ext>
                    </a:extLst>
                  </p:cNvPr>
                  <p:cNvGrpSpPr/>
                  <p:nvPr/>
                </p:nvGrpSpPr>
                <p:grpSpPr>
                  <a:xfrm rot="233501">
                    <a:off x="4841418" y="4479548"/>
                    <a:ext cx="742540" cy="305098"/>
                    <a:chOff x="7076088" y="2851202"/>
                    <a:chExt cx="742540" cy="305098"/>
                  </a:xfrm>
                </p:grpSpPr>
                <p:sp>
                  <p:nvSpPr>
                    <p:cNvPr id="1468" name="Flowchart: Delay 1467">
                      <a:extLst>
                        <a:ext uri="{FF2B5EF4-FFF2-40B4-BE49-F238E27FC236}">
                          <a16:creationId xmlns:a16="http://schemas.microsoft.com/office/drawing/2014/main" id="{926F1F07-B188-CC55-10BB-EF5E152FC37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47357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accent5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9" name="Flowchart: Delay 1468">
                      <a:extLst>
                        <a:ext uri="{FF2B5EF4-FFF2-40B4-BE49-F238E27FC236}">
                          <a16:creationId xmlns:a16="http://schemas.microsoft.com/office/drawing/2014/main" id="{11C65D90-6D3E-03E6-0C3E-4DF3F5B78EE6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7076088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70" name="Oval 1469">
                      <a:extLst>
                        <a:ext uri="{FF2B5EF4-FFF2-40B4-BE49-F238E27FC236}">
                          <a16:creationId xmlns:a16="http://schemas.microsoft.com/office/drawing/2014/main" id="{9344B7B4-96D9-A3F2-61C4-BA3BD1EE78F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194682" y="2880413"/>
                      <a:ext cx="480690" cy="45719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60" name="Group 1459">
                    <a:extLst>
                      <a:ext uri="{FF2B5EF4-FFF2-40B4-BE49-F238E27FC236}">
                        <a16:creationId xmlns:a16="http://schemas.microsoft.com/office/drawing/2014/main" id="{19039B4D-5A35-AF97-26F6-3422445C888C}"/>
                      </a:ext>
                    </a:extLst>
                  </p:cNvPr>
                  <p:cNvGrpSpPr/>
                  <p:nvPr/>
                </p:nvGrpSpPr>
                <p:grpSpPr>
                  <a:xfrm rot="20799848">
                    <a:off x="5465274" y="4439560"/>
                    <a:ext cx="742540" cy="305098"/>
                    <a:chOff x="7076088" y="2851202"/>
                    <a:chExt cx="742540" cy="305098"/>
                  </a:xfrm>
                </p:grpSpPr>
                <p:sp>
                  <p:nvSpPr>
                    <p:cNvPr id="1465" name="Flowchart: Delay 1464">
                      <a:extLst>
                        <a:ext uri="{FF2B5EF4-FFF2-40B4-BE49-F238E27FC236}">
                          <a16:creationId xmlns:a16="http://schemas.microsoft.com/office/drawing/2014/main" id="{574509CF-0129-9936-91B8-C9212917C0A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47357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accent5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6" name="Flowchart: Delay 1465">
                      <a:extLst>
                        <a:ext uri="{FF2B5EF4-FFF2-40B4-BE49-F238E27FC236}">
                          <a16:creationId xmlns:a16="http://schemas.microsoft.com/office/drawing/2014/main" id="{1D8E634A-CA6B-8445-647E-06B1C32CBC44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7076088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7" name="Oval 1466">
                      <a:extLst>
                        <a:ext uri="{FF2B5EF4-FFF2-40B4-BE49-F238E27FC236}">
                          <a16:creationId xmlns:a16="http://schemas.microsoft.com/office/drawing/2014/main" id="{F6587746-A451-1760-0610-1229C59E7A1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194682" y="2880413"/>
                      <a:ext cx="480690" cy="45719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461" name="Group 1460">
                    <a:extLst>
                      <a:ext uri="{FF2B5EF4-FFF2-40B4-BE49-F238E27FC236}">
                        <a16:creationId xmlns:a16="http://schemas.microsoft.com/office/drawing/2014/main" id="{77D0E653-D357-B59E-50F0-1B68E74A6D67}"/>
                      </a:ext>
                    </a:extLst>
                  </p:cNvPr>
                  <p:cNvGrpSpPr/>
                  <p:nvPr/>
                </p:nvGrpSpPr>
                <p:grpSpPr>
                  <a:xfrm>
                    <a:off x="5195394" y="4697802"/>
                    <a:ext cx="742540" cy="305098"/>
                    <a:chOff x="7076088" y="2851202"/>
                    <a:chExt cx="742540" cy="305098"/>
                  </a:xfrm>
                </p:grpSpPr>
                <p:sp>
                  <p:nvSpPr>
                    <p:cNvPr id="1462" name="Flowchart: Delay 1461">
                      <a:extLst>
                        <a:ext uri="{FF2B5EF4-FFF2-40B4-BE49-F238E27FC236}">
                          <a16:creationId xmlns:a16="http://schemas.microsoft.com/office/drawing/2014/main" id="{90CD1C86-E02D-7438-82B2-6E20C1C800B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47357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accent5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3" name="Flowchart: Delay 1462">
                      <a:extLst>
                        <a:ext uri="{FF2B5EF4-FFF2-40B4-BE49-F238E27FC236}">
                          <a16:creationId xmlns:a16="http://schemas.microsoft.com/office/drawing/2014/main" id="{7C8EFA3F-B607-CA94-72C0-BA91B791AAE4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7076088" y="2851202"/>
                      <a:ext cx="371271" cy="305098"/>
                    </a:xfrm>
                    <a:prstGeom prst="flowChartDelay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4" name="Oval 1463">
                      <a:extLst>
                        <a:ext uri="{FF2B5EF4-FFF2-40B4-BE49-F238E27FC236}">
                          <a16:creationId xmlns:a16="http://schemas.microsoft.com/office/drawing/2014/main" id="{30300B60-A741-7C0A-3E8B-F4914C3C134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194682" y="2880413"/>
                      <a:ext cx="480690" cy="45719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grpSp>
            <p:nvGrpSpPr>
              <p:cNvPr id="1423" name="Group 1422">
                <a:extLst>
                  <a:ext uri="{FF2B5EF4-FFF2-40B4-BE49-F238E27FC236}">
                    <a16:creationId xmlns:a16="http://schemas.microsoft.com/office/drawing/2014/main" id="{2336792D-D8B0-6769-0AF8-56B3EA9EC421}"/>
                  </a:ext>
                </a:extLst>
              </p:cNvPr>
              <p:cNvGrpSpPr/>
              <p:nvPr/>
            </p:nvGrpSpPr>
            <p:grpSpPr>
              <a:xfrm>
                <a:off x="6599008" y="1017202"/>
                <a:ext cx="1172824" cy="1610796"/>
                <a:chOff x="9397873" y="926947"/>
                <a:chExt cx="1172824" cy="1610796"/>
              </a:xfrm>
            </p:grpSpPr>
            <p:sp>
              <p:nvSpPr>
                <p:cNvPr id="1429" name="Rectangle 1023">
                  <a:extLst>
                    <a:ext uri="{FF2B5EF4-FFF2-40B4-BE49-F238E27FC236}">
                      <a16:creationId xmlns:a16="http://schemas.microsoft.com/office/drawing/2014/main" id="{0707CA37-3D0E-7927-2E58-FA9AD2CF4A60}"/>
                    </a:ext>
                  </a:extLst>
                </p:cNvPr>
                <p:cNvSpPr/>
                <p:nvPr/>
              </p:nvSpPr>
              <p:spPr>
                <a:xfrm>
                  <a:off x="9397873" y="926947"/>
                  <a:ext cx="1172824" cy="1610796"/>
                </a:xfrm>
                <a:custGeom>
                  <a:avLst/>
                  <a:gdLst>
                    <a:gd name="csX0" fmla="*/ 0 w 1172824"/>
                    <a:gd name="csY0" fmla="*/ 0 h 1408176"/>
                    <a:gd name="csX1" fmla="*/ 1172824 w 1172824"/>
                    <a:gd name="csY1" fmla="*/ 0 h 1408176"/>
                    <a:gd name="csX2" fmla="*/ 1172824 w 1172824"/>
                    <a:gd name="csY2" fmla="*/ 1408176 h 1408176"/>
                    <a:gd name="csX3" fmla="*/ 0 w 1172824"/>
                    <a:gd name="csY3" fmla="*/ 1408176 h 1408176"/>
                    <a:gd name="csX4" fmla="*/ 0 w 1172824"/>
                    <a:gd name="csY4" fmla="*/ 0 h 1408176"/>
                    <a:gd name="csX0" fmla="*/ 0 w 1172824"/>
                    <a:gd name="csY0" fmla="*/ 0 h 1455589"/>
                    <a:gd name="csX1" fmla="*/ 1172824 w 1172824"/>
                    <a:gd name="csY1" fmla="*/ 0 h 1455589"/>
                    <a:gd name="csX2" fmla="*/ 1172824 w 1172824"/>
                    <a:gd name="csY2" fmla="*/ 1408176 h 1455589"/>
                    <a:gd name="csX3" fmla="*/ 0 w 1172824"/>
                    <a:gd name="csY3" fmla="*/ 1408176 h 1455589"/>
                    <a:gd name="csX4" fmla="*/ 0 w 1172824"/>
                    <a:gd name="csY4" fmla="*/ 0 h 1455589"/>
                    <a:gd name="csX0" fmla="*/ 0 w 1172824"/>
                    <a:gd name="csY0" fmla="*/ 0 h 1488186"/>
                    <a:gd name="csX1" fmla="*/ 1172824 w 1172824"/>
                    <a:gd name="csY1" fmla="*/ 0 h 1488186"/>
                    <a:gd name="csX2" fmla="*/ 1172824 w 1172824"/>
                    <a:gd name="csY2" fmla="*/ 1408176 h 1488186"/>
                    <a:gd name="csX3" fmla="*/ 0 w 1172824"/>
                    <a:gd name="csY3" fmla="*/ 1408176 h 1488186"/>
                    <a:gd name="csX4" fmla="*/ 0 w 1172824"/>
                    <a:gd name="csY4" fmla="*/ 0 h 1488186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1172824" h="1488186">
                      <a:moveTo>
                        <a:pt x="0" y="0"/>
                      </a:moveTo>
                      <a:lnTo>
                        <a:pt x="1172824" y="0"/>
                      </a:lnTo>
                      <a:lnTo>
                        <a:pt x="1172824" y="1408176"/>
                      </a:lnTo>
                      <a:cubicBezTo>
                        <a:pt x="778073" y="1514856"/>
                        <a:pt x="387131" y="1514856"/>
                        <a:pt x="0" y="140817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accent6">
                    <a:lumMod val="40000"/>
                    <a:lumOff val="60000"/>
                    <a:alpha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0" name="Rectangle 1429">
                  <a:extLst>
                    <a:ext uri="{FF2B5EF4-FFF2-40B4-BE49-F238E27FC236}">
                      <a16:creationId xmlns:a16="http://schemas.microsoft.com/office/drawing/2014/main" id="{BFF3710E-FD84-B25E-A2EA-73F6CC84B2BC}"/>
                    </a:ext>
                  </a:extLst>
                </p:cNvPr>
                <p:cNvSpPr/>
                <p:nvPr/>
              </p:nvSpPr>
              <p:spPr>
                <a:xfrm>
                  <a:off x="10085265" y="933367"/>
                  <a:ext cx="227081" cy="1468771"/>
                </a:xfrm>
                <a:prstGeom prst="rect">
                  <a:avLst/>
                </a:prstGeom>
                <a:solidFill>
                  <a:schemeClr val="bg1">
                    <a:alpha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1" name="Rectangle 1430">
                  <a:extLst>
                    <a:ext uri="{FF2B5EF4-FFF2-40B4-BE49-F238E27FC236}">
                      <a16:creationId xmlns:a16="http://schemas.microsoft.com/office/drawing/2014/main" id="{038FF19B-0A5A-D1B6-0057-AB1FEBBCCDF4}"/>
                    </a:ext>
                  </a:extLst>
                </p:cNvPr>
                <p:cNvSpPr/>
                <p:nvPr/>
              </p:nvSpPr>
              <p:spPr>
                <a:xfrm>
                  <a:off x="9764013" y="933367"/>
                  <a:ext cx="135845" cy="1468771"/>
                </a:xfrm>
                <a:prstGeom prst="rect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2" name="Rectangle 1431">
                  <a:extLst>
                    <a:ext uri="{FF2B5EF4-FFF2-40B4-BE49-F238E27FC236}">
                      <a16:creationId xmlns:a16="http://schemas.microsoft.com/office/drawing/2014/main" id="{E2B28E14-BBA1-73CA-CA6C-1C82DFB9FAE2}"/>
                    </a:ext>
                  </a:extLst>
                </p:cNvPr>
                <p:cNvSpPr/>
                <p:nvPr/>
              </p:nvSpPr>
              <p:spPr>
                <a:xfrm>
                  <a:off x="9571951" y="935402"/>
                  <a:ext cx="64292" cy="1468771"/>
                </a:xfrm>
                <a:prstGeom prst="rect">
                  <a:avLst/>
                </a:prstGeom>
                <a:solidFill>
                  <a:schemeClr val="bg1">
                    <a:alpha val="7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3" name="Rectangle 1432">
                  <a:extLst>
                    <a:ext uri="{FF2B5EF4-FFF2-40B4-BE49-F238E27FC236}">
                      <a16:creationId xmlns:a16="http://schemas.microsoft.com/office/drawing/2014/main" id="{C7DDE8B3-B426-6D33-8CCB-89FB0AEADEF2}"/>
                    </a:ext>
                  </a:extLst>
                </p:cNvPr>
                <p:cNvSpPr/>
                <p:nvPr/>
              </p:nvSpPr>
              <p:spPr>
                <a:xfrm>
                  <a:off x="9489883" y="935402"/>
                  <a:ext cx="45719" cy="1468771"/>
                </a:xfrm>
                <a:prstGeom prst="rect">
                  <a:avLst/>
                </a:prstGeom>
                <a:solidFill>
                  <a:schemeClr val="bg1">
                    <a:alpha val="8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24" name="Group 1423">
                <a:extLst>
                  <a:ext uri="{FF2B5EF4-FFF2-40B4-BE49-F238E27FC236}">
                    <a16:creationId xmlns:a16="http://schemas.microsoft.com/office/drawing/2014/main" id="{88478ECD-52C4-0F6E-C18E-C7FC35451573}"/>
                  </a:ext>
                </a:extLst>
              </p:cNvPr>
              <p:cNvGrpSpPr/>
              <p:nvPr/>
            </p:nvGrpSpPr>
            <p:grpSpPr>
              <a:xfrm rot="14538645">
                <a:off x="6734824" y="1827496"/>
                <a:ext cx="386372" cy="736252"/>
                <a:chOff x="5231700" y="2188402"/>
                <a:chExt cx="386372" cy="736252"/>
              </a:xfrm>
            </p:grpSpPr>
            <p:sp>
              <p:nvSpPr>
                <p:cNvPr id="1426" name="Flowchart: Delay 1425">
                  <a:extLst>
                    <a:ext uri="{FF2B5EF4-FFF2-40B4-BE49-F238E27FC236}">
                      <a16:creationId xmlns:a16="http://schemas.microsoft.com/office/drawing/2014/main" id="{B30162F2-9C2E-AC77-58E3-A37F3146A8FD}"/>
                    </a:ext>
                  </a:extLst>
                </p:cNvPr>
                <p:cNvSpPr/>
                <p:nvPr/>
              </p:nvSpPr>
              <p:spPr>
                <a:xfrm rot="15432939">
                  <a:off x="5197272" y="2222830"/>
                  <a:ext cx="372746" cy="303890"/>
                </a:xfrm>
                <a:prstGeom prst="flowChartDelay">
                  <a:avLst/>
                </a:prstGeom>
                <a:solidFill>
                  <a:schemeClr val="accent5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7" name="Flowchart: Delay 1426">
                  <a:extLst>
                    <a:ext uri="{FF2B5EF4-FFF2-40B4-BE49-F238E27FC236}">
                      <a16:creationId xmlns:a16="http://schemas.microsoft.com/office/drawing/2014/main" id="{52B6B5FA-CF34-3333-6D8F-E35C5F61E46F}"/>
                    </a:ext>
                  </a:extLst>
                </p:cNvPr>
                <p:cNvSpPr/>
                <p:nvPr/>
              </p:nvSpPr>
              <p:spPr>
                <a:xfrm rot="4632939">
                  <a:off x="5279754" y="2586336"/>
                  <a:ext cx="372746" cy="303890"/>
                </a:xfrm>
                <a:prstGeom prst="flowChartDelay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8" name="Oval 1427">
                  <a:extLst>
                    <a:ext uri="{FF2B5EF4-FFF2-40B4-BE49-F238E27FC236}">
                      <a16:creationId xmlns:a16="http://schemas.microsoft.com/office/drawing/2014/main" id="{03020DC2-D182-ED5E-242D-B0EBB32F17CA}"/>
                    </a:ext>
                  </a:extLst>
                </p:cNvPr>
                <p:cNvSpPr/>
                <p:nvPr/>
              </p:nvSpPr>
              <p:spPr>
                <a:xfrm rot="15432939">
                  <a:off x="5088726" y="2567979"/>
                  <a:ext cx="482600" cy="45538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25" name="Rectangle 1424">
                <a:extLst>
                  <a:ext uri="{FF2B5EF4-FFF2-40B4-BE49-F238E27FC236}">
                    <a16:creationId xmlns:a16="http://schemas.microsoft.com/office/drawing/2014/main" id="{00E97317-652E-4CC2-9F53-4C6D5DDBF14D}"/>
                  </a:ext>
                </a:extLst>
              </p:cNvPr>
              <p:cNvSpPr/>
              <p:nvPr/>
            </p:nvSpPr>
            <p:spPr>
              <a:xfrm>
                <a:off x="6643857" y="1063267"/>
                <a:ext cx="1077325" cy="57084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b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1" name="Rectangle 1420">
              <a:extLst>
                <a:ext uri="{FF2B5EF4-FFF2-40B4-BE49-F238E27FC236}">
                  <a16:creationId xmlns:a16="http://schemas.microsoft.com/office/drawing/2014/main" id="{24975782-9A51-AA75-BBF4-D7AD751FB18A}"/>
                </a:ext>
              </a:extLst>
            </p:cNvPr>
            <p:cNvSpPr/>
            <p:nvPr/>
          </p:nvSpPr>
          <p:spPr>
            <a:xfrm>
              <a:off x="-102873" y="4586380"/>
              <a:ext cx="1496635" cy="31219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b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ntiviral</a:t>
              </a:r>
            </a:p>
            <a:p>
              <a:pPr algn="ctr"/>
              <a:r>
                <a:rPr lang="en-US" sz="450" b="1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Drug</a:t>
              </a:r>
            </a:p>
          </p:txBody>
        </p:sp>
      </p:grpSp>
      <p:sp>
        <p:nvSpPr>
          <p:cNvPr id="490" name="Rectangle: Rounded Corners 489">
            <a:extLst>
              <a:ext uri="{FF2B5EF4-FFF2-40B4-BE49-F238E27FC236}">
                <a16:creationId xmlns:a16="http://schemas.microsoft.com/office/drawing/2014/main" id="{C118965D-7B9F-78A9-471B-F2F5D0210F60}"/>
              </a:ext>
            </a:extLst>
          </p:cNvPr>
          <p:cNvSpPr/>
          <p:nvPr/>
        </p:nvSpPr>
        <p:spPr>
          <a:xfrm>
            <a:off x="2550582" y="1613530"/>
            <a:ext cx="548640" cy="231438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CSB</a:t>
            </a:r>
          </a:p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PDB</a:t>
            </a:r>
          </a:p>
        </p:txBody>
      </p:sp>
      <p:sp>
        <p:nvSpPr>
          <p:cNvPr id="168" name="Oval 167">
            <a:extLst>
              <a:ext uri="{FF2B5EF4-FFF2-40B4-BE49-F238E27FC236}">
                <a16:creationId xmlns:a16="http://schemas.microsoft.com/office/drawing/2014/main" id="{613D0D76-5CBD-6DE8-2A9C-9FDFC9F7A891}"/>
              </a:ext>
            </a:extLst>
          </p:cNvPr>
          <p:cNvSpPr/>
          <p:nvPr/>
        </p:nvSpPr>
        <p:spPr>
          <a:xfrm rot="2691445">
            <a:off x="2297314" y="1463653"/>
            <a:ext cx="301809" cy="156157"/>
          </a:xfrm>
          <a:prstGeom prst="ellipse">
            <a:avLst/>
          </a:prstGeom>
          <a:noFill/>
          <a:ln w="3175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grpSp>
        <p:nvGrpSpPr>
          <p:cNvPr id="3207" name="Group 3206">
            <a:extLst>
              <a:ext uri="{FF2B5EF4-FFF2-40B4-BE49-F238E27FC236}">
                <a16:creationId xmlns:a16="http://schemas.microsoft.com/office/drawing/2014/main" id="{F2421DAB-B6AA-3BC1-FA96-195EE8517F1F}"/>
              </a:ext>
            </a:extLst>
          </p:cNvPr>
          <p:cNvGrpSpPr/>
          <p:nvPr/>
        </p:nvGrpSpPr>
        <p:grpSpPr>
          <a:xfrm>
            <a:off x="-42814" y="227522"/>
            <a:ext cx="2796095" cy="1626598"/>
            <a:chOff x="-42814" y="227522"/>
            <a:chExt cx="2796095" cy="1626598"/>
          </a:xfrm>
        </p:grpSpPr>
        <p:grpSp>
          <p:nvGrpSpPr>
            <p:cNvPr id="3208" name="Group 3207">
              <a:extLst>
                <a:ext uri="{FF2B5EF4-FFF2-40B4-BE49-F238E27FC236}">
                  <a16:creationId xmlns:a16="http://schemas.microsoft.com/office/drawing/2014/main" id="{60814FA2-F337-FBAA-0C07-40FE114385DE}"/>
                </a:ext>
              </a:extLst>
            </p:cNvPr>
            <p:cNvGrpSpPr/>
            <p:nvPr/>
          </p:nvGrpSpPr>
          <p:grpSpPr>
            <a:xfrm>
              <a:off x="1126448" y="227522"/>
              <a:ext cx="1626833" cy="1626598"/>
              <a:chOff x="4389120" y="2560320"/>
              <a:chExt cx="2366171" cy="2365829"/>
            </a:xfrm>
          </p:grpSpPr>
          <p:grpSp>
            <p:nvGrpSpPr>
              <p:cNvPr id="3233" name="Group 3232">
                <a:extLst>
                  <a:ext uri="{FF2B5EF4-FFF2-40B4-BE49-F238E27FC236}">
                    <a16:creationId xmlns:a16="http://schemas.microsoft.com/office/drawing/2014/main" id="{590F7DA8-F26F-438E-FEAD-089ABDC1FABA}"/>
                  </a:ext>
                </a:extLst>
              </p:cNvPr>
              <p:cNvGrpSpPr/>
              <p:nvPr/>
            </p:nvGrpSpPr>
            <p:grpSpPr>
              <a:xfrm>
                <a:off x="5478494" y="4391488"/>
                <a:ext cx="183480" cy="534661"/>
                <a:chOff x="5847022" y="5624570"/>
                <a:chExt cx="417724" cy="1217248"/>
              </a:xfrm>
            </p:grpSpPr>
            <p:grpSp>
              <p:nvGrpSpPr>
                <p:cNvPr id="3842" name="Group 3841">
                  <a:extLst>
                    <a:ext uri="{FF2B5EF4-FFF2-40B4-BE49-F238E27FC236}">
                      <a16:creationId xmlns:a16="http://schemas.microsoft.com/office/drawing/2014/main" id="{B6FD0589-95EF-12B3-DD36-4C7E94033FBD}"/>
                    </a:ext>
                  </a:extLst>
                </p:cNvPr>
                <p:cNvGrpSpPr/>
                <p:nvPr/>
              </p:nvGrpSpPr>
              <p:grpSpPr>
                <a:xfrm rot="10800000">
                  <a:off x="5847022" y="5624570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44" name="Rectangle: Rounded Corners 3843">
                    <a:extLst>
                      <a:ext uri="{FF2B5EF4-FFF2-40B4-BE49-F238E27FC236}">
                        <a16:creationId xmlns:a16="http://schemas.microsoft.com/office/drawing/2014/main" id="{03818507-CE1C-944B-0F38-31612B51A15B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5" name="Rectangle: Rounded Corners 3844">
                    <a:extLst>
                      <a:ext uri="{FF2B5EF4-FFF2-40B4-BE49-F238E27FC236}">
                        <a16:creationId xmlns:a16="http://schemas.microsoft.com/office/drawing/2014/main" id="{61F162FF-AF7C-23FB-B024-01D4B05C6F73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6" name="Rectangle: Rounded Corners 3845">
                    <a:extLst>
                      <a:ext uri="{FF2B5EF4-FFF2-40B4-BE49-F238E27FC236}">
                        <a16:creationId xmlns:a16="http://schemas.microsoft.com/office/drawing/2014/main" id="{51C30FAC-E500-BCD3-219F-A2719C13B3BF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7" name="Rectangle: Rounded Corners 3846">
                    <a:extLst>
                      <a:ext uri="{FF2B5EF4-FFF2-40B4-BE49-F238E27FC236}">
                        <a16:creationId xmlns:a16="http://schemas.microsoft.com/office/drawing/2014/main" id="{0AF3EF59-C60D-0C25-F288-8D518C2D5CB8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43" name="Rectangle 3842">
                  <a:extLst>
                    <a:ext uri="{FF2B5EF4-FFF2-40B4-BE49-F238E27FC236}">
                      <a16:creationId xmlns:a16="http://schemas.microsoft.com/office/drawing/2014/main" id="{01CB84AC-05DB-DC04-9805-424E0D014D13}"/>
                    </a:ext>
                  </a:extLst>
                </p:cNvPr>
                <p:cNvSpPr/>
                <p:nvPr/>
              </p:nvSpPr>
              <p:spPr>
                <a:xfrm>
                  <a:off x="6085240" y="6369813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4" name="Group 3233">
                <a:extLst>
                  <a:ext uri="{FF2B5EF4-FFF2-40B4-BE49-F238E27FC236}">
                    <a16:creationId xmlns:a16="http://schemas.microsoft.com/office/drawing/2014/main" id="{D9AC5F7D-4737-5F3A-A465-88813B208BC5}"/>
                  </a:ext>
                </a:extLst>
              </p:cNvPr>
              <p:cNvGrpSpPr/>
              <p:nvPr/>
            </p:nvGrpSpPr>
            <p:grpSpPr>
              <a:xfrm>
                <a:off x="5959715" y="4293213"/>
                <a:ext cx="534661" cy="216938"/>
                <a:chOff x="6923588" y="5302058"/>
                <a:chExt cx="1217248" cy="493897"/>
              </a:xfrm>
            </p:grpSpPr>
            <p:grpSp>
              <p:nvGrpSpPr>
                <p:cNvPr id="3836" name="Group 3835">
                  <a:extLst>
                    <a:ext uri="{FF2B5EF4-FFF2-40B4-BE49-F238E27FC236}">
                      <a16:creationId xmlns:a16="http://schemas.microsoft.com/office/drawing/2014/main" id="{7053ED46-C5E1-00B3-BF1B-2101E57C3980}"/>
                    </a:ext>
                  </a:extLst>
                </p:cNvPr>
                <p:cNvGrpSpPr/>
                <p:nvPr/>
              </p:nvGrpSpPr>
              <p:grpSpPr>
                <a:xfrm rot="8041546">
                  <a:off x="7323350" y="4902296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38" name="Rectangle: Rounded Corners 3837">
                    <a:extLst>
                      <a:ext uri="{FF2B5EF4-FFF2-40B4-BE49-F238E27FC236}">
                        <a16:creationId xmlns:a16="http://schemas.microsoft.com/office/drawing/2014/main" id="{D844E271-4D20-62B5-1922-06AA1DF76C1A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9" name="Rectangle: Rounded Corners 3838">
                    <a:extLst>
                      <a:ext uri="{FF2B5EF4-FFF2-40B4-BE49-F238E27FC236}">
                        <a16:creationId xmlns:a16="http://schemas.microsoft.com/office/drawing/2014/main" id="{756328E2-248B-31F7-7C7A-93D7FCD614A5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0" name="Rectangle: Rounded Corners 3839">
                    <a:extLst>
                      <a:ext uri="{FF2B5EF4-FFF2-40B4-BE49-F238E27FC236}">
                        <a16:creationId xmlns:a16="http://schemas.microsoft.com/office/drawing/2014/main" id="{E482D5DE-0BDE-257C-2620-03BCDF40DF6B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41" name="Rectangle: Rounded Corners 3840">
                    <a:extLst>
                      <a:ext uri="{FF2B5EF4-FFF2-40B4-BE49-F238E27FC236}">
                        <a16:creationId xmlns:a16="http://schemas.microsoft.com/office/drawing/2014/main" id="{986255EB-1CEB-7183-D5F7-803DA0B3BD08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37" name="Rectangle 3836">
                  <a:extLst>
                    <a:ext uri="{FF2B5EF4-FFF2-40B4-BE49-F238E27FC236}">
                      <a16:creationId xmlns:a16="http://schemas.microsoft.com/office/drawing/2014/main" id="{078C151D-E90D-F80C-A35E-8B2836D360FE}"/>
                    </a:ext>
                  </a:extLst>
                </p:cNvPr>
                <p:cNvSpPr/>
                <p:nvPr/>
              </p:nvSpPr>
              <p:spPr>
                <a:xfrm rot="18845021">
                  <a:off x="7736664" y="5545329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5" name="Group 3234">
                <a:extLst>
                  <a:ext uri="{FF2B5EF4-FFF2-40B4-BE49-F238E27FC236}">
                    <a16:creationId xmlns:a16="http://schemas.microsoft.com/office/drawing/2014/main" id="{C05F716E-1FAF-CBA3-5517-83E53401AAB4}"/>
                  </a:ext>
                </a:extLst>
              </p:cNvPr>
              <p:cNvGrpSpPr/>
              <p:nvPr/>
            </p:nvGrpSpPr>
            <p:grpSpPr>
              <a:xfrm>
                <a:off x="6220630" y="3649788"/>
                <a:ext cx="534661" cy="183480"/>
                <a:chOff x="7574788" y="3909430"/>
                <a:chExt cx="1217248" cy="417724"/>
              </a:xfrm>
            </p:grpSpPr>
            <p:grpSp>
              <p:nvGrpSpPr>
                <p:cNvPr id="3830" name="Group 3829">
                  <a:extLst>
                    <a:ext uri="{FF2B5EF4-FFF2-40B4-BE49-F238E27FC236}">
                      <a16:creationId xmlns:a16="http://schemas.microsoft.com/office/drawing/2014/main" id="{0D511408-3F1C-E104-1F30-3A0488D7803A}"/>
                    </a:ext>
                  </a:extLst>
                </p:cNvPr>
                <p:cNvGrpSpPr/>
                <p:nvPr/>
              </p:nvGrpSpPr>
              <p:grpSpPr>
                <a:xfrm rot="5400000">
                  <a:off x="7974550" y="3509668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32" name="Rectangle: Rounded Corners 3831">
                    <a:extLst>
                      <a:ext uri="{FF2B5EF4-FFF2-40B4-BE49-F238E27FC236}">
                        <a16:creationId xmlns:a16="http://schemas.microsoft.com/office/drawing/2014/main" id="{9E7EF965-5F7C-24EC-3F31-CAA1DF1DDC73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3" name="Rectangle: Rounded Corners 3832">
                    <a:extLst>
                      <a:ext uri="{FF2B5EF4-FFF2-40B4-BE49-F238E27FC236}">
                        <a16:creationId xmlns:a16="http://schemas.microsoft.com/office/drawing/2014/main" id="{739E9EE5-6531-706F-7A0B-BAACB674BB88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4" name="Rectangle: Rounded Corners 3833">
                    <a:extLst>
                      <a:ext uri="{FF2B5EF4-FFF2-40B4-BE49-F238E27FC236}">
                        <a16:creationId xmlns:a16="http://schemas.microsoft.com/office/drawing/2014/main" id="{48BFDFFE-73C6-AB5E-A349-248D7F908BA6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35" name="Rectangle: Rounded Corners 3834">
                    <a:extLst>
                      <a:ext uri="{FF2B5EF4-FFF2-40B4-BE49-F238E27FC236}">
                        <a16:creationId xmlns:a16="http://schemas.microsoft.com/office/drawing/2014/main" id="{97462380-EE41-582F-0E01-4D6E481F1FD0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31" name="Rectangle 3830">
                  <a:extLst>
                    <a:ext uri="{FF2B5EF4-FFF2-40B4-BE49-F238E27FC236}">
                      <a16:creationId xmlns:a16="http://schemas.microsoft.com/office/drawing/2014/main" id="{79D185EA-D619-6084-12EA-B9DB115D29DB}"/>
                    </a:ext>
                  </a:extLst>
                </p:cNvPr>
                <p:cNvSpPr/>
                <p:nvPr/>
              </p:nvSpPr>
              <p:spPr>
                <a:xfrm rot="5400000">
                  <a:off x="8516878" y="3847232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6" name="Group 3235">
                <a:extLst>
                  <a:ext uri="{FF2B5EF4-FFF2-40B4-BE49-F238E27FC236}">
                    <a16:creationId xmlns:a16="http://schemas.microsoft.com/office/drawing/2014/main" id="{C7212E0D-9B4D-1DF2-A6B7-F4CDC9E1F38D}"/>
                  </a:ext>
                </a:extLst>
              </p:cNvPr>
              <p:cNvGrpSpPr/>
              <p:nvPr/>
            </p:nvGrpSpPr>
            <p:grpSpPr>
              <a:xfrm>
                <a:off x="4665392" y="2988968"/>
                <a:ext cx="534661" cy="194771"/>
                <a:chOff x="4004238" y="2445354"/>
                <a:chExt cx="1217248" cy="443429"/>
              </a:xfrm>
            </p:grpSpPr>
            <p:grpSp>
              <p:nvGrpSpPr>
                <p:cNvPr id="3824" name="Group 3823">
                  <a:extLst>
                    <a:ext uri="{FF2B5EF4-FFF2-40B4-BE49-F238E27FC236}">
                      <a16:creationId xmlns:a16="http://schemas.microsoft.com/office/drawing/2014/main" id="{89D384D4-6AEE-6E91-9672-C3CE9D21ED30}"/>
                    </a:ext>
                  </a:extLst>
                </p:cNvPr>
                <p:cNvGrpSpPr/>
                <p:nvPr/>
              </p:nvGrpSpPr>
              <p:grpSpPr>
                <a:xfrm rot="18880432">
                  <a:off x="4404000" y="2071297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26" name="Rectangle: Rounded Corners 3825">
                    <a:extLst>
                      <a:ext uri="{FF2B5EF4-FFF2-40B4-BE49-F238E27FC236}">
                        <a16:creationId xmlns:a16="http://schemas.microsoft.com/office/drawing/2014/main" id="{399EFCC9-0AD4-F65A-CCDF-07202B344870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7" name="Rectangle: Rounded Corners 3826">
                    <a:extLst>
                      <a:ext uri="{FF2B5EF4-FFF2-40B4-BE49-F238E27FC236}">
                        <a16:creationId xmlns:a16="http://schemas.microsoft.com/office/drawing/2014/main" id="{52B5EC59-FA76-3492-4033-E5CCAE076E6A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8" name="Rectangle: Rounded Corners 3827">
                    <a:extLst>
                      <a:ext uri="{FF2B5EF4-FFF2-40B4-BE49-F238E27FC236}">
                        <a16:creationId xmlns:a16="http://schemas.microsoft.com/office/drawing/2014/main" id="{EE276321-DE5B-F0EA-76C7-ACC63E436C36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9" name="Rectangle: Rounded Corners 3828">
                    <a:extLst>
                      <a:ext uri="{FF2B5EF4-FFF2-40B4-BE49-F238E27FC236}">
                        <a16:creationId xmlns:a16="http://schemas.microsoft.com/office/drawing/2014/main" id="{7728015C-2AFE-5E0D-1DC7-B8721DD38DCF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25" name="Rectangle 3824">
                  <a:extLst>
                    <a:ext uri="{FF2B5EF4-FFF2-40B4-BE49-F238E27FC236}">
                      <a16:creationId xmlns:a16="http://schemas.microsoft.com/office/drawing/2014/main" id="{4765D787-22C9-E9EB-E9E1-1D63C5EFEDB8}"/>
                    </a:ext>
                  </a:extLst>
                </p:cNvPr>
                <p:cNvSpPr/>
                <p:nvPr/>
              </p:nvSpPr>
              <p:spPr>
                <a:xfrm rot="18854215">
                  <a:off x="4327443" y="2240447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7" name="Group 3236">
                <a:extLst>
                  <a:ext uri="{FF2B5EF4-FFF2-40B4-BE49-F238E27FC236}">
                    <a16:creationId xmlns:a16="http://schemas.microsoft.com/office/drawing/2014/main" id="{5F63B56B-80FA-EBAC-BE38-E328F2074FDB}"/>
                  </a:ext>
                </a:extLst>
              </p:cNvPr>
              <p:cNvGrpSpPr/>
              <p:nvPr/>
            </p:nvGrpSpPr>
            <p:grpSpPr>
              <a:xfrm>
                <a:off x="4389120" y="3643432"/>
                <a:ext cx="534661" cy="183480"/>
                <a:chOff x="3380002" y="3914460"/>
                <a:chExt cx="1217248" cy="417724"/>
              </a:xfrm>
            </p:grpSpPr>
            <p:grpSp>
              <p:nvGrpSpPr>
                <p:cNvPr id="3818" name="Group 3817">
                  <a:extLst>
                    <a:ext uri="{FF2B5EF4-FFF2-40B4-BE49-F238E27FC236}">
                      <a16:creationId xmlns:a16="http://schemas.microsoft.com/office/drawing/2014/main" id="{07991B80-CB53-135E-883C-351835EFD417}"/>
                    </a:ext>
                  </a:extLst>
                </p:cNvPr>
                <p:cNvGrpSpPr/>
                <p:nvPr/>
              </p:nvGrpSpPr>
              <p:grpSpPr>
                <a:xfrm rot="16200000">
                  <a:off x="3779764" y="3514698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20" name="Rectangle: Rounded Corners 3819">
                    <a:extLst>
                      <a:ext uri="{FF2B5EF4-FFF2-40B4-BE49-F238E27FC236}">
                        <a16:creationId xmlns:a16="http://schemas.microsoft.com/office/drawing/2014/main" id="{9424EF47-1175-0CA9-8F37-4B5520C08967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1" name="Rectangle: Rounded Corners 3820">
                    <a:extLst>
                      <a:ext uri="{FF2B5EF4-FFF2-40B4-BE49-F238E27FC236}">
                        <a16:creationId xmlns:a16="http://schemas.microsoft.com/office/drawing/2014/main" id="{41B75B90-6F49-FA78-A6B9-1E556C420618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2" name="Rectangle: Rounded Corners 3821">
                    <a:extLst>
                      <a:ext uri="{FF2B5EF4-FFF2-40B4-BE49-F238E27FC236}">
                        <a16:creationId xmlns:a16="http://schemas.microsoft.com/office/drawing/2014/main" id="{B3840992-BB57-D74E-4975-099B24B3B86A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23" name="Rectangle: Rounded Corners 3822">
                    <a:extLst>
                      <a:ext uri="{FF2B5EF4-FFF2-40B4-BE49-F238E27FC236}">
                        <a16:creationId xmlns:a16="http://schemas.microsoft.com/office/drawing/2014/main" id="{53BF3FBC-F59A-1406-3AD4-1768716FB93E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19" name="Rectangle 3818">
                  <a:extLst>
                    <a:ext uri="{FF2B5EF4-FFF2-40B4-BE49-F238E27FC236}">
                      <a16:creationId xmlns:a16="http://schemas.microsoft.com/office/drawing/2014/main" id="{751B342F-1147-8DC0-702D-C3D2D1BA6368}"/>
                    </a:ext>
                  </a:extLst>
                </p:cNvPr>
                <p:cNvSpPr/>
                <p:nvPr/>
              </p:nvSpPr>
              <p:spPr>
                <a:xfrm rot="5400000">
                  <a:off x="3625552" y="3927580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8" name="Group 3237">
                <a:extLst>
                  <a:ext uri="{FF2B5EF4-FFF2-40B4-BE49-F238E27FC236}">
                    <a16:creationId xmlns:a16="http://schemas.microsoft.com/office/drawing/2014/main" id="{AF944EE8-3E1A-A00F-056B-904BF9D78FDB}"/>
                  </a:ext>
                </a:extLst>
              </p:cNvPr>
              <p:cNvGrpSpPr/>
              <p:nvPr/>
            </p:nvGrpSpPr>
            <p:grpSpPr>
              <a:xfrm rot="21326329">
                <a:off x="4645315" y="4280132"/>
                <a:ext cx="534661" cy="215286"/>
                <a:chOff x="3934437" y="5334081"/>
                <a:chExt cx="1217248" cy="490136"/>
              </a:xfrm>
            </p:grpSpPr>
            <p:grpSp>
              <p:nvGrpSpPr>
                <p:cNvPr id="3812" name="Group 3811">
                  <a:extLst>
                    <a:ext uri="{FF2B5EF4-FFF2-40B4-BE49-F238E27FC236}">
                      <a16:creationId xmlns:a16="http://schemas.microsoft.com/office/drawing/2014/main" id="{FEF03E52-CC32-01F1-436F-432D93EC06D7}"/>
                    </a:ext>
                  </a:extLst>
                </p:cNvPr>
                <p:cNvGrpSpPr/>
                <p:nvPr/>
              </p:nvGrpSpPr>
              <p:grpSpPr>
                <a:xfrm rot="13795952">
                  <a:off x="4334199" y="4934319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814" name="Rectangle: Rounded Corners 3813">
                    <a:extLst>
                      <a:ext uri="{FF2B5EF4-FFF2-40B4-BE49-F238E27FC236}">
                        <a16:creationId xmlns:a16="http://schemas.microsoft.com/office/drawing/2014/main" id="{40662CE5-84C9-145B-2600-7E2F2E0B02AD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15" name="Rectangle: Rounded Corners 3814">
                    <a:extLst>
                      <a:ext uri="{FF2B5EF4-FFF2-40B4-BE49-F238E27FC236}">
                        <a16:creationId xmlns:a16="http://schemas.microsoft.com/office/drawing/2014/main" id="{A8068B13-3EE9-2587-CA77-92EB7421124B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16" name="Rectangle: Rounded Corners 3815">
                    <a:extLst>
                      <a:ext uri="{FF2B5EF4-FFF2-40B4-BE49-F238E27FC236}">
                        <a16:creationId xmlns:a16="http://schemas.microsoft.com/office/drawing/2014/main" id="{6FED8404-34FB-82B0-92EF-FEE7D2756249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17" name="Rectangle: Rounded Corners 3816">
                    <a:extLst>
                      <a:ext uri="{FF2B5EF4-FFF2-40B4-BE49-F238E27FC236}">
                        <a16:creationId xmlns:a16="http://schemas.microsoft.com/office/drawing/2014/main" id="{58979CDE-ABAB-F0B3-8FCD-E2C4DBF0B3B3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813" name="Rectangle 3812">
                  <a:extLst>
                    <a:ext uri="{FF2B5EF4-FFF2-40B4-BE49-F238E27FC236}">
                      <a16:creationId xmlns:a16="http://schemas.microsoft.com/office/drawing/2014/main" id="{5103350D-566F-F064-F595-9724C0BBE0F2}"/>
                    </a:ext>
                  </a:extLst>
                </p:cNvPr>
                <p:cNvSpPr/>
                <p:nvPr/>
              </p:nvSpPr>
              <p:spPr>
                <a:xfrm rot="2982674">
                  <a:off x="4280587" y="5573591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39" name="Group 3238">
                <a:extLst>
                  <a:ext uri="{FF2B5EF4-FFF2-40B4-BE49-F238E27FC236}">
                    <a16:creationId xmlns:a16="http://schemas.microsoft.com/office/drawing/2014/main" id="{2CB7B4D2-343D-40BD-84E7-24F767215239}"/>
                  </a:ext>
                </a:extLst>
              </p:cNvPr>
              <p:cNvGrpSpPr/>
              <p:nvPr/>
            </p:nvGrpSpPr>
            <p:grpSpPr>
              <a:xfrm rot="5400000">
                <a:off x="6237072" y="3624271"/>
                <a:ext cx="207255" cy="232423"/>
                <a:chOff x="2591387" y="425153"/>
                <a:chExt cx="471853" cy="529151"/>
              </a:xfrm>
            </p:grpSpPr>
            <p:sp>
              <p:nvSpPr>
                <p:cNvPr id="3808" name="Flowchart: Delay 3807">
                  <a:extLst>
                    <a:ext uri="{FF2B5EF4-FFF2-40B4-BE49-F238E27FC236}">
                      <a16:creationId xmlns:a16="http://schemas.microsoft.com/office/drawing/2014/main" id="{1CD73F8A-31C3-32B0-91B3-4E2B1C545EF4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9" name="Flowchart: Delay 3808">
                  <a:extLst>
                    <a:ext uri="{FF2B5EF4-FFF2-40B4-BE49-F238E27FC236}">
                      <a16:creationId xmlns:a16="http://schemas.microsoft.com/office/drawing/2014/main" id="{3CB9ED58-C041-82D7-C335-F68026DC0361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10" name="Oval 3809">
                  <a:extLst>
                    <a:ext uri="{FF2B5EF4-FFF2-40B4-BE49-F238E27FC236}">
                      <a16:creationId xmlns:a16="http://schemas.microsoft.com/office/drawing/2014/main" id="{CE2CC411-C963-87D0-C31C-FC752F4F58B1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11" name="Oval 3810">
                  <a:extLst>
                    <a:ext uri="{FF2B5EF4-FFF2-40B4-BE49-F238E27FC236}">
                      <a16:creationId xmlns:a16="http://schemas.microsoft.com/office/drawing/2014/main" id="{E9823B0F-1B45-108B-E28C-7F50030AB60E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0" name="Group 3239">
                <a:extLst>
                  <a:ext uri="{FF2B5EF4-FFF2-40B4-BE49-F238E27FC236}">
                    <a16:creationId xmlns:a16="http://schemas.microsoft.com/office/drawing/2014/main" id="{931F4CE1-5ED5-E1F8-4CB1-D3CF4AE71CD0}"/>
                  </a:ext>
                </a:extLst>
              </p:cNvPr>
              <p:cNvGrpSpPr/>
              <p:nvPr/>
            </p:nvGrpSpPr>
            <p:grpSpPr>
              <a:xfrm rot="18929928">
                <a:off x="4937384" y="3082982"/>
                <a:ext cx="207255" cy="232423"/>
                <a:chOff x="2591387" y="425153"/>
                <a:chExt cx="471853" cy="529151"/>
              </a:xfrm>
            </p:grpSpPr>
            <p:sp>
              <p:nvSpPr>
                <p:cNvPr id="3804" name="Flowchart: Delay 3803">
                  <a:extLst>
                    <a:ext uri="{FF2B5EF4-FFF2-40B4-BE49-F238E27FC236}">
                      <a16:creationId xmlns:a16="http://schemas.microsoft.com/office/drawing/2014/main" id="{0A02778E-15B3-89BF-B4F0-039FBF8314F3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5" name="Flowchart: Delay 3804">
                  <a:extLst>
                    <a:ext uri="{FF2B5EF4-FFF2-40B4-BE49-F238E27FC236}">
                      <a16:creationId xmlns:a16="http://schemas.microsoft.com/office/drawing/2014/main" id="{F3A471CB-CBDE-861C-5C44-C8AA9F179750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6" name="Oval 3805">
                  <a:extLst>
                    <a:ext uri="{FF2B5EF4-FFF2-40B4-BE49-F238E27FC236}">
                      <a16:creationId xmlns:a16="http://schemas.microsoft.com/office/drawing/2014/main" id="{D56AA327-5CB8-676B-5A53-80FB39584F3B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7" name="Oval 3806">
                  <a:extLst>
                    <a:ext uri="{FF2B5EF4-FFF2-40B4-BE49-F238E27FC236}">
                      <a16:creationId xmlns:a16="http://schemas.microsoft.com/office/drawing/2014/main" id="{6953949A-9E51-B453-060E-55BB9ABA853C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1" name="Group 3240">
                <a:extLst>
                  <a:ext uri="{FF2B5EF4-FFF2-40B4-BE49-F238E27FC236}">
                    <a16:creationId xmlns:a16="http://schemas.microsoft.com/office/drawing/2014/main" id="{0A541314-A8A4-3183-D437-6C0BC8B00971}"/>
                  </a:ext>
                </a:extLst>
              </p:cNvPr>
              <p:cNvGrpSpPr/>
              <p:nvPr/>
            </p:nvGrpSpPr>
            <p:grpSpPr>
              <a:xfrm rot="16200000">
                <a:off x="4710286" y="3619679"/>
                <a:ext cx="207255" cy="232423"/>
                <a:chOff x="2591387" y="425153"/>
                <a:chExt cx="471853" cy="529151"/>
              </a:xfrm>
            </p:grpSpPr>
            <p:sp>
              <p:nvSpPr>
                <p:cNvPr id="3800" name="Flowchart: Delay 3799">
                  <a:extLst>
                    <a:ext uri="{FF2B5EF4-FFF2-40B4-BE49-F238E27FC236}">
                      <a16:creationId xmlns:a16="http://schemas.microsoft.com/office/drawing/2014/main" id="{5C21D78B-1E8E-075F-B79C-EB0720F2D13F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1" name="Flowchart: Delay 3800">
                  <a:extLst>
                    <a:ext uri="{FF2B5EF4-FFF2-40B4-BE49-F238E27FC236}">
                      <a16:creationId xmlns:a16="http://schemas.microsoft.com/office/drawing/2014/main" id="{62966034-2061-7BE5-83C8-B4D9BC50B814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2" name="Oval 3801">
                  <a:extLst>
                    <a:ext uri="{FF2B5EF4-FFF2-40B4-BE49-F238E27FC236}">
                      <a16:creationId xmlns:a16="http://schemas.microsoft.com/office/drawing/2014/main" id="{0E6BED80-B61B-25EE-D41D-113E1F2C3009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03" name="Oval 3802">
                  <a:extLst>
                    <a:ext uri="{FF2B5EF4-FFF2-40B4-BE49-F238E27FC236}">
                      <a16:creationId xmlns:a16="http://schemas.microsoft.com/office/drawing/2014/main" id="{35D0DBD7-6CB8-E302-3DBF-72BF9D11E027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2" name="Group 3241">
                <a:extLst>
                  <a:ext uri="{FF2B5EF4-FFF2-40B4-BE49-F238E27FC236}">
                    <a16:creationId xmlns:a16="http://schemas.microsoft.com/office/drawing/2014/main" id="{F657A367-CAAA-1447-5A78-5394D3D8EA58}"/>
                  </a:ext>
                </a:extLst>
              </p:cNvPr>
              <p:cNvGrpSpPr/>
              <p:nvPr/>
            </p:nvGrpSpPr>
            <p:grpSpPr>
              <a:xfrm rot="2765206">
                <a:off x="4918998" y="4147293"/>
                <a:ext cx="207255" cy="232423"/>
                <a:chOff x="2591387" y="425153"/>
                <a:chExt cx="471853" cy="529151"/>
              </a:xfrm>
            </p:grpSpPr>
            <p:sp>
              <p:nvSpPr>
                <p:cNvPr id="3796" name="Flowchart: Delay 3795">
                  <a:extLst>
                    <a:ext uri="{FF2B5EF4-FFF2-40B4-BE49-F238E27FC236}">
                      <a16:creationId xmlns:a16="http://schemas.microsoft.com/office/drawing/2014/main" id="{3BC4382D-BCF8-00FD-FDB1-A77FFDB6CACA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7" name="Flowchart: Delay 3796">
                  <a:extLst>
                    <a:ext uri="{FF2B5EF4-FFF2-40B4-BE49-F238E27FC236}">
                      <a16:creationId xmlns:a16="http://schemas.microsoft.com/office/drawing/2014/main" id="{14377D6D-DE4E-B8D2-9D1D-C0579192487B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8" name="Oval 3797">
                  <a:extLst>
                    <a:ext uri="{FF2B5EF4-FFF2-40B4-BE49-F238E27FC236}">
                      <a16:creationId xmlns:a16="http://schemas.microsoft.com/office/drawing/2014/main" id="{EEA3F284-FE53-7146-E2FF-825A1F2F2D91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9" name="Oval 3798">
                  <a:extLst>
                    <a:ext uri="{FF2B5EF4-FFF2-40B4-BE49-F238E27FC236}">
                      <a16:creationId xmlns:a16="http://schemas.microsoft.com/office/drawing/2014/main" id="{35D01DD8-E0CC-7317-41BD-3EA047B668E5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3" name="Group 3242">
                <a:extLst>
                  <a:ext uri="{FF2B5EF4-FFF2-40B4-BE49-F238E27FC236}">
                    <a16:creationId xmlns:a16="http://schemas.microsoft.com/office/drawing/2014/main" id="{19C12D69-78C1-C7FB-4DD8-BB290D9F1263}"/>
                  </a:ext>
                </a:extLst>
              </p:cNvPr>
              <p:cNvGrpSpPr/>
              <p:nvPr/>
            </p:nvGrpSpPr>
            <p:grpSpPr>
              <a:xfrm rot="18857834">
                <a:off x="6011635" y="4164373"/>
                <a:ext cx="207255" cy="232423"/>
                <a:chOff x="2591387" y="425153"/>
                <a:chExt cx="471853" cy="529151"/>
              </a:xfrm>
            </p:grpSpPr>
            <p:sp>
              <p:nvSpPr>
                <p:cNvPr id="3792" name="Flowchart: Delay 3791">
                  <a:extLst>
                    <a:ext uri="{FF2B5EF4-FFF2-40B4-BE49-F238E27FC236}">
                      <a16:creationId xmlns:a16="http://schemas.microsoft.com/office/drawing/2014/main" id="{E7570F98-041D-8B3F-F89D-984C8E79F6B4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3" name="Flowchart: Delay 3792">
                  <a:extLst>
                    <a:ext uri="{FF2B5EF4-FFF2-40B4-BE49-F238E27FC236}">
                      <a16:creationId xmlns:a16="http://schemas.microsoft.com/office/drawing/2014/main" id="{3DC08C00-DDE8-69D4-843A-692160E54748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4" name="Oval 3793">
                  <a:extLst>
                    <a:ext uri="{FF2B5EF4-FFF2-40B4-BE49-F238E27FC236}">
                      <a16:creationId xmlns:a16="http://schemas.microsoft.com/office/drawing/2014/main" id="{53F03233-9F6E-7B63-C00E-818F98BF34DE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5" name="Oval 3794">
                  <a:extLst>
                    <a:ext uri="{FF2B5EF4-FFF2-40B4-BE49-F238E27FC236}">
                      <a16:creationId xmlns:a16="http://schemas.microsoft.com/office/drawing/2014/main" id="{6B745976-2F40-5740-0325-7627BF797FFC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4" name="Group 3243">
                <a:extLst>
                  <a:ext uri="{FF2B5EF4-FFF2-40B4-BE49-F238E27FC236}">
                    <a16:creationId xmlns:a16="http://schemas.microsoft.com/office/drawing/2014/main" id="{B26614B5-8034-7B4B-8676-E4C702855C2B}"/>
                  </a:ext>
                </a:extLst>
              </p:cNvPr>
              <p:cNvGrpSpPr/>
              <p:nvPr/>
            </p:nvGrpSpPr>
            <p:grpSpPr>
              <a:xfrm>
                <a:off x="5466606" y="4384232"/>
                <a:ext cx="207255" cy="232423"/>
                <a:chOff x="2591387" y="425153"/>
                <a:chExt cx="471853" cy="529151"/>
              </a:xfrm>
            </p:grpSpPr>
            <p:sp>
              <p:nvSpPr>
                <p:cNvPr id="3788" name="Flowchart: Delay 3787">
                  <a:extLst>
                    <a:ext uri="{FF2B5EF4-FFF2-40B4-BE49-F238E27FC236}">
                      <a16:creationId xmlns:a16="http://schemas.microsoft.com/office/drawing/2014/main" id="{BFB813D7-5DDC-A790-40C9-33A0F8118B56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9" name="Flowchart: Delay 3788">
                  <a:extLst>
                    <a:ext uri="{FF2B5EF4-FFF2-40B4-BE49-F238E27FC236}">
                      <a16:creationId xmlns:a16="http://schemas.microsoft.com/office/drawing/2014/main" id="{08288DFD-584D-6DF0-2682-E0A5FE31C96C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0" name="Oval 3789">
                  <a:extLst>
                    <a:ext uri="{FF2B5EF4-FFF2-40B4-BE49-F238E27FC236}">
                      <a16:creationId xmlns:a16="http://schemas.microsoft.com/office/drawing/2014/main" id="{90905584-18D1-5157-5303-996D90A86FE1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91" name="Oval 3790">
                  <a:extLst>
                    <a:ext uri="{FF2B5EF4-FFF2-40B4-BE49-F238E27FC236}">
                      <a16:creationId xmlns:a16="http://schemas.microsoft.com/office/drawing/2014/main" id="{C3D03B09-D5AE-D69E-707E-4B8C2BB1230E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5" name="Group 3244">
                <a:extLst>
                  <a:ext uri="{FF2B5EF4-FFF2-40B4-BE49-F238E27FC236}">
                    <a16:creationId xmlns:a16="http://schemas.microsoft.com/office/drawing/2014/main" id="{A12C7601-0AF9-7B13-C787-76D2A48FD6D0}"/>
                  </a:ext>
                </a:extLst>
              </p:cNvPr>
              <p:cNvGrpSpPr/>
              <p:nvPr/>
            </p:nvGrpSpPr>
            <p:grpSpPr>
              <a:xfrm rot="21439973">
                <a:off x="5956697" y="2980558"/>
                <a:ext cx="534661" cy="214212"/>
                <a:chOff x="7017438" y="2471500"/>
                <a:chExt cx="1217248" cy="487691"/>
              </a:xfrm>
            </p:grpSpPr>
            <p:grpSp>
              <p:nvGrpSpPr>
                <p:cNvPr id="3782" name="Group 3781">
                  <a:extLst>
                    <a:ext uri="{FF2B5EF4-FFF2-40B4-BE49-F238E27FC236}">
                      <a16:creationId xmlns:a16="http://schemas.microsoft.com/office/drawing/2014/main" id="{2C3B20BC-2546-4CF7-ADC3-AB36A17853C1}"/>
                    </a:ext>
                  </a:extLst>
                </p:cNvPr>
                <p:cNvGrpSpPr/>
                <p:nvPr/>
              </p:nvGrpSpPr>
              <p:grpSpPr>
                <a:xfrm rot="2957822">
                  <a:off x="7417200" y="2141705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784" name="Rectangle: Rounded Corners 3783">
                    <a:extLst>
                      <a:ext uri="{FF2B5EF4-FFF2-40B4-BE49-F238E27FC236}">
                        <a16:creationId xmlns:a16="http://schemas.microsoft.com/office/drawing/2014/main" id="{6711F1F8-396C-7DCA-E10A-C93952BE4B3D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85" name="Rectangle: Rounded Corners 3784">
                    <a:extLst>
                      <a:ext uri="{FF2B5EF4-FFF2-40B4-BE49-F238E27FC236}">
                        <a16:creationId xmlns:a16="http://schemas.microsoft.com/office/drawing/2014/main" id="{5A698EB9-6352-48E5-110C-E0A0DAC28117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86" name="Rectangle: Rounded Corners 3785">
                    <a:extLst>
                      <a:ext uri="{FF2B5EF4-FFF2-40B4-BE49-F238E27FC236}">
                        <a16:creationId xmlns:a16="http://schemas.microsoft.com/office/drawing/2014/main" id="{3B07D481-1CB7-3843-93DD-B8D5170E21C0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87" name="Rectangle: Rounded Corners 3786">
                    <a:extLst>
                      <a:ext uri="{FF2B5EF4-FFF2-40B4-BE49-F238E27FC236}">
                        <a16:creationId xmlns:a16="http://schemas.microsoft.com/office/drawing/2014/main" id="{A9D05D83-52E9-4475-14FA-6888D0FE9F05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83" name="Rectangle 3782">
                  <a:extLst>
                    <a:ext uri="{FF2B5EF4-FFF2-40B4-BE49-F238E27FC236}">
                      <a16:creationId xmlns:a16="http://schemas.microsoft.com/office/drawing/2014/main" id="{16DE0C0D-DCF2-1BC9-0981-650C8300B690}"/>
                    </a:ext>
                  </a:extLst>
                </p:cNvPr>
                <p:cNvSpPr/>
                <p:nvPr/>
              </p:nvSpPr>
              <p:spPr>
                <a:xfrm rot="2922205">
                  <a:off x="7832344" y="2266593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6" name="Group 3245">
                <a:extLst>
                  <a:ext uri="{FF2B5EF4-FFF2-40B4-BE49-F238E27FC236}">
                    <a16:creationId xmlns:a16="http://schemas.microsoft.com/office/drawing/2014/main" id="{A34A25B4-9CEB-D1A4-1CF1-B3414BC1FC2E}"/>
                  </a:ext>
                </a:extLst>
              </p:cNvPr>
              <p:cNvGrpSpPr/>
              <p:nvPr/>
            </p:nvGrpSpPr>
            <p:grpSpPr>
              <a:xfrm rot="2823065">
                <a:off x="6011756" y="3088058"/>
                <a:ext cx="207255" cy="232423"/>
                <a:chOff x="2591387" y="425153"/>
                <a:chExt cx="471853" cy="529151"/>
              </a:xfrm>
            </p:grpSpPr>
            <p:sp>
              <p:nvSpPr>
                <p:cNvPr id="3778" name="Flowchart: Delay 3777">
                  <a:extLst>
                    <a:ext uri="{FF2B5EF4-FFF2-40B4-BE49-F238E27FC236}">
                      <a16:creationId xmlns:a16="http://schemas.microsoft.com/office/drawing/2014/main" id="{AA14E070-5125-45D0-1DA8-DDBB958E6A9F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79" name="Flowchart: Delay 3778">
                  <a:extLst>
                    <a:ext uri="{FF2B5EF4-FFF2-40B4-BE49-F238E27FC236}">
                      <a16:creationId xmlns:a16="http://schemas.microsoft.com/office/drawing/2014/main" id="{0F683CEA-663B-65C5-BAAF-9F618D4B8630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0" name="Oval 3779">
                  <a:extLst>
                    <a:ext uri="{FF2B5EF4-FFF2-40B4-BE49-F238E27FC236}">
                      <a16:creationId xmlns:a16="http://schemas.microsoft.com/office/drawing/2014/main" id="{990EA25C-F579-C1D3-A6E6-7FCDD6443C30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1" name="Oval 3780">
                  <a:extLst>
                    <a:ext uri="{FF2B5EF4-FFF2-40B4-BE49-F238E27FC236}">
                      <a16:creationId xmlns:a16="http://schemas.microsoft.com/office/drawing/2014/main" id="{93D0A8EF-6EB4-A7FC-73DE-80DCB19EA5F0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7" name="Group 3246">
                <a:extLst>
                  <a:ext uri="{FF2B5EF4-FFF2-40B4-BE49-F238E27FC236}">
                    <a16:creationId xmlns:a16="http://schemas.microsoft.com/office/drawing/2014/main" id="{F60AAD65-3495-5165-65C5-20546B68D4C5}"/>
                  </a:ext>
                </a:extLst>
              </p:cNvPr>
              <p:cNvGrpSpPr/>
              <p:nvPr/>
            </p:nvGrpSpPr>
            <p:grpSpPr>
              <a:xfrm rot="2718529">
                <a:off x="5315798" y="2730265"/>
                <a:ext cx="534661" cy="194771"/>
                <a:chOff x="4004238" y="2445354"/>
                <a:chExt cx="1217248" cy="443429"/>
              </a:xfrm>
            </p:grpSpPr>
            <p:grpSp>
              <p:nvGrpSpPr>
                <p:cNvPr id="3772" name="Group 3771">
                  <a:extLst>
                    <a:ext uri="{FF2B5EF4-FFF2-40B4-BE49-F238E27FC236}">
                      <a16:creationId xmlns:a16="http://schemas.microsoft.com/office/drawing/2014/main" id="{833D8756-5DDF-2DDE-A6B4-9FB9F6F8586F}"/>
                    </a:ext>
                  </a:extLst>
                </p:cNvPr>
                <p:cNvGrpSpPr/>
                <p:nvPr/>
              </p:nvGrpSpPr>
              <p:grpSpPr>
                <a:xfrm rot="18880432">
                  <a:off x="4404000" y="2071297"/>
                  <a:ext cx="417724" cy="1217248"/>
                  <a:chOff x="5291240" y="502920"/>
                  <a:chExt cx="731520" cy="2131648"/>
                </a:xfrm>
              </p:grpSpPr>
              <p:sp>
                <p:nvSpPr>
                  <p:cNvPr id="3774" name="Rectangle: Rounded Corners 3773">
                    <a:extLst>
                      <a:ext uri="{FF2B5EF4-FFF2-40B4-BE49-F238E27FC236}">
                        <a16:creationId xmlns:a16="http://schemas.microsoft.com/office/drawing/2014/main" id="{807AB496-2D4B-2C91-F1BF-CDAB1C47E798}"/>
                      </a:ext>
                    </a:extLst>
                  </p:cNvPr>
                  <p:cNvSpPr/>
                  <p:nvPr/>
                </p:nvSpPr>
                <p:spPr>
                  <a:xfrm>
                    <a:off x="565700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75" name="Rectangle: Rounded Corners 3774">
                    <a:extLst>
                      <a:ext uri="{FF2B5EF4-FFF2-40B4-BE49-F238E27FC236}">
                        <a16:creationId xmlns:a16="http://schemas.microsoft.com/office/drawing/2014/main" id="{ADF0611C-DDD0-4F31-6A2C-4A47B5CE343C}"/>
                      </a:ext>
                    </a:extLst>
                  </p:cNvPr>
                  <p:cNvSpPr/>
                  <p:nvPr/>
                </p:nvSpPr>
                <p:spPr>
                  <a:xfrm>
                    <a:off x="5291240" y="611839"/>
                    <a:ext cx="365760" cy="9144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76" name="Rectangle: Rounded Corners 3775">
                    <a:extLst>
                      <a:ext uri="{FF2B5EF4-FFF2-40B4-BE49-F238E27FC236}">
                        <a16:creationId xmlns:a16="http://schemas.microsoft.com/office/drawing/2014/main" id="{30B3D45F-136E-CDFD-8D06-88DBE24EF543}"/>
                      </a:ext>
                    </a:extLst>
                  </p:cNvPr>
                  <p:cNvSpPr/>
                  <p:nvPr/>
                </p:nvSpPr>
                <p:spPr>
                  <a:xfrm>
                    <a:off x="5563400" y="1384386"/>
                    <a:ext cx="182880" cy="1250182"/>
                  </a:xfrm>
                  <a:prstGeom prst="roundRect">
                    <a:avLst>
                      <a:gd name="adj" fmla="val 40626"/>
                    </a:avLst>
                  </a:prstGeom>
                  <a:solidFill>
                    <a:srgbClr val="1F7F88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77" name="Rectangle: Rounded Corners 3776">
                    <a:extLst>
                      <a:ext uri="{FF2B5EF4-FFF2-40B4-BE49-F238E27FC236}">
                        <a16:creationId xmlns:a16="http://schemas.microsoft.com/office/drawing/2014/main" id="{A76BF2BC-C499-9576-8832-33B69540B34E}"/>
                      </a:ext>
                    </a:extLst>
                  </p:cNvPr>
                  <p:cNvSpPr/>
                  <p:nvPr/>
                </p:nvSpPr>
                <p:spPr>
                  <a:xfrm>
                    <a:off x="5474120" y="502920"/>
                    <a:ext cx="365760" cy="914400"/>
                  </a:xfrm>
                  <a:prstGeom prst="roundRect">
                    <a:avLst>
                      <a:gd name="adj" fmla="val 41667"/>
                    </a:avLst>
                  </a:prstGeom>
                  <a:gradFill flip="none" rotWithShape="1">
                    <a:gsLst>
                      <a:gs pos="0">
                        <a:srgbClr val="1F7F88">
                          <a:shade val="30000"/>
                          <a:satMod val="115000"/>
                        </a:srgbClr>
                      </a:gs>
                      <a:gs pos="50000">
                        <a:srgbClr val="1F7F88">
                          <a:shade val="67500"/>
                          <a:satMod val="115000"/>
                        </a:srgbClr>
                      </a:gs>
                      <a:gs pos="100000">
                        <a:srgbClr val="1F7F88">
                          <a:shade val="100000"/>
                          <a:satMod val="115000"/>
                        </a:srgbClr>
                      </a:gs>
                    </a:gsLst>
                    <a:lin ang="10800000" scaled="1"/>
                    <a:tileRect/>
                  </a:gra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73" name="Rectangle 3772">
                  <a:extLst>
                    <a:ext uri="{FF2B5EF4-FFF2-40B4-BE49-F238E27FC236}">
                      <a16:creationId xmlns:a16="http://schemas.microsoft.com/office/drawing/2014/main" id="{F063D694-8260-0B7C-255A-292FD577C253}"/>
                    </a:ext>
                  </a:extLst>
                </p:cNvPr>
                <p:cNvSpPr/>
                <p:nvPr/>
              </p:nvSpPr>
              <p:spPr>
                <a:xfrm rot="18854215">
                  <a:off x="4327443" y="2240447"/>
                  <a:ext cx="45719" cy="455533"/>
                </a:xfrm>
                <a:prstGeom prst="rect">
                  <a:avLst/>
                </a:prstGeom>
                <a:solidFill>
                  <a:schemeClr val="bg1">
                    <a:alpha val="50000"/>
                  </a:schemeClr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8" name="Group 3247">
                <a:extLst>
                  <a:ext uri="{FF2B5EF4-FFF2-40B4-BE49-F238E27FC236}">
                    <a16:creationId xmlns:a16="http://schemas.microsoft.com/office/drawing/2014/main" id="{8FE7A2F8-CF28-B8E3-3719-E50EC96DA8AE}"/>
                  </a:ext>
                </a:extLst>
              </p:cNvPr>
              <p:cNvGrpSpPr/>
              <p:nvPr/>
            </p:nvGrpSpPr>
            <p:grpSpPr>
              <a:xfrm rot="48457">
                <a:off x="5473177" y="2865274"/>
                <a:ext cx="207255" cy="232423"/>
                <a:chOff x="2591387" y="425153"/>
                <a:chExt cx="471853" cy="529151"/>
              </a:xfrm>
            </p:grpSpPr>
            <p:sp>
              <p:nvSpPr>
                <p:cNvPr id="3768" name="Flowchart: Delay 3767">
                  <a:extLst>
                    <a:ext uri="{FF2B5EF4-FFF2-40B4-BE49-F238E27FC236}">
                      <a16:creationId xmlns:a16="http://schemas.microsoft.com/office/drawing/2014/main" id="{4D4EA7AC-678E-29BB-B405-0110AFD617CF}"/>
                    </a:ext>
                  </a:extLst>
                </p:cNvPr>
                <p:cNvSpPr/>
                <p:nvPr/>
              </p:nvSpPr>
              <p:spPr>
                <a:xfrm>
                  <a:off x="2909533" y="425153"/>
                  <a:ext cx="153707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69" name="Flowchart: Delay 3768">
                  <a:extLst>
                    <a:ext uri="{FF2B5EF4-FFF2-40B4-BE49-F238E27FC236}">
                      <a16:creationId xmlns:a16="http://schemas.microsoft.com/office/drawing/2014/main" id="{2FD2C99F-D83F-8B87-3CF8-7B04A6866601}"/>
                    </a:ext>
                  </a:extLst>
                </p:cNvPr>
                <p:cNvSpPr/>
                <p:nvPr/>
              </p:nvSpPr>
              <p:spPr>
                <a:xfrm rot="10800000">
                  <a:off x="2591387" y="433220"/>
                  <a:ext cx="158396" cy="521084"/>
                </a:xfrm>
                <a:prstGeom prst="flowChartDelay">
                  <a:avLst/>
                </a:prstGeom>
                <a:solidFill>
                  <a:srgbClr val="CFE283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70" name="Oval 3769">
                  <a:extLst>
                    <a:ext uri="{FF2B5EF4-FFF2-40B4-BE49-F238E27FC236}">
                      <a16:creationId xmlns:a16="http://schemas.microsoft.com/office/drawing/2014/main" id="{AD394ADF-12D7-5871-4079-150D202A1EDA}"/>
                    </a:ext>
                  </a:extLst>
                </p:cNvPr>
                <p:cNvSpPr/>
                <p:nvPr/>
              </p:nvSpPr>
              <p:spPr>
                <a:xfrm>
                  <a:off x="2973294" y="494251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71" name="Oval 3770">
                  <a:extLst>
                    <a:ext uri="{FF2B5EF4-FFF2-40B4-BE49-F238E27FC236}">
                      <a16:creationId xmlns:a16="http://schemas.microsoft.com/office/drawing/2014/main" id="{75F668E7-C6C9-2948-168A-1A7DED33C51D}"/>
                    </a:ext>
                  </a:extLst>
                </p:cNvPr>
                <p:cNvSpPr/>
                <p:nvPr/>
              </p:nvSpPr>
              <p:spPr>
                <a:xfrm>
                  <a:off x="2623481" y="485013"/>
                  <a:ext cx="45719" cy="411103"/>
                </a:xfrm>
                <a:prstGeom prst="ellipse">
                  <a:avLst/>
                </a:prstGeom>
                <a:solidFill>
                  <a:schemeClr val="bg1">
                    <a:alpha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49" name="Group 3248">
                <a:extLst>
                  <a:ext uri="{FF2B5EF4-FFF2-40B4-BE49-F238E27FC236}">
                    <a16:creationId xmlns:a16="http://schemas.microsoft.com/office/drawing/2014/main" id="{0F3866CF-6E45-E4B2-3C5A-B2698769C4CA}"/>
                  </a:ext>
                </a:extLst>
              </p:cNvPr>
              <p:cNvGrpSpPr/>
              <p:nvPr/>
            </p:nvGrpSpPr>
            <p:grpSpPr>
              <a:xfrm>
                <a:off x="4672483" y="2856913"/>
                <a:ext cx="1790422" cy="1777488"/>
                <a:chOff x="2075276" y="-24324"/>
                <a:chExt cx="4076206" cy="4046760"/>
              </a:xfrm>
            </p:grpSpPr>
            <p:sp>
              <p:nvSpPr>
                <p:cNvPr id="3719" name="Oval 3718">
                  <a:extLst>
                    <a:ext uri="{FF2B5EF4-FFF2-40B4-BE49-F238E27FC236}">
                      <a16:creationId xmlns:a16="http://schemas.microsoft.com/office/drawing/2014/main" id="{CBD101DB-1F8C-D2FD-6EF4-458B80AEF5D9}"/>
                    </a:ext>
                  </a:extLst>
                </p:cNvPr>
                <p:cNvSpPr/>
                <p:nvPr/>
              </p:nvSpPr>
              <p:spPr>
                <a:xfrm>
                  <a:off x="2663394" y="553278"/>
                  <a:ext cx="2892467" cy="2892467"/>
                </a:xfrm>
                <a:prstGeom prst="ellipse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720" name="Group 3719">
                  <a:extLst>
                    <a:ext uri="{FF2B5EF4-FFF2-40B4-BE49-F238E27FC236}">
                      <a16:creationId xmlns:a16="http://schemas.microsoft.com/office/drawing/2014/main" id="{016937FA-5A1D-98F1-1B3C-66C0C059CE49}"/>
                    </a:ext>
                  </a:extLst>
                </p:cNvPr>
                <p:cNvGrpSpPr/>
                <p:nvPr/>
              </p:nvGrpSpPr>
              <p:grpSpPr>
                <a:xfrm>
                  <a:off x="3041691" y="216106"/>
                  <a:ext cx="599742" cy="384312"/>
                  <a:chOff x="3057893" y="239026"/>
                  <a:chExt cx="599742" cy="384312"/>
                </a:xfrm>
              </p:grpSpPr>
              <p:sp>
                <p:nvSpPr>
                  <p:cNvPr id="3765" name="Teardrop 3764">
                    <a:extLst>
                      <a:ext uri="{FF2B5EF4-FFF2-40B4-BE49-F238E27FC236}">
                        <a16:creationId xmlns:a16="http://schemas.microsoft.com/office/drawing/2014/main" id="{150E3A81-3F24-1CA0-FF58-679DEEE9EE2E}"/>
                      </a:ext>
                    </a:extLst>
                  </p:cNvPr>
                  <p:cNvSpPr/>
                  <p:nvPr/>
                </p:nvSpPr>
                <p:spPr>
                  <a:xfrm rot="7022745">
                    <a:off x="3469253" y="239026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66" name="Teardrop 3765">
                    <a:extLst>
                      <a:ext uri="{FF2B5EF4-FFF2-40B4-BE49-F238E27FC236}">
                        <a16:creationId xmlns:a16="http://schemas.microsoft.com/office/drawing/2014/main" id="{5F56BACC-1A7C-EFA4-0F0D-D0FA9E7DA3E4}"/>
                      </a:ext>
                    </a:extLst>
                  </p:cNvPr>
                  <p:cNvSpPr/>
                  <p:nvPr/>
                </p:nvSpPr>
                <p:spPr>
                  <a:xfrm rot="6770818">
                    <a:off x="3261785" y="322376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67" name="Teardrop 3766">
                    <a:extLst>
                      <a:ext uri="{FF2B5EF4-FFF2-40B4-BE49-F238E27FC236}">
                        <a16:creationId xmlns:a16="http://schemas.microsoft.com/office/drawing/2014/main" id="{59687ABA-3E9E-86DF-4077-DD1BBC58E231}"/>
                      </a:ext>
                    </a:extLst>
                  </p:cNvPr>
                  <p:cNvSpPr/>
                  <p:nvPr/>
                </p:nvSpPr>
                <p:spPr>
                  <a:xfrm rot="6448850">
                    <a:off x="3057893" y="434956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1" name="Group 3720">
                  <a:extLst>
                    <a:ext uri="{FF2B5EF4-FFF2-40B4-BE49-F238E27FC236}">
                      <a16:creationId xmlns:a16="http://schemas.microsoft.com/office/drawing/2014/main" id="{FC889124-B127-2B3A-F99C-FA7932985E73}"/>
                    </a:ext>
                  </a:extLst>
                </p:cNvPr>
                <p:cNvGrpSpPr/>
                <p:nvPr/>
              </p:nvGrpSpPr>
              <p:grpSpPr>
                <a:xfrm rot="19686157">
                  <a:off x="2229994" y="988816"/>
                  <a:ext cx="592415" cy="415377"/>
                  <a:chOff x="2861153" y="334852"/>
                  <a:chExt cx="592415" cy="415377"/>
                </a:xfrm>
              </p:grpSpPr>
              <p:grpSp>
                <p:nvGrpSpPr>
                  <p:cNvPr id="3761" name="Group 3760">
                    <a:extLst>
                      <a:ext uri="{FF2B5EF4-FFF2-40B4-BE49-F238E27FC236}">
                        <a16:creationId xmlns:a16="http://schemas.microsoft.com/office/drawing/2014/main" id="{064941CD-B195-ACF2-C481-A1592D7C4682}"/>
                      </a:ext>
                    </a:extLst>
                  </p:cNvPr>
                  <p:cNvGrpSpPr/>
                  <p:nvPr/>
                </p:nvGrpSpPr>
                <p:grpSpPr>
                  <a:xfrm>
                    <a:off x="3061236" y="334852"/>
                    <a:ext cx="392332" cy="283361"/>
                    <a:chOff x="3061236" y="334852"/>
                    <a:chExt cx="392332" cy="283361"/>
                  </a:xfrm>
                </p:grpSpPr>
                <p:sp>
                  <p:nvSpPr>
                    <p:cNvPr id="3763" name="Teardrop 3762">
                      <a:extLst>
                        <a:ext uri="{FF2B5EF4-FFF2-40B4-BE49-F238E27FC236}">
                          <a16:creationId xmlns:a16="http://schemas.microsoft.com/office/drawing/2014/main" id="{ADFD82CC-B862-0D00-7FC7-ED88F8343A19}"/>
                        </a:ext>
                      </a:extLst>
                    </p:cNvPr>
                    <p:cNvSpPr/>
                    <p:nvPr/>
                  </p:nvSpPr>
                  <p:spPr>
                    <a:xfrm rot="6566463">
                      <a:off x="3265186" y="334852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64" name="Teardrop 3763">
                      <a:extLst>
                        <a:ext uri="{FF2B5EF4-FFF2-40B4-BE49-F238E27FC236}">
                          <a16:creationId xmlns:a16="http://schemas.microsoft.com/office/drawing/2014/main" id="{46911376-B564-CAF0-9CBB-1C82151DD5BD}"/>
                        </a:ext>
                      </a:extLst>
                    </p:cNvPr>
                    <p:cNvSpPr/>
                    <p:nvPr/>
                  </p:nvSpPr>
                  <p:spPr>
                    <a:xfrm rot="6311519">
                      <a:off x="3061236" y="429831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762" name="Teardrop 3761">
                    <a:extLst>
                      <a:ext uri="{FF2B5EF4-FFF2-40B4-BE49-F238E27FC236}">
                        <a16:creationId xmlns:a16="http://schemas.microsoft.com/office/drawing/2014/main" id="{A6D440B8-14FC-8307-0AEC-EEF7DA7D70E4}"/>
                      </a:ext>
                    </a:extLst>
                  </p:cNvPr>
                  <p:cNvSpPr/>
                  <p:nvPr/>
                </p:nvSpPr>
                <p:spPr>
                  <a:xfrm rot="5854622">
                    <a:off x="2861153" y="561847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2" name="Group 3721">
                  <a:extLst>
                    <a:ext uri="{FF2B5EF4-FFF2-40B4-BE49-F238E27FC236}">
                      <a16:creationId xmlns:a16="http://schemas.microsoft.com/office/drawing/2014/main" id="{1C8D6DA9-2D4C-616A-8492-83B4902CB6B9}"/>
                    </a:ext>
                  </a:extLst>
                </p:cNvPr>
                <p:cNvGrpSpPr/>
                <p:nvPr/>
              </p:nvGrpSpPr>
              <p:grpSpPr>
                <a:xfrm rot="18006452">
                  <a:off x="1936875" y="1716765"/>
                  <a:ext cx="819925" cy="543124"/>
                  <a:chOff x="2840263" y="245404"/>
                  <a:chExt cx="819925" cy="543124"/>
                </a:xfrm>
              </p:grpSpPr>
              <p:sp>
                <p:nvSpPr>
                  <p:cNvPr id="3759" name="Teardrop 3758">
                    <a:extLst>
                      <a:ext uri="{FF2B5EF4-FFF2-40B4-BE49-F238E27FC236}">
                        <a16:creationId xmlns:a16="http://schemas.microsoft.com/office/drawing/2014/main" id="{A78FE57A-DBE5-E950-C5FB-E8947738053D}"/>
                      </a:ext>
                    </a:extLst>
                  </p:cNvPr>
                  <p:cNvSpPr/>
                  <p:nvPr/>
                </p:nvSpPr>
                <p:spPr>
                  <a:xfrm rot="7128540">
                    <a:off x="3471806" y="245404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60" name="Teardrop 3759">
                    <a:extLst>
                      <a:ext uri="{FF2B5EF4-FFF2-40B4-BE49-F238E27FC236}">
                        <a16:creationId xmlns:a16="http://schemas.microsoft.com/office/drawing/2014/main" id="{6DE14B0A-5BE7-169D-1A49-F59859A85B5D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40263" y="600146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3" name="Group 3722">
                  <a:extLst>
                    <a:ext uri="{FF2B5EF4-FFF2-40B4-BE49-F238E27FC236}">
                      <a16:creationId xmlns:a16="http://schemas.microsoft.com/office/drawing/2014/main" id="{4A4A5432-7E71-6522-937D-34B808D360AB}"/>
                    </a:ext>
                  </a:extLst>
                </p:cNvPr>
                <p:cNvGrpSpPr/>
                <p:nvPr/>
              </p:nvGrpSpPr>
              <p:grpSpPr>
                <a:xfrm rot="16200000">
                  <a:off x="2211146" y="2590818"/>
                  <a:ext cx="602932" cy="397182"/>
                  <a:chOff x="3035011" y="246148"/>
                  <a:chExt cx="602932" cy="397182"/>
                </a:xfrm>
              </p:grpSpPr>
              <p:sp>
                <p:nvSpPr>
                  <p:cNvPr id="3756" name="Teardrop 3755">
                    <a:extLst>
                      <a:ext uri="{FF2B5EF4-FFF2-40B4-BE49-F238E27FC236}">
                        <a16:creationId xmlns:a16="http://schemas.microsoft.com/office/drawing/2014/main" id="{4A284C6C-616D-3C1B-C453-2ACCA2A31D9C}"/>
                      </a:ext>
                    </a:extLst>
                  </p:cNvPr>
                  <p:cNvSpPr/>
                  <p:nvPr/>
                </p:nvSpPr>
                <p:spPr>
                  <a:xfrm rot="6984830">
                    <a:off x="3449561" y="246148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57" name="Teardrop 3756">
                    <a:extLst>
                      <a:ext uri="{FF2B5EF4-FFF2-40B4-BE49-F238E27FC236}">
                        <a16:creationId xmlns:a16="http://schemas.microsoft.com/office/drawing/2014/main" id="{BFE37BF3-C725-A058-2882-C8B8503DB692}"/>
                      </a:ext>
                    </a:extLst>
                  </p:cNvPr>
                  <p:cNvSpPr/>
                  <p:nvPr/>
                </p:nvSpPr>
                <p:spPr>
                  <a:xfrm rot="6729344">
                    <a:off x="3240829" y="336078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58" name="Teardrop 3757">
                    <a:extLst>
                      <a:ext uri="{FF2B5EF4-FFF2-40B4-BE49-F238E27FC236}">
                        <a16:creationId xmlns:a16="http://schemas.microsoft.com/office/drawing/2014/main" id="{4AD9986C-DAC5-457B-DCDD-997E2B8433E6}"/>
                      </a:ext>
                    </a:extLst>
                  </p:cNvPr>
                  <p:cNvSpPr/>
                  <p:nvPr/>
                </p:nvSpPr>
                <p:spPr>
                  <a:xfrm rot="6122891">
                    <a:off x="3035011" y="454948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4" name="Group 3723">
                  <a:extLst>
                    <a:ext uri="{FF2B5EF4-FFF2-40B4-BE49-F238E27FC236}">
                      <a16:creationId xmlns:a16="http://schemas.microsoft.com/office/drawing/2014/main" id="{2FBE5AFA-DA5D-DCE7-B4A9-01C537FBBE54}"/>
                    </a:ext>
                  </a:extLst>
                </p:cNvPr>
                <p:cNvGrpSpPr/>
                <p:nvPr/>
              </p:nvGrpSpPr>
              <p:grpSpPr>
                <a:xfrm rot="14383403">
                  <a:off x="3008602" y="3378503"/>
                  <a:ext cx="583348" cy="430186"/>
                  <a:chOff x="2866819" y="322376"/>
                  <a:chExt cx="583348" cy="430186"/>
                </a:xfrm>
              </p:grpSpPr>
              <p:grpSp>
                <p:nvGrpSpPr>
                  <p:cNvPr id="3752" name="Group 3751">
                    <a:extLst>
                      <a:ext uri="{FF2B5EF4-FFF2-40B4-BE49-F238E27FC236}">
                        <a16:creationId xmlns:a16="http://schemas.microsoft.com/office/drawing/2014/main" id="{71C5D879-D1C8-02A3-904E-FD4083B5F0AE}"/>
                      </a:ext>
                    </a:extLst>
                  </p:cNvPr>
                  <p:cNvGrpSpPr/>
                  <p:nvPr/>
                </p:nvGrpSpPr>
                <p:grpSpPr>
                  <a:xfrm>
                    <a:off x="3061237" y="322376"/>
                    <a:ext cx="388930" cy="295837"/>
                    <a:chOff x="3061237" y="322376"/>
                    <a:chExt cx="388930" cy="295837"/>
                  </a:xfrm>
                </p:grpSpPr>
                <p:sp>
                  <p:nvSpPr>
                    <p:cNvPr id="3754" name="Teardrop 3753">
                      <a:extLst>
                        <a:ext uri="{FF2B5EF4-FFF2-40B4-BE49-F238E27FC236}">
                          <a16:creationId xmlns:a16="http://schemas.microsoft.com/office/drawing/2014/main" id="{29F99D38-9A65-1A32-2502-C9B3C094FE16}"/>
                        </a:ext>
                      </a:extLst>
                    </p:cNvPr>
                    <p:cNvSpPr/>
                    <p:nvPr/>
                  </p:nvSpPr>
                  <p:spPr>
                    <a:xfrm rot="6566463">
                      <a:off x="3261785" y="322376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55" name="Teardrop 3754">
                      <a:extLst>
                        <a:ext uri="{FF2B5EF4-FFF2-40B4-BE49-F238E27FC236}">
                          <a16:creationId xmlns:a16="http://schemas.microsoft.com/office/drawing/2014/main" id="{3935E5A8-B97B-BE11-FBD8-5A23726D4C1A}"/>
                        </a:ext>
                      </a:extLst>
                    </p:cNvPr>
                    <p:cNvSpPr/>
                    <p:nvPr/>
                  </p:nvSpPr>
                  <p:spPr>
                    <a:xfrm rot="6183168">
                      <a:off x="3061237" y="429831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753" name="Teardrop 3752">
                    <a:extLst>
                      <a:ext uri="{FF2B5EF4-FFF2-40B4-BE49-F238E27FC236}">
                        <a16:creationId xmlns:a16="http://schemas.microsoft.com/office/drawing/2014/main" id="{D1BDB8D8-22DF-14C2-4592-30E8F6209A75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66819" y="564180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5" name="Group 3724">
                  <a:extLst>
                    <a:ext uri="{FF2B5EF4-FFF2-40B4-BE49-F238E27FC236}">
                      <a16:creationId xmlns:a16="http://schemas.microsoft.com/office/drawing/2014/main" id="{BA7A3359-CDB7-8423-2660-009F9AA82FC2}"/>
                    </a:ext>
                  </a:extLst>
                </p:cNvPr>
                <p:cNvGrpSpPr/>
                <p:nvPr/>
              </p:nvGrpSpPr>
              <p:grpSpPr>
                <a:xfrm rot="12531233">
                  <a:off x="3710286" y="3497586"/>
                  <a:ext cx="799053" cy="524850"/>
                  <a:chOff x="2858582" y="239026"/>
                  <a:chExt cx="799053" cy="524850"/>
                </a:xfrm>
              </p:grpSpPr>
              <p:sp>
                <p:nvSpPr>
                  <p:cNvPr id="3750" name="Teardrop 3749">
                    <a:extLst>
                      <a:ext uri="{FF2B5EF4-FFF2-40B4-BE49-F238E27FC236}">
                        <a16:creationId xmlns:a16="http://schemas.microsoft.com/office/drawing/2014/main" id="{81B8B11A-5DFD-63FA-42A0-EB160CFEFB4C}"/>
                      </a:ext>
                    </a:extLst>
                  </p:cNvPr>
                  <p:cNvSpPr/>
                  <p:nvPr/>
                </p:nvSpPr>
                <p:spPr>
                  <a:xfrm rot="6899127">
                    <a:off x="3469253" y="239026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51" name="Teardrop 3750">
                    <a:extLst>
                      <a:ext uri="{FF2B5EF4-FFF2-40B4-BE49-F238E27FC236}">
                        <a16:creationId xmlns:a16="http://schemas.microsoft.com/office/drawing/2014/main" id="{06FCD570-A920-4524-D2C5-FB63FC9BE6B4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58582" y="575494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6" name="Group 3725">
                  <a:extLst>
                    <a:ext uri="{FF2B5EF4-FFF2-40B4-BE49-F238E27FC236}">
                      <a16:creationId xmlns:a16="http://schemas.microsoft.com/office/drawing/2014/main" id="{D183262A-6199-76C9-F824-BC89FC14200A}"/>
                    </a:ext>
                  </a:extLst>
                </p:cNvPr>
                <p:cNvGrpSpPr/>
                <p:nvPr/>
              </p:nvGrpSpPr>
              <p:grpSpPr>
                <a:xfrm rot="10800000">
                  <a:off x="4597800" y="3404506"/>
                  <a:ext cx="599215" cy="385696"/>
                  <a:chOff x="3065619" y="250519"/>
                  <a:chExt cx="599215" cy="385696"/>
                </a:xfrm>
              </p:grpSpPr>
              <p:sp>
                <p:nvSpPr>
                  <p:cNvPr id="3747" name="Teardrop 3746">
                    <a:extLst>
                      <a:ext uri="{FF2B5EF4-FFF2-40B4-BE49-F238E27FC236}">
                        <a16:creationId xmlns:a16="http://schemas.microsoft.com/office/drawing/2014/main" id="{D692EA21-7BAB-2486-F159-9B4F32F8425C}"/>
                      </a:ext>
                    </a:extLst>
                  </p:cNvPr>
                  <p:cNvSpPr/>
                  <p:nvPr/>
                </p:nvSpPr>
                <p:spPr>
                  <a:xfrm rot="6899127">
                    <a:off x="3476452" y="250519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48" name="Teardrop 3747">
                    <a:extLst>
                      <a:ext uri="{FF2B5EF4-FFF2-40B4-BE49-F238E27FC236}">
                        <a16:creationId xmlns:a16="http://schemas.microsoft.com/office/drawing/2014/main" id="{288DD0CF-450A-CA9D-6447-2B1790D1F851}"/>
                      </a:ext>
                    </a:extLst>
                  </p:cNvPr>
                  <p:cNvSpPr/>
                  <p:nvPr/>
                </p:nvSpPr>
                <p:spPr>
                  <a:xfrm rot="6566463">
                    <a:off x="3261635" y="337445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49" name="Teardrop 3748">
                    <a:extLst>
                      <a:ext uri="{FF2B5EF4-FFF2-40B4-BE49-F238E27FC236}">
                        <a16:creationId xmlns:a16="http://schemas.microsoft.com/office/drawing/2014/main" id="{9190BCC1-16DF-A084-49CD-6DDE3A500F58}"/>
                      </a:ext>
                    </a:extLst>
                  </p:cNvPr>
                  <p:cNvSpPr/>
                  <p:nvPr/>
                </p:nvSpPr>
                <p:spPr>
                  <a:xfrm rot="6336065">
                    <a:off x="3065619" y="447833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7" name="Group 3726">
                  <a:extLst>
                    <a:ext uri="{FF2B5EF4-FFF2-40B4-BE49-F238E27FC236}">
                      <a16:creationId xmlns:a16="http://schemas.microsoft.com/office/drawing/2014/main" id="{65150A11-DD70-5248-240B-3AA9DBF2A9E3}"/>
                    </a:ext>
                  </a:extLst>
                </p:cNvPr>
                <p:cNvGrpSpPr/>
                <p:nvPr/>
              </p:nvGrpSpPr>
              <p:grpSpPr>
                <a:xfrm rot="8837901">
                  <a:off x="5415044" y="2580117"/>
                  <a:ext cx="600635" cy="430496"/>
                  <a:chOff x="2866819" y="322066"/>
                  <a:chExt cx="600635" cy="430496"/>
                </a:xfrm>
              </p:grpSpPr>
              <p:grpSp>
                <p:nvGrpSpPr>
                  <p:cNvPr id="3743" name="Group 3742">
                    <a:extLst>
                      <a:ext uri="{FF2B5EF4-FFF2-40B4-BE49-F238E27FC236}">
                        <a16:creationId xmlns:a16="http://schemas.microsoft.com/office/drawing/2014/main" id="{06D4EA0E-2C89-8676-78FF-E87FF24459C9}"/>
                      </a:ext>
                    </a:extLst>
                  </p:cNvPr>
                  <p:cNvGrpSpPr/>
                  <p:nvPr/>
                </p:nvGrpSpPr>
                <p:grpSpPr>
                  <a:xfrm>
                    <a:off x="3061237" y="322066"/>
                    <a:ext cx="406217" cy="296147"/>
                    <a:chOff x="3061237" y="322066"/>
                    <a:chExt cx="406217" cy="296147"/>
                  </a:xfrm>
                </p:grpSpPr>
                <p:sp>
                  <p:nvSpPr>
                    <p:cNvPr id="3745" name="Teardrop 3744">
                      <a:extLst>
                        <a:ext uri="{FF2B5EF4-FFF2-40B4-BE49-F238E27FC236}">
                          <a16:creationId xmlns:a16="http://schemas.microsoft.com/office/drawing/2014/main" id="{1593321A-DBD1-7D40-D9B7-A66B113C9989}"/>
                        </a:ext>
                      </a:extLst>
                    </p:cNvPr>
                    <p:cNvSpPr/>
                    <p:nvPr/>
                  </p:nvSpPr>
                  <p:spPr>
                    <a:xfrm rot="6652036">
                      <a:off x="3279072" y="322066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46" name="Teardrop 3745">
                      <a:extLst>
                        <a:ext uri="{FF2B5EF4-FFF2-40B4-BE49-F238E27FC236}">
                          <a16:creationId xmlns:a16="http://schemas.microsoft.com/office/drawing/2014/main" id="{3D4062B0-0C10-0941-D167-CF07F13CB38A}"/>
                        </a:ext>
                      </a:extLst>
                    </p:cNvPr>
                    <p:cNvSpPr/>
                    <p:nvPr/>
                  </p:nvSpPr>
                  <p:spPr>
                    <a:xfrm rot="6183168">
                      <a:off x="3061237" y="429831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744" name="Teardrop 3743">
                    <a:extLst>
                      <a:ext uri="{FF2B5EF4-FFF2-40B4-BE49-F238E27FC236}">
                        <a16:creationId xmlns:a16="http://schemas.microsoft.com/office/drawing/2014/main" id="{3D4414C8-6F4D-A6B0-8EE0-96E0A1018CEA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66819" y="564180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8" name="Group 3727">
                  <a:extLst>
                    <a:ext uri="{FF2B5EF4-FFF2-40B4-BE49-F238E27FC236}">
                      <a16:creationId xmlns:a16="http://schemas.microsoft.com/office/drawing/2014/main" id="{AF661C8A-51F4-5B87-32EE-F46D7522452D}"/>
                    </a:ext>
                  </a:extLst>
                </p:cNvPr>
                <p:cNvGrpSpPr/>
                <p:nvPr/>
              </p:nvGrpSpPr>
              <p:grpSpPr>
                <a:xfrm rot="7122429">
                  <a:off x="5503821" y="1730992"/>
                  <a:ext cx="780865" cy="514456"/>
                  <a:chOff x="2876770" y="239027"/>
                  <a:chExt cx="780865" cy="514456"/>
                </a:xfrm>
              </p:grpSpPr>
              <p:sp>
                <p:nvSpPr>
                  <p:cNvPr id="3741" name="Teardrop 3740">
                    <a:extLst>
                      <a:ext uri="{FF2B5EF4-FFF2-40B4-BE49-F238E27FC236}">
                        <a16:creationId xmlns:a16="http://schemas.microsoft.com/office/drawing/2014/main" id="{0AF31A78-3A78-1A83-830D-DC08BDF053E5}"/>
                      </a:ext>
                    </a:extLst>
                  </p:cNvPr>
                  <p:cNvSpPr/>
                  <p:nvPr/>
                </p:nvSpPr>
                <p:spPr>
                  <a:xfrm rot="6899127">
                    <a:off x="3469253" y="239027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42" name="Teardrop 3741">
                    <a:extLst>
                      <a:ext uri="{FF2B5EF4-FFF2-40B4-BE49-F238E27FC236}">
                        <a16:creationId xmlns:a16="http://schemas.microsoft.com/office/drawing/2014/main" id="{A164C135-6B2D-9CBC-BCCD-B31AF972D21E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76770" y="565101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29" name="Group 3728">
                  <a:extLst>
                    <a:ext uri="{FF2B5EF4-FFF2-40B4-BE49-F238E27FC236}">
                      <a16:creationId xmlns:a16="http://schemas.microsoft.com/office/drawing/2014/main" id="{C7D5B3B4-5FCD-2A6D-EABE-2CACFF20E597}"/>
                    </a:ext>
                  </a:extLst>
                </p:cNvPr>
                <p:cNvGrpSpPr/>
                <p:nvPr/>
              </p:nvGrpSpPr>
              <p:grpSpPr>
                <a:xfrm rot="5229364">
                  <a:off x="5402424" y="1020992"/>
                  <a:ext cx="620806" cy="388343"/>
                  <a:chOff x="3067811" y="247959"/>
                  <a:chExt cx="620806" cy="388343"/>
                </a:xfrm>
              </p:grpSpPr>
              <p:sp>
                <p:nvSpPr>
                  <p:cNvPr id="3738" name="Teardrop 3737">
                    <a:extLst>
                      <a:ext uri="{FF2B5EF4-FFF2-40B4-BE49-F238E27FC236}">
                        <a16:creationId xmlns:a16="http://schemas.microsoft.com/office/drawing/2014/main" id="{9BDAD4C2-870E-9C9F-0094-F52F3818B875}"/>
                      </a:ext>
                    </a:extLst>
                  </p:cNvPr>
                  <p:cNvSpPr/>
                  <p:nvPr/>
                </p:nvSpPr>
                <p:spPr>
                  <a:xfrm rot="7091339">
                    <a:off x="3500235" y="247959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39" name="Teardrop 3738">
                    <a:extLst>
                      <a:ext uri="{FF2B5EF4-FFF2-40B4-BE49-F238E27FC236}">
                        <a16:creationId xmlns:a16="http://schemas.microsoft.com/office/drawing/2014/main" id="{0002FE5B-5955-2482-B862-B0C92D9BA4BA}"/>
                      </a:ext>
                    </a:extLst>
                  </p:cNvPr>
                  <p:cNvSpPr/>
                  <p:nvPr/>
                </p:nvSpPr>
                <p:spPr>
                  <a:xfrm rot="6752909">
                    <a:off x="3281296" y="324114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40" name="Teardrop 3739">
                    <a:extLst>
                      <a:ext uri="{FF2B5EF4-FFF2-40B4-BE49-F238E27FC236}">
                        <a16:creationId xmlns:a16="http://schemas.microsoft.com/office/drawing/2014/main" id="{DD726555-A749-5AB9-5661-6960184C3D1C}"/>
                      </a:ext>
                    </a:extLst>
                  </p:cNvPr>
                  <p:cNvSpPr/>
                  <p:nvPr/>
                </p:nvSpPr>
                <p:spPr>
                  <a:xfrm rot="6285733">
                    <a:off x="3067811" y="447920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30" name="Group 3729">
                  <a:extLst>
                    <a:ext uri="{FF2B5EF4-FFF2-40B4-BE49-F238E27FC236}">
                      <a16:creationId xmlns:a16="http://schemas.microsoft.com/office/drawing/2014/main" id="{7EA30DDD-6982-2FA1-69F0-1C60854197F2}"/>
                    </a:ext>
                  </a:extLst>
                </p:cNvPr>
                <p:cNvGrpSpPr/>
                <p:nvPr/>
              </p:nvGrpSpPr>
              <p:grpSpPr>
                <a:xfrm rot="3554030">
                  <a:off x="4632036" y="180692"/>
                  <a:ext cx="584926" cy="439582"/>
                  <a:chOff x="2880038" y="309770"/>
                  <a:chExt cx="584926" cy="439582"/>
                </a:xfrm>
              </p:grpSpPr>
              <p:grpSp>
                <p:nvGrpSpPr>
                  <p:cNvPr id="3734" name="Group 3733">
                    <a:extLst>
                      <a:ext uri="{FF2B5EF4-FFF2-40B4-BE49-F238E27FC236}">
                        <a16:creationId xmlns:a16="http://schemas.microsoft.com/office/drawing/2014/main" id="{23E27B6F-46F3-2F23-3BA9-8C6DC75FABB3}"/>
                      </a:ext>
                    </a:extLst>
                  </p:cNvPr>
                  <p:cNvGrpSpPr/>
                  <p:nvPr/>
                </p:nvGrpSpPr>
                <p:grpSpPr>
                  <a:xfrm>
                    <a:off x="3068498" y="309770"/>
                    <a:ext cx="396466" cy="301345"/>
                    <a:chOff x="3068498" y="309770"/>
                    <a:chExt cx="396466" cy="301345"/>
                  </a:xfrm>
                </p:grpSpPr>
                <p:sp>
                  <p:nvSpPr>
                    <p:cNvPr id="3736" name="Teardrop 3735">
                      <a:extLst>
                        <a:ext uri="{FF2B5EF4-FFF2-40B4-BE49-F238E27FC236}">
                          <a16:creationId xmlns:a16="http://schemas.microsoft.com/office/drawing/2014/main" id="{72006A3E-1ACF-2AE3-711F-7E1BF78E2F0E}"/>
                        </a:ext>
                      </a:extLst>
                    </p:cNvPr>
                    <p:cNvSpPr/>
                    <p:nvPr/>
                  </p:nvSpPr>
                  <p:spPr>
                    <a:xfrm rot="6657053">
                      <a:off x="3276582" y="309770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37" name="Teardrop 3736">
                      <a:extLst>
                        <a:ext uri="{FF2B5EF4-FFF2-40B4-BE49-F238E27FC236}">
                          <a16:creationId xmlns:a16="http://schemas.microsoft.com/office/drawing/2014/main" id="{04208ED9-6BF1-CE5F-CF34-1C9484AD9180}"/>
                        </a:ext>
                      </a:extLst>
                    </p:cNvPr>
                    <p:cNvSpPr/>
                    <p:nvPr/>
                  </p:nvSpPr>
                  <p:spPr>
                    <a:xfrm rot="6183168">
                      <a:off x="3068498" y="422733"/>
                      <a:ext cx="188382" cy="188382"/>
                    </a:xfrm>
                    <a:prstGeom prst="teardrop">
                      <a:avLst>
                        <a:gd name="adj" fmla="val 151245"/>
                      </a:avLst>
                    </a:prstGeom>
                    <a:gradFill flip="none" rotWithShape="1">
                      <a:gsLst>
                        <a:gs pos="0">
                          <a:srgbClr val="A50021">
                            <a:shade val="30000"/>
                            <a:satMod val="115000"/>
                          </a:srgbClr>
                        </a:gs>
                        <a:gs pos="50000">
                          <a:srgbClr val="A50021">
                            <a:shade val="67500"/>
                            <a:satMod val="115000"/>
                          </a:srgbClr>
                        </a:gs>
                        <a:gs pos="100000">
                          <a:srgbClr val="A50021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735" name="Teardrop 3734">
                    <a:extLst>
                      <a:ext uri="{FF2B5EF4-FFF2-40B4-BE49-F238E27FC236}">
                        <a16:creationId xmlns:a16="http://schemas.microsoft.com/office/drawing/2014/main" id="{FB1C7A5D-F58C-A462-F34B-D5B251021A2D}"/>
                      </a:ext>
                    </a:extLst>
                  </p:cNvPr>
                  <p:cNvSpPr/>
                  <p:nvPr/>
                </p:nvSpPr>
                <p:spPr>
                  <a:xfrm rot="5721802">
                    <a:off x="2880038" y="560970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31" name="Group 3730">
                  <a:extLst>
                    <a:ext uri="{FF2B5EF4-FFF2-40B4-BE49-F238E27FC236}">
                      <a16:creationId xmlns:a16="http://schemas.microsoft.com/office/drawing/2014/main" id="{8743962C-F2FE-BD47-C4DD-C509CDF3ECB5}"/>
                    </a:ext>
                  </a:extLst>
                </p:cNvPr>
                <p:cNvGrpSpPr/>
                <p:nvPr/>
              </p:nvGrpSpPr>
              <p:grpSpPr>
                <a:xfrm rot="1682760">
                  <a:off x="3706906" y="-24324"/>
                  <a:ext cx="816632" cy="532340"/>
                  <a:chOff x="2848500" y="233297"/>
                  <a:chExt cx="816632" cy="532340"/>
                </a:xfrm>
              </p:grpSpPr>
              <p:sp>
                <p:nvSpPr>
                  <p:cNvPr id="3732" name="Teardrop 3731">
                    <a:extLst>
                      <a:ext uri="{FF2B5EF4-FFF2-40B4-BE49-F238E27FC236}">
                        <a16:creationId xmlns:a16="http://schemas.microsoft.com/office/drawing/2014/main" id="{7FAE4BAF-0803-868D-8683-1166C0B82DB5}"/>
                      </a:ext>
                    </a:extLst>
                  </p:cNvPr>
                  <p:cNvSpPr/>
                  <p:nvPr/>
                </p:nvSpPr>
                <p:spPr>
                  <a:xfrm rot="6991918">
                    <a:off x="3476750" y="233297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33" name="Teardrop 3732">
                    <a:extLst>
                      <a:ext uri="{FF2B5EF4-FFF2-40B4-BE49-F238E27FC236}">
                        <a16:creationId xmlns:a16="http://schemas.microsoft.com/office/drawing/2014/main" id="{0FBE90A5-DFAD-56DF-1A11-25F2347724C1}"/>
                      </a:ext>
                    </a:extLst>
                  </p:cNvPr>
                  <p:cNvSpPr/>
                  <p:nvPr/>
                </p:nvSpPr>
                <p:spPr>
                  <a:xfrm rot="5654401">
                    <a:off x="2848500" y="577255"/>
                    <a:ext cx="188382" cy="188382"/>
                  </a:xfrm>
                  <a:prstGeom prst="teardrop">
                    <a:avLst>
                      <a:gd name="adj" fmla="val 151245"/>
                    </a:avLst>
                  </a:prstGeom>
                  <a:gradFill flip="none" rotWithShape="1">
                    <a:gsLst>
                      <a:gs pos="0">
                        <a:srgbClr val="A50021">
                          <a:shade val="30000"/>
                          <a:satMod val="115000"/>
                        </a:srgbClr>
                      </a:gs>
                      <a:gs pos="50000">
                        <a:srgbClr val="A50021">
                          <a:shade val="67500"/>
                          <a:satMod val="115000"/>
                        </a:srgbClr>
                      </a:gs>
                      <a:gs pos="100000">
                        <a:srgbClr val="A50021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60" name="Group 559">
                <a:extLst>
                  <a:ext uri="{FF2B5EF4-FFF2-40B4-BE49-F238E27FC236}">
                    <a16:creationId xmlns:a16="http://schemas.microsoft.com/office/drawing/2014/main" id="{6FFF86AE-C7BF-5E2E-6E5B-D709887A8E47}"/>
                  </a:ext>
                </a:extLst>
              </p:cNvPr>
              <p:cNvGrpSpPr/>
              <p:nvPr/>
            </p:nvGrpSpPr>
            <p:grpSpPr>
              <a:xfrm>
                <a:off x="4808522" y="2975319"/>
                <a:ext cx="1516372" cy="1535756"/>
                <a:chOff x="4808522" y="2975319"/>
                <a:chExt cx="1516372" cy="1535756"/>
              </a:xfrm>
              <a:solidFill>
                <a:srgbClr val="0070C0"/>
              </a:solidFill>
            </p:grpSpPr>
            <p:grpSp>
              <p:nvGrpSpPr>
                <p:cNvPr id="3651" name="Group 3650">
                  <a:extLst>
                    <a:ext uri="{FF2B5EF4-FFF2-40B4-BE49-F238E27FC236}">
                      <a16:creationId xmlns:a16="http://schemas.microsoft.com/office/drawing/2014/main" id="{B64C5177-9B0C-E169-F8F8-419EA8D41E92}"/>
                    </a:ext>
                  </a:extLst>
                </p:cNvPr>
                <p:cNvGrpSpPr/>
                <p:nvPr/>
              </p:nvGrpSpPr>
              <p:grpSpPr>
                <a:xfrm rot="16200000">
                  <a:off x="4571603" y="3604539"/>
                  <a:ext cx="747766" cy="273928"/>
                  <a:chOff x="1991303" y="673757"/>
                  <a:chExt cx="1702420" cy="623644"/>
                </a:xfrm>
                <a:grpFill/>
              </p:grpSpPr>
              <p:grpSp>
                <p:nvGrpSpPr>
                  <p:cNvPr id="3707" name="Group 3706">
                    <a:extLst>
                      <a:ext uri="{FF2B5EF4-FFF2-40B4-BE49-F238E27FC236}">
                        <a16:creationId xmlns:a16="http://schemas.microsoft.com/office/drawing/2014/main" id="{5EB72CA5-5385-B517-D281-36C59D3AE5F7}"/>
                      </a:ext>
                    </a:extLst>
                  </p:cNvPr>
                  <p:cNvGrpSpPr/>
                  <p:nvPr/>
                </p:nvGrpSpPr>
                <p:grpSpPr>
                  <a:xfrm>
                    <a:off x="1991303" y="793572"/>
                    <a:ext cx="535921" cy="503829"/>
                    <a:chOff x="1991303" y="793572"/>
                    <a:chExt cx="535921" cy="503829"/>
                  </a:xfrm>
                  <a:grpFill/>
                </p:grpSpPr>
                <p:sp>
                  <p:nvSpPr>
                    <p:cNvPr id="3716" name="Oval 3715">
                      <a:extLst>
                        <a:ext uri="{FF2B5EF4-FFF2-40B4-BE49-F238E27FC236}">
                          <a16:creationId xmlns:a16="http://schemas.microsoft.com/office/drawing/2014/main" id="{7FBECD23-7BB3-F084-EFDA-D6091C3AE825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91303" y="93261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7" name="Oval 3716">
                      <a:extLst>
                        <a:ext uri="{FF2B5EF4-FFF2-40B4-BE49-F238E27FC236}">
                          <a16:creationId xmlns:a16="http://schemas.microsoft.com/office/drawing/2014/main" id="{9E0CC873-A726-D774-DDBA-2CC42F759473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8" name="Oval 3717">
                      <a:extLst>
                        <a:ext uri="{FF2B5EF4-FFF2-40B4-BE49-F238E27FC236}">
                          <a16:creationId xmlns:a16="http://schemas.microsoft.com/office/drawing/2014/main" id="{82FA3430-55B6-551B-51CC-46678684144D}"/>
                        </a:ext>
                      </a:extLst>
                    </p:cNvPr>
                    <p:cNvSpPr/>
                    <p:nvPr/>
                  </p:nvSpPr>
                  <p:spPr>
                    <a:xfrm rot="20617957">
                      <a:off x="2354890" y="7935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708" name="Group 3707">
                    <a:extLst>
                      <a:ext uri="{FF2B5EF4-FFF2-40B4-BE49-F238E27FC236}">
                        <a16:creationId xmlns:a16="http://schemas.microsoft.com/office/drawing/2014/main" id="{D18949D6-F9F7-6160-BADE-29C807398342}"/>
                      </a:ext>
                    </a:extLst>
                  </p:cNvPr>
                  <p:cNvGrpSpPr/>
                  <p:nvPr/>
                </p:nvGrpSpPr>
                <p:grpSpPr>
                  <a:xfrm rot="2647133">
                    <a:off x="3147386" y="774127"/>
                    <a:ext cx="546337" cy="504957"/>
                    <a:chOff x="1979498" y="805655"/>
                    <a:chExt cx="546337" cy="504957"/>
                  </a:xfrm>
                  <a:grpFill/>
                </p:grpSpPr>
                <p:sp>
                  <p:nvSpPr>
                    <p:cNvPr id="3713" name="Oval 3712">
                      <a:extLst>
                        <a:ext uri="{FF2B5EF4-FFF2-40B4-BE49-F238E27FC236}">
                          <a16:creationId xmlns:a16="http://schemas.microsoft.com/office/drawing/2014/main" id="{F573E211-F4B8-A17F-A474-113CEACE0CA0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79498" y="9458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4" name="Oval 3713">
                      <a:extLst>
                        <a:ext uri="{FF2B5EF4-FFF2-40B4-BE49-F238E27FC236}">
                          <a16:creationId xmlns:a16="http://schemas.microsoft.com/office/drawing/2014/main" id="{0818B355-FE1F-4906-DAEF-9365EA88D4A2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3356" y="863510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5" name="Oval 3714">
                      <a:extLst>
                        <a:ext uri="{FF2B5EF4-FFF2-40B4-BE49-F238E27FC236}">
                          <a16:creationId xmlns:a16="http://schemas.microsoft.com/office/drawing/2014/main" id="{8CF815FA-8588-CAE0-B4FA-B2FFE0F556C0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3501" y="80565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709" name="Group 3708">
                    <a:extLst>
                      <a:ext uri="{FF2B5EF4-FFF2-40B4-BE49-F238E27FC236}">
                        <a16:creationId xmlns:a16="http://schemas.microsoft.com/office/drawing/2014/main" id="{4D7A68FC-B80A-C02E-654B-DD69FF92218A}"/>
                      </a:ext>
                    </a:extLst>
                  </p:cNvPr>
                  <p:cNvGrpSpPr/>
                  <p:nvPr/>
                </p:nvGrpSpPr>
                <p:grpSpPr>
                  <a:xfrm rot="1247309">
                    <a:off x="2565342" y="673757"/>
                    <a:ext cx="543537" cy="502446"/>
                    <a:chOff x="1987646" y="800415"/>
                    <a:chExt cx="543537" cy="502446"/>
                  </a:xfrm>
                  <a:grpFill/>
                </p:grpSpPr>
                <p:sp>
                  <p:nvSpPr>
                    <p:cNvPr id="3710" name="Oval 3709">
                      <a:extLst>
                        <a:ext uri="{FF2B5EF4-FFF2-40B4-BE49-F238E27FC236}">
                          <a16:creationId xmlns:a16="http://schemas.microsoft.com/office/drawing/2014/main" id="{8C4F986D-4616-FFB8-6FF3-1DC758EBBA3A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1" name="Oval 3710">
                      <a:extLst>
                        <a:ext uri="{FF2B5EF4-FFF2-40B4-BE49-F238E27FC236}">
                          <a16:creationId xmlns:a16="http://schemas.microsoft.com/office/drawing/2014/main" id="{4DD8F28D-4009-B253-8458-F0DD6AFED5E7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12" name="Oval 3711">
                      <a:extLst>
                        <a:ext uri="{FF2B5EF4-FFF2-40B4-BE49-F238E27FC236}">
                          <a16:creationId xmlns:a16="http://schemas.microsoft.com/office/drawing/2014/main" id="{11F9A627-66C1-F87B-1796-E86DEF355D44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8849" y="8004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652" name="Group 3651">
                  <a:extLst>
                    <a:ext uri="{FF2B5EF4-FFF2-40B4-BE49-F238E27FC236}">
                      <a16:creationId xmlns:a16="http://schemas.microsoft.com/office/drawing/2014/main" id="{EA20A00F-EF48-766D-408A-DDDCBA201DAC}"/>
                    </a:ext>
                  </a:extLst>
                </p:cNvPr>
                <p:cNvGrpSpPr/>
                <p:nvPr/>
              </p:nvGrpSpPr>
              <p:grpSpPr>
                <a:xfrm rot="10800000">
                  <a:off x="5190814" y="4234749"/>
                  <a:ext cx="745908" cy="276326"/>
                  <a:chOff x="1987646" y="673757"/>
                  <a:chExt cx="1698188" cy="629104"/>
                </a:xfrm>
                <a:grpFill/>
              </p:grpSpPr>
              <p:grpSp>
                <p:nvGrpSpPr>
                  <p:cNvPr id="3695" name="Group 3694">
                    <a:extLst>
                      <a:ext uri="{FF2B5EF4-FFF2-40B4-BE49-F238E27FC236}">
                        <a16:creationId xmlns:a16="http://schemas.microsoft.com/office/drawing/2014/main" id="{BE166939-2F05-C806-D95B-2E4582A1B829}"/>
                      </a:ext>
                    </a:extLst>
                  </p:cNvPr>
                  <p:cNvGrpSpPr/>
                  <p:nvPr/>
                </p:nvGrpSpPr>
                <p:grpSpPr>
                  <a:xfrm>
                    <a:off x="1987646" y="793572"/>
                    <a:ext cx="539578" cy="509289"/>
                    <a:chOff x="1987646" y="793572"/>
                    <a:chExt cx="539578" cy="509289"/>
                  </a:xfrm>
                  <a:grpFill/>
                </p:grpSpPr>
                <p:sp>
                  <p:nvSpPr>
                    <p:cNvPr id="3704" name="Oval 3703">
                      <a:extLst>
                        <a:ext uri="{FF2B5EF4-FFF2-40B4-BE49-F238E27FC236}">
                          <a16:creationId xmlns:a16="http://schemas.microsoft.com/office/drawing/2014/main" id="{921E6630-8AE8-0E3C-B9C5-D30A16BF7841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05" name="Oval 3704">
                      <a:extLst>
                        <a:ext uri="{FF2B5EF4-FFF2-40B4-BE49-F238E27FC236}">
                          <a16:creationId xmlns:a16="http://schemas.microsoft.com/office/drawing/2014/main" id="{420C38D7-4EBD-6A9B-0DAF-A85F5CC8AF39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06" name="Oval 3705">
                      <a:extLst>
                        <a:ext uri="{FF2B5EF4-FFF2-40B4-BE49-F238E27FC236}">
                          <a16:creationId xmlns:a16="http://schemas.microsoft.com/office/drawing/2014/main" id="{21377A94-D546-969D-080F-0BB7BFA3D4E9}"/>
                        </a:ext>
                      </a:extLst>
                    </p:cNvPr>
                    <p:cNvSpPr/>
                    <p:nvPr/>
                  </p:nvSpPr>
                  <p:spPr>
                    <a:xfrm rot="20617957">
                      <a:off x="2354890" y="7935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96" name="Group 3695">
                    <a:extLst>
                      <a:ext uri="{FF2B5EF4-FFF2-40B4-BE49-F238E27FC236}">
                        <a16:creationId xmlns:a16="http://schemas.microsoft.com/office/drawing/2014/main" id="{0789BFBE-7FE6-3099-B697-FBF5AAA18532}"/>
                      </a:ext>
                    </a:extLst>
                  </p:cNvPr>
                  <p:cNvGrpSpPr/>
                  <p:nvPr/>
                </p:nvGrpSpPr>
                <p:grpSpPr>
                  <a:xfrm rot="2647133">
                    <a:off x="3147144" y="780717"/>
                    <a:ext cx="538690" cy="507128"/>
                    <a:chOff x="1985746" y="812910"/>
                    <a:chExt cx="538690" cy="507128"/>
                  </a:xfrm>
                  <a:grpFill/>
                </p:grpSpPr>
                <p:sp>
                  <p:nvSpPr>
                    <p:cNvPr id="3701" name="Oval 3700">
                      <a:extLst>
                        <a:ext uri="{FF2B5EF4-FFF2-40B4-BE49-F238E27FC236}">
                          <a16:creationId xmlns:a16="http://schemas.microsoft.com/office/drawing/2014/main" id="{9EF2E838-5EF5-775E-9D9D-CFEA8AF9F566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5746" y="955249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02" name="Oval 3701">
                      <a:extLst>
                        <a:ext uri="{FF2B5EF4-FFF2-40B4-BE49-F238E27FC236}">
                          <a16:creationId xmlns:a16="http://schemas.microsoft.com/office/drawing/2014/main" id="{22E86871-43E9-A3C6-8288-7B4DB0D8ED2D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3812" y="87419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03" name="Oval 3702">
                      <a:extLst>
                        <a:ext uri="{FF2B5EF4-FFF2-40B4-BE49-F238E27FC236}">
                          <a16:creationId xmlns:a16="http://schemas.microsoft.com/office/drawing/2014/main" id="{F5150DC2-05E1-3B2B-E253-416FDA52FB78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2102" y="812910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97" name="Group 3696">
                    <a:extLst>
                      <a:ext uri="{FF2B5EF4-FFF2-40B4-BE49-F238E27FC236}">
                        <a16:creationId xmlns:a16="http://schemas.microsoft.com/office/drawing/2014/main" id="{AD7B4457-E559-9040-4E90-30D61EFA7E9E}"/>
                      </a:ext>
                    </a:extLst>
                  </p:cNvPr>
                  <p:cNvGrpSpPr/>
                  <p:nvPr/>
                </p:nvGrpSpPr>
                <p:grpSpPr>
                  <a:xfrm rot="1247309">
                    <a:off x="2565342" y="673757"/>
                    <a:ext cx="543537" cy="502446"/>
                    <a:chOff x="1987646" y="800415"/>
                    <a:chExt cx="543537" cy="502446"/>
                  </a:xfrm>
                  <a:grpFill/>
                </p:grpSpPr>
                <p:sp>
                  <p:nvSpPr>
                    <p:cNvPr id="3698" name="Oval 3697">
                      <a:extLst>
                        <a:ext uri="{FF2B5EF4-FFF2-40B4-BE49-F238E27FC236}">
                          <a16:creationId xmlns:a16="http://schemas.microsoft.com/office/drawing/2014/main" id="{C4E59905-CBD9-ECAD-CBB1-9F8F9E1AFCE6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99" name="Oval 3698">
                      <a:extLst>
                        <a:ext uri="{FF2B5EF4-FFF2-40B4-BE49-F238E27FC236}">
                          <a16:creationId xmlns:a16="http://schemas.microsoft.com/office/drawing/2014/main" id="{C2B32C6F-CE0B-327D-FC89-C66783E8BEBB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00" name="Oval 3699">
                      <a:extLst>
                        <a:ext uri="{FF2B5EF4-FFF2-40B4-BE49-F238E27FC236}">
                          <a16:creationId xmlns:a16="http://schemas.microsoft.com/office/drawing/2014/main" id="{D466C194-F8A2-D9BD-436F-77D7908587D9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8849" y="8004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653" name="Group 3652">
                  <a:extLst>
                    <a:ext uri="{FF2B5EF4-FFF2-40B4-BE49-F238E27FC236}">
                      <a16:creationId xmlns:a16="http://schemas.microsoft.com/office/drawing/2014/main" id="{66258768-43F8-A2C4-0D8B-77284FCAED18}"/>
                    </a:ext>
                  </a:extLst>
                </p:cNvPr>
                <p:cNvGrpSpPr/>
                <p:nvPr/>
              </p:nvGrpSpPr>
              <p:grpSpPr>
                <a:xfrm>
                  <a:off x="5198448" y="2975319"/>
                  <a:ext cx="752872" cy="276326"/>
                  <a:chOff x="1987646" y="673757"/>
                  <a:chExt cx="1714044" cy="629104"/>
                </a:xfrm>
                <a:grpFill/>
              </p:grpSpPr>
              <p:grpSp>
                <p:nvGrpSpPr>
                  <p:cNvPr id="3683" name="Group 3682">
                    <a:extLst>
                      <a:ext uri="{FF2B5EF4-FFF2-40B4-BE49-F238E27FC236}">
                        <a16:creationId xmlns:a16="http://schemas.microsoft.com/office/drawing/2014/main" id="{7BF2FC48-C34B-878C-364A-B29EF1854881}"/>
                      </a:ext>
                    </a:extLst>
                  </p:cNvPr>
                  <p:cNvGrpSpPr/>
                  <p:nvPr/>
                </p:nvGrpSpPr>
                <p:grpSpPr>
                  <a:xfrm>
                    <a:off x="1987646" y="793572"/>
                    <a:ext cx="539578" cy="509289"/>
                    <a:chOff x="1987646" y="793572"/>
                    <a:chExt cx="539578" cy="509289"/>
                  </a:xfrm>
                  <a:grpFill/>
                </p:grpSpPr>
                <p:sp>
                  <p:nvSpPr>
                    <p:cNvPr id="3692" name="Oval 3691">
                      <a:extLst>
                        <a:ext uri="{FF2B5EF4-FFF2-40B4-BE49-F238E27FC236}">
                          <a16:creationId xmlns:a16="http://schemas.microsoft.com/office/drawing/2014/main" id="{D40AC268-7324-D4BC-944B-725DD8C597EC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93" name="Oval 3692">
                      <a:extLst>
                        <a:ext uri="{FF2B5EF4-FFF2-40B4-BE49-F238E27FC236}">
                          <a16:creationId xmlns:a16="http://schemas.microsoft.com/office/drawing/2014/main" id="{68D0FBD4-827D-5E1E-06F8-9FBAB7F49D39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94" name="Oval 3693">
                      <a:extLst>
                        <a:ext uri="{FF2B5EF4-FFF2-40B4-BE49-F238E27FC236}">
                          <a16:creationId xmlns:a16="http://schemas.microsoft.com/office/drawing/2014/main" id="{031F1ACF-B1CD-5D46-A51E-49A47596B76B}"/>
                        </a:ext>
                      </a:extLst>
                    </p:cNvPr>
                    <p:cNvSpPr/>
                    <p:nvPr/>
                  </p:nvSpPr>
                  <p:spPr>
                    <a:xfrm rot="20617957">
                      <a:off x="2354890" y="7935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84" name="Group 3683">
                    <a:extLst>
                      <a:ext uri="{FF2B5EF4-FFF2-40B4-BE49-F238E27FC236}">
                        <a16:creationId xmlns:a16="http://schemas.microsoft.com/office/drawing/2014/main" id="{E6CE511A-5AA9-235A-1774-FCB8EFA97332}"/>
                      </a:ext>
                    </a:extLst>
                  </p:cNvPr>
                  <p:cNvGrpSpPr/>
                  <p:nvPr/>
                </p:nvGrpSpPr>
                <p:grpSpPr>
                  <a:xfrm rot="2647133">
                    <a:off x="3158153" y="775417"/>
                    <a:ext cx="543537" cy="502446"/>
                    <a:chOff x="1987646" y="800415"/>
                    <a:chExt cx="543537" cy="502446"/>
                  </a:xfrm>
                  <a:grpFill/>
                </p:grpSpPr>
                <p:sp>
                  <p:nvSpPr>
                    <p:cNvPr id="3689" name="Oval 3688">
                      <a:extLst>
                        <a:ext uri="{FF2B5EF4-FFF2-40B4-BE49-F238E27FC236}">
                          <a16:creationId xmlns:a16="http://schemas.microsoft.com/office/drawing/2014/main" id="{B50DA2CB-9606-C3CC-8A7F-A9DA6FE19265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90" name="Oval 3689">
                      <a:extLst>
                        <a:ext uri="{FF2B5EF4-FFF2-40B4-BE49-F238E27FC236}">
                          <a16:creationId xmlns:a16="http://schemas.microsoft.com/office/drawing/2014/main" id="{C0514E5C-B764-A5C0-4767-3BA18EDB82B1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91" name="Oval 3690">
                      <a:extLst>
                        <a:ext uri="{FF2B5EF4-FFF2-40B4-BE49-F238E27FC236}">
                          <a16:creationId xmlns:a16="http://schemas.microsoft.com/office/drawing/2014/main" id="{0EB7BE03-0713-8BFC-E30C-94DA9C8BAD00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8849" y="8004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85" name="Group 3684">
                    <a:extLst>
                      <a:ext uri="{FF2B5EF4-FFF2-40B4-BE49-F238E27FC236}">
                        <a16:creationId xmlns:a16="http://schemas.microsoft.com/office/drawing/2014/main" id="{EC30EF7A-E8A3-1E2F-31D3-9521090BE4E5}"/>
                      </a:ext>
                    </a:extLst>
                  </p:cNvPr>
                  <p:cNvGrpSpPr/>
                  <p:nvPr/>
                </p:nvGrpSpPr>
                <p:grpSpPr>
                  <a:xfrm rot="1247309">
                    <a:off x="2565342" y="673757"/>
                    <a:ext cx="543537" cy="502446"/>
                    <a:chOff x="1987646" y="800415"/>
                    <a:chExt cx="543537" cy="502446"/>
                  </a:xfrm>
                  <a:grpFill/>
                </p:grpSpPr>
                <p:sp>
                  <p:nvSpPr>
                    <p:cNvPr id="3686" name="Oval 3685">
                      <a:extLst>
                        <a:ext uri="{FF2B5EF4-FFF2-40B4-BE49-F238E27FC236}">
                          <a16:creationId xmlns:a16="http://schemas.microsoft.com/office/drawing/2014/main" id="{446D8458-6622-F89C-017F-717D180050EC}"/>
                        </a:ext>
                      </a:extLst>
                    </p:cNvPr>
                    <p:cNvSpPr/>
                    <p:nvPr/>
                  </p:nvSpPr>
                  <p:spPr>
                    <a:xfrm rot="19835667">
                      <a:off x="1987646" y="938072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87" name="Oval 3686">
                      <a:extLst>
                        <a:ext uri="{FF2B5EF4-FFF2-40B4-BE49-F238E27FC236}">
                          <a16:creationId xmlns:a16="http://schemas.microsoft.com/office/drawing/2014/main" id="{61D89236-3400-B5F6-2D89-EDB224CF446D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88" name="Oval 3687">
                      <a:extLst>
                        <a:ext uri="{FF2B5EF4-FFF2-40B4-BE49-F238E27FC236}">
                          <a16:creationId xmlns:a16="http://schemas.microsoft.com/office/drawing/2014/main" id="{010DCAE9-02B1-9079-F814-DCBEFAE2F2A3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8849" y="8004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654" name="Group 3653">
                  <a:extLst>
                    <a:ext uri="{FF2B5EF4-FFF2-40B4-BE49-F238E27FC236}">
                      <a16:creationId xmlns:a16="http://schemas.microsoft.com/office/drawing/2014/main" id="{A1E1554C-424D-DAC8-1DBF-CAFD46E90CDE}"/>
                    </a:ext>
                  </a:extLst>
                </p:cNvPr>
                <p:cNvGrpSpPr/>
                <p:nvPr/>
              </p:nvGrpSpPr>
              <p:grpSpPr>
                <a:xfrm rot="5400000">
                  <a:off x="5818928" y="3616094"/>
                  <a:ext cx="747200" cy="264733"/>
                  <a:chOff x="1997320" y="675377"/>
                  <a:chExt cx="1701130" cy="602710"/>
                </a:xfrm>
                <a:grpFill/>
              </p:grpSpPr>
              <p:grpSp>
                <p:nvGrpSpPr>
                  <p:cNvPr id="3671" name="Group 3670">
                    <a:extLst>
                      <a:ext uri="{FF2B5EF4-FFF2-40B4-BE49-F238E27FC236}">
                        <a16:creationId xmlns:a16="http://schemas.microsoft.com/office/drawing/2014/main" id="{1AC97046-E051-C5D4-4039-3C43BF22C4DD}"/>
                      </a:ext>
                    </a:extLst>
                  </p:cNvPr>
                  <p:cNvGrpSpPr/>
                  <p:nvPr/>
                </p:nvGrpSpPr>
                <p:grpSpPr>
                  <a:xfrm>
                    <a:off x="1997320" y="759166"/>
                    <a:ext cx="540936" cy="517429"/>
                    <a:chOff x="1997320" y="759166"/>
                    <a:chExt cx="540936" cy="517429"/>
                  </a:xfrm>
                  <a:grpFill/>
                </p:grpSpPr>
                <p:sp>
                  <p:nvSpPr>
                    <p:cNvPr id="3680" name="Oval 3679">
                      <a:extLst>
                        <a:ext uri="{FF2B5EF4-FFF2-40B4-BE49-F238E27FC236}">
                          <a16:creationId xmlns:a16="http://schemas.microsoft.com/office/drawing/2014/main" id="{AFDAE31E-8143-0B18-47AB-7622A156550B}"/>
                        </a:ext>
                      </a:extLst>
                    </p:cNvPr>
                    <p:cNvSpPr/>
                    <p:nvPr/>
                  </p:nvSpPr>
                  <p:spPr>
                    <a:xfrm rot="20154817">
                      <a:off x="1997320" y="911806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81" name="Oval 3680">
                      <a:extLst>
                        <a:ext uri="{FF2B5EF4-FFF2-40B4-BE49-F238E27FC236}">
                          <a16:creationId xmlns:a16="http://schemas.microsoft.com/office/drawing/2014/main" id="{D0E98927-45FD-C2CB-F23C-89A41C16C1E3}"/>
                        </a:ext>
                      </a:extLst>
                    </p:cNvPr>
                    <p:cNvSpPr/>
                    <p:nvPr/>
                  </p:nvSpPr>
                  <p:spPr>
                    <a:xfrm rot="20653880">
                      <a:off x="2177503" y="818074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82" name="Oval 3681">
                      <a:extLst>
                        <a:ext uri="{FF2B5EF4-FFF2-40B4-BE49-F238E27FC236}">
                          <a16:creationId xmlns:a16="http://schemas.microsoft.com/office/drawing/2014/main" id="{D44BAA35-0426-12BB-67D4-268FF0B4E909}"/>
                        </a:ext>
                      </a:extLst>
                    </p:cNvPr>
                    <p:cNvSpPr/>
                    <p:nvPr/>
                  </p:nvSpPr>
                  <p:spPr>
                    <a:xfrm rot="20957550">
                      <a:off x="2365922" y="759166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72" name="Group 3671">
                    <a:extLst>
                      <a:ext uri="{FF2B5EF4-FFF2-40B4-BE49-F238E27FC236}">
                        <a16:creationId xmlns:a16="http://schemas.microsoft.com/office/drawing/2014/main" id="{DF8887EA-16EC-AD68-CE65-E1BBE757BE2E}"/>
                      </a:ext>
                    </a:extLst>
                  </p:cNvPr>
                  <p:cNvGrpSpPr/>
                  <p:nvPr/>
                </p:nvGrpSpPr>
                <p:grpSpPr>
                  <a:xfrm rot="2647133">
                    <a:off x="3152559" y="753643"/>
                    <a:ext cx="545891" cy="524444"/>
                    <a:chOff x="1975798" y="784755"/>
                    <a:chExt cx="545891" cy="524444"/>
                  </a:xfrm>
                  <a:grpFill/>
                </p:grpSpPr>
                <p:sp>
                  <p:nvSpPr>
                    <p:cNvPr id="3677" name="Oval 3676">
                      <a:extLst>
                        <a:ext uri="{FF2B5EF4-FFF2-40B4-BE49-F238E27FC236}">
                          <a16:creationId xmlns:a16="http://schemas.microsoft.com/office/drawing/2014/main" id="{6DD4653F-929D-E3A6-210F-ECAED7E5985A}"/>
                        </a:ext>
                      </a:extLst>
                    </p:cNvPr>
                    <p:cNvSpPr/>
                    <p:nvPr/>
                  </p:nvSpPr>
                  <p:spPr>
                    <a:xfrm rot="19793195">
                      <a:off x="1975798" y="944410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78" name="Oval 3677">
                      <a:extLst>
                        <a:ext uri="{FF2B5EF4-FFF2-40B4-BE49-F238E27FC236}">
                          <a16:creationId xmlns:a16="http://schemas.microsoft.com/office/drawing/2014/main" id="{4F6ED61F-3218-3D79-B11A-303E443D3127}"/>
                        </a:ext>
                      </a:extLst>
                    </p:cNvPr>
                    <p:cNvSpPr/>
                    <p:nvPr/>
                  </p:nvSpPr>
                  <p:spPr>
                    <a:xfrm rot="20110040">
                      <a:off x="2160157" y="86624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79" name="Oval 3678">
                      <a:extLst>
                        <a:ext uri="{FF2B5EF4-FFF2-40B4-BE49-F238E27FC236}">
                          <a16:creationId xmlns:a16="http://schemas.microsoft.com/office/drawing/2014/main" id="{1111F1BD-87FB-C0A3-EB76-272FB8536A84}"/>
                        </a:ext>
                      </a:extLst>
                    </p:cNvPr>
                    <p:cNvSpPr/>
                    <p:nvPr/>
                  </p:nvSpPr>
                  <p:spPr>
                    <a:xfrm rot="20598034">
                      <a:off x="2349355" y="78475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673" name="Group 3672">
                    <a:extLst>
                      <a:ext uri="{FF2B5EF4-FFF2-40B4-BE49-F238E27FC236}">
                        <a16:creationId xmlns:a16="http://schemas.microsoft.com/office/drawing/2014/main" id="{32E11E42-7123-B488-F6F8-FCA4E1E8C2BF}"/>
                      </a:ext>
                    </a:extLst>
                  </p:cNvPr>
                  <p:cNvGrpSpPr/>
                  <p:nvPr/>
                </p:nvGrpSpPr>
                <p:grpSpPr>
                  <a:xfrm rot="1247309">
                    <a:off x="2574172" y="675377"/>
                    <a:ext cx="535704" cy="495389"/>
                    <a:chOff x="1995479" y="800415"/>
                    <a:chExt cx="535704" cy="495389"/>
                  </a:xfrm>
                  <a:grpFill/>
                </p:grpSpPr>
                <p:sp>
                  <p:nvSpPr>
                    <p:cNvPr id="3674" name="Oval 3673">
                      <a:extLst>
                        <a:ext uri="{FF2B5EF4-FFF2-40B4-BE49-F238E27FC236}">
                          <a16:creationId xmlns:a16="http://schemas.microsoft.com/office/drawing/2014/main" id="{1CF5E2B9-980E-7A6B-D4BE-52BDADB0BD48}"/>
                        </a:ext>
                      </a:extLst>
                    </p:cNvPr>
                    <p:cNvSpPr/>
                    <p:nvPr/>
                  </p:nvSpPr>
                  <p:spPr>
                    <a:xfrm rot="19982481">
                      <a:off x="1995479" y="9310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75" name="Oval 3674">
                      <a:extLst>
                        <a:ext uri="{FF2B5EF4-FFF2-40B4-BE49-F238E27FC236}">
                          <a16:creationId xmlns:a16="http://schemas.microsoft.com/office/drawing/2014/main" id="{C6ED9FEC-D8D2-B30E-9957-CE6A2E173928}"/>
                        </a:ext>
                      </a:extLst>
                    </p:cNvPr>
                    <p:cNvSpPr/>
                    <p:nvPr/>
                  </p:nvSpPr>
                  <p:spPr>
                    <a:xfrm rot="20279576">
                      <a:off x="2168765" y="853323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76" name="Oval 3675">
                      <a:extLst>
                        <a:ext uri="{FF2B5EF4-FFF2-40B4-BE49-F238E27FC236}">
                          <a16:creationId xmlns:a16="http://schemas.microsoft.com/office/drawing/2014/main" id="{9434A874-1027-54AE-DFAF-875C2B53E82E}"/>
                        </a:ext>
                      </a:extLst>
                    </p:cNvPr>
                    <p:cNvSpPr/>
                    <p:nvPr/>
                  </p:nvSpPr>
                  <p:spPr>
                    <a:xfrm rot="20823807">
                      <a:off x="2358849" y="800415"/>
                      <a:ext cx="172334" cy="364789"/>
                    </a:xfrm>
                    <a:prstGeom prst="ellipse">
                      <a:avLst/>
                    </a:pr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655" name="Group 3654">
                  <a:extLst>
                    <a:ext uri="{FF2B5EF4-FFF2-40B4-BE49-F238E27FC236}">
                      <a16:creationId xmlns:a16="http://schemas.microsoft.com/office/drawing/2014/main" id="{8F5F5361-2C16-CED0-A613-2CCC41C535C8}"/>
                    </a:ext>
                  </a:extLst>
                </p:cNvPr>
                <p:cNvGrpSpPr/>
                <p:nvPr/>
              </p:nvGrpSpPr>
              <p:grpSpPr>
                <a:xfrm>
                  <a:off x="5943398" y="3135448"/>
                  <a:ext cx="233749" cy="237961"/>
                  <a:chOff x="6918555" y="2757293"/>
                  <a:chExt cx="532171" cy="541759"/>
                </a:xfrm>
                <a:grpFill/>
              </p:grpSpPr>
              <p:sp>
                <p:nvSpPr>
                  <p:cNvPr id="3668" name="Oval 3667">
                    <a:extLst>
                      <a:ext uri="{FF2B5EF4-FFF2-40B4-BE49-F238E27FC236}">
                        <a16:creationId xmlns:a16="http://schemas.microsoft.com/office/drawing/2014/main" id="{F4BB2D4F-7F48-C4F3-ECB8-D901ADF702D8}"/>
                      </a:ext>
                    </a:extLst>
                  </p:cNvPr>
                  <p:cNvSpPr/>
                  <p:nvPr/>
                </p:nvSpPr>
                <p:spPr>
                  <a:xfrm rot="2451569">
                    <a:off x="6918555" y="2757293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9" name="Oval 3668">
                    <a:extLst>
                      <a:ext uri="{FF2B5EF4-FFF2-40B4-BE49-F238E27FC236}">
                        <a16:creationId xmlns:a16="http://schemas.microsoft.com/office/drawing/2014/main" id="{51F963EA-9593-A82F-7C29-F5493C89945B}"/>
                      </a:ext>
                    </a:extLst>
                  </p:cNvPr>
                  <p:cNvSpPr/>
                  <p:nvPr/>
                </p:nvSpPr>
                <p:spPr>
                  <a:xfrm rot="2705213">
                    <a:off x="7058219" y="2887011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70" name="Oval 3669">
                    <a:extLst>
                      <a:ext uri="{FF2B5EF4-FFF2-40B4-BE49-F238E27FC236}">
                        <a16:creationId xmlns:a16="http://schemas.microsoft.com/office/drawing/2014/main" id="{9999A3B8-413E-5BF8-E884-BA94F024A22A}"/>
                      </a:ext>
                    </a:extLst>
                  </p:cNvPr>
                  <p:cNvSpPr/>
                  <p:nvPr/>
                </p:nvSpPr>
                <p:spPr>
                  <a:xfrm rot="3422900">
                    <a:off x="7182165" y="3030490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656" name="Group 3655">
                  <a:extLst>
                    <a:ext uri="{FF2B5EF4-FFF2-40B4-BE49-F238E27FC236}">
                      <a16:creationId xmlns:a16="http://schemas.microsoft.com/office/drawing/2014/main" id="{4D4E9EC4-442D-CFEB-18A0-79F277BEF465}"/>
                    </a:ext>
                  </a:extLst>
                </p:cNvPr>
                <p:cNvGrpSpPr/>
                <p:nvPr/>
              </p:nvGrpSpPr>
              <p:grpSpPr>
                <a:xfrm rot="5191674">
                  <a:off x="5932841" y="4108945"/>
                  <a:ext cx="233749" cy="237961"/>
                  <a:chOff x="6918555" y="2757293"/>
                  <a:chExt cx="532171" cy="541759"/>
                </a:xfrm>
                <a:grpFill/>
              </p:grpSpPr>
              <p:sp>
                <p:nvSpPr>
                  <p:cNvPr id="3665" name="Oval 3664">
                    <a:extLst>
                      <a:ext uri="{FF2B5EF4-FFF2-40B4-BE49-F238E27FC236}">
                        <a16:creationId xmlns:a16="http://schemas.microsoft.com/office/drawing/2014/main" id="{E26DD50E-E016-7C1D-039C-06FAB8AC7059}"/>
                      </a:ext>
                    </a:extLst>
                  </p:cNvPr>
                  <p:cNvSpPr/>
                  <p:nvPr/>
                </p:nvSpPr>
                <p:spPr>
                  <a:xfrm rot="2451569">
                    <a:off x="6918555" y="2757293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6" name="Oval 3665">
                    <a:extLst>
                      <a:ext uri="{FF2B5EF4-FFF2-40B4-BE49-F238E27FC236}">
                        <a16:creationId xmlns:a16="http://schemas.microsoft.com/office/drawing/2014/main" id="{D1E0756E-7BB6-EF3A-531E-A13F53A802E1}"/>
                      </a:ext>
                    </a:extLst>
                  </p:cNvPr>
                  <p:cNvSpPr/>
                  <p:nvPr/>
                </p:nvSpPr>
                <p:spPr>
                  <a:xfrm rot="2705213">
                    <a:off x="7058219" y="2887011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7" name="Oval 3666">
                    <a:extLst>
                      <a:ext uri="{FF2B5EF4-FFF2-40B4-BE49-F238E27FC236}">
                        <a16:creationId xmlns:a16="http://schemas.microsoft.com/office/drawing/2014/main" id="{2574D3C4-29CF-5986-DC44-513BBC656255}"/>
                      </a:ext>
                    </a:extLst>
                  </p:cNvPr>
                  <p:cNvSpPr/>
                  <p:nvPr/>
                </p:nvSpPr>
                <p:spPr>
                  <a:xfrm rot="3422900">
                    <a:off x="7182165" y="3030490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657" name="Group 3656">
                  <a:extLst>
                    <a:ext uri="{FF2B5EF4-FFF2-40B4-BE49-F238E27FC236}">
                      <a16:creationId xmlns:a16="http://schemas.microsoft.com/office/drawing/2014/main" id="{CC6B7F7B-11C4-E61A-3EB9-BF8E6A285F44}"/>
                    </a:ext>
                  </a:extLst>
                </p:cNvPr>
                <p:cNvGrpSpPr/>
                <p:nvPr/>
              </p:nvGrpSpPr>
              <p:grpSpPr>
                <a:xfrm rot="10800000">
                  <a:off x="4958418" y="4116858"/>
                  <a:ext cx="233749" cy="237961"/>
                  <a:chOff x="6918555" y="2757293"/>
                  <a:chExt cx="532171" cy="541759"/>
                </a:xfrm>
                <a:grpFill/>
              </p:grpSpPr>
              <p:sp>
                <p:nvSpPr>
                  <p:cNvPr id="3662" name="Oval 3661">
                    <a:extLst>
                      <a:ext uri="{FF2B5EF4-FFF2-40B4-BE49-F238E27FC236}">
                        <a16:creationId xmlns:a16="http://schemas.microsoft.com/office/drawing/2014/main" id="{2E4D1388-7F27-953B-2649-219307505725}"/>
                      </a:ext>
                    </a:extLst>
                  </p:cNvPr>
                  <p:cNvSpPr/>
                  <p:nvPr/>
                </p:nvSpPr>
                <p:spPr>
                  <a:xfrm rot="2451569">
                    <a:off x="6918555" y="2757293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3" name="Oval 3662">
                    <a:extLst>
                      <a:ext uri="{FF2B5EF4-FFF2-40B4-BE49-F238E27FC236}">
                        <a16:creationId xmlns:a16="http://schemas.microsoft.com/office/drawing/2014/main" id="{F66A9C92-5E1D-5BDE-3128-52BF2B58EBCB}"/>
                      </a:ext>
                    </a:extLst>
                  </p:cNvPr>
                  <p:cNvSpPr/>
                  <p:nvPr/>
                </p:nvSpPr>
                <p:spPr>
                  <a:xfrm rot="2705213">
                    <a:off x="7058219" y="2887011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4" name="Oval 3663">
                    <a:extLst>
                      <a:ext uri="{FF2B5EF4-FFF2-40B4-BE49-F238E27FC236}">
                        <a16:creationId xmlns:a16="http://schemas.microsoft.com/office/drawing/2014/main" id="{0F60A0EB-3509-B3BE-A275-0CF874C63D85}"/>
                      </a:ext>
                    </a:extLst>
                  </p:cNvPr>
                  <p:cNvSpPr/>
                  <p:nvPr/>
                </p:nvSpPr>
                <p:spPr>
                  <a:xfrm rot="3422900">
                    <a:off x="7182165" y="3030490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658" name="Group 3657">
                  <a:extLst>
                    <a:ext uri="{FF2B5EF4-FFF2-40B4-BE49-F238E27FC236}">
                      <a16:creationId xmlns:a16="http://schemas.microsoft.com/office/drawing/2014/main" id="{BBACFCCF-76E0-B073-8123-E99EBD866044}"/>
                    </a:ext>
                  </a:extLst>
                </p:cNvPr>
                <p:cNvGrpSpPr/>
                <p:nvPr/>
              </p:nvGrpSpPr>
              <p:grpSpPr>
                <a:xfrm rot="16200000">
                  <a:off x="4969614" y="3140089"/>
                  <a:ext cx="233749" cy="237961"/>
                  <a:chOff x="6918555" y="2757293"/>
                  <a:chExt cx="532171" cy="541759"/>
                </a:xfrm>
                <a:grpFill/>
              </p:grpSpPr>
              <p:sp>
                <p:nvSpPr>
                  <p:cNvPr id="3659" name="Oval 3658">
                    <a:extLst>
                      <a:ext uri="{FF2B5EF4-FFF2-40B4-BE49-F238E27FC236}">
                        <a16:creationId xmlns:a16="http://schemas.microsoft.com/office/drawing/2014/main" id="{01392F7C-B774-A6F2-B250-0B52DC6BA62F}"/>
                      </a:ext>
                    </a:extLst>
                  </p:cNvPr>
                  <p:cNvSpPr/>
                  <p:nvPr/>
                </p:nvSpPr>
                <p:spPr>
                  <a:xfrm rot="2451569">
                    <a:off x="6918555" y="2757293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0" name="Oval 3659">
                    <a:extLst>
                      <a:ext uri="{FF2B5EF4-FFF2-40B4-BE49-F238E27FC236}">
                        <a16:creationId xmlns:a16="http://schemas.microsoft.com/office/drawing/2014/main" id="{A27A6170-80C6-A8AD-2A18-A216AF937A77}"/>
                      </a:ext>
                    </a:extLst>
                  </p:cNvPr>
                  <p:cNvSpPr/>
                  <p:nvPr/>
                </p:nvSpPr>
                <p:spPr>
                  <a:xfrm rot="2705213">
                    <a:off x="7058219" y="2887011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61" name="Oval 3660">
                    <a:extLst>
                      <a:ext uri="{FF2B5EF4-FFF2-40B4-BE49-F238E27FC236}">
                        <a16:creationId xmlns:a16="http://schemas.microsoft.com/office/drawing/2014/main" id="{A52997AE-1330-55BB-C89E-88696CB211C3}"/>
                      </a:ext>
                    </a:extLst>
                  </p:cNvPr>
                  <p:cNvSpPr/>
                  <p:nvPr/>
                </p:nvSpPr>
                <p:spPr>
                  <a:xfrm rot="3422900">
                    <a:off x="7182165" y="3030490"/>
                    <a:ext cx="172334" cy="364789"/>
                  </a:xfrm>
                  <a:prstGeom prst="ellipse">
                    <a:avLst/>
                  </a:prstGeom>
                  <a:grpFill/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61" name="Group 560">
                <a:extLst>
                  <a:ext uri="{FF2B5EF4-FFF2-40B4-BE49-F238E27FC236}">
                    <a16:creationId xmlns:a16="http://schemas.microsoft.com/office/drawing/2014/main" id="{376066EB-A335-B69C-68C0-75F10D9A9C75}"/>
                  </a:ext>
                </a:extLst>
              </p:cNvPr>
              <p:cNvGrpSpPr/>
              <p:nvPr/>
            </p:nvGrpSpPr>
            <p:grpSpPr>
              <a:xfrm>
                <a:off x="5401954" y="3548984"/>
                <a:ext cx="354580" cy="437024"/>
                <a:chOff x="5619244" y="3639522"/>
                <a:chExt cx="873279" cy="1076325"/>
              </a:xfrm>
            </p:grpSpPr>
            <p:grpSp>
              <p:nvGrpSpPr>
                <p:cNvPr id="3450" name="Group 3449">
                  <a:extLst>
                    <a:ext uri="{FF2B5EF4-FFF2-40B4-BE49-F238E27FC236}">
                      <a16:creationId xmlns:a16="http://schemas.microsoft.com/office/drawing/2014/main" id="{E194CFBD-4A3A-1C93-7B21-F9F599E2DB37}"/>
                    </a:ext>
                  </a:extLst>
                </p:cNvPr>
                <p:cNvGrpSpPr/>
                <p:nvPr/>
              </p:nvGrpSpPr>
              <p:grpSpPr>
                <a:xfrm>
                  <a:off x="5692240" y="3990255"/>
                  <a:ext cx="727287" cy="263705"/>
                  <a:chOff x="867704" y="2005998"/>
                  <a:chExt cx="1008754" cy="365761"/>
                </a:xfrm>
              </p:grpSpPr>
              <p:grpSp>
                <p:nvGrpSpPr>
                  <p:cNvPr id="3570" name="Group 3569">
                    <a:extLst>
                      <a:ext uri="{FF2B5EF4-FFF2-40B4-BE49-F238E27FC236}">
                        <a16:creationId xmlns:a16="http://schemas.microsoft.com/office/drawing/2014/main" id="{2C16FC70-FEE7-9C9F-756A-B6CE54244108}"/>
                      </a:ext>
                    </a:extLst>
                  </p:cNvPr>
                  <p:cNvGrpSpPr/>
                  <p:nvPr/>
                </p:nvGrpSpPr>
                <p:grpSpPr>
                  <a:xfrm>
                    <a:off x="867704" y="2005998"/>
                    <a:ext cx="1004339" cy="80077"/>
                    <a:chOff x="471861" y="2316558"/>
                    <a:chExt cx="19574040" cy="1558174"/>
                  </a:xfrm>
                </p:grpSpPr>
                <p:sp>
                  <p:nvSpPr>
                    <p:cNvPr id="3625" name="Parallelogram 53">
                      <a:extLst>
                        <a:ext uri="{FF2B5EF4-FFF2-40B4-BE49-F238E27FC236}">
                          <a16:creationId xmlns:a16="http://schemas.microsoft.com/office/drawing/2014/main" id="{5BD117FB-50E4-2A73-7C91-30A00BBC668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6" name="Parallelogram 53">
                      <a:extLst>
                        <a:ext uri="{FF2B5EF4-FFF2-40B4-BE49-F238E27FC236}">
                          <a16:creationId xmlns:a16="http://schemas.microsoft.com/office/drawing/2014/main" id="{BBDC35AC-9FDA-542F-B317-188C321B535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7" name="Parallelogram 53">
                      <a:extLst>
                        <a:ext uri="{FF2B5EF4-FFF2-40B4-BE49-F238E27FC236}">
                          <a16:creationId xmlns:a16="http://schemas.microsoft.com/office/drawing/2014/main" id="{02FA128F-961A-57CD-9A42-B5527E2FD89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8" name="Parallelogram 53">
                      <a:extLst>
                        <a:ext uri="{FF2B5EF4-FFF2-40B4-BE49-F238E27FC236}">
                          <a16:creationId xmlns:a16="http://schemas.microsoft.com/office/drawing/2014/main" id="{8F6FE035-D537-316F-A167-A9B08AD38A7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9" name="Parallelogram 53">
                      <a:extLst>
                        <a:ext uri="{FF2B5EF4-FFF2-40B4-BE49-F238E27FC236}">
                          <a16:creationId xmlns:a16="http://schemas.microsoft.com/office/drawing/2014/main" id="{EF22097A-0F29-767D-5FD2-746F07655E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0" name="Parallelogram 53">
                      <a:extLst>
                        <a:ext uri="{FF2B5EF4-FFF2-40B4-BE49-F238E27FC236}">
                          <a16:creationId xmlns:a16="http://schemas.microsoft.com/office/drawing/2014/main" id="{9B1816B6-E975-606C-54EA-74AE086D593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1" name="Parallelogram 53">
                      <a:extLst>
                        <a:ext uri="{FF2B5EF4-FFF2-40B4-BE49-F238E27FC236}">
                          <a16:creationId xmlns:a16="http://schemas.microsoft.com/office/drawing/2014/main" id="{5F8C4822-75CD-AE81-6B35-7284668335E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2" name="Parallelogram 53">
                      <a:extLst>
                        <a:ext uri="{FF2B5EF4-FFF2-40B4-BE49-F238E27FC236}">
                          <a16:creationId xmlns:a16="http://schemas.microsoft.com/office/drawing/2014/main" id="{6657B083-57D0-D8AB-4DAB-3A13CBC4B431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3" name="Parallelogram 53">
                      <a:extLst>
                        <a:ext uri="{FF2B5EF4-FFF2-40B4-BE49-F238E27FC236}">
                          <a16:creationId xmlns:a16="http://schemas.microsoft.com/office/drawing/2014/main" id="{184CF86D-2237-3E76-6529-474D7E86378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4" name="Parallelogram 53">
                      <a:extLst>
                        <a:ext uri="{FF2B5EF4-FFF2-40B4-BE49-F238E27FC236}">
                          <a16:creationId xmlns:a16="http://schemas.microsoft.com/office/drawing/2014/main" id="{921726C8-1A0F-ECDF-B19F-1457B3DCA71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5" name="Parallelogram 53">
                      <a:extLst>
                        <a:ext uri="{FF2B5EF4-FFF2-40B4-BE49-F238E27FC236}">
                          <a16:creationId xmlns:a16="http://schemas.microsoft.com/office/drawing/2014/main" id="{CEBB00D0-1380-3F4C-EEB3-CDB76993B56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6" name="Parallelogram 53">
                      <a:extLst>
                        <a:ext uri="{FF2B5EF4-FFF2-40B4-BE49-F238E27FC236}">
                          <a16:creationId xmlns:a16="http://schemas.microsoft.com/office/drawing/2014/main" id="{5EF34721-E3FA-2E21-67D9-67B4C07DFB6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7" name="Parallelogram 53">
                      <a:extLst>
                        <a:ext uri="{FF2B5EF4-FFF2-40B4-BE49-F238E27FC236}">
                          <a16:creationId xmlns:a16="http://schemas.microsoft.com/office/drawing/2014/main" id="{F6F02B04-8320-F5E6-D9B6-664C51227CD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8" name="Parallelogram 53">
                      <a:extLst>
                        <a:ext uri="{FF2B5EF4-FFF2-40B4-BE49-F238E27FC236}">
                          <a16:creationId xmlns:a16="http://schemas.microsoft.com/office/drawing/2014/main" id="{55187636-CE84-5DF4-20D9-F21A88C3B2C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39" name="Parallelogram 53">
                      <a:extLst>
                        <a:ext uri="{FF2B5EF4-FFF2-40B4-BE49-F238E27FC236}">
                          <a16:creationId xmlns:a16="http://schemas.microsoft.com/office/drawing/2014/main" id="{3F007167-F5E6-7687-D987-1AD4729DC82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0" name="Parallelogram 53">
                      <a:extLst>
                        <a:ext uri="{FF2B5EF4-FFF2-40B4-BE49-F238E27FC236}">
                          <a16:creationId xmlns:a16="http://schemas.microsoft.com/office/drawing/2014/main" id="{5C385DE8-6D73-96B3-6CBA-846273FD5D8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1" name="Parallelogram 53">
                      <a:extLst>
                        <a:ext uri="{FF2B5EF4-FFF2-40B4-BE49-F238E27FC236}">
                          <a16:creationId xmlns:a16="http://schemas.microsoft.com/office/drawing/2014/main" id="{CF4182BC-3BDC-35D6-B113-3E27A44DD91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2" name="Parallelogram 53">
                      <a:extLst>
                        <a:ext uri="{FF2B5EF4-FFF2-40B4-BE49-F238E27FC236}">
                          <a16:creationId xmlns:a16="http://schemas.microsoft.com/office/drawing/2014/main" id="{A23461A1-E4D3-AD34-EBB3-88DE42D004C8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3" name="Parallelogram 53">
                      <a:extLst>
                        <a:ext uri="{FF2B5EF4-FFF2-40B4-BE49-F238E27FC236}">
                          <a16:creationId xmlns:a16="http://schemas.microsoft.com/office/drawing/2014/main" id="{2F1A5855-4176-8989-C4AC-7AF1FA90D81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4" name="Parallelogram 53">
                      <a:extLst>
                        <a:ext uri="{FF2B5EF4-FFF2-40B4-BE49-F238E27FC236}">
                          <a16:creationId xmlns:a16="http://schemas.microsoft.com/office/drawing/2014/main" id="{3950630D-876E-9F4F-1907-2308D157D646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5" name="Parallelogram 53">
                      <a:extLst>
                        <a:ext uri="{FF2B5EF4-FFF2-40B4-BE49-F238E27FC236}">
                          <a16:creationId xmlns:a16="http://schemas.microsoft.com/office/drawing/2014/main" id="{47302EE4-B99D-1A8B-5768-6FED65B6F8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6" name="Parallelogram 53">
                      <a:extLst>
                        <a:ext uri="{FF2B5EF4-FFF2-40B4-BE49-F238E27FC236}">
                          <a16:creationId xmlns:a16="http://schemas.microsoft.com/office/drawing/2014/main" id="{D8A04C98-33BE-71A0-DC29-0D87517F7A5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7" name="Parallelogram 53">
                      <a:extLst>
                        <a:ext uri="{FF2B5EF4-FFF2-40B4-BE49-F238E27FC236}">
                          <a16:creationId xmlns:a16="http://schemas.microsoft.com/office/drawing/2014/main" id="{259E2533-8DBC-F5C7-7520-4AF2657EABC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8" name="Parallelogram 53">
                      <a:extLst>
                        <a:ext uri="{FF2B5EF4-FFF2-40B4-BE49-F238E27FC236}">
                          <a16:creationId xmlns:a16="http://schemas.microsoft.com/office/drawing/2014/main" id="{29878EB7-51BC-60CD-AC14-72DE1DC1E5E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49" name="Parallelogram 53">
                      <a:extLst>
                        <a:ext uri="{FF2B5EF4-FFF2-40B4-BE49-F238E27FC236}">
                          <a16:creationId xmlns:a16="http://schemas.microsoft.com/office/drawing/2014/main" id="{F9C95455-58C2-903B-9C37-470B95AD4F1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50" name="Parallelogram 53">
                      <a:extLst>
                        <a:ext uri="{FF2B5EF4-FFF2-40B4-BE49-F238E27FC236}">
                          <a16:creationId xmlns:a16="http://schemas.microsoft.com/office/drawing/2014/main" id="{5F3098BE-4F9D-A757-8533-48F22B64ACF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571" name="Group 3570">
                    <a:extLst>
                      <a:ext uri="{FF2B5EF4-FFF2-40B4-BE49-F238E27FC236}">
                        <a16:creationId xmlns:a16="http://schemas.microsoft.com/office/drawing/2014/main" id="{2F7D6DBA-ED40-00B9-E8AA-FE41B9009547}"/>
                      </a:ext>
                    </a:extLst>
                  </p:cNvPr>
                  <p:cNvGrpSpPr/>
                  <p:nvPr/>
                </p:nvGrpSpPr>
                <p:grpSpPr>
                  <a:xfrm>
                    <a:off x="868680" y="2148840"/>
                    <a:ext cx="1004339" cy="80077"/>
                    <a:chOff x="471861" y="2316558"/>
                    <a:chExt cx="19574040" cy="1558174"/>
                  </a:xfrm>
                </p:grpSpPr>
                <p:sp>
                  <p:nvSpPr>
                    <p:cNvPr id="3599" name="Parallelogram 53">
                      <a:extLst>
                        <a:ext uri="{FF2B5EF4-FFF2-40B4-BE49-F238E27FC236}">
                          <a16:creationId xmlns:a16="http://schemas.microsoft.com/office/drawing/2014/main" id="{6DE4008B-D448-707F-769B-313FB75A539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0" name="Parallelogram 53">
                      <a:extLst>
                        <a:ext uri="{FF2B5EF4-FFF2-40B4-BE49-F238E27FC236}">
                          <a16:creationId xmlns:a16="http://schemas.microsoft.com/office/drawing/2014/main" id="{0F1D140E-B703-9A38-7168-8CE7B244758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1" name="Parallelogram 53">
                      <a:extLst>
                        <a:ext uri="{FF2B5EF4-FFF2-40B4-BE49-F238E27FC236}">
                          <a16:creationId xmlns:a16="http://schemas.microsoft.com/office/drawing/2014/main" id="{19E73C0A-656A-A940-EC34-9585672F51D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2" name="Parallelogram 53">
                      <a:extLst>
                        <a:ext uri="{FF2B5EF4-FFF2-40B4-BE49-F238E27FC236}">
                          <a16:creationId xmlns:a16="http://schemas.microsoft.com/office/drawing/2014/main" id="{28035D1E-28A7-D1D0-7C04-71F6D53E6E4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3" name="Parallelogram 53">
                      <a:extLst>
                        <a:ext uri="{FF2B5EF4-FFF2-40B4-BE49-F238E27FC236}">
                          <a16:creationId xmlns:a16="http://schemas.microsoft.com/office/drawing/2014/main" id="{70B6E5DA-E0B3-703C-47AB-779685C45C2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4" name="Parallelogram 53">
                      <a:extLst>
                        <a:ext uri="{FF2B5EF4-FFF2-40B4-BE49-F238E27FC236}">
                          <a16:creationId xmlns:a16="http://schemas.microsoft.com/office/drawing/2014/main" id="{BA39BFC0-B984-1D22-0176-8518D75D289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5" name="Parallelogram 53">
                      <a:extLst>
                        <a:ext uri="{FF2B5EF4-FFF2-40B4-BE49-F238E27FC236}">
                          <a16:creationId xmlns:a16="http://schemas.microsoft.com/office/drawing/2014/main" id="{0864FD03-1476-BAEE-8B5F-60D0FF8D3C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6" name="Parallelogram 53">
                      <a:extLst>
                        <a:ext uri="{FF2B5EF4-FFF2-40B4-BE49-F238E27FC236}">
                          <a16:creationId xmlns:a16="http://schemas.microsoft.com/office/drawing/2014/main" id="{7B2020C2-5545-9967-EA34-95E6C1E7AE8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7" name="Parallelogram 53">
                      <a:extLst>
                        <a:ext uri="{FF2B5EF4-FFF2-40B4-BE49-F238E27FC236}">
                          <a16:creationId xmlns:a16="http://schemas.microsoft.com/office/drawing/2014/main" id="{D4352524-4786-174D-C814-E0064876317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8" name="Parallelogram 53">
                      <a:extLst>
                        <a:ext uri="{FF2B5EF4-FFF2-40B4-BE49-F238E27FC236}">
                          <a16:creationId xmlns:a16="http://schemas.microsoft.com/office/drawing/2014/main" id="{4FE41BFF-2EC0-3615-EF95-11F865AED62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09" name="Parallelogram 53">
                      <a:extLst>
                        <a:ext uri="{FF2B5EF4-FFF2-40B4-BE49-F238E27FC236}">
                          <a16:creationId xmlns:a16="http://schemas.microsoft.com/office/drawing/2014/main" id="{F4D8A753-E510-E677-D234-0250C7633D0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0" name="Parallelogram 53">
                      <a:extLst>
                        <a:ext uri="{FF2B5EF4-FFF2-40B4-BE49-F238E27FC236}">
                          <a16:creationId xmlns:a16="http://schemas.microsoft.com/office/drawing/2014/main" id="{189EAA9B-F428-2F23-287F-223B4C55298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1" name="Parallelogram 53">
                      <a:extLst>
                        <a:ext uri="{FF2B5EF4-FFF2-40B4-BE49-F238E27FC236}">
                          <a16:creationId xmlns:a16="http://schemas.microsoft.com/office/drawing/2014/main" id="{79E98BC0-C1DE-1EC0-E14E-E4BB29A58C7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2" name="Parallelogram 53">
                      <a:extLst>
                        <a:ext uri="{FF2B5EF4-FFF2-40B4-BE49-F238E27FC236}">
                          <a16:creationId xmlns:a16="http://schemas.microsoft.com/office/drawing/2014/main" id="{5A144E7B-6BE8-46C8-12C7-EE4A77B5FBB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3" name="Parallelogram 53">
                      <a:extLst>
                        <a:ext uri="{FF2B5EF4-FFF2-40B4-BE49-F238E27FC236}">
                          <a16:creationId xmlns:a16="http://schemas.microsoft.com/office/drawing/2014/main" id="{1F0F618E-8462-4A5A-E937-580E6B5D094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4" name="Parallelogram 53">
                      <a:extLst>
                        <a:ext uri="{FF2B5EF4-FFF2-40B4-BE49-F238E27FC236}">
                          <a16:creationId xmlns:a16="http://schemas.microsoft.com/office/drawing/2014/main" id="{A77799FD-7355-019F-B889-F63A9F38101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5" name="Parallelogram 53">
                      <a:extLst>
                        <a:ext uri="{FF2B5EF4-FFF2-40B4-BE49-F238E27FC236}">
                          <a16:creationId xmlns:a16="http://schemas.microsoft.com/office/drawing/2014/main" id="{3BA92F20-9F16-AC6C-7543-A6F0E97A596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6" name="Parallelogram 53">
                      <a:extLst>
                        <a:ext uri="{FF2B5EF4-FFF2-40B4-BE49-F238E27FC236}">
                          <a16:creationId xmlns:a16="http://schemas.microsoft.com/office/drawing/2014/main" id="{EC2DD05F-794C-9A11-82C7-E34DDE81B9E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7" name="Parallelogram 53">
                      <a:extLst>
                        <a:ext uri="{FF2B5EF4-FFF2-40B4-BE49-F238E27FC236}">
                          <a16:creationId xmlns:a16="http://schemas.microsoft.com/office/drawing/2014/main" id="{610A37AC-4701-8414-9CA3-B3483FA619F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8" name="Parallelogram 53">
                      <a:extLst>
                        <a:ext uri="{FF2B5EF4-FFF2-40B4-BE49-F238E27FC236}">
                          <a16:creationId xmlns:a16="http://schemas.microsoft.com/office/drawing/2014/main" id="{1341035E-2C63-86F5-4A89-A0D1AFA2CFE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19" name="Parallelogram 53">
                      <a:extLst>
                        <a:ext uri="{FF2B5EF4-FFF2-40B4-BE49-F238E27FC236}">
                          <a16:creationId xmlns:a16="http://schemas.microsoft.com/office/drawing/2014/main" id="{DFE411DC-30E0-9B1C-5C3E-2CD8EE87F99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0" name="Parallelogram 53">
                      <a:extLst>
                        <a:ext uri="{FF2B5EF4-FFF2-40B4-BE49-F238E27FC236}">
                          <a16:creationId xmlns:a16="http://schemas.microsoft.com/office/drawing/2014/main" id="{598E4AB8-7A71-DC83-A4D8-6785678D76A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1" name="Parallelogram 53">
                      <a:extLst>
                        <a:ext uri="{FF2B5EF4-FFF2-40B4-BE49-F238E27FC236}">
                          <a16:creationId xmlns:a16="http://schemas.microsoft.com/office/drawing/2014/main" id="{2CD70F14-FF8F-3B51-5903-F1C60C1DDE4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2" name="Parallelogram 53">
                      <a:extLst>
                        <a:ext uri="{FF2B5EF4-FFF2-40B4-BE49-F238E27FC236}">
                          <a16:creationId xmlns:a16="http://schemas.microsoft.com/office/drawing/2014/main" id="{5D1ACFF8-B428-EBDB-59C5-8D800DCD316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3" name="Parallelogram 53">
                      <a:extLst>
                        <a:ext uri="{FF2B5EF4-FFF2-40B4-BE49-F238E27FC236}">
                          <a16:creationId xmlns:a16="http://schemas.microsoft.com/office/drawing/2014/main" id="{D2445951-8796-5ABF-399D-E8EA63B4941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24" name="Parallelogram 53">
                      <a:extLst>
                        <a:ext uri="{FF2B5EF4-FFF2-40B4-BE49-F238E27FC236}">
                          <a16:creationId xmlns:a16="http://schemas.microsoft.com/office/drawing/2014/main" id="{D3A7BB57-5FEC-F5DD-A8E8-404AF130C7D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572" name="Group 3571">
                    <a:extLst>
                      <a:ext uri="{FF2B5EF4-FFF2-40B4-BE49-F238E27FC236}">
                        <a16:creationId xmlns:a16="http://schemas.microsoft.com/office/drawing/2014/main" id="{BF828100-AAF5-671D-EF58-2AC16D1A2555}"/>
                      </a:ext>
                    </a:extLst>
                  </p:cNvPr>
                  <p:cNvGrpSpPr/>
                  <p:nvPr/>
                </p:nvGrpSpPr>
                <p:grpSpPr>
                  <a:xfrm>
                    <a:off x="872119" y="2291682"/>
                    <a:ext cx="1004339" cy="80077"/>
                    <a:chOff x="471861" y="2316558"/>
                    <a:chExt cx="19574040" cy="1558174"/>
                  </a:xfrm>
                </p:grpSpPr>
                <p:sp>
                  <p:nvSpPr>
                    <p:cNvPr id="3573" name="Parallelogram 53">
                      <a:extLst>
                        <a:ext uri="{FF2B5EF4-FFF2-40B4-BE49-F238E27FC236}">
                          <a16:creationId xmlns:a16="http://schemas.microsoft.com/office/drawing/2014/main" id="{5F7185AE-79C0-6300-9634-9FDC1FFC612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4" name="Parallelogram 53">
                      <a:extLst>
                        <a:ext uri="{FF2B5EF4-FFF2-40B4-BE49-F238E27FC236}">
                          <a16:creationId xmlns:a16="http://schemas.microsoft.com/office/drawing/2014/main" id="{43C5DBFD-4291-69A3-A60E-6CE305E7421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5" name="Parallelogram 53">
                      <a:extLst>
                        <a:ext uri="{FF2B5EF4-FFF2-40B4-BE49-F238E27FC236}">
                          <a16:creationId xmlns:a16="http://schemas.microsoft.com/office/drawing/2014/main" id="{174B2250-A59A-B314-06DF-6F24600AADB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6" name="Parallelogram 53">
                      <a:extLst>
                        <a:ext uri="{FF2B5EF4-FFF2-40B4-BE49-F238E27FC236}">
                          <a16:creationId xmlns:a16="http://schemas.microsoft.com/office/drawing/2014/main" id="{40EEF784-2E5C-3AE8-95F3-71E3520AF0B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7" name="Parallelogram 53">
                      <a:extLst>
                        <a:ext uri="{FF2B5EF4-FFF2-40B4-BE49-F238E27FC236}">
                          <a16:creationId xmlns:a16="http://schemas.microsoft.com/office/drawing/2014/main" id="{22E5E8BD-43F7-1C6F-E86A-1DE76E2FE5A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8" name="Parallelogram 53">
                      <a:extLst>
                        <a:ext uri="{FF2B5EF4-FFF2-40B4-BE49-F238E27FC236}">
                          <a16:creationId xmlns:a16="http://schemas.microsoft.com/office/drawing/2014/main" id="{D16477D2-2C27-6694-7303-F6CC5ADBA34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79" name="Parallelogram 53">
                      <a:extLst>
                        <a:ext uri="{FF2B5EF4-FFF2-40B4-BE49-F238E27FC236}">
                          <a16:creationId xmlns:a16="http://schemas.microsoft.com/office/drawing/2014/main" id="{81DB2EB6-915A-A923-3464-233624EE6FC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0" name="Parallelogram 53">
                      <a:extLst>
                        <a:ext uri="{FF2B5EF4-FFF2-40B4-BE49-F238E27FC236}">
                          <a16:creationId xmlns:a16="http://schemas.microsoft.com/office/drawing/2014/main" id="{053B7D58-43F3-80B3-5EAC-A0867B383AA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1" name="Parallelogram 53">
                      <a:extLst>
                        <a:ext uri="{FF2B5EF4-FFF2-40B4-BE49-F238E27FC236}">
                          <a16:creationId xmlns:a16="http://schemas.microsoft.com/office/drawing/2014/main" id="{DA8BC000-6D90-6EF0-9BE1-EBFF9E38285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2" name="Parallelogram 53">
                      <a:extLst>
                        <a:ext uri="{FF2B5EF4-FFF2-40B4-BE49-F238E27FC236}">
                          <a16:creationId xmlns:a16="http://schemas.microsoft.com/office/drawing/2014/main" id="{977BD58E-6565-7904-EFD6-E722B6CD0E9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3" name="Parallelogram 53">
                      <a:extLst>
                        <a:ext uri="{FF2B5EF4-FFF2-40B4-BE49-F238E27FC236}">
                          <a16:creationId xmlns:a16="http://schemas.microsoft.com/office/drawing/2014/main" id="{63FB22E1-1865-6437-2062-114BE00D637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4" name="Parallelogram 53">
                      <a:extLst>
                        <a:ext uri="{FF2B5EF4-FFF2-40B4-BE49-F238E27FC236}">
                          <a16:creationId xmlns:a16="http://schemas.microsoft.com/office/drawing/2014/main" id="{17C89613-C6C3-9186-8B08-6A4372BEE5B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5" name="Parallelogram 53">
                      <a:extLst>
                        <a:ext uri="{FF2B5EF4-FFF2-40B4-BE49-F238E27FC236}">
                          <a16:creationId xmlns:a16="http://schemas.microsoft.com/office/drawing/2014/main" id="{D3FDCE9A-E56B-6595-7CF3-464982F8584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6" name="Parallelogram 53">
                      <a:extLst>
                        <a:ext uri="{FF2B5EF4-FFF2-40B4-BE49-F238E27FC236}">
                          <a16:creationId xmlns:a16="http://schemas.microsoft.com/office/drawing/2014/main" id="{EDD98E10-D1AF-086F-D53A-256AEAF3700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7" name="Parallelogram 53">
                      <a:extLst>
                        <a:ext uri="{FF2B5EF4-FFF2-40B4-BE49-F238E27FC236}">
                          <a16:creationId xmlns:a16="http://schemas.microsoft.com/office/drawing/2014/main" id="{4AB891B8-124C-943F-10C8-F047771916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8" name="Parallelogram 53">
                      <a:extLst>
                        <a:ext uri="{FF2B5EF4-FFF2-40B4-BE49-F238E27FC236}">
                          <a16:creationId xmlns:a16="http://schemas.microsoft.com/office/drawing/2014/main" id="{B2191130-AA8F-9297-1B71-CA4FF62702D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89" name="Parallelogram 53">
                      <a:extLst>
                        <a:ext uri="{FF2B5EF4-FFF2-40B4-BE49-F238E27FC236}">
                          <a16:creationId xmlns:a16="http://schemas.microsoft.com/office/drawing/2014/main" id="{CF275832-FF5E-7B92-FD72-31EB89E9469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0" name="Parallelogram 53">
                      <a:extLst>
                        <a:ext uri="{FF2B5EF4-FFF2-40B4-BE49-F238E27FC236}">
                          <a16:creationId xmlns:a16="http://schemas.microsoft.com/office/drawing/2014/main" id="{771D7734-59D9-E835-FA84-D3242C8F3AD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1" name="Parallelogram 53">
                      <a:extLst>
                        <a:ext uri="{FF2B5EF4-FFF2-40B4-BE49-F238E27FC236}">
                          <a16:creationId xmlns:a16="http://schemas.microsoft.com/office/drawing/2014/main" id="{EEB3DFD6-FC09-DED8-60AA-8447507D577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2" name="Parallelogram 53">
                      <a:extLst>
                        <a:ext uri="{FF2B5EF4-FFF2-40B4-BE49-F238E27FC236}">
                          <a16:creationId xmlns:a16="http://schemas.microsoft.com/office/drawing/2014/main" id="{D253D892-E3F5-C85F-EA27-7546FD738F9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3" name="Parallelogram 53">
                      <a:extLst>
                        <a:ext uri="{FF2B5EF4-FFF2-40B4-BE49-F238E27FC236}">
                          <a16:creationId xmlns:a16="http://schemas.microsoft.com/office/drawing/2014/main" id="{220A0F52-2974-33C7-B806-C32A89342B6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4" name="Parallelogram 53">
                      <a:extLst>
                        <a:ext uri="{FF2B5EF4-FFF2-40B4-BE49-F238E27FC236}">
                          <a16:creationId xmlns:a16="http://schemas.microsoft.com/office/drawing/2014/main" id="{55F78A9E-3697-BD0A-B915-9019FAEE9AE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5" name="Parallelogram 53">
                      <a:extLst>
                        <a:ext uri="{FF2B5EF4-FFF2-40B4-BE49-F238E27FC236}">
                          <a16:creationId xmlns:a16="http://schemas.microsoft.com/office/drawing/2014/main" id="{29541050-4D7E-0200-E854-0EBF2B2892C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6" name="Parallelogram 53">
                      <a:extLst>
                        <a:ext uri="{FF2B5EF4-FFF2-40B4-BE49-F238E27FC236}">
                          <a16:creationId xmlns:a16="http://schemas.microsoft.com/office/drawing/2014/main" id="{2836BC14-6336-F74E-B7CA-B5662D0CAE7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7" name="Parallelogram 53">
                      <a:extLst>
                        <a:ext uri="{FF2B5EF4-FFF2-40B4-BE49-F238E27FC236}">
                          <a16:creationId xmlns:a16="http://schemas.microsoft.com/office/drawing/2014/main" id="{D06A471B-07A4-C5BA-B0E9-D340AA63F25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98" name="Parallelogram 53">
                      <a:extLst>
                        <a:ext uri="{FF2B5EF4-FFF2-40B4-BE49-F238E27FC236}">
                          <a16:creationId xmlns:a16="http://schemas.microsoft.com/office/drawing/2014/main" id="{A544BABE-BF23-B4B7-6860-20EB72B19D3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451" name="Group 3450">
                  <a:extLst>
                    <a:ext uri="{FF2B5EF4-FFF2-40B4-BE49-F238E27FC236}">
                      <a16:creationId xmlns:a16="http://schemas.microsoft.com/office/drawing/2014/main" id="{C0E5D76A-5F48-FBF3-F54D-348ACD49E166}"/>
                    </a:ext>
                  </a:extLst>
                </p:cNvPr>
                <p:cNvGrpSpPr/>
                <p:nvPr/>
              </p:nvGrpSpPr>
              <p:grpSpPr>
                <a:xfrm>
                  <a:off x="5619244" y="3639522"/>
                  <a:ext cx="873279" cy="256022"/>
                  <a:chOff x="1790672" y="1646194"/>
                  <a:chExt cx="1211247" cy="355105"/>
                </a:xfrm>
              </p:grpSpPr>
              <p:grpSp>
                <p:nvGrpSpPr>
                  <p:cNvPr id="3471" name="Group 3470">
                    <a:extLst>
                      <a:ext uri="{FF2B5EF4-FFF2-40B4-BE49-F238E27FC236}">
                        <a16:creationId xmlns:a16="http://schemas.microsoft.com/office/drawing/2014/main" id="{E9C4369F-AFA4-D235-A82F-95C0D4F616D7}"/>
                      </a:ext>
                    </a:extLst>
                  </p:cNvPr>
                  <p:cNvGrpSpPr/>
                  <p:nvPr/>
                </p:nvGrpSpPr>
                <p:grpSpPr>
                  <a:xfrm>
                    <a:off x="1790672" y="1646194"/>
                    <a:ext cx="1211247" cy="80077"/>
                    <a:chOff x="471861" y="2316558"/>
                    <a:chExt cx="23606582" cy="1558174"/>
                  </a:xfrm>
                  <a:solidFill>
                    <a:schemeClr val="accent6"/>
                  </a:solidFill>
                </p:grpSpPr>
                <p:sp>
                  <p:nvSpPr>
                    <p:cNvPr id="3538" name="Parallelogram 53">
                      <a:extLst>
                        <a:ext uri="{FF2B5EF4-FFF2-40B4-BE49-F238E27FC236}">
                          <a16:creationId xmlns:a16="http://schemas.microsoft.com/office/drawing/2014/main" id="{FD7E480A-EB1C-F9FB-9CCE-03ED8C45C3A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9" name="Parallelogram 53">
                      <a:extLst>
                        <a:ext uri="{FF2B5EF4-FFF2-40B4-BE49-F238E27FC236}">
                          <a16:creationId xmlns:a16="http://schemas.microsoft.com/office/drawing/2014/main" id="{EC8A7E0C-8E23-AB0B-EDBD-D53C5BC8D21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0" name="Parallelogram 53">
                      <a:extLst>
                        <a:ext uri="{FF2B5EF4-FFF2-40B4-BE49-F238E27FC236}">
                          <a16:creationId xmlns:a16="http://schemas.microsoft.com/office/drawing/2014/main" id="{F720F1FB-63AB-F98C-1437-37789339BBD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1" name="Parallelogram 53">
                      <a:extLst>
                        <a:ext uri="{FF2B5EF4-FFF2-40B4-BE49-F238E27FC236}">
                          <a16:creationId xmlns:a16="http://schemas.microsoft.com/office/drawing/2014/main" id="{26B8564B-86E9-C00C-1F4D-6AC5C68BF7D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2" name="Parallelogram 53">
                      <a:extLst>
                        <a:ext uri="{FF2B5EF4-FFF2-40B4-BE49-F238E27FC236}">
                          <a16:creationId xmlns:a16="http://schemas.microsoft.com/office/drawing/2014/main" id="{1E767E1D-741F-1F1A-A707-1D5C673029D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3" name="Parallelogram 53">
                      <a:extLst>
                        <a:ext uri="{FF2B5EF4-FFF2-40B4-BE49-F238E27FC236}">
                          <a16:creationId xmlns:a16="http://schemas.microsoft.com/office/drawing/2014/main" id="{8E02A34D-062B-6FCD-037D-9D956FD291A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4" name="Parallelogram 53">
                      <a:extLst>
                        <a:ext uri="{FF2B5EF4-FFF2-40B4-BE49-F238E27FC236}">
                          <a16:creationId xmlns:a16="http://schemas.microsoft.com/office/drawing/2014/main" id="{95E85BB4-D61B-996B-6FEE-74EDC7BA8D9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5" name="Parallelogram 53">
                      <a:extLst>
                        <a:ext uri="{FF2B5EF4-FFF2-40B4-BE49-F238E27FC236}">
                          <a16:creationId xmlns:a16="http://schemas.microsoft.com/office/drawing/2014/main" id="{520A03FA-09A0-F427-D2A2-4059859B7E1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6" name="Parallelogram 53">
                      <a:extLst>
                        <a:ext uri="{FF2B5EF4-FFF2-40B4-BE49-F238E27FC236}">
                          <a16:creationId xmlns:a16="http://schemas.microsoft.com/office/drawing/2014/main" id="{5CCA1411-5478-F7D8-436B-206D47B9795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7" name="Parallelogram 53">
                      <a:extLst>
                        <a:ext uri="{FF2B5EF4-FFF2-40B4-BE49-F238E27FC236}">
                          <a16:creationId xmlns:a16="http://schemas.microsoft.com/office/drawing/2014/main" id="{F699A09A-3AD6-420D-38ED-0C6E1A37987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8" name="Parallelogram 53">
                      <a:extLst>
                        <a:ext uri="{FF2B5EF4-FFF2-40B4-BE49-F238E27FC236}">
                          <a16:creationId xmlns:a16="http://schemas.microsoft.com/office/drawing/2014/main" id="{E02A10DE-6689-5F93-BB0F-03D00CB354C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49" name="Parallelogram 53">
                      <a:extLst>
                        <a:ext uri="{FF2B5EF4-FFF2-40B4-BE49-F238E27FC236}">
                          <a16:creationId xmlns:a16="http://schemas.microsoft.com/office/drawing/2014/main" id="{4758F611-F658-1ACE-8BC9-E30F3A377C0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0" name="Parallelogram 53">
                      <a:extLst>
                        <a:ext uri="{FF2B5EF4-FFF2-40B4-BE49-F238E27FC236}">
                          <a16:creationId xmlns:a16="http://schemas.microsoft.com/office/drawing/2014/main" id="{E14E7962-6488-5547-92C4-0487A755988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1" name="Parallelogram 53">
                      <a:extLst>
                        <a:ext uri="{FF2B5EF4-FFF2-40B4-BE49-F238E27FC236}">
                          <a16:creationId xmlns:a16="http://schemas.microsoft.com/office/drawing/2014/main" id="{58A53DFB-E44F-3B61-0565-574F11AECD1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2" name="Parallelogram 53">
                      <a:extLst>
                        <a:ext uri="{FF2B5EF4-FFF2-40B4-BE49-F238E27FC236}">
                          <a16:creationId xmlns:a16="http://schemas.microsoft.com/office/drawing/2014/main" id="{FAA05B3B-C94F-C5FF-107D-6A55080243E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94766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3" name="Parallelogram 53">
                      <a:extLst>
                        <a:ext uri="{FF2B5EF4-FFF2-40B4-BE49-F238E27FC236}">
                          <a16:creationId xmlns:a16="http://schemas.microsoft.com/office/drawing/2014/main" id="{1F0EAB37-A9B0-27A9-B769-93AC9B87814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082539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4" name="Parallelogram 53">
                      <a:extLst>
                        <a:ext uri="{FF2B5EF4-FFF2-40B4-BE49-F238E27FC236}">
                          <a16:creationId xmlns:a16="http://schemas.microsoft.com/office/drawing/2014/main" id="{777E8DF9-B815-CDD5-074B-9351081006D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5" name="Parallelogram 53">
                      <a:extLst>
                        <a:ext uri="{FF2B5EF4-FFF2-40B4-BE49-F238E27FC236}">
                          <a16:creationId xmlns:a16="http://schemas.microsoft.com/office/drawing/2014/main" id="{D9629FCA-07E0-FBD0-C1B3-EB7C81C7709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6" name="Parallelogram 53">
                      <a:extLst>
                        <a:ext uri="{FF2B5EF4-FFF2-40B4-BE49-F238E27FC236}">
                          <a16:creationId xmlns:a16="http://schemas.microsoft.com/office/drawing/2014/main" id="{660D1226-EEE2-0A02-D19F-E129D3E5D1D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7" name="Parallelogram 53">
                      <a:extLst>
                        <a:ext uri="{FF2B5EF4-FFF2-40B4-BE49-F238E27FC236}">
                          <a16:creationId xmlns:a16="http://schemas.microsoft.com/office/drawing/2014/main" id="{00E177B6-5201-0780-8A19-3A5CE864811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8" name="Parallelogram 53">
                      <a:extLst>
                        <a:ext uri="{FF2B5EF4-FFF2-40B4-BE49-F238E27FC236}">
                          <a16:creationId xmlns:a16="http://schemas.microsoft.com/office/drawing/2014/main" id="{6DB027DD-698B-690B-55D7-1D4A8CBA1B1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59" name="Parallelogram 53">
                      <a:extLst>
                        <a:ext uri="{FF2B5EF4-FFF2-40B4-BE49-F238E27FC236}">
                          <a16:creationId xmlns:a16="http://schemas.microsoft.com/office/drawing/2014/main" id="{E0AE20CA-5AF6-2ED1-4E60-AC615F46E74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0" name="Parallelogram 53">
                      <a:extLst>
                        <a:ext uri="{FF2B5EF4-FFF2-40B4-BE49-F238E27FC236}">
                          <a16:creationId xmlns:a16="http://schemas.microsoft.com/office/drawing/2014/main" id="{88D95163-54D2-D7C5-8B51-87A24F7B01D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1" name="Parallelogram 53">
                      <a:extLst>
                        <a:ext uri="{FF2B5EF4-FFF2-40B4-BE49-F238E27FC236}">
                          <a16:creationId xmlns:a16="http://schemas.microsoft.com/office/drawing/2014/main" id="{164B074E-C908-1DFE-E904-8C9EEC62DF7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2" name="Parallelogram 53">
                      <a:extLst>
                        <a:ext uri="{FF2B5EF4-FFF2-40B4-BE49-F238E27FC236}">
                          <a16:creationId xmlns:a16="http://schemas.microsoft.com/office/drawing/2014/main" id="{3E09E1BB-9BA4-4E7C-7AF8-E9890648018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3" name="Parallelogram 53">
                      <a:extLst>
                        <a:ext uri="{FF2B5EF4-FFF2-40B4-BE49-F238E27FC236}">
                          <a16:creationId xmlns:a16="http://schemas.microsoft.com/office/drawing/2014/main" id="{54F62C30-DF74-DD26-C768-9B1C4B23F4E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4" name="Parallelogram 53">
                      <a:extLst>
                        <a:ext uri="{FF2B5EF4-FFF2-40B4-BE49-F238E27FC236}">
                          <a16:creationId xmlns:a16="http://schemas.microsoft.com/office/drawing/2014/main" id="{F6FCCA78-F5D3-B408-E452-E8DC7294CDA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5" name="Parallelogram 53">
                      <a:extLst>
                        <a:ext uri="{FF2B5EF4-FFF2-40B4-BE49-F238E27FC236}">
                          <a16:creationId xmlns:a16="http://schemas.microsoft.com/office/drawing/2014/main" id="{EB380BA4-EB0E-8551-9CE8-05C7A55A02DA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6" name="Parallelogram 53">
                      <a:extLst>
                        <a:ext uri="{FF2B5EF4-FFF2-40B4-BE49-F238E27FC236}">
                          <a16:creationId xmlns:a16="http://schemas.microsoft.com/office/drawing/2014/main" id="{3550A8C0-1DCB-988E-8662-40578879A4F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80792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7" name="Parallelogram 53">
                      <a:extLst>
                        <a:ext uri="{FF2B5EF4-FFF2-40B4-BE49-F238E27FC236}">
                          <a16:creationId xmlns:a16="http://schemas.microsoft.com/office/drawing/2014/main" id="{562139D5-403E-4D9E-F604-326B2023CA7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942799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8" name="Parallelogram 53">
                      <a:extLst>
                        <a:ext uri="{FF2B5EF4-FFF2-40B4-BE49-F238E27FC236}">
                          <a16:creationId xmlns:a16="http://schemas.microsoft.com/office/drawing/2014/main" id="{9D4876EC-3D04-9479-1909-33FA914373B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7942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69" name="Parallelogram 53">
                      <a:extLst>
                        <a:ext uri="{FF2B5EF4-FFF2-40B4-BE49-F238E27FC236}">
                          <a16:creationId xmlns:a16="http://schemas.microsoft.com/office/drawing/2014/main" id="{93FBB33B-59CA-2ABF-4AEC-1DBEFE655D0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214296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472" name="Group 3471">
                    <a:extLst>
                      <a:ext uri="{FF2B5EF4-FFF2-40B4-BE49-F238E27FC236}">
                        <a16:creationId xmlns:a16="http://schemas.microsoft.com/office/drawing/2014/main" id="{FD9370B7-B66D-F8E0-1841-0B5B910FF199}"/>
                      </a:ext>
                    </a:extLst>
                  </p:cNvPr>
                  <p:cNvGrpSpPr/>
                  <p:nvPr/>
                </p:nvGrpSpPr>
                <p:grpSpPr>
                  <a:xfrm>
                    <a:off x="1790672" y="1783080"/>
                    <a:ext cx="1211247" cy="80077"/>
                    <a:chOff x="471861" y="2316558"/>
                    <a:chExt cx="23606582" cy="1558174"/>
                  </a:xfrm>
                  <a:solidFill>
                    <a:schemeClr val="accent6"/>
                  </a:solidFill>
                </p:grpSpPr>
                <p:sp>
                  <p:nvSpPr>
                    <p:cNvPr id="3506" name="Parallelogram 53">
                      <a:extLst>
                        <a:ext uri="{FF2B5EF4-FFF2-40B4-BE49-F238E27FC236}">
                          <a16:creationId xmlns:a16="http://schemas.microsoft.com/office/drawing/2014/main" id="{DC97C4DA-A2A8-CBB5-A931-54E17E520B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7" name="Parallelogram 53">
                      <a:extLst>
                        <a:ext uri="{FF2B5EF4-FFF2-40B4-BE49-F238E27FC236}">
                          <a16:creationId xmlns:a16="http://schemas.microsoft.com/office/drawing/2014/main" id="{8D741796-5969-121C-5D17-673BA31F1C5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8" name="Parallelogram 53">
                      <a:extLst>
                        <a:ext uri="{FF2B5EF4-FFF2-40B4-BE49-F238E27FC236}">
                          <a16:creationId xmlns:a16="http://schemas.microsoft.com/office/drawing/2014/main" id="{D5185752-6A27-8E49-57DF-887B1BF630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9" name="Parallelogram 53">
                      <a:extLst>
                        <a:ext uri="{FF2B5EF4-FFF2-40B4-BE49-F238E27FC236}">
                          <a16:creationId xmlns:a16="http://schemas.microsoft.com/office/drawing/2014/main" id="{3FA2D241-B56A-60F8-9248-A3F7FF8BEB3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0" name="Parallelogram 53">
                      <a:extLst>
                        <a:ext uri="{FF2B5EF4-FFF2-40B4-BE49-F238E27FC236}">
                          <a16:creationId xmlns:a16="http://schemas.microsoft.com/office/drawing/2014/main" id="{A37DF592-CF30-E87F-457D-0E3B83B5DF7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1" name="Parallelogram 53">
                      <a:extLst>
                        <a:ext uri="{FF2B5EF4-FFF2-40B4-BE49-F238E27FC236}">
                          <a16:creationId xmlns:a16="http://schemas.microsoft.com/office/drawing/2014/main" id="{DE97B603-ABD4-4BF7-1BE6-83EFFAD3F99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2" name="Parallelogram 53">
                      <a:extLst>
                        <a:ext uri="{FF2B5EF4-FFF2-40B4-BE49-F238E27FC236}">
                          <a16:creationId xmlns:a16="http://schemas.microsoft.com/office/drawing/2014/main" id="{0A39884B-859F-7691-D6AA-660E496C5B7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3" name="Parallelogram 53">
                      <a:extLst>
                        <a:ext uri="{FF2B5EF4-FFF2-40B4-BE49-F238E27FC236}">
                          <a16:creationId xmlns:a16="http://schemas.microsoft.com/office/drawing/2014/main" id="{A5290E5D-FE03-EBF8-47BE-AC3484C3468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4" name="Parallelogram 53">
                      <a:extLst>
                        <a:ext uri="{FF2B5EF4-FFF2-40B4-BE49-F238E27FC236}">
                          <a16:creationId xmlns:a16="http://schemas.microsoft.com/office/drawing/2014/main" id="{CCB85544-795E-DE16-2377-75A1953EE6B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5" name="Parallelogram 53">
                      <a:extLst>
                        <a:ext uri="{FF2B5EF4-FFF2-40B4-BE49-F238E27FC236}">
                          <a16:creationId xmlns:a16="http://schemas.microsoft.com/office/drawing/2014/main" id="{40753C4D-BA6C-51C6-70C4-736D2DCB840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6" name="Parallelogram 53">
                      <a:extLst>
                        <a:ext uri="{FF2B5EF4-FFF2-40B4-BE49-F238E27FC236}">
                          <a16:creationId xmlns:a16="http://schemas.microsoft.com/office/drawing/2014/main" id="{44F97AAE-9971-A07E-608B-00AFC6C23E8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7" name="Parallelogram 53">
                      <a:extLst>
                        <a:ext uri="{FF2B5EF4-FFF2-40B4-BE49-F238E27FC236}">
                          <a16:creationId xmlns:a16="http://schemas.microsoft.com/office/drawing/2014/main" id="{55F83F42-B9F0-5622-71CC-7E2B6E1E062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8" name="Parallelogram 53">
                      <a:extLst>
                        <a:ext uri="{FF2B5EF4-FFF2-40B4-BE49-F238E27FC236}">
                          <a16:creationId xmlns:a16="http://schemas.microsoft.com/office/drawing/2014/main" id="{8213C40B-6070-A1D1-8D86-A12CF83F3CC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19" name="Parallelogram 53">
                      <a:extLst>
                        <a:ext uri="{FF2B5EF4-FFF2-40B4-BE49-F238E27FC236}">
                          <a16:creationId xmlns:a16="http://schemas.microsoft.com/office/drawing/2014/main" id="{7BD78A22-37C0-364F-26EB-C5CA46CF7DD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0" name="Parallelogram 53">
                      <a:extLst>
                        <a:ext uri="{FF2B5EF4-FFF2-40B4-BE49-F238E27FC236}">
                          <a16:creationId xmlns:a16="http://schemas.microsoft.com/office/drawing/2014/main" id="{208D2EBC-B349-17CA-D6E0-4C434D666A6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94766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1" name="Parallelogram 53">
                      <a:extLst>
                        <a:ext uri="{FF2B5EF4-FFF2-40B4-BE49-F238E27FC236}">
                          <a16:creationId xmlns:a16="http://schemas.microsoft.com/office/drawing/2014/main" id="{4F7F3ECB-A380-859B-B940-3FA0B9346E4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082539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2" name="Parallelogram 53">
                      <a:extLst>
                        <a:ext uri="{FF2B5EF4-FFF2-40B4-BE49-F238E27FC236}">
                          <a16:creationId xmlns:a16="http://schemas.microsoft.com/office/drawing/2014/main" id="{B51C6FFB-C63E-E629-03D8-9F4030E11E0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3" name="Parallelogram 53">
                      <a:extLst>
                        <a:ext uri="{FF2B5EF4-FFF2-40B4-BE49-F238E27FC236}">
                          <a16:creationId xmlns:a16="http://schemas.microsoft.com/office/drawing/2014/main" id="{C536D86A-93F6-98B1-BA21-99FF61FBB6B6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4" name="Parallelogram 53">
                      <a:extLst>
                        <a:ext uri="{FF2B5EF4-FFF2-40B4-BE49-F238E27FC236}">
                          <a16:creationId xmlns:a16="http://schemas.microsoft.com/office/drawing/2014/main" id="{5E208542-27EA-223A-2BF5-30BE3CECA81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5" name="Parallelogram 53">
                      <a:extLst>
                        <a:ext uri="{FF2B5EF4-FFF2-40B4-BE49-F238E27FC236}">
                          <a16:creationId xmlns:a16="http://schemas.microsoft.com/office/drawing/2014/main" id="{F8A49F28-AC96-82F5-8436-15CF6A26675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6" name="Parallelogram 53">
                      <a:extLst>
                        <a:ext uri="{FF2B5EF4-FFF2-40B4-BE49-F238E27FC236}">
                          <a16:creationId xmlns:a16="http://schemas.microsoft.com/office/drawing/2014/main" id="{39F58647-A65C-4F1D-47F4-703FAD8CE08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7" name="Parallelogram 53">
                      <a:extLst>
                        <a:ext uri="{FF2B5EF4-FFF2-40B4-BE49-F238E27FC236}">
                          <a16:creationId xmlns:a16="http://schemas.microsoft.com/office/drawing/2014/main" id="{972EEFC3-5188-C114-5768-1DB80DA6CA5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8" name="Parallelogram 53">
                      <a:extLst>
                        <a:ext uri="{FF2B5EF4-FFF2-40B4-BE49-F238E27FC236}">
                          <a16:creationId xmlns:a16="http://schemas.microsoft.com/office/drawing/2014/main" id="{C63A52FF-8DF1-1FF3-CC9D-FAFAFDF3CF9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29" name="Parallelogram 53">
                      <a:extLst>
                        <a:ext uri="{FF2B5EF4-FFF2-40B4-BE49-F238E27FC236}">
                          <a16:creationId xmlns:a16="http://schemas.microsoft.com/office/drawing/2014/main" id="{7F7785D7-DF02-89CD-35AD-8A40CB854AC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0" name="Parallelogram 53">
                      <a:extLst>
                        <a:ext uri="{FF2B5EF4-FFF2-40B4-BE49-F238E27FC236}">
                          <a16:creationId xmlns:a16="http://schemas.microsoft.com/office/drawing/2014/main" id="{158686B4-B725-F51E-57D6-6BC12EE1DF7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1" name="Parallelogram 53">
                      <a:extLst>
                        <a:ext uri="{FF2B5EF4-FFF2-40B4-BE49-F238E27FC236}">
                          <a16:creationId xmlns:a16="http://schemas.microsoft.com/office/drawing/2014/main" id="{CCB65C57-871F-F8C2-EC63-DF516CF06F7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2" name="Parallelogram 53">
                      <a:extLst>
                        <a:ext uri="{FF2B5EF4-FFF2-40B4-BE49-F238E27FC236}">
                          <a16:creationId xmlns:a16="http://schemas.microsoft.com/office/drawing/2014/main" id="{6E395533-5E0D-D2D5-5300-E36350FF8A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3" name="Parallelogram 53">
                      <a:extLst>
                        <a:ext uri="{FF2B5EF4-FFF2-40B4-BE49-F238E27FC236}">
                          <a16:creationId xmlns:a16="http://schemas.microsoft.com/office/drawing/2014/main" id="{60C6E2B9-3DAB-4A30-24DF-282DD81E253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4" name="Parallelogram 53">
                      <a:extLst>
                        <a:ext uri="{FF2B5EF4-FFF2-40B4-BE49-F238E27FC236}">
                          <a16:creationId xmlns:a16="http://schemas.microsoft.com/office/drawing/2014/main" id="{5C168E7D-8402-29EC-A054-D1BC22C608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80792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5" name="Parallelogram 53">
                      <a:extLst>
                        <a:ext uri="{FF2B5EF4-FFF2-40B4-BE49-F238E27FC236}">
                          <a16:creationId xmlns:a16="http://schemas.microsoft.com/office/drawing/2014/main" id="{EA02C830-F73C-7539-393B-CB852A92048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942799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6" name="Parallelogram 53">
                      <a:extLst>
                        <a:ext uri="{FF2B5EF4-FFF2-40B4-BE49-F238E27FC236}">
                          <a16:creationId xmlns:a16="http://schemas.microsoft.com/office/drawing/2014/main" id="{8DFFB205-2810-DE0C-137D-B26860D58B9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7942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37" name="Parallelogram 53">
                      <a:extLst>
                        <a:ext uri="{FF2B5EF4-FFF2-40B4-BE49-F238E27FC236}">
                          <a16:creationId xmlns:a16="http://schemas.microsoft.com/office/drawing/2014/main" id="{E9FD32EB-F942-AABE-0E17-78BFD15CD3E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214296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473" name="Group 3472">
                    <a:extLst>
                      <a:ext uri="{FF2B5EF4-FFF2-40B4-BE49-F238E27FC236}">
                        <a16:creationId xmlns:a16="http://schemas.microsoft.com/office/drawing/2014/main" id="{499ED8EC-93AE-C26F-9C7A-6D0D875CCB2D}"/>
                      </a:ext>
                    </a:extLst>
                  </p:cNvPr>
                  <p:cNvGrpSpPr/>
                  <p:nvPr/>
                </p:nvGrpSpPr>
                <p:grpSpPr>
                  <a:xfrm>
                    <a:off x="1790672" y="1921222"/>
                    <a:ext cx="1211247" cy="80077"/>
                    <a:chOff x="471861" y="2316558"/>
                    <a:chExt cx="23606582" cy="1558174"/>
                  </a:xfrm>
                  <a:solidFill>
                    <a:schemeClr val="accent6"/>
                  </a:solidFill>
                </p:grpSpPr>
                <p:sp>
                  <p:nvSpPr>
                    <p:cNvPr id="3474" name="Parallelogram 53">
                      <a:extLst>
                        <a:ext uri="{FF2B5EF4-FFF2-40B4-BE49-F238E27FC236}">
                          <a16:creationId xmlns:a16="http://schemas.microsoft.com/office/drawing/2014/main" id="{543FD25F-2E80-4D73-1F63-3D171541496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5" name="Parallelogram 53">
                      <a:extLst>
                        <a:ext uri="{FF2B5EF4-FFF2-40B4-BE49-F238E27FC236}">
                          <a16:creationId xmlns:a16="http://schemas.microsoft.com/office/drawing/2014/main" id="{C6463170-6042-7C9E-5A6A-2F4AC1CE4CC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6" name="Parallelogram 53">
                      <a:extLst>
                        <a:ext uri="{FF2B5EF4-FFF2-40B4-BE49-F238E27FC236}">
                          <a16:creationId xmlns:a16="http://schemas.microsoft.com/office/drawing/2014/main" id="{E7433985-6FB8-E42A-2D6D-E267B947D97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7" name="Parallelogram 53">
                      <a:extLst>
                        <a:ext uri="{FF2B5EF4-FFF2-40B4-BE49-F238E27FC236}">
                          <a16:creationId xmlns:a16="http://schemas.microsoft.com/office/drawing/2014/main" id="{CA7CEBF1-0743-7F76-8A9B-ADB3C7D6264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8" name="Parallelogram 53">
                      <a:extLst>
                        <a:ext uri="{FF2B5EF4-FFF2-40B4-BE49-F238E27FC236}">
                          <a16:creationId xmlns:a16="http://schemas.microsoft.com/office/drawing/2014/main" id="{49BCC714-0627-A880-12C9-0F54D58E6FC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9" name="Parallelogram 53">
                      <a:extLst>
                        <a:ext uri="{FF2B5EF4-FFF2-40B4-BE49-F238E27FC236}">
                          <a16:creationId xmlns:a16="http://schemas.microsoft.com/office/drawing/2014/main" id="{3A03161A-80E7-3176-91C4-823A55A7FAD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0" name="Parallelogram 53">
                      <a:extLst>
                        <a:ext uri="{FF2B5EF4-FFF2-40B4-BE49-F238E27FC236}">
                          <a16:creationId xmlns:a16="http://schemas.microsoft.com/office/drawing/2014/main" id="{CEA25A27-4172-7389-6E86-4B9E9353B08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1" name="Parallelogram 53">
                      <a:extLst>
                        <a:ext uri="{FF2B5EF4-FFF2-40B4-BE49-F238E27FC236}">
                          <a16:creationId xmlns:a16="http://schemas.microsoft.com/office/drawing/2014/main" id="{ECF683BC-D539-2F0F-062B-124EF938818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2" name="Parallelogram 53">
                      <a:extLst>
                        <a:ext uri="{FF2B5EF4-FFF2-40B4-BE49-F238E27FC236}">
                          <a16:creationId xmlns:a16="http://schemas.microsoft.com/office/drawing/2014/main" id="{79016A81-B93C-CF9C-BB1E-419AAB1672C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3317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3" name="Parallelogram 53">
                      <a:extLst>
                        <a:ext uri="{FF2B5EF4-FFF2-40B4-BE49-F238E27FC236}">
                          <a16:creationId xmlns:a16="http://schemas.microsoft.com/office/drawing/2014/main" id="{189C62D2-039D-7CC7-BBDB-AAFC2AB3080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26804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4" name="Parallelogram 53">
                      <a:extLst>
                        <a:ext uri="{FF2B5EF4-FFF2-40B4-BE49-F238E27FC236}">
                          <a16:creationId xmlns:a16="http://schemas.microsoft.com/office/drawing/2014/main" id="{2D1C482F-0846-CF25-8E6E-5F9F103DF53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0467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5" name="Parallelogram 53">
                      <a:extLst>
                        <a:ext uri="{FF2B5EF4-FFF2-40B4-BE49-F238E27FC236}">
                          <a16:creationId xmlns:a16="http://schemas.microsoft.com/office/drawing/2014/main" id="{32102077-8D2C-F4DC-7525-52DD049565B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53954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6" name="Parallelogram 53">
                      <a:extLst>
                        <a:ext uri="{FF2B5EF4-FFF2-40B4-BE49-F238E27FC236}">
                          <a16:creationId xmlns:a16="http://schemas.microsoft.com/office/drawing/2014/main" id="{B8E930EE-6A6B-5F63-54C8-8B6ABCB9A3A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168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7" name="Parallelogram 53">
                      <a:extLst>
                        <a:ext uri="{FF2B5EF4-FFF2-40B4-BE49-F238E27FC236}">
                          <a16:creationId xmlns:a16="http://schemas.microsoft.com/office/drawing/2014/main" id="{C8EF32D1-395B-2778-F0BE-311AA294A49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11042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8" name="Parallelogram 53">
                      <a:extLst>
                        <a:ext uri="{FF2B5EF4-FFF2-40B4-BE49-F238E27FC236}">
                          <a16:creationId xmlns:a16="http://schemas.microsoft.com/office/drawing/2014/main" id="{F351003D-C70D-9036-D170-C3C8EAE481C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947665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89" name="Parallelogram 53">
                      <a:extLst>
                        <a:ext uri="{FF2B5EF4-FFF2-40B4-BE49-F238E27FC236}">
                          <a16:creationId xmlns:a16="http://schemas.microsoft.com/office/drawing/2014/main" id="{6B131D10-A013-F6F6-F02A-B799905EEF4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082539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0" name="Parallelogram 53">
                      <a:extLst>
                        <a:ext uri="{FF2B5EF4-FFF2-40B4-BE49-F238E27FC236}">
                          <a16:creationId xmlns:a16="http://schemas.microsoft.com/office/drawing/2014/main" id="{50DF3D14-B125-FDFA-105A-506371CFFF2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1" name="Parallelogram 53">
                      <a:extLst>
                        <a:ext uri="{FF2B5EF4-FFF2-40B4-BE49-F238E27FC236}">
                          <a16:creationId xmlns:a16="http://schemas.microsoft.com/office/drawing/2014/main" id="{A6B4FB09-6440-B9BA-039B-E86353E98831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2" name="Parallelogram 53">
                      <a:extLst>
                        <a:ext uri="{FF2B5EF4-FFF2-40B4-BE49-F238E27FC236}">
                          <a16:creationId xmlns:a16="http://schemas.microsoft.com/office/drawing/2014/main" id="{3CC94075-016F-967C-B307-3CB322F5658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3" name="Parallelogram 53">
                      <a:extLst>
                        <a:ext uri="{FF2B5EF4-FFF2-40B4-BE49-F238E27FC236}">
                          <a16:creationId xmlns:a16="http://schemas.microsoft.com/office/drawing/2014/main" id="{755163E0-8804-47F2-0C79-C787386F04C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4" name="Parallelogram 53">
                      <a:extLst>
                        <a:ext uri="{FF2B5EF4-FFF2-40B4-BE49-F238E27FC236}">
                          <a16:creationId xmlns:a16="http://schemas.microsoft.com/office/drawing/2014/main" id="{6FBE506C-414A-A023-03F8-2D7598F55D9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5" name="Parallelogram 53">
                      <a:extLst>
                        <a:ext uri="{FF2B5EF4-FFF2-40B4-BE49-F238E27FC236}">
                          <a16:creationId xmlns:a16="http://schemas.microsoft.com/office/drawing/2014/main" id="{325E2D2F-CF2F-27FD-2689-596B47423B7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6" name="Parallelogram 53">
                      <a:extLst>
                        <a:ext uri="{FF2B5EF4-FFF2-40B4-BE49-F238E27FC236}">
                          <a16:creationId xmlns:a16="http://schemas.microsoft.com/office/drawing/2014/main" id="{70F0B77E-D9A3-34F5-E090-CD8CF54CDCC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7" name="Parallelogram 53">
                      <a:extLst>
                        <a:ext uri="{FF2B5EF4-FFF2-40B4-BE49-F238E27FC236}">
                          <a16:creationId xmlns:a16="http://schemas.microsoft.com/office/drawing/2014/main" id="{60C73642-767A-56CB-FF9C-AA80C0BCA78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8" name="Parallelogram 53">
                      <a:extLst>
                        <a:ext uri="{FF2B5EF4-FFF2-40B4-BE49-F238E27FC236}">
                          <a16:creationId xmlns:a16="http://schemas.microsoft.com/office/drawing/2014/main" id="{C82858C9-8A6F-7B76-9F6C-819149D3E1E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6493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99" name="Parallelogram 53">
                      <a:extLst>
                        <a:ext uri="{FF2B5EF4-FFF2-40B4-BE49-F238E27FC236}">
                          <a16:creationId xmlns:a16="http://schemas.microsoft.com/office/drawing/2014/main" id="{F8F97862-7461-ED3F-462A-5E0225FEF72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39980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0" name="Parallelogram 53">
                      <a:extLst>
                        <a:ext uri="{FF2B5EF4-FFF2-40B4-BE49-F238E27FC236}">
                          <a16:creationId xmlns:a16="http://schemas.microsoft.com/office/drawing/2014/main" id="{DE48E4C8-903E-F42F-6F32-4415D0D389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42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1" name="Parallelogram 53">
                      <a:extLst>
                        <a:ext uri="{FF2B5EF4-FFF2-40B4-BE49-F238E27FC236}">
                          <a16:creationId xmlns:a16="http://schemas.microsoft.com/office/drawing/2014/main" id="{945DC1C6-CD07-96AF-A46A-1825362E00A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67130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2" name="Parallelogram 53">
                      <a:extLst>
                        <a:ext uri="{FF2B5EF4-FFF2-40B4-BE49-F238E27FC236}">
                          <a16:creationId xmlns:a16="http://schemas.microsoft.com/office/drawing/2014/main" id="{F7491868-2AE4-DB06-A401-F5E396F5E14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807925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3" name="Parallelogram 53">
                      <a:extLst>
                        <a:ext uri="{FF2B5EF4-FFF2-40B4-BE49-F238E27FC236}">
                          <a16:creationId xmlns:a16="http://schemas.microsoft.com/office/drawing/2014/main" id="{F7E5DCDA-C1C5-D476-7204-F9A8951D4DD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942799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4" name="Parallelogram 53">
                      <a:extLst>
                        <a:ext uri="{FF2B5EF4-FFF2-40B4-BE49-F238E27FC236}">
                          <a16:creationId xmlns:a16="http://schemas.microsoft.com/office/drawing/2014/main" id="{8B870CD4-47B2-C8E7-03BF-E3704229173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79422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505" name="Parallelogram 53">
                      <a:extLst>
                        <a:ext uri="{FF2B5EF4-FFF2-40B4-BE49-F238E27FC236}">
                          <a16:creationId xmlns:a16="http://schemas.microsoft.com/office/drawing/2014/main" id="{95F8B174-B623-47AB-90B5-E34244CB354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2214296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452" name="Group 3451">
                  <a:extLst>
                    <a:ext uri="{FF2B5EF4-FFF2-40B4-BE49-F238E27FC236}">
                      <a16:creationId xmlns:a16="http://schemas.microsoft.com/office/drawing/2014/main" id="{E8A4F2D9-CD98-4737-2549-73ED58EA556F}"/>
                    </a:ext>
                  </a:extLst>
                </p:cNvPr>
                <p:cNvGrpSpPr/>
                <p:nvPr/>
              </p:nvGrpSpPr>
              <p:grpSpPr>
                <a:xfrm>
                  <a:off x="5819663" y="4349157"/>
                  <a:ext cx="472440" cy="366690"/>
                  <a:chOff x="2330471" y="1497396"/>
                  <a:chExt cx="655279" cy="508603"/>
                </a:xfrm>
              </p:grpSpPr>
              <p:grpSp>
                <p:nvGrpSpPr>
                  <p:cNvPr id="3453" name="Group 3452">
                    <a:extLst>
                      <a:ext uri="{FF2B5EF4-FFF2-40B4-BE49-F238E27FC236}">
                        <a16:creationId xmlns:a16="http://schemas.microsoft.com/office/drawing/2014/main" id="{3CE8F661-B49F-89E9-957E-C3B08D88E093}"/>
                      </a:ext>
                    </a:extLst>
                  </p:cNvPr>
                  <p:cNvGrpSpPr/>
                  <p:nvPr/>
                </p:nvGrpSpPr>
                <p:grpSpPr>
                  <a:xfrm>
                    <a:off x="2331720" y="1783080"/>
                    <a:ext cx="654030" cy="80077"/>
                    <a:chOff x="471861" y="2316558"/>
                    <a:chExt cx="12746702" cy="1558174"/>
                  </a:xfrm>
                  <a:solidFill>
                    <a:schemeClr val="accent2">
                      <a:lumMod val="75000"/>
                    </a:schemeClr>
                  </a:solidFill>
                </p:grpSpPr>
                <p:sp>
                  <p:nvSpPr>
                    <p:cNvPr id="1669" name="Parallelogram 53">
                      <a:extLst>
                        <a:ext uri="{FF2B5EF4-FFF2-40B4-BE49-F238E27FC236}">
                          <a16:creationId xmlns:a16="http://schemas.microsoft.com/office/drawing/2014/main" id="{74F779B5-A22C-9C6B-227A-71C4911460F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56" name="Parallelogram 53">
                      <a:extLst>
                        <a:ext uri="{FF2B5EF4-FFF2-40B4-BE49-F238E27FC236}">
                          <a16:creationId xmlns:a16="http://schemas.microsoft.com/office/drawing/2014/main" id="{E6B23169-CB3E-D7D4-0DFE-17ED0A167F1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57" name="Parallelogram 53">
                      <a:extLst>
                        <a:ext uri="{FF2B5EF4-FFF2-40B4-BE49-F238E27FC236}">
                          <a16:creationId xmlns:a16="http://schemas.microsoft.com/office/drawing/2014/main" id="{738C4870-3699-2A2E-B9D4-3017D01C4F4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58" name="Parallelogram 53">
                      <a:extLst>
                        <a:ext uri="{FF2B5EF4-FFF2-40B4-BE49-F238E27FC236}">
                          <a16:creationId xmlns:a16="http://schemas.microsoft.com/office/drawing/2014/main" id="{139F8A37-2B0F-5E5A-F341-98779C3B102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59" name="Parallelogram 53">
                      <a:extLst>
                        <a:ext uri="{FF2B5EF4-FFF2-40B4-BE49-F238E27FC236}">
                          <a16:creationId xmlns:a16="http://schemas.microsoft.com/office/drawing/2014/main" id="{2D84CE2F-395A-70BD-CA5F-2018A37DA3B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0" name="Parallelogram 53">
                      <a:extLst>
                        <a:ext uri="{FF2B5EF4-FFF2-40B4-BE49-F238E27FC236}">
                          <a16:creationId xmlns:a16="http://schemas.microsoft.com/office/drawing/2014/main" id="{2E38E94F-C0C0-0571-29A2-F3685011A0CE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1" name="Parallelogram 53">
                      <a:extLst>
                        <a:ext uri="{FF2B5EF4-FFF2-40B4-BE49-F238E27FC236}">
                          <a16:creationId xmlns:a16="http://schemas.microsoft.com/office/drawing/2014/main" id="{BDDEABC1-CAFB-AAAC-3F3C-4B1A4A7B195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2" name="Parallelogram 53">
                      <a:extLst>
                        <a:ext uri="{FF2B5EF4-FFF2-40B4-BE49-F238E27FC236}">
                          <a16:creationId xmlns:a16="http://schemas.microsoft.com/office/drawing/2014/main" id="{1AB70C07-6693-8AE5-1B6E-78F4A16732D8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3" name="Parallelogram 53">
                      <a:extLst>
                        <a:ext uri="{FF2B5EF4-FFF2-40B4-BE49-F238E27FC236}">
                          <a16:creationId xmlns:a16="http://schemas.microsoft.com/office/drawing/2014/main" id="{C302CBE9-A492-D127-86A2-13B9DA86F40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4" name="Parallelogram 53">
                      <a:extLst>
                        <a:ext uri="{FF2B5EF4-FFF2-40B4-BE49-F238E27FC236}">
                          <a16:creationId xmlns:a16="http://schemas.microsoft.com/office/drawing/2014/main" id="{2F56E3C1-F29B-D5FC-53E3-F44BCC38ADB5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5" name="Parallelogram 53">
                      <a:extLst>
                        <a:ext uri="{FF2B5EF4-FFF2-40B4-BE49-F238E27FC236}">
                          <a16:creationId xmlns:a16="http://schemas.microsoft.com/office/drawing/2014/main" id="{21165997-28B4-2A9E-7145-AB968EA7CF1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6" name="Parallelogram 53">
                      <a:extLst>
                        <a:ext uri="{FF2B5EF4-FFF2-40B4-BE49-F238E27FC236}">
                          <a16:creationId xmlns:a16="http://schemas.microsoft.com/office/drawing/2014/main" id="{9407A176-680B-9A55-0786-CCE5A2FAA66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7" name="Parallelogram 53">
                      <a:extLst>
                        <a:ext uri="{FF2B5EF4-FFF2-40B4-BE49-F238E27FC236}">
                          <a16:creationId xmlns:a16="http://schemas.microsoft.com/office/drawing/2014/main" id="{356CE7DB-EEA8-391F-EC60-A05BC40C593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8" name="Parallelogram 53">
                      <a:extLst>
                        <a:ext uri="{FF2B5EF4-FFF2-40B4-BE49-F238E27FC236}">
                          <a16:creationId xmlns:a16="http://schemas.microsoft.com/office/drawing/2014/main" id="{914E8F1E-ECBF-6AAD-0FFB-1FEEA4BDDFC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69" name="Parallelogram 53">
                      <a:extLst>
                        <a:ext uri="{FF2B5EF4-FFF2-40B4-BE49-F238E27FC236}">
                          <a16:creationId xmlns:a16="http://schemas.microsoft.com/office/drawing/2014/main" id="{ED83592E-A66E-5989-7437-35C6709DEA0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470" name="Parallelogram 53">
                      <a:extLst>
                        <a:ext uri="{FF2B5EF4-FFF2-40B4-BE49-F238E27FC236}">
                          <a16:creationId xmlns:a16="http://schemas.microsoft.com/office/drawing/2014/main" id="{EE158F08-B96B-EBF8-165E-5FA234332791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454" name="Group 3453">
                    <a:extLst>
                      <a:ext uri="{FF2B5EF4-FFF2-40B4-BE49-F238E27FC236}">
                        <a16:creationId xmlns:a16="http://schemas.microsoft.com/office/drawing/2014/main" id="{65B0E3D1-F8ED-33C8-523D-FD5988EE1CC6}"/>
                      </a:ext>
                    </a:extLst>
                  </p:cNvPr>
                  <p:cNvGrpSpPr/>
                  <p:nvPr/>
                </p:nvGrpSpPr>
                <p:grpSpPr>
                  <a:xfrm>
                    <a:off x="2331720" y="1640238"/>
                    <a:ext cx="654030" cy="80077"/>
                    <a:chOff x="471861" y="2316558"/>
                    <a:chExt cx="12746702" cy="1558174"/>
                  </a:xfrm>
                  <a:solidFill>
                    <a:schemeClr val="accent2">
                      <a:lumMod val="75000"/>
                    </a:schemeClr>
                  </a:solidFill>
                </p:grpSpPr>
                <p:sp>
                  <p:nvSpPr>
                    <p:cNvPr id="1589" name="Parallelogram 53">
                      <a:extLst>
                        <a:ext uri="{FF2B5EF4-FFF2-40B4-BE49-F238E27FC236}">
                          <a16:creationId xmlns:a16="http://schemas.microsoft.com/office/drawing/2014/main" id="{41AD2832-8035-3A81-B755-7DD96399585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0" name="Parallelogram 53">
                      <a:extLst>
                        <a:ext uri="{FF2B5EF4-FFF2-40B4-BE49-F238E27FC236}">
                          <a16:creationId xmlns:a16="http://schemas.microsoft.com/office/drawing/2014/main" id="{4B53F64F-CBC7-76D3-D312-3FB08B0FF79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1" name="Parallelogram 53">
                      <a:extLst>
                        <a:ext uri="{FF2B5EF4-FFF2-40B4-BE49-F238E27FC236}">
                          <a16:creationId xmlns:a16="http://schemas.microsoft.com/office/drawing/2014/main" id="{62434917-2CF3-7B48-A935-CF44447DAEC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2" name="Parallelogram 53">
                      <a:extLst>
                        <a:ext uri="{FF2B5EF4-FFF2-40B4-BE49-F238E27FC236}">
                          <a16:creationId xmlns:a16="http://schemas.microsoft.com/office/drawing/2014/main" id="{ECAFA279-19C3-D209-DF85-C528F626867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3" name="Parallelogram 53">
                      <a:extLst>
                        <a:ext uri="{FF2B5EF4-FFF2-40B4-BE49-F238E27FC236}">
                          <a16:creationId xmlns:a16="http://schemas.microsoft.com/office/drawing/2014/main" id="{91404EB9-1725-E1E9-9B82-BFD66F16287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4" name="Parallelogram 53">
                      <a:extLst>
                        <a:ext uri="{FF2B5EF4-FFF2-40B4-BE49-F238E27FC236}">
                          <a16:creationId xmlns:a16="http://schemas.microsoft.com/office/drawing/2014/main" id="{E6945B08-01A1-BB16-4534-34E2A007FB7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5" name="Parallelogram 53">
                      <a:extLst>
                        <a:ext uri="{FF2B5EF4-FFF2-40B4-BE49-F238E27FC236}">
                          <a16:creationId xmlns:a16="http://schemas.microsoft.com/office/drawing/2014/main" id="{46C57F9A-EA0A-571C-85C8-671CD7098F6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6" name="Parallelogram 53">
                      <a:extLst>
                        <a:ext uri="{FF2B5EF4-FFF2-40B4-BE49-F238E27FC236}">
                          <a16:creationId xmlns:a16="http://schemas.microsoft.com/office/drawing/2014/main" id="{7BD5653B-6DD5-03F9-B287-6555F875A5A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7" name="Parallelogram 53">
                      <a:extLst>
                        <a:ext uri="{FF2B5EF4-FFF2-40B4-BE49-F238E27FC236}">
                          <a16:creationId xmlns:a16="http://schemas.microsoft.com/office/drawing/2014/main" id="{B147F177-805A-3B60-6564-39EECE133B0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8" name="Parallelogram 53">
                      <a:extLst>
                        <a:ext uri="{FF2B5EF4-FFF2-40B4-BE49-F238E27FC236}">
                          <a16:creationId xmlns:a16="http://schemas.microsoft.com/office/drawing/2014/main" id="{E0072EB2-A253-025C-8664-840C3599EF9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99" name="Parallelogram 53">
                      <a:extLst>
                        <a:ext uri="{FF2B5EF4-FFF2-40B4-BE49-F238E27FC236}">
                          <a16:creationId xmlns:a16="http://schemas.microsoft.com/office/drawing/2014/main" id="{806EB1BF-3F11-A793-79F4-507F51780B8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64" name="Parallelogram 53">
                      <a:extLst>
                        <a:ext uri="{FF2B5EF4-FFF2-40B4-BE49-F238E27FC236}">
                          <a16:creationId xmlns:a16="http://schemas.microsoft.com/office/drawing/2014/main" id="{2DD034AE-A121-28BE-C31D-B03561D1A88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65" name="Parallelogram 53">
                      <a:extLst>
                        <a:ext uri="{FF2B5EF4-FFF2-40B4-BE49-F238E27FC236}">
                          <a16:creationId xmlns:a16="http://schemas.microsoft.com/office/drawing/2014/main" id="{A12F4334-0000-9377-DC49-7E64F6E674B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66" name="Parallelogram 53">
                      <a:extLst>
                        <a:ext uri="{FF2B5EF4-FFF2-40B4-BE49-F238E27FC236}">
                          <a16:creationId xmlns:a16="http://schemas.microsoft.com/office/drawing/2014/main" id="{746B6715-73B3-A823-4EA9-2B2DC1EE436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67" name="Parallelogram 53">
                      <a:extLst>
                        <a:ext uri="{FF2B5EF4-FFF2-40B4-BE49-F238E27FC236}">
                          <a16:creationId xmlns:a16="http://schemas.microsoft.com/office/drawing/2014/main" id="{503FD5BA-DE70-D27A-3C3A-5879FB1A325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68" name="Parallelogram 53">
                      <a:extLst>
                        <a:ext uri="{FF2B5EF4-FFF2-40B4-BE49-F238E27FC236}">
                          <a16:creationId xmlns:a16="http://schemas.microsoft.com/office/drawing/2014/main" id="{925D3E1F-5104-1CD1-1214-BB6351B510A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455" name="Group 3454">
                    <a:extLst>
                      <a:ext uri="{FF2B5EF4-FFF2-40B4-BE49-F238E27FC236}">
                        <a16:creationId xmlns:a16="http://schemas.microsoft.com/office/drawing/2014/main" id="{A6816854-65CB-E522-CF01-7ABFE6D6CD36}"/>
                      </a:ext>
                    </a:extLst>
                  </p:cNvPr>
                  <p:cNvGrpSpPr/>
                  <p:nvPr/>
                </p:nvGrpSpPr>
                <p:grpSpPr>
                  <a:xfrm>
                    <a:off x="2330471" y="1497396"/>
                    <a:ext cx="654030" cy="80077"/>
                    <a:chOff x="471861" y="2316558"/>
                    <a:chExt cx="12746702" cy="1558174"/>
                  </a:xfrm>
                  <a:solidFill>
                    <a:schemeClr val="accent2">
                      <a:lumMod val="75000"/>
                    </a:schemeClr>
                  </a:solidFill>
                </p:grpSpPr>
                <p:sp>
                  <p:nvSpPr>
                    <p:cNvPr id="1573" name="Parallelogram 53">
                      <a:extLst>
                        <a:ext uri="{FF2B5EF4-FFF2-40B4-BE49-F238E27FC236}">
                          <a16:creationId xmlns:a16="http://schemas.microsoft.com/office/drawing/2014/main" id="{4F448A20-80FD-66B5-8A9F-4E211FC320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4" name="Parallelogram 53">
                      <a:extLst>
                        <a:ext uri="{FF2B5EF4-FFF2-40B4-BE49-F238E27FC236}">
                          <a16:creationId xmlns:a16="http://schemas.microsoft.com/office/drawing/2014/main" id="{B877D6F2-3E1E-BEBC-A554-E889A12BFD7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5" name="Parallelogram 53">
                      <a:extLst>
                        <a:ext uri="{FF2B5EF4-FFF2-40B4-BE49-F238E27FC236}">
                          <a16:creationId xmlns:a16="http://schemas.microsoft.com/office/drawing/2014/main" id="{70797C0A-C851-630C-EB86-489EA184888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6" name="Parallelogram 53">
                      <a:extLst>
                        <a:ext uri="{FF2B5EF4-FFF2-40B4-BE49-F238E27FC236}">
                          <a16:creationId xmlns:a16="http://schemas.microsoft.com/office/drawing/2014/main" id="{1D7C8407-C6F4-7027-2F1A-91FF0375C6F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7" name="Parallelogram 53">
                      <a:extLst>
                        <a:ext uri="{FF2B5EF4-FFF2-40B4-BE49-F238E27FC236}">
                          <a16:creationId xmlns:a16="http://schemas.microsoft.com/office/drawing/2014/main" id="{E0F6B1C0-53B8-6DC6-D14C-87B36685315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8" name="Parallelogram 53">
                      <a:extLst>
                        <a:ext uri="{FF2B5EF4-FFF2-40B4-BE49-F238E27FC236}">
                          <a16:creationId xmlns:a16="http://schemas.microsoft.com/office/drawing/2014/main" id="{4A2BC43B-DD8D-5570-D820-511979C1A03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9" name="Parallelogram 53">
                      <a:extLst>
                        <a:ext uri="{FF2B5EF4-FFF2-40B4-BE49-F238E27FC236}">
                          <a16:creationId xmlns:a16="http://schemas.microsoft.com/office/drawing/2014/main" id="{83F5EBFD-C190-7B35-922B-0FD97EA9824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0" name="Parallelogram 53">
                      <a:extLst>
                        <a:ext uri="{FF2B5EF4-FFF2-40B4-BE49-F238E27FC236}">
                          <a16:creationId xmlns:a16="http://schemas.microsoft.com/office/drawing/2014/main" id="{C3B135B4-CD4D-F5B5-55A4-9E15FD790C0B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1" name="Parallelogram 53">
                      <a:extLst>
                        <a:ext uri="{FF2B5EF4-FFF2-40B4-BE49-F238E27FC236}">
                          <a16:creationId xmlns:a16="http://schemas.microsoft.com/office/drawing/2014/main" id="{6A3FB6A3-2E1B-E727-AAF6-F2E0793782E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2" name="Parallelogram 53">
                      <a:extLst>
                        <a:ext uri="{FF2B5EF4-FFF2-40B4-BE49-F238E27FC236}">
                          <a16:creationId xmlns:a16="http://schemas.microsoft.com/office/drawing/2014/main" id="{AC75F9BD-EE0C-0CE5-A655-AA7C81FC5E4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3" name="Parallelogram 53">
                      <a:extLst>
                        <a:ext uri="{FF2B5EF4-FFF2-40B4-BE49-F238E27FC236}">
                          <a16:creationId xmlns:a16="http://schemas.microsoft.com/office/drawing/2014/main" id="{57CBB75E-9F75-A5FD-C823-BAC2B78BA15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4" name="Parallelogram 53">
                      <a:extLst>
                        <a:ext uri="{FF2B5EF4-FFF2-40B4-BE49-F238E27FC236}">
                          <a16:creationId xmlns:a16="http://schemas.microsoft.com/office/drawing/2014/main" id="{C112C0F6-C853-59B5-78E3-CD66B403421C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5" name="Parallelogram 53">
                      <a:extLst>
                        <a:ext uri="{FF2B5EF4-FFF2-40B4-BE49-F238E27FC236}">
                          <a16:creationId xmlns:a16="http://schemas.microsoft.com/office/drawing/2014/main" id="{BFC96E7E-F529-6441-EA9F-73089AB2A40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6" name="Parallelogram 53">
                      <a:extLst>
                        <a:ext uri="{FF2B5EF4-FFF2-40B4-BE49-F238E27FC236}">
                          <a16:creationId xmlns:a16="http://schemas.microsoft.com/office/drawing/2014/main" id="{47D4078A-2E5D-0F18-37C0-0398CA4B68F2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7" name="Parallelogram 53">
                      <a:extLst>
                        <a:ext uri="{FF2B5EF4-FFF2-40B4-BE49-F238E27FC236}">
                          <a16:creationId xmlns:a16="http://schemas.microsoft.com/office/drawing/2014/main" id="{8A3AB63A-3E9E-C6BF-C4A0-EA1C1C7E770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88" name="Parallelogram 53">
                      <a:extLst>
                        <a:ext uri="{FF2B5EF4-FFF2-40B4-BE49-F238E27FC236}">
                          <a16:creationId xmlns:a16="http://schemas.microsoft.com/office/drawing/2014/main" id="{318BC517-AE14-F8B0-7FA4-88833EE59EF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20" name="Group 919">
                    <a:extLst>
                      <a:ext uri="{FF2B5EF4-FFF2-40B4-BE49-F238E27FC236}">
                        <a16:creationId xmlns:a16="http://schemas.microsoft.com/office/drawing/2014/main" id="{29945D63-D24C-138D-6956-1572AE413C08}"/>
                      </a:ext>
                    </a:extLst>
                  </p:cNvPr>
                  <p:cNvGrpSpPr/>
                  <p:nvPr/>
                </p:nvGrpSpPr>
                <p:grpSpPr>
                  <a:xfrm>
                    <a:off x="2330607" y="1925922"/>
                    <a:ext cx="654030" cy="80077"/>
                    <a:chOff x="471861" y="2316558"/>
                    <a:chExt cx="12746702" cy="1558174"/>
                  </a:xfrm>
                  <a:solidFill>
                    <a:schemeClr val="accent2">
                      <a:lumMod val="75000"/>
                    </a:schemeClr>
                  </a:solidFill>
                </p:grpSpPr>
                <p:sp>
                  <p:nvSpPr>
                    <p:cNvPr id="1557" name="Parallelogram 53">
                      <a:extLst>
                        <a:ext uri="{FF2B5EF4-FFF2-40B4-BE49-F238E27FC236}">
                          <a16:creationId xmlns:a16="http://schemas.microsoft.com/office/drawing/2014/main" id="{983AC371-C5A9-4394-92DD-86B0C1F6BD8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86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58" name="Parallelogram 53">
                      <a:extLst>
                        <a:ext uri="{FF2B5EF4-FFF2-40B4-BE49-F238E27FC236}">
                          <a16:creationId xmlns:a16="http://schemas.microsoft.com/office/drawing/2014/main" id="{0B98ED98-380C-4D78-68C5-F3AC39C5ADB0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8206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59" name="Parallelogram 53">
                      <a:extLst>
                        <a:ext uri="{FF2B5EF4-FFF2-40B4-BE49-F238E27FC236}">
                          <a16:creationId xmlns:a16="http://schemas.microsoft.com/office/drawing/2014/main" id="{9B7E9E8F-7AF0-DC63-79F9-E6B60931CF2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8683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0" name="Parallelogram 53">
                      <a:extLst>
                        <a:ext uri="{FF2B5EF4-FFF2-40B4-BE49-F238E27FC236}">
                          <a16:creationId xmlns:a16="http://schemas.microsoft.com/office/drawing/2014/main" id="{D8AF962C-DD43-5397-EB1A-AB025E5EA23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45355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1" name="Parallelogram 53">
                      <a:extLst>
                        <a:ext uri="{FF2B5EF4-FFF2-40B4-BE49-F238E27FC236}">
                          <a16:creationId xmlns:a16="http://schemas.microsoft.com/office/drawing/2014/main" id="{92A615E4-14CC-FE3F-EA55-793CB68E616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0180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2" name="Parallelogram 53">
                      <a:extLst>
                        <a:ext uri="{FF2B5EF4-FFF2-40B4-BE49-F238E27FC236}">
                          <a16:creationId xmlns:a16="http://schemas.microsoft.com/office/drawing/2014/main" id="{36034CF0-92D9-B51E-0F78-391EA13AED94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725054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3" name="Parallelogram 53">
                      <a:extLst>
                        <a:ext uri="{FF2B5EF4-FFF2-40B4-BE49-F238E27FC236}">
                          <a16:creationId xmlns:a16="http://schemas.microsoft.com/office/drawing/2014/main" id="{470F1FE6-D1A0-C228-5953-CE702EED812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1677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4" name="Parallelogram 53">
                      <a:extLst>
                        <a:ext uri="{FF2B5EF4-FFF2-40B4-BE49-F238E27FC236}">
                          <a16:creationId xmlns:a16="http://schemas.microsoft.com/office/drawing/2014/main" id="{7B21991F-F2ED-9F34-726B-7CDDA773426F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9965511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5" name="Parallelogram 53">
                      <a:extLst>
                        <a:ext uri="{FF2B5EF4-FFF2-40B4-BE49-F238E27FC236}">
                          <a16:creationId xmlns:a16="http://schemas.microsoft.com/office/drawing/2014/main" id="{E2D27EA7-7EC2-64C7-46AB-DDC3854AFF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8943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6" name="Parallelogram 53">
                      <a:extLst>
                        <a:ext uri="{FF2B5EF4-FFF2-40B4-BE49-F238E27FC236}">
                          <a16:creationId xmlns:a16="http://schemas.microsoft.com/office/drawing/2014/main" id="{BE813476-EB7C-737A-D584-33392C0A48A6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1381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7" name="Parallelogram 53">
                      <a:extLst>
                        <a:ext uri="{FF2B5EF4-FFF2-40B4-BE49-F238E27FC236}">
                          <a16:creationId xmlns:a16="http://schemas.microsoft.com/office/drawing/2014/main" id="{825B0E76-CCEE-DE13-3328-71D17AAC639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0440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8" name="Parallelogram 53">
                      <a:extLst>
                        <a:ext uri="{FF2B5EF4-FFF2-40B4-BE49-F238E27FC236}">
                          <a16:creationId xmlns:a16="http://schemas.microsoft.com/office/drawing/2014/main" id="{55469812-E616-F732-015A-ACD9257808B7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8531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69" name="Parallelogram 53">
                      <a:extLst>
                        <a:ext uri="{FF2B5EF4-FFF2-40B4-BE49-F238E27FC236}">
                          <a16:creationId xmlns:a16="http://schemas.microsoft.com/office/drawing/2014/main" id="{4D7461CE-98A4-3631-5139-56DB80A24C2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21937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0" name="Parallelogram 53">
                      <a:extLst>
                        <a:ext uri="{FF2B5EF4-FFF2-40B4-BE49-F238E27FC236}">
                          <a16:creationId xmlns:a16="http://schemas.microsoft.com/office/drawing/2014/main" id="{5539168E-FDB0-DB28-5A08-AA9D9C5BA856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856811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1" name="Parallelogram 53">
                      <a:extLst>
                        <a:ext uri="{FF2B5EF4-FFF2-40B4-BE49-F238E27FC236}">
                          <a16:creationId xmlns:a16="http://schemas.microsoft.com/office/drawing/2014/main" id="{1286E4BB-8F11-569F-2F2D-1B264EBC90C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93434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n>
                          <a:solidFill>
                            <a:schemeClr val="tx1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72" name="Parallelogram 53">
                      <a:extLst>
                        <a:ext uri="{FF2B5EF4-FFF2-40B4-BE49-F238E27FC236}">
                          <a16:creationId xmlns:a16="http://schemas.microsoft.com/office/drawing/2014/main" id="{6A48629D-E6BF-EBC8-F2B8-7D5F7EB31FF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1283083" y="2316558"/>
                      <a:ext cx="1935480" cy="1558174"/>
                    </a:xfrm>
                    <a:custGeom>
                      <a:avLst/>
                      <a:gdLst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  <a:gd name="csX0" fmla="*/ 0 w 1935480"/>
                        <a:gd name="csY0" fmla="*/ 1044817 h 1044817"/>
                        <a:gd name="csX1" fmla="*/ 1323146 w 1935480"/>
                        <a:gd name="csY1" fmla="*/ 0 h 1044817"/>
                        <a:gd name="csX2" fmla="*/ 1935480 w 1935480"/>
                        <a:gd name="csY2" fmla="*/ 0 h 1044817"/>
                        <a:gd name="csX3" fmla="*/ 612334 w 1935480"/>
                        <a:gd name="csY3" fmla="*/ 1044817 h 1044817"/>
                        <a:gd name="csX4" fmla="*/ 0 w 1935480"/>
                        <a:gd name="csY4" fmla="*/ 1044817 h 1044817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1935480" h="1044817">
                          <a:moveTo>
                            <a:pt x="0" y="1044817"/>
                          </a:moveTo>
                          <a:cubicBezTo>
                            <a:pt x="441049" y="696545"/>
                            <a:pt x="501097" y="93002"/>
                            <a:pt x="1323146" y="0"/>
                          </a:cubicBezTo>
                          <a:lnTo>
                            <a:pt x="1935480" y="0"/>
                          </a:lnTo>
                          <a:cubicBezTo>
                            <a:pt x="1010561" y="253022"/>
                            <a:pt x="1053383" y="696545"/>
                            <a:pt x="612334" y="1044817"/>
                          </a:cubicBezTo>
                          <a:lnTo>
                            <a:pt x="0" y="1044817"/>
                          </a:lnTo>
                          <a:close/>
                        </a:path>
                      </a:pathLst>
                    </a:custGeom>
                    <a:grpFill/>
                    <a:ln w="3175">
                      <a:noFill/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grpSp>
            <p:nvGrpSpPr>
              <p:cNvPr id="562" name="Group 561">
                <a:extLst>
                  <a:ext uri="{FF2B5EF4-FFF2-40B4-BE49-F238E27FC236}">
                    <a16:creationId xmlns:a16="http://schemas.microsoft.com/office/drawing/2014/main" id="{5BDA7D7A-E47D-DF87-76EE-F55C658900D4}"/>
                  </a:ext>
                </a:extLst>
              </p:cNvPr>
              <p:cNvGrpSpPr/>
              <p:nvPr/>
            </p:nvGrpSpPr>
            <p:grpSpPr>
              <a:xfrm>
                <a:off x="5180805" y="3401215"/>
                <a:ext cx="801164" cy="703744"/>
                <a:chOff x="5087807" y="3310945"/>
                <a:chExt cx="1943230" cy="1706936"/>
              </a:xfrm>
            </p:grpSpPr>
            <p:grpSp>
              <p:nvGrpSpPr>
                <p:cNvPr id="3432" name="Group 3431">
                  <a:extLst>
                    <a:ext uri="{FF2B5EF4-FFF2-40B4-BE49-F238E27FC236}">
                      <a16:creationId xmlns:a16="http://schemas.microsoft.com/office/drawing/2014/main" id="{2D658FAC-736C-53C8-D0F0-AAEB39A70DC9}"/>
                    </a:ext>
                  </a:extLst>
                </p:cNvPr>
                <p:cNvGrpSpPr/>
                <p:nvPr/>
              </p:nvGrpSpPr>
              <p:grpSpPr>
                <a:xfrm rot="20704377">
                  <a:off x="6231882" y="4780292"/>
                  <a:ext cx="354170" cy="237589"/>
                  <a:chOff x="2646491" y="3175988"/>
                  <a:chExt cx="354170" cy="237589"/>
                </a:xfrm>
              </p:grpSpPr>
              <p:sp>
                <p:nvSpPr>
                  <p:cNvPr id="3448" name="Chord 1245">
                    <a:extLst>
                      <a:ext uri="{FF2B5EF4-FFF2-40B4-BE49-F238E27FC236}">
                        <a16:creationId xmlns:a16="http://schemas.microsoft.com/office/drawing/2014/main" id="{4814DC26-9D50-7CF0-3194-2940A2953D64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802055" y="3194052"/>
                    <a:ext cx="182880" cy="146751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49" name="Partial Circle 1244">
                    <a:extLst>
                      <a:ext uri="{FF2B5EF4-FFF2-40B4-BE49-F238E27FC236}">
                        <a16:creationId xmlns:a16="http://schemas.microsoft.com/office/drawing/2014/main" id="{AE4B0D8A-D8D9-55CD-FA19-6A9C558B251D}"/>
                      </a:ext>
                    </a:extLst>
                  </p:cNvPr>
                  <p:cNvSpPr/>
                  <p:nvPr/>
                </p:nvSpPr>
                <p:spPr>
                  <a:xfrm>
                    <a:off x="2646491" y="3200151"/>
                    <a:ext cx="354170" cy="213426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433" name="Group 3432">
                  <a:extLst>
                    <a:ext uri="{FF2B5EF4-FFF2-40B4-BE49-F238E27FC236}">
                      <a16:creationId xmlns:a16="http://schemas.microsoft.com/office/drawing/2014/main" id="{CBE1E1AF-82F1-E939-371C-9B348F9A612B}"/>
                    </a:ext>
                  </a:extLst>
                </p:cNvPr>
                <p:cNvGrpSpPr/>
                <p:nvPr/>
              </p:nvGrpSpPr>
              <p:grpSpPr>
                <a:xfrm rot="2571459">
                  <a:off x="5312586" y="4682998"/>
                  <a:ext cx="354170" cy="229988"/>
                  <a:chOff x="2573468" y="3179600"/>
                  <a:chExt cx="354170" cy="229988"/>
                </a:xfrm>
              </p:grpSpPr>
              <p:sp>
                <p:nvSpPr>
                  <p:cNvPr id="3446" name="Chord 1245">
                    <a:extLst>
                      <a:ext uri="{FF2B5EF4-FFF2-40B4-BE49-F238E27FC236}">
                        <a16:creationId xmlns:a16="http://schemas.microsoft.com/office/drawing/2014/main" id="{49614BA7-D427-DFB3-AD15-D7ACC0C33292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731465" y="3197665"/>
                    <a:ext cx="182880" cy="146749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47" name="Partial Circle 1244">
                    <a:extLst>
                      <a:ext uri="{FF2B5EF4-FFF2-40B4-BE49-F238E27FC236}">
                        <a16:creationId xmlns:a16="http://schemas.microsoft.com/office/drawing/2014/main" id="{4A80345F-1664-8764-6E04-6E1381BC05AB}"/>
                      </a:ext>
                    </a:extLst>
                  </p:cNvPr>
                  <p:cNvSpPr/>
                  <p:nvPr/>
                </p:nvSpPr>
                <p:spPr>
                  <a:xfrm>
                    <a:off x="2573468" y="3196164"/>
                    <a:ext cx="354170" cy="213424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434" name="Group 3433">
                  <a:extLst>
                    <a:ext uri="{FF2B5EF4-FFF2-40B4-BE49-F238E27FC236}">
                      <a16:creationId xmlns:a16="http://schemas.microsoft.com/office/drawing/2014/main" id="{0132E3CA-4E17-1C99-129E-01A2CC71B58F}"/>
                    </a:ext>
                  </a:extLst>
                </p:cNvPr>
                <p:cNvGrpSpPr/>
                <p:nvPr/>
              </p:nvGrpSpPr>
              <p:grpSpPr>
                <a:xfrm rot="5400000">
                  <a:off x="5029518" y="3988941"/>
                  <a:ext cx="354170" cy="237591"/>
                  <a:chOff x="2648666" y="3189503"/>
                  <a:chExt cx="354170" cy="237591"/>
                </a:xfrm>
              </p:grpSpPr>
              <p:sp>
                <p:nvSpPr>
                  <p:cNvPr id="3444" name="Chord 1245">
                    <a:extLst>
                      <a:ext uri="{FF2B5EF4-FFF2-40B4-BE49-F238E27FC236}">
                        <a16:creationId xmlns:a16="http://schemas.microsoft.com/office/drawing/2014/main" id="{EF29C601-E979-E37C-DF23-5F0035343195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804230" y="3207567"/>
                    <a:ext cx="182880" cy="146751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45" name="Partial Circle 1244">
                    <a:extLst>
                      <a:ext uri="{FF2B5EF4-FFF2-40B4-BE49-F238E27FC236}">
                        <a16:creationId xmlns:a16="http://schemas.microsoft.com/office/drawing/2014/main" id="{F63C892C-279D-EC92-9D53-39B61AEC9B9E}"/>
                      </a:ext>
                    </a:extLst>
                  </p:cNvPr>
                  <p:cNvSpPr/>
                  <p:nvPr/>
                </p:nvSpPr>
                <p:spPr>
                  <a:xfrm>
                    <a:off x="2648666" y="3213668"/>
                    <a:ext cx="354170" cy="213426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435" name="Group 3434">
                  <a:extLst>
                    <a:ext uri="{FF2B5EF4-FFF2-40B4-BE49-F238E27FC236}">
                      <a16:creationId xmlns:a16="http://schemas.microsoft.com/office/drawing/2014/main" id="{F80F2BBD-A19A-3EE9-6DA8-95083A6ADE0F}"/>
                    </a:ext>
                  </a:extLst>
                </p:cNvPr>
                <p:cNvGrpSpPr/>
                <p:nvPr/>
              </p:nvGrpSpPr>
              <p:grpSpPr>
                <a:xfrm rot="9052241">
                  <a:off x="5459048" y="3310945"/>
                  <a:ext cx="354170" cy="237591"/>
                  <a:chOff x="2648666" y="3189503"/>
                  <a:chExt cx="354170" cy="237591"/>
                </a:xfrm>
              </p:grpSpPr>
              <p:sp>
                <p:nvSpPr>
                  <p:cNvPr id="3442" name="Chord 1245">
                    <a:extLst>
                      <a:ext uri="{FF2B5EF4-FFF2-40B4-BE49-F238E27FC236}">
                        <a16:creationId xmlns:a16="http://schemas.microsoft.com/office/drawing/2014/main" id="{FE706032-C277-A18E-A1E1-C62EF01D11A6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804230" y="3207567"/>
                    <a:ext cx="182880" cy="146751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43" name="Partial Circle 1244">
                    <a:extLst>
                      <a:ext uri="{FF2B5EF4-FFF2-40B4-BE49-F238E27FC236}">
                        <a16:creationId xmlns:a16="http://schemas.microsoft.com/office/drawing/2014/main" id="{63550273-EE5F-4243-5F12-C67F59C42A2F}"/>
                      </a:ext>
                    </a:extLst>
                  </p:cNvPr>
                  <p:cNvSpPr/>
                  <p:nvPr/>
                </p:nvSpPr>
                <p:spPr>
                  <a:xfrm>
                    <a:off x="2648666" y="3213668"/>
                    <a:ext cx="354170" cy="213426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436" name="Group 3435">
                  <a:extLst>
                    <a:ext uri="{FF2B5EF4-FFF2-40B4-BE49-F238E27FC236}">
                      <a16:creationId xmlns:a16="http://schemas.microsoft.com/office/drawing/2014/main" id="{27D98897-C4E1-1B73-B674-136271387FCC}"/>
                    </a:ext>
                  </a:extLst>
                </p:cNvPr>
                <p:cNvGrpSpPr/>
                <p:nvPr/>
              </p:nvGrpSpPr>
              <p:grpSpPr>
                <a:xfrm rot="12565088">
                  <a:off x="6385843" y="3348486"/>
                  <a:ext cx="354170" cy="237591"/>
                  <a:chOff x="2648666" y="3189503"/>
                  <a:chExt cx="354170" cy="237591"/>
                </a:xfrm>
              </p:grpSpPr>
              <p:sp>
                <p:nvSpPr>
                  <p:cNvPr id="3440" name="Chord 1245">
                    <a:extLst>
                      <a:ext uri="{FF2B5EF4-FFF2-40B4-BE49-F238E27FC236}">
                        <a16:creationId xmlns:a16="http://schemas.microsoft.com/office/drawing/2014/main" id="{0AB80991-0A9F-64CE-A217-61174ABADDA7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804230" y="3207567"/>
                    <a:ext cx="182880" cy="146751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41" name="Partial Circle 1244">
                    <a:extLst>
                      <a:ext uri="{FF2B5EF4-FFF2-40B4-BE49-F238E27FC236}">
                        <a16:creationId xmlns:a16="http://schemas.microsoft.com/office/drawing/2014/main" id="{6C129DD8-828E-44A1-26B7-AEED135BC916}"/>
                      </a:ext>
                    </a:extLst>
                  </p:cNvPr>
                  <p:cNvSpPr/>
                  <p:nvPr/>
                </p:nvSpPr>
                <p:spPr>
                  <a:xfrm>
                    <a:off x="2648666" y="3213668"/>
                    <a:ext cx="354170" cy="213426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437" name="Group 3436">
                  <a:extLst>
                    <a:ext uri="{FF2B5EF4-FFF2-40B4-BE49-F238E27FC236}">
                      <a16:creationId xmlns:a16="http://schemas.microsoft.com/office/drawing/2014/main" id="{59186FBE-EEC2-2EEF-11A0-1588419D685D}"/>
                    </a:ext>
                  </a:extLst>
                </p:cNvPr>
                <p:cNvGrpSpPr/>
                <p:nvPr/>
              </p:nvGrpSpPr>
              <p:grpSpPr>
                <a:xfrm rot="16578579">
                  <a:off x="6735157" y="4086186"/>
                  <a:ext cx="354170" cy="237591"/>
                  <a:chOff x="2648666" y="3189503"/>
                  <a:chExt cx="354170" cy="237591"/>
                </a:xfrm>
              </p:grpSpPr>
              <p:sp>
                <p:nvSpPr>
                  <p:cNvPr id="3438" name="Chord 1245">
                    <a:extLst>
                      <a:ext uri="{FF2B5EF4-FFF2-40B4-BE49-F238E27FC236}">
                        <a16:creationId xmlns:a16="http://schemas.microsoft.com/office/drawing/2014/main" id="{470F4D65-24BA-B25D-A5D1-BC87D8F5E099}"/>
                      </a:ext>
                    </a:extLst>
                  </p:cNvPr>
                  <p:cNvSpPr/>
                  <p:nvPr/>
                </p:nvSpPr>
                <p:spPr>
                  <a:xfrm rot="2778846">
                    <a:off x="2804230" y="3207567"/>
                    <a:ext cx="182880" cy="146751"/>
                  </a:xfrm>
                  <a:custGeom>
                    <a:avLst/>
                    <a:gdLst>
                      <a:gd name="csX0" fmla="*/ 326839 w 365760"/>
                      <a:gd name="csY0" fmla="*/ 377383 h 466848"/>
                      <a:gd name="csX1" fmla="*/ 98970 w 365760"/>
                      <a:gd name="csY1" fmla="*/ 440828 h 466848"/>
                      <a:gd name="csX2" fmla="*/ 15 w 365760"/>
                      <a:gd name="csY2" fmla="*/ 236444 h 466848"/>
                      <a:gd name="csX3" fmla="*/ 92783 w 365760"/>
                      <a:gd name="csY3" fmla="*/ 30293 h 466848"/>
                      <a:gd name="csX4" fmla="*/ 326839 w 365760"/>
                      <a:gd name="csY4" fmla="*/ 377383 h 466848"/>
                      <a:gd name="csX0" fmla="*/ 326839 w 326839"/>
                      <a:gd name="csY0" fmla="*/ 298322 h 387803"/>
                      <a:gd name="csX1" fmla="*/ 98970 w 326839"/>
                      <a:gd name="csY1" fmla="*/ 361767 h 387803"/>
                      <a:gd name="csX2" fmla="*/ 15 w 326839"/>
                      <a:gd name="csY2" fmla="*/ 157383 h 387803"/>
                      <a:gd name="csX3" fmla="*/ 92783 w 326839"/>
                      <a:gd name="csY3" fmla="*/ 0 h 387803"/>
                      <a:gd name="csX4" fmla="*/ 326839 w 326839"/>
                      <a:gd name="csY4" fmla="*/ 298322 h 387803"/>
                      <a:gd name="csX0" fmla="*/ 229303 w 229303"/>
                      <a:gd name="csY0" fmla="*/ 298322 h 375392"/>
                      <a:gd name="csX1" fmla="*/ 98970 w 229303"/>
                      <a:gd name="csY1" fmla="*/ 361767 h 375392"/>
                      <a:gd name="csX2" fmla="*/ 15 w 229303"/>
                      <a:gd name="csY2" fmla="*/ 157383 h 375392"/>
                      <a:gd name="csX3" fmla="*/ 92783 w 229303"/>
                      <a:gd name="csY3" fmla="*/ 0 h 375392"/>
                      <a:gd name="csX4" fmla="*/ 229303 w 229303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75392"/>
                      <a:gd name="csX1" fmla="*/ 98970 w 278071"/>
                      <a:gd name="csY1" fmla="*/ 361767 h 375392"/>
                      <a:gd name="csX2" fmla="*/ 15 w 278071"/>
                      <a:gd name="csY2" fmla="*/ 157383 h 375392"/>
                      <a:gd name="csX3" fmla="*/ 92783 w 278071"/>
                      <a:gd name="csY3" fmla="*/ 0 h 375392"/>
                      <a:gd name="csX4" fmla="*/ 278071 w 278071"/>
                      <a:gd name="csY4" fmla="*/ 298322 h 375392"/>
                      <a:gd name="csX0" fmla="*/ 278071 w 278071"/>
                      <a:gd name="csY0" fmla="*/ 298322 h 366159"/>
                      <a:gd name="csX1" fmla="*/ 98970 w 278071"/>
                      <a:gd name="csY1" fmla="*/ 361767 h 366159"/>
                      <a:gd name="csX2" fmla="*/ 15 w 278071"/>
                      <a:gd name="csY2" fmla="*/ 157383 h 366159"/>
                      <a:gd name="csX3" fmla="*/ 92783 w 278071"/>
                      <a:gd name="csY3" fmla="*/ 0 h 366159"/>
                      <a:gd name="csX4" fmla="*/ 278071 w 278071"/>
                      <a:gd name="csY4" fmla="*/ 298322 h 366159"/>
                      <a:gd name="csX0" fmla="*/ 278071 w 278071"/>
                      <a:gd name="csY0" fmla="*/ 298322 h 368563"/>
                      <a:gd name="csX1" fmla="*/ 98970 w 278071"/>
                      <a:gd name="csY1" fmla="*/ 361767 h 368563"/>
                      <a:gd name="csX2" fmla="*/ 15 w 278071"/>
                      <a:gd name="csY2" fmla="*/ 157383 h 368563"/>
                      <a:gd name="csX3" fmla="*/ 92783 w 278071"/>
                      <a:gd name="csY3" fmla="*/ 0 h 368563"/>
                      <a:gd name="csX4" fmla="*/ 278071 w 278071"/>
                      <a:gd name="csY4" fmla="*/ 298322 h 368563"/>
                      <a:gd name="csX0" fmla="*/ 278071 w 278071"/>
                      <a:gd name="csY0" fmla="*/ 298322 h 347919"/>
                      <a:gd name="csX1" fmla="*/ 98970 w 278071"/>
                      <a:gd name="csY1" fmla="*/ 337383 h 347919"/>
                      <a:gd name="csX2" fmla="*/ 15 w 278071"/>
                      <a:gd name="csY2" fmla="*/ 157383 h 347919"/>
                      <a:gd name="csX3" fmla="*/ 92783 w 278071"/>
                      <a:gd name="csY3" fmla="*/ 0 h 347919"/>
                      <a:gd name="csX4" fmla="*/ 278071 w 278071"/>
                      <a:gd name="csY4" fmla="*/ 298322 h 347919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1 w 278071"/>
                      <a:gd name="csY0" fmla="*/ 280034 h 329631"/>
                      <a:gd name="csX1" fmla="*/ 98970 w 278071"/>
                      <a:gd name="csY1" fmla="*/ 319095 h 329631"/>
                      <a:gd name="csX2" fmla="*/ 15 w 278071"/>
                      <a:gd name="csY2" fmla="*/ 139095 h 329631"/>
                      <a:gd name="csX3" fmla="*/ 92783 w 278071"/>
                      <a:gd name="csY3" fmla="*/ 0 h 329631"/>
                      <a:gd name="csX4" fmla="*/ 278071 w 278071"/>
                      <a:gd name="csY4" fmla="*/ 280034 h 329631"/>
                      <a:gd name="csX0" fmla="*/ 278078 w 278078"/>
                      <a:gd name="csY0" fmla="*/ 280034 h 329631"/>
                      <a:gd name="csX1" fmla="*/ 98977 w 278078"/>
                      <a:gd name="csY1" fmla="*/ 319095 h 329631"/>
                      <a:gd name="csX2" fmla="*/ 22 w 278078"/>
                      <a:gd name="csY2" fmla="*/ 139095 h 329631"/>
                      <a:gd name="csX3" fmla="*/ 92790 w 278078"/>
                      <a:gd name="csY3" fmla="*/ 0 h 329631"/>
                      <a:gd name="csX4" fmla="*/ 278078 w 278078"/>
                      <a:gd name="csY4" fmla="*/ 280034 h 32963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278078" h="329631">
                        <a:moveTo>
                          <a:pt x="278078" y="280034"/>
                        </a:moveTo>
                        <a:cubicBezTo>
                          <a:pt x="254392" y="325606"/>
                          <a:pt x="145320" y="342585"/>
                          <a:pt x="98977" y="319095"/>
                        </a:cubicBezTo>
                        <a:cubicBezTo>
                          <a:pt x="52634" y="295605"/>
                          <a:pt x="896" y="225324"/>
                          <a:pt x="22" y="139095"/>
                        </a:cubicBezTo>
                        <a:cubicBezTo>
                          <a:pt x="-841" y="53921"/>
                          <a:pt x="22522" y="23677"/>
                          <a:pt x="92790" y="0"/>
                        </a:cubicBezTo>
                        <a:cubicBezTo>
                          <a:pt x="201289" y="103505"/>
                          <a:pt x="114715" y="182625"/>
                          <a:pt x="278078" y="280034"/>
                        </a:cubicBezTo>
                        <a:close/>
                      </a:path>
                    </a:pathLst>
                  </a:custGeom>
                  <a:solidFill>
                    <a:srgbClr val="4D5277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39" name="Partial Circle 1244">
                    <a:extLst>
                      <a:ext uri="{FF2B5EF4-FFF2-40B4-BE49-F238E27FC236}">
                        <a16:creationId xmlns:a16="http://schemas.microsoft.com/office/drawing/2014/main" id="{CFD20AD3-5027-AAA5-A116-0C73C3EC02E7}"/>
                      </a:ext>
                    </a:extLst>
                  </p:cNvPr>
                  <p:cNvSpPr/>
                  <p:nvPr/>
                </p:nvSpPr>
                <p:spPr>
                  <a:xfrm>
                    <a:off x="2648666" y="3213668"/>
                    <a:ext cx="354170" cy="213426"/>
                  </a:xfrm>
                  <a:custGeom>
                    <a:avLst/>
                    <a:gdLst>
                      <a:gd name="csX0" fmla="*/ 365760 w 365760"/>
                      <a:gd name="csY0" fmla="*/ 182880 h 365760"/>
                      <a:gd name="csX1" fmla="*/ 241472 w 365760"/>
                      <a:gd name="csY1" fmla="*/ 356120 h 365760"/>
                      <a:gd name="csX2" fmla="*/ 37544 w 365760"/>
                      <a:gd name="csY2" fmla="*/ 293887 h 365760"/>
                      <a:gd name="csX3" fmla="*/ 31161 w 365760"/>
                      <a:gd name="csY3" fmla="*/ 80770 h 365760"/>
                      <a:gd name="csX4" fmla="*/ 230999 w 365760"/>
                      <a:gd name="csY4" fmla="*/ 6444 h 365760"/>
                      <a:gd name="csX5" fmla="*/ 182880 w 365760"/>
                      <a:gd name="csY5" fmla="*/ 182880 h 365760"/>
                      <a:gd name="csX6" fmla="*/ 365760 w 365760"/>
                      <a:gd name="csY6" fmla="*/ 182880 h 365760"/>
                      <a:gd name="csX0" fmla="*/ 395287 w 395287"/>
                      <a:gd name="csY0" fmla="*/ 182892 h 362970"/>
                      <a:gd name="csX1" fmla="*/ 270999 w 395287"/>
                      <a:gd name="csY1" fmla="*/ 356132 h 362970"/>
                      <a:gd name="csX2" fmla="*/ 67071 w 395287"/>
                      <a:gd name="csY2" fmla="*/ 293899 h 362970"/>
                      <a:gd name="csX3" fmla="*/ 60688 w 395287"/>
                      <a:gd name="csY3" fmla="*/ 80782 h 362970"/>
                      <a:gd name="csX4" fmla="*/ 260526 w 395287"/>
                      <a:gd name="csY4" fmla="*/ 6456 h 362970"/>
                      <a:gd name="csX5" fmla="*/ 212407 w 395287"/>
                      <a:gd name="csY5" fmla="*/ 182892 h 362970"/>
                      <a:gd name="csX6" fmla="*/ 395287 w 395287"/>
                      <a:gd name="csY6" fmla="*/ 182892 h 362970"/>
                      <a:gd name="csX0" fmla="*/ 395287 w 395287"/>
                      <a:gd name="csY0" fmla="*/ 182892 h 375210"/>
                      <a:gd name="csX1" fmla="*/ 270999 w 395287"/>
                      <a:gd name="csY1" fmla="*/ 356132 h 375210"/>
                      <a:gd name="csX2" fmla="*/ 67071 w 395287"/>
                      <a:gd name="csY2" fmla="*/ 293899 h 375210"/>
                      <a:gd name="csX3" fmla="*/ 60688 w 395287"/>
                      <a:gd name="csY3" fmla="*/ 80782 h 375210"/>
                      <a:gd name="csX4" fmla="*/ 260526 w 395287"/>
                      <a:gd name="csY4" fmla="*/ 6456 h 375210"/>
                      <a:gd name="csX5" fmla="*/ 212407 w 395287"/>
                      <a:gd name="csY5" fmla="*/ 182892 h 375210"/>
                      <a:gd name="csX6" fmla="*/ 395287 w 395287"/>
                      <a:gd name="csY6" fmla="*/ 182892 h 375210"/>
                      <a:gd name="csX0" fmla="*/ 395287 w 395287"/>
                      <a:gd name="csY0" fmla="*/ 182892 h 357963"/>
                      <a:gd name="csX1" fmla="*/ 270999 w 395287"/>
                      <a:gd name="csY1" fmla="*/ 356132 h 357963"/>
                      <a:gd name="csX2" fmla="*/ 67071 w 395287"/>
                      <a:gd name="csY2" fmla="*/ 293899 h 357963"/>
                      <a:gd name="csX3" fmla="*/ 60688 w 395287"/>
                      <a:gd name="csY3" fmla="*/ 80782 h 357963"/>
                      <a:gd name="csX4" fmla="*/ 260526 w 395287"/>
                      <a:gd name="csY4" fmla="*/ 6456 h 357963"/>
                      <a:gd name="csX5" fmla="*/ 212407 w 395287"/>
                      <a:gd name="csY5" fmla="*/ 182892 h 357963"/>
                      <a:gd name="csX6" fmla="*/ 395287 w 395287"/>
                      <a:gd name="csY6" fmla="*/ 182892 h 357963"/>
                      <a:gd name="csX0" fmla="*/ 395287 w 403108"/>
                      <a:gd name="csY0" fmla="*/ 182892 h 357419"/>
                      <a:gd name="csX1" fmla="*/ 270999 w 403108"/>
                      <a:gd name="csY1" fmla="*/ 356132 h 357419"/>
                      <a:gd name="csX2" fmla="*/ 67071 w 403108"/>
                      <a:gd name="csY2" fmla="*/ 293899 h 357419"/>
                      <a:gd name="csX3" fmla="*/ 60688 w 403108"/>
                      <a:gd name="csY3" fmla="*/ 80782 h 357419"/>
                      <a:gd name="csX4" fmla="*/ 260526 w 403108"/>
                      <a:gd name="csY4" fmla="*/ 6456 h 357419"/>
                      <a:gd name="csX5" fmla="*/ 212407 w 403108"/>
                      <a:gd name="csY5" fmla="*/ 182892 h 357419"/>
                      <a:gd name="csX6" fmla="*/ 395287 w 403108"/>
                      <a:gd name="csY6" fmla="*/ 182892 h 357419"/>
                      <a:gd name="csX0" fmla="*/ 389191 w 395086"/>
                      <a:gd name="csY0" fmla="*/ 158508 h 362026"/>
                      <a:gd name="csX1" fmla="*/ 270999 w 395086"/>
                      <a:gd name="csY1" fmla="*/ 356132 h 362026"/>
                      <a:gd name="csX2" fmla="*/ 67071 w 395086"/>
                      <a:gd name="csY2" fmla="*/ 293899 h 362026"/>
                      <a:gd name="csX3" fmla="*/ 60688 w 395086"/>
                      <a:gd name="csY3" fmla="*/ 80782 h 362026"/>
                      <a:gd name="csX4" fmla="*/ 260526 w 395086"/>
                      <a:gd name="csY4" fmla="*/ 6456 h 362026"/>
                      <a:gd name="csX5" fmla="*/ 212407 w 395086"/>
                      <a:gd name="csY5" fmla="*/ 182892 h 362026"/>
                      <a:gd name="csX6" fmla="*/ 389191 w 395086"/>
                      <a:gd name="csY6" fmla="*/ 158508 h 362026"/>
                      <a:gd name="csX0" fmla="*/ 355741 w 361947"/>
                      <a:gd name="csY0" fmla="*/ 158508 h 327493"/>
                      <a:gd name="csX1" fmla="*/ 243645 w 361947"/>
                      <a:gd name="csY1" fmla="*/ 313460 h 327493"/>
                      <a:gd name="csX2" fmla="*/ 33621 w 361947"/>
                      <a:gd name="csY2" fmla="*/ 293899 h 327493"/>
                      <a:gd name="csX3" fmla="*/ 27238 w 361947"/>
                      <a:gd name="csY3" fmla="*/ 80782 h 327493"/>
                      <a:gd name="csX4" fmla="*/ 227076 w 361947"/>
                      <a:gd name="csY4" fmla="*/ 6456 h 327493"/>
                      <a:gd name="csX5" fmla="*/ 178957 w 361947"/>
                      <a:gd name="csY5" fmla="*/ 182892 h 327493"/>
                      <a:gd name="csX6" fmla="*/ 355741 w 361947"/>
                      <a:gd name="csY6" fmla="*/ 158508 h 327493"/>
                      <a:gd name="csX0" fmla="*/ 385322 w 391968"/>
                      <a:gd name="csY0" fmla="*/ 157038 h 326023"/>
                      <a:gd name="csX1" fmla="*/ 273226 w 391968"/>
                      <a:gd name="csY1" fmla="*/ 311990 h 326023"/>
                      <a:gd name="csX2" fmla="*/ 14434 w 391968"/>
                      <a:gd name="csY2" fmla="*/ 292429 h 326023"/>
                      <a:gd name="csX3" fmla="*/ 56819 w 391968"/>
                      <a:gd name="csY3" fmla="*/ 79312 h 326023"/>
                      <a:gd name="csX4" fmla="*/ 256657 w 391968"/>
                      <a:gd name="csY4" fmla="*/ 4986 h 326023"/>
                      <a:gd name="csX5" fmla="*/ 208538 w 391968"/>
                      <a:gd name="csY5" fmla="*/ 181422 h 326023"/>
                      <a:gd name="csX6" fmla="*/ 385322 w 39196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57038 h 326023"/>
                      <a:gd name="csX1" fmla="*/ 272396 w 391138"/>
                      <a:gd name="csY1" fmla="*/ 311990 h 326023"/>
                      <a:gd name="csX2" fmla="*/ 13604 w 391138"/>
                      <a:gd name="csY2" fmla="*/ 292429 h 326023"/>
                      <a:gd name="csX3" fmla="*/ 55989 w 391138"/>
                      <a:gd name="csY3" fmla="*/ 79312 h 326023"/>
                      <a:gd name="csX4" fmla="*/ 225347 w 391138"/>
                      <a:gd name="csY4" fmla="*/ 4986 h 326023"/>
                      <a:gd name="csX5" fmla="*/ 207708 w 391138"/>
                      <a:gd name="csY5" fmla="*/ 181422 h 326023"/>
                      <a:gd name="csX6" fmla="*/ 384492 w 391138"/>
                      <a:gd name="csY6" fmla="*/ 157038 h 326023"/>
                      <a:gd name="csX0" fmla="*/ 384492 w 391138"/>
                      <a:gd name="csY0" fmla="*/ 138750 h 327338"/>
                      <a:gd name="csX1" fmla="*/ 272396 w 391138"/>
                      <a:gd name="csY1" fmla="*/ 311990 h 327338"/>
                      <a:gd name="csX2" fmla="*/ 13604 w 391138"/>
                      <a:gd name="csY2" fmla="*/ 292429 h 327338"/>
                      <a:gd name="csX3" fmla="*/ 55989 w 391138"/>
                      <a:gd name="csY3" fmla="*/ 79312 h 327338"/>
                      <a:gd name="csX4" fmla="*/ 225347 w 391138"/>
                      <a:gd name="csY4" fmla="*/ 4986 h 327338"/>
                      <a:gd name="csX5" fmla="*/ 207708 w 391138"/>
                      <a:gd name="csY5" fmla="*/ 181422 h 327338"/>
                      <a:gd name="csX6" fmla="*/ 384492 w 391138"/>
                      <a:gd name="csY6" fmla="*/ 138750 h 327338"/>
                      <a:gd name="csX0" fmla="*/ 390588 w 396935"/>
                      <a:gd name="csY0" fmla="*/ 199710 h 322990"/>
                      <a:gd name="csX1" fmla="*/ 272396 w 396935"/>
                      <a:gd name="csY1" fmla="*/ 311990 h 322990"/>
                      <a:gd name="csX2" fmla="*/ 13604 w 396935"/>
                      <a:gd name="csY2" fmla="*/ 292429 h 322990"/>
                      <a:gd name="csX3" fmla="*/ 55989 w 396935"/>
                      <a:gd name="csY3" fmla="*/ 79312 h 322990"/>
                      <a:gd name="csX4" fmla="*/ 225347 w 396935"/>
                      <a:gd name="csY4" fmla="*/ 4986 h 322990"/>
                      <a:gd name="csX5" fmla="*/ 207708 w 396935"/>
                      <a:gd name="csY5" fmla="*/ 181422 h 322990"/>
                      <a:gd name="csX6" fmla="*/ 390588 w 396935"/>
                      <a:gd name="csY6" fmla="*/ 199710 h 322990"/>
                      <a:gd name="csX0" fmla="*/ 390588 w 396935"/>
                      <a:gd name="csY0" fmla="*/ 199710 h 310233"/>
                      <a:gd name="csX1" fmla="*/ 272396 w 396935"/>
                      <a:gd name="csY1" fmla="*/ 287606 h 310233"/>
                      <a:gd name="csX2" fmla="*/ 13604 w 396935"/>
                      <a:gd name="csY2" fmla="*/ 292429 h 310233"/>
                      <a:gd name="csX3" fmla="*/ 55989 w 396935"/>
                      <a:gd name="csY3" fmla="*/ 79312 h 310233"/>
                      <a:gd name="csX4" fmla="*/ 225347 w 396935"/>
                      <a:gd name="csY4" fmla="*/ 4986 h 310233"/>
                      <a:gd name="csX5" fmla="*/ 207708 w 396935"/>
                      <a:gd name="csY5" fmla="*/ 181422 h 310233"/>
                      <a:gd name="csX6" fmla="*/ 390588 w 396935"/>
                      <a:gd name="csY6" fmla="*/ 199710 h 310233"/>
                      <a:gd name="csX0" fmla="*/ 401162 w 407618"/>
                      <a:gd name="csY0" fmla="*/ 199710 h 310233"/>
                      <a:gd name="csX1" fmla="*/ 282970 w 407618"/>
                      <a:gd name="csY1" fmla="*/ 287606 h 310233"/>
                      <a:gd name="csX2" fmla="*/ 11986 w 407618"/>
                      <a:gd name="csY2" fmla="*/ 292429 h 310233"/>
                      <a:gd name="csX3" fmla="*/ 66563 w 407618"/>
                      <a:gd name="csY3" fmla="*/ 79312 h 310233"/>
                      <a:gd name="csX4" fmla="*/ 235921 w 407618"/>
                      <a:gd name="csY4" fmla="*/ 4986 h 310233"/>
                      <a:gd name="csX5" fmla="*/ 218282 w 407618"/>
                      <a:gd name="csY5" fmla="*/ 181422 h 310233"/>
                      <a:gd name="csX6" fmla="*/ 401162 w 407618"/>
                      <a:gd name="csY6" fmla="*/ 199710 h 310233"/>
                      <a:gd name="csX0" fmla="*/ 408845 w 415301"/>
                      <a:gd name="csY0" fmla="*/ 199710 h 315603"/>
                      <a:gd name="csX1" fmla="*/ 290653 w 415301"/>
                      <a:gd name="csY1" fmla="*/ 287606 h 315603"/>
                      <a:gd name="csX2" fmla="*/ 19669 w 415301"/>
                      <a:gd name="csY2" fmla="*/ 292429 h 315603"/>
                      <a:gd name="csX3" fmla="*/ 74246 w 415301"/>
                      <a:gd name="csY3" fmla="*/ 79312 h 315603"/>
                      <a:gd name="csX4" fmla="*/ 243604 w 415301"/>
                      <a:gd name="csY4" fmla="*/ 4986 h 315603"/>
                      <a:gd name="csX5" fmla="*/ 225965 w 415301"/>
                      <a:gd name="csY5" fmla="*/ 181422 h 315603"/>
                      <a:gd name="csX6" fmla="*/ 408845 w 415301"/>
                      <a:gd name="csY6" fmla="*/ 199710 h 315603"/>
                      <a:gd name="csX0" fmla="*/ 416705 w 423161"/>
                      <a:gd name="csY0" fmla="*/ 199710 h 320993"/>
                      <a:gd name="csX1" fmla="*/ 298513 w 423161"/>
                      <a:gd name="csY1" fmla="*/ 287606 h 320993"/>
                      <a:gd name="csX2" fmla="*/ 27529 w 423161"/>
                      <a:gd name="csY2" fmla="*/ 292429 h 320993"/>
                      <a:gd name="csX3" fmla="*/ 82106 w 423161"/>
                      <a:gd name="csY3" fmla="*/ 79312 h 320993"/>
                      <a:gd name="csX4" fmla="*/ 251464 w 423161"/>
                      <a:gd name="csY4" fmla="*/ 4986 h 320993"/>
                      <a:gd name="csX5" fmla="*/ 233825 w 423161"/>
                      <a:gd name="csY5" fmla="*/ 181422 h 320993"/>
                      <a:gd name="csX6" fmla="*/ 416705 w 423161"/>
                      <a:gd name="csY6" fmla="*/ 199710 h 320993"/>
                      <a:gd name="csX0" fmla="*/ 419935 w 426391"/>
                      <a:gd name="csY0" fmla="*/ 198681 h 319964"/>
                      <a:gd name="csX1" fmla="*/ 301743 w 426391"/>
                      <a:gd name="csY1" fmla="*/ 286577 h 319964"/>
                      <a:gd name="csX2" fmla="*/ 30759 w 426391"/>
                      <a:gd name="csY2" fmla="*/ 291400 h 319964"/>
                      <a:gd name="csX3" fmla="*/ 85336 w 426391"/>
                      <a:gd name="csY3" fmla="*/ 78283 h 319964"/>
                      <a:gd name="csX4" fmla="*/ 254694 w 426391"/>
                      <a:gd name="csY4" fmla="*/ 3957 h 319964"/>
                      <a:gd name="csX5" fmla="*/ 237055 w 426391"/>
                      <a:gd name="csY5" fmla="*/ 180393 h 319964"/>
                      <a:gd name="csX6" fmla="*/ 419935 w 426391"/>
                      <a:gd name="csY6" fmla="*/ 198681 h 319964"/>
                      <a:gd name="csX0" fmla="*/ 493087 w 497239"/>
                      <a:gd name="csY0" fmla="*/ 125529 h 323199"/>
                      <a:gd name="csX1" fmla="*/ 301743 w 497239"/>
                      <a:gd name="csY1" fmla="*/ 286577 h 323199"/>
                      <a:gd name="csX2" fmla="*/ 30759 w 497239"/>
                      <a:gd name="csY2" fmla="*/ 291400 h 323199"/>
                      <a:gd name="csX3" fmla="*/ 85336 w 497239"/>
                      <a:gd name="csY3" fmla="*/ 78283 h 323199"/>
                      <a:gd name="csX4" fmla="*/ 254694 w 497239"/>
                      <a:gd name="csY4" fmla="*/ 3957 h 323199"/>
                      <a:gd name="csX5" fmla="*/ 237055 w 497239"/>
                      <a:gd name="csY5" fmla="*/ 180393 h 323199"/>
                      <a:gd name="csX6" fmla="*/ 493087 w 497239"/>
                      <a:gd name="csY6" fmla="*/ 125529 h 323199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224534 w 486360"/>
                      <a:gd name="csY5" fmla="*/ 180393 h 336281"/>
                      <a:gd name="csX6" fmla="*/ 480566 w 486360"/>
                      <a:gd name="csY6" fmla="*/ 125529 h 336281"/>
                      <a:gd name="csX0" fmla="*/ 480566 w 486360"/>
                      <a:gd name="csY0" fmla="*/ 125529 h 336281"/>
                      <a:gd name="csX1" fmla="*/ 337990 w 486360"/>
                      <a:gd name="csY1" fmla="*/ 323153 h 336281"/>
                      <a:gd name="csX2" fmla="*/ 18238 w 486360"/>
                      <a:gd name="csY2" fmla="*/ 291400 h 336281"/>
                      <a:gd name="csX3" fmla="*/ 72815 w 486360"/>
                      <a:gd name="csY3" fmla="*/ 78283 h 336281"/>
                      <a:gd name="csX4" fmla="*/ 242173 w 486360"/>
                      <a:gd name="csY4" fmla="*/ 3957 h 336281"/>
                      <a:gd name="csX5" fmla="*/ 181862 w 486360"/>
                      <a:gd name="csY5" fmla="*/ 180393 h 336281"/>
                      <a:gd name="csX6" fmla="*/ 480566 w 486360"/>
                      <a:gd name="csY6" fmla="*/ 125529 h 336281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  <a:cxn ang="0">
                        <a:pos x="csX5" y="csY5"/>
                      </a:cxn>
                      <a:cxn ang="0">
                        <a:pos x="csX6" y="csY6"/>
                      </a:cxn>
                    </a:cxnLst>
                    <a:rect l="l" t="t" r="r" b="b"/>
                    <a:pathLst>
                      <a:path w="486360" h="336281">
                        <a:moveTo>
                          <a:pt x="480566" y="125529"/>
                        </a:moveTo>
                        <a:cubicBezTo>
                          <a:pt x="511046" y="149087"/>
                          <a:pt x="415045" y="295508"/>
                          <a:pt x="337990" y="323153"/>
                        </a:cubicBezTo>
                        <a:cubicBezTo>
                          <a:pt x="260935" y="350798"/>
                          <a:pt x="62434" y="332212"/>
                          <a:pt x="18238" y="291400"/>
                        </a:cubicBezTo>
                        <a:cubicBezTo>
                          <a:pt x="-25958" y="250588"/>
                          <a:pt x="17205" y="107902"/>
                          <a:pt x="72815" y="78283"/>
                        </a:cubicBezTo>
                        <a:cubicBezTo>
                          <a:pt x="128425" y="48664"/>
                          <a:pt x="166514" y="-16677"/>
                          <a:pt x="242173" y="3957"/>
                        </a:cubicBezTo>
                        <a:cubicBezTo>
                          <a:pt x="254581" y="62769"/>
                          <a:pt x="187742" y="121581"/>
                          <a:pt x="181862" y="180393"/>
                        </a:cubicBezTo>
                        <a:cubicBezTo>
                          <a:pt x="261110" y="210873"/>
                          <a:pt x="395222" y="143817"/>
                          <a:pt x="480566" y="125529"/>
                        </a:cubicBezTo>
                        <a:close/>
                      </a:path>
                    </a:pathLst>
                  </a:custGeom>
                  <a:solidFill>
                    <a:srgbClr val="1F7E82"/>
                  </a:solidFill>
                  <a:ln w="3175">
                    <a:noFill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63" name="Group 562">
                <a:extLst>
                  <a:ext uri="{FF2B5EF4-FFF2-40B4-BE49-F238E27FC236}">
                    <a16:creationId xmlns:a16="http://schemas.microsoft.com/office/drawing/2014/main" id="{11C99963-6052-5B8B-91AF-C0DBA5691A08}"/>
                  </a:ext>
                </a:extLst>
              </p:cNvPr>
              <p:cNvGrpSpPr/>
              <p:nvPr/>
            </p:nvGrpSpPr>
            <p:grpSpPr>
              <a:xfrm>
                <a:off x="5019922" y="3222309"/>
                <a:ext cx="1077582" cy="1048621"/>
                <a:chOff x="7025893" y="1238591"/>
                <a:chExt cx="2613684" cy="2543438"/>
              </a:xfrm>
              <a:effectLst/>
            </p:grpSpPr>
            <p:grpSp>
              <p:nvGrpSpPr>
                <p:cNvPr id="564" name="Group 563">
                  <a:extLst>
                    <a:ext uri="{FF2B5EF4-FFF2-40B4-BE49-F238E27FC236}">
                      <a16:creationId xmlns:a16="http://schemas.microsoft.com/office/drawing/2014/main" id="{0B8A4A72-C2AC-1784-EE79-1FA489A59E04}"/>
                    </a:ext>
                  </a:extLst>
                </p:cNvPr>
                <p:cNvGrpSpPr/>
                <p:nvPr/>
              </p:nvGrpSpPr>
              <p:grpSpPr>
                <a:xfrm rot="9089347">
                  <a:off x="8625100" y="3490079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609" name="Oval 608">
                    <a:extLst>
                      <a:ext uri="{FF2B5EF4-FFF2-40B4-BE49-F238E27FC236}">
                        <a16:creationId xmlns:a16="http://schemas.microsoft.com/office/drawing/2014/main" id="{5F42D6A9-BC4D-A58C-3B06-DBEABD327544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31" name="Oval 3430">
                    <a:extLst>
                      <a:ext uri="{FF2B5EF4-FFF2-40B4-BE49-F238E27FC236}">
                        <a16:creationId xmlns:a16="http://schemas.microsoft.com/office/drawing/2014/main" id="{5762090B-6304-8B06-3857-F55160CD6241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65" name="Group 564">
                  <a:extLst>
                    <a:ext uri="{FF2B5EF4-FFF2-40B4-BE49-F238E27FC236}">
                      <a16:creationId xmlns:a16="http://schemas.microsoft.com/office/drawing/2014/main" id="{E183173E-9141-3AF9-0A1D-578256DADED1}"/>
                    </a:ext>
                  </a:extLst>
                </p:cNvPr>
                <p:cNvGrpSpPr/>
                <p:nvPr/>
              </p:nvGrpSpPr>
              <p:grpSpPr>
                <a:xfrm rot="6238309">
                  <a:off x="9252482" y="2669172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607" name="Oval 606">
                    <a:extLst>
                      <a:ext uri="{FF2B5EF4-FFF2-40B4-BE49-F238E27FC236}">
                        <a16:creationId xmlns:a16="http://schemas.microsoft.com/office/drawing/2014/main" id="{A4ED1EF1-3530-E6FB-ABE4-765EA48D0E59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8" name="Oval 607">
                    <a:extLst>
                      <a:ext uri="{FF2B5EF4-FFF2-40B4-BE49-F238E27FC236}">
                        <a16:creationId xmlns:a16="http://schemas.microsoft.com/office/drawing/2014/main" id="{E1C67445-A6DD-BB08-7C73-37C4762A1B23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66" name="Group 565">
                  <a:extLst>
                    <a:ext uri="{FF2B5EF4-FFF2-40B4-BE49-F238E27FC236}">
                      <a16:creationId xmlns:a16="http://schemas.microsoft.com/office/drawing/2014/main" id="{AC82D433-8B3D-0EF4-A2C7-9BADFC102B53}"/>
                    </a:ext>
                  </a:extLst>
                </p:cNvPr>
                <p:cNvGrpSpPr/>
                <p:nvPr/>
              </p:nvGrpSpPr>
              <p:grpSpPr>
                <a:xfrm rot="2910607">
                  <a:off x="8984130" y="1660743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605" name="Oval 604">
                    <a:extLst>
                      <a:ext uri="{FF2B5EF4-FFF2-40B4-BE49-F238E27FC236}">
                        <a16:creationId xmlns:a16="http://schemas.microsoft.com/office/drawing/2014/main" id="{557A1BA9-4FC9-CEFE-77DB-86C256101750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6" name="Oval 605">
                    <a:extLst>
                      <a:ext uri="{FF2B5EF4-FFF2-40B4-BE49-F238E27FC236}">
                        <a16:creationId xmlns:a16="http://schemas.microsoft.com/office/drawing/2014/main" id="{F126C41D-1AA8-4F7F-C280-B83D5E4FBD40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67" name="Group 566">
                  <a:extLst>
                    <a:ext uri="{FF2B5EF4-FFF2-40B4-BE49-F238E27FC236}">
                      <a16:creationId xmlns:a16="http://schemas.microsoft.com/office/drawing/2014/main" id="{29A23F6F-89D1-9662-B923-DE754D0ACD7F}"/>
                    </a:ext>
                  </a:extLst>
                </p:cNvPr>
                <p:cNvGrpSpPr/>
                <p:nvPr/>
              </p:nvGrpSpPr>
              <p:grpSpPr>
                <a:xfrm rot="11891786">
                  <a:off x="7597247" y="3537806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603" name="Oval 602">
                    <a:extLst>
                      <a:ext uri="{FF2B5EF4-FFF2-40B4-BE49-F238E27FC236}">
                        <a16:creationId xmlns:a16="http://schemas.microsoft.com/office/drawing/2014/main" id="{4285009F-92DA-138B-C0EF-78F37F4BB13E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4" name="Oval 603">
                    <a:extLst>
                      <a:ext uri="{FF2B5EF4-FFF2-40B4-BE49-F238E27FC236}">
                        <a16:creationId xmlns:a16="http://schemas.microsoft.com/office/drawing/2014/main" id="{832EE7A9-AFAC-A329-A3D8-01D773A17B3F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68" name="Group 567">
                  <a:extLst>
                    <a:ext uri="{FF2B5EF4-FFF2-40B4-BE49-F238E27FC236}">
                      <a16:creationId xmlns:a16="http://schemas.microsoft.com/office/drawing/2014/main" id="{7727AB6F-E229-70DE-96BE-9D340506A0F1}"/>
                    </a:ext>
                  </a:extLst>
                </p:cNvPr>
                <p:cNvGrpSpPr/>
                <p:nvPr/>
              </p:nvGrpSpPr>
              <p:grpSpPr>
                <a:xfrm rot="15381565">
                  <a:off x="6896325" y="2722559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601" name="Oval 600">
                    <a:extLst>
                      <a:ext uri="{FF2B5EF4-FFF2-40B4-BE49-F238E27FC236}">
                        <a16:creationId xmlns:a16="http://schemas.microsoft.com/office/drawing/2014/main" id="{B2DB815E-44D5-AC4A-9524-4B794815A4A7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2" name="Oval 601">
                    <a:extLst>
                      <a:ext uri="{FF2B5EF4-FFF2-40B4-BE49-F238E27FC236}">
                        <a16:creationId xmlns:a16="http://schemas.microsoft.com/office/drawing/2014/main" id="{AFBE9257-29BE-DD34-19CD-3EE4972142AF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69" name="Group 568">
                  <a:extLst>
                    <a:ext uri="{FF2B5EF4-FFF2-40B4-BE49-F238E27FC236}">
                      <a16:creationId xmlns:a16="http://schemas.microsoft.com/office/drawing/2014/main" id="{A2A8759F-3715-4697-CD97-28CED570F004}"/>
                    </a:ext>
                  </a:extLst>
                </p:cNvPr>
                <p:cNvGrpSpPr/>
                <p:nvPr/>
              </p:nvGrpSpPr>
              <p:grpSpPr>
                <a:xfrm rot="18174401">
                  <a:off x="7120478" y="1733586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599" name="Oval 598">
                    <a:extLst>
                      <a:ext uri="{FF2B5EF4-FFF2-40B4-BE49-F238E27FC236}">
                        <a16:creationId xmlns:a16="http://schemas.microsoft.com/office/drawing/2014/main" id="{09D0DF89-8304-0603-F6C5-2D93F5B5B3FB}"/>
                      </a:ext>
                    </a:extLst>
                  </p:cNvPr>
                  <p:cNvSpPr/>
                  <p:nvPr/>
                </p:nvSpPr>
                <p:spPr>
                  <a:xfrm rot="1745836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0" name="Oval 599">
                    <a:extLst>
                      <a:ext uri="{FF2B5EF4-FFF2-40B4-BE49-F238E27FC236}">
                        <a16:creationId xmlns:a16="http://schemas.microsoft.com/office/drawing/2014/main" id="{10D15BEC-EA21-84F4-AEF4-E2F828AB89A3}"/>
                      </a:ext>
                    </a:extLst>
                  </p:cNvPr>
                  <p:cNvSpPr/>
                  <p:nvPr/>
                </p:nvSpPr>
                <p:spPr>
                  <a:xfrm rot="9807333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70" name="Group 569">
                  <a:extLst>
                    <a:ext uri="{FF2B5EF4-FFF2-40B4-BE49-F238E27FC236}">
                      <a16:creationId xmlns:a16="http://schemas.microsoft.com/office/drawing/2014/main" id="{FF242D4D-3A55-E032-7850-8D59ECC9E39E}"/>
                    </a:ext>
                  </a:extLst>
                </p:cNvPr>
                <p:cNvGrpSpPr/>
                <p:nvPr/>
              </p:nvGrpSpPr>
              <p:grpSpPr>
                <a:xfrm rot="21418652">
                  <a:off x="8018716" y="1238591"/>
                  <a:ext cx="617468" cy="156723"/>
                  <a:chOff x="3877742" y="791604"/>
                  <a:chExt cx="617468" cy="156723"/>
                </a:xfrm>
                <a:solidFill>
                  <a:srgbClr val="92D050"/>
                </a:solidFill>
              </p:grpSpPr>
              <p:sp>
                <p:nvSpPr>
                  <p:cNvPr id="597" name="Oval 596">
                    <a:extLst>
                      <a:ext uri="{FF2B5EF4-FFF2-40B4-BE49-F238E27FC236}">
                        <a16:creationId xmlns:a16="http://schemas.microsoft.com/office/drawing/2014/main" id="{A23383E8-7408-80B9-6D5B-53426D10FF72}"/>
                      </a:ext>
                    </a:extLst>
                  </p:cNvPr>
                  <p:cNvSpPr/>
                  <p:nvPr/>
                </p:nvSpPr>
                <p:spPr>
                  <a:xfrm rot="725987">
                    <a:off x="4227120" y="802275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8" name="Oval 597">
                    <a:extLst>
                      <a:ext uri="{FF2B5EF4-FFF2-40B4-BE49-F238E27FC236}">
                        <a16:creationId xmlns:a16="http://schemas.microsoft.com/office/drawing/2014/main" id="{25C28EE1-C369-7E83-628F-857BB76D46DC}"/>
                      </a:ext>
                    </a:extLst>
                  </p:cNvPr>
                  <p:cNvSpPr/>
                  <p:nvPr/>
                </p:nvSpPr>
                <p:spPr>
                  <a:xfrm rot="10432799">
                    <a:off x="3877742" y="791604"/>
                    <a:ext cx="268090" cy="146052"/>
                  </a:xfrm>
                  <a:prstGeom prst="ellipse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75000"/>
                          <a:shade val="30000"/>
                          <a:satMod val="115000"/>
                        </a:schemeClr>
                      </a:gs>
                      <a:gs pos="50000">
                        <a:schemeClr val="accent2">
                          <a:lumMod val="75000"/>
                          <a:shade val="67500"/>
                          <a:satMod val="115000"/>
                        </a:schemeClr>
                      </a:gs>
                      <a:gs pos="100000">
                        <a:schemeClr val="accent2">
                          <a:lumMod val="75000"/>
                          <a:shade val="100000"/>
                          <a:satMod val="115000"/>
                        </a:schemeClr>
                      </a:gs>
                    </a:gsLst>
                    <a:lin ang="13500000" scaled="1"/>
                    <a:tileRect/>
                  </a:gradFill>
                  <a:ln w="3175">
                    <a:noFill/>
                  </a:ln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71" name="Group 570">
                  <a:extLst>
                    <a:ext uri="{FF2B5EF4-FFF2-40B4-BE49-F238E27FC236}">
                      <a16:creationId xmlns:a16="http://schemas.microsoft.com/office/drawing/2014/main" id="{8B767592-DD6D-88D4-527F-5774781614AA}"/>
                    </a:ext>
                  </a:extLst>
                </p:cNvPr>
                <p:cNvGrpSpPr/>
                <p:nvPr/>
              </p:nvGrpSpPr>
              <p:grpSpPr>
                <a:xfrm rot="187238">
                  <a:off x="7025893" y="1350159"/>
                  <a:ext cx="2530109" cy="2431870"/>
                  <a:chOff x="2872599" y="976335"/>
                  <a:chExt cx="2530109" cy="2431870"/>
                </a:xfrm>
                <a:solidFill>
                  <a:srgbClr val="CC6600"/>
                </a:solidFill>
              </p:grpSpPr>
              <p:grpSp>
                <p:nvGrpSpPr>
                  <p:cNvPr id="572" name="Group 571">
                    <a:extLst>
                      <a:ext uri="{FF2B5EF4-FFF2-40B4-BE49-F238E27FC236}">
                        <a16:creationId xmlns:a16="http://schemas.microsoft.com/office/drawing/2014/main" id="{292D1D7E-23C4-2D97-0DAE-3D04AF0773A8}"/>
                      </a:ext>
                    </a:extLst>
                  </p:cNvPr>
                  <p:cNvGrpSpPr/>
                  <p:nvPr/>
                </p:nvGrpSpPr>
                <p:grpSpPr>
                  <a:xfrm>
                    <a:off x="4159082" y="976335"/>
                    <a:ext cx="1243626" cy="1258913"/>
                    <a:chOff x="3881724" y="1054165"/>
                    <a:chExt cx="1243626" cy="1258913"/>
                  </a:xfrm>
                  <a:grpFill/>
                </p:grpSpPr>
                <p:sp>
                  <p:nvSpPr>
                    <p:cNvPr id="591" name="Chord 8">
                      <a:extLst>
                        <a:ext uri="{FF2B5EF4-FFF2-40B4-BE49-F238E27FC236}">
                          <a16:creationId xmlns:a16="http://schemas.microsoft.com/office/drawing/2014/main" id="{94DD9520-EE88-7245-9352-B9770D96AE75}"/>
                        </a:ext>
                      </a:extLst>
                    </p:cNvPr>
                    <p:cNvSpPr/>
                    <p:nvPr/>
                  </p:nvSpPr>
                  <p:spPr>
                    <a:xfrm rot="6890665">
                      <a:off x="3900542" y="1035347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2" name="Chord 8">
                      <a:extLst>
                        <a:ext uri="{FF2B5EF4-FFF2-40B4-BE49-F238E27FC236}">
                          <a16:creationId xmlns:a16="http://schemas.microsoft.com/office/drawing/2014/main" id="{2F556C2B-0170-54DD-C1A6-389EF3E6B199}"/>
                        </a:ext>
                      </a:extLst>
                    </p:cNvPr>
                    <p:cNvSpPr/>
                    <p:nvPr/>
                  </p:nvSpPr>
                  <p:spPr>
                    <a:xfrm rot="12061517">
                      <a:off x="4899592" y="2047324"/>
                      <a:ext cx="225758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3" name="Chord 8">
                      <a:extLst>
                        <a:ext uri="{FF2B5EF4-FFF2-40B4-BE49-F238E27FC236}">
                          <a16:creationId xmlns:a16="http://schemas.microsoft.com/office/drawing/2014/main" id="{1040D00F-630C-65F5-0170-E8194B7ECFB1}"/>
                        </a:ext>
                      </a:extLst>
                    </p:cNvPr>
                    <p:cNvSpPr/>
                    <p:nvPr/>
                  </p:nvSpPr>
                  <p:spPr>
                    <a:xfrm rot="7809369">
                      <a:off x="4199498" y="1092049"/>
                      <a:ext cx="226844" cy="264481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4" name="Chord 8">
                      <a:extLst>
                        <a:ext uri="{FF2B5EF4-FFF2-40B4-BE49-F238E27FC236}">
                          <a16:creationId xmlns:a16="http://schemas.microsoft.com/office/drawing/2014/main" id="{262BB0EB-5767-4742-0BC9-61F87FED3097}"/>
                        </a:ext>
                      </a:extLst>
                    </p:cNvPr>
                    <p:cNvSpPr/>
                    <p:nvPr/>
                  </p:nvSpPr>
                  <p:spPr>
                    <a:xfrm rot="8883565">
                      <a:off x="4483699" y="1238359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5" name="Chord 8">
                      <a:extLst>
                        <a:ext uri="{FF2B5EF4-FFF2-40B4-BE49-F238E27FC236}">
                          <a16:creationId xmlns:a16="http://schemas.microsoft.com/office/drawing/2014/main" id="{05FACF89-A856-EEFC-605E-69BEEE46327F}"/>
                        </a:ext>
                      </a:extLst>
                    </p:cNvPr>
                    <p:cNvSpPr/>
                    <p:nvPr/>
                  </p:nvSpPr>
                  <p:spPr>
                    <a:xfrm rot="9952404">
                      <a:off x="4709008" y="1466526"/>
                      <a:ext cx="225759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6" name="Chord 8">
                      <a:extLst>
                        <a:ext uri="{FF2B5EF4-FFF2-40B4-BE49-F238E27FC236}">
                          <a16:creationId xmlns:a16="http://schemas.microsoft.com/office/drawing/2014/main" id="{98617106-7DB3-0D37-88B9-B3D59D00E77F}"/>
                        </a:ext>
                      </a:extLst>
                    </p:cNvPr>
                    <p:cNvSpPr/>
                    <p:nvPr/>
                  </p:nvSpPr>
                  <p:spPr>
                    <a:xfrm rot="10967966">
                      <a:off x="4852792" y="1744562"/>
                      <a:ext cx="225759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573" name="Group 572">
                    <a:extLst>
                      <a:ext uri="{FF2B5EF4-FFF2-40B4-BE49-F238E27FC236}">
                        <a16:creationId xmlns:a16="http://schemas.microsoft.com/office/drawing/2014/main" id="{922E9DE3-08FA-086F-9848-25018383A9D5}"/>
                      </a:ext>
                    </a:extLst>
                  </p:cNvPr>
                  <p:cNvGrpSpPr/>
                  <p:nvPr/>
                </p:nvGrpSpPr>
                <p:grpSpPr>
                  <a:xfrm rot="18665489">
                    <a:off x="3293097" y="1192888"/>
                    <a:ext cx="565303" cy="281392"/>
                    <a:chOff x="3879858" y="1056320"/>
                    <a:chExt cx="565303" cy="281392"/>
                  </a:xfrm>
                  <a:grpFill/>
                </p:grpSpPr>
                <p:sp>
                  <p:nvSpPr>
                    <p:cNvPr id="589" name="Chord 8">
                      <a:extLst>
                        <a:ext uri="{FF2B5EF4-FFF2-40B4-BE49-F238E27FC236}">
                          <a16:creationId xmlns:a16="http://schemas.microsoft.com/office/drawing/2014/main" id="{F00B5E7F-014E-2F91-99CB-61CA0E2D7E73}"/>
                        </a:ext>
                      </a:extLst>
                    </p:cNvPr>
                    <p:cNvSpPr/>
                    <p:nvPr/>
                  </p:nvSpPr>
                  <p:spPr>
                    <a:xfrm rot="6763649">
                      <a:off x="3898676" y="1037502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90" name="Chord 8">
                      <a:extLst>
                        <a:ext uri="{FF2B5EF4-FFF2-40B4-BE49-F238E27FC236}">
                          <a16:creationId xmlns:a16="http://schemas.microsoft.com/office/drawing/2014/main" id="{3CE41146-5293-224E-8D62-E1B108F6FF8D}"/>
                        </a:ext>
                      </a:extLst>
                    </p:cNvPr>
                    <p:cNvSpPr/>
                    <p:nvPr/>
                  </p:nvSpPr>
                  <p:spPr>
                    <a:xfrm rot="7929518">
                      <a:off x="4199499" y="1092049"/>
                      <a:ext cx="226844" cy="264481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574" name="Group 573">
                    <a:extLst>
                      <a:ext uri="{FF2B5EF4-FFF2-40B4-BE49-F238E27FC236}">
                        <a16:creationId xmlns:a16="http://schemas.microsoft.com/office/drawing/2014/main" id="{F2026B1D-6A37-D9C8-36B9-5AA45D41B3CE}"/>
                      </a:ext>
                    </a:extLst>
                  </p:cNvPr>
                  <p:cNvGrpSpPr/>
                  <p:nvPr/>
                </p:nvGrpSpPr>
                <p:grpSpPr>
                  <a:xfrm rot="12476886">
                    <a:off x="2872599" y="1738273"/>
                    <a:ext cx="1260384" cy="1268876"/>
                    <a:chOff x="3864966" y="1044202"/>
                    <a:chExt cx="1260384" cy="1268876"/>
                  </a:xfrm>
                  <a:grpFill/>
                </p:grpSpPr>
                <p:sp>
                  <p:nvSpPr>
                    <p:cNvPr id="583" name="Chord 8">
                      <a:extLst>
                        <a:ext uri="{FF2B5EF4-FFF2-40B4-BE49-F238E27FC236}">
                          <a16:creationId xmlns:a16="http://schemas.microsoft.com/office/drawing/2014/main" id="{FAFC685D-ADA9-3294-749F-9B1A58B336E9}"/>
                        </a:ext>
                      </a:extLst>
                    </p:cNvPr>
                    <p:cNvSpPr/>
                    <p:nvPr/>
                  </p:nvSpPr>
                  <p:spPr>
                    <a:xfrm rot="6867466">
                      <a:off x="3883784" y="1025384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4" name="Chord 8">
                      <a:extLst>
                        <a:ext uri="{FF2B5EF4-FFF2-40B4-BE49-F238E27FC236}">
                          <a16:creationId xmlns:a16="http://schemas.microsoft.com/office/drawing/2014/main" id="{86F794AF-356E-2BD7-C16E-638691D49F82}"/>
                        </a:ext>
                      </a:extLst>
                    </p:cNvPr>
                    <p:cNvSpPr/>
                    <p:nvPr/>
                  </p:nvSpPr>
                  <p:spPr>
                    <a:xfrm rot="12061517">
                      <a:off x="4899592" y="2047324"/>
                      <a:ext cx="225758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5" name="Chord 8">
                      <a:extLst>
                        <a:ext uri="{FF2B5EF4-FFF2-40B4-BE49-F238E27FC236}">
                          <a16:creationId xmlns:a16="http://schemas.microsoft.com/office/drawing/2014/main" id="{FB9BC21C-13AA-33EB-ED5B-78792B485190}"/>
                        </a:ext>
                      </a:extLst>
                    </p:cNvPr>
                    <p:cNvSpPr/>
                    <p:nvPr/>
                  </p:nvSpPr>
                  <p:spPr>
                    <a:xfrm rot="7809369">
                      <a:off x="4199498" y="1092049"/>
                      <a:ext cx="226844" cy="264481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6" name="Chord 8">
                      <a:extLst>
                        <a:ext uri="{FF2B5EF4-FFF2-40B4-BE49-F238E27FC236}">
                          <a16:creationId xmlns:a16="http://schemas.microsoft.com/office/drawing/2014/main" id="{31D39AE8-95CC-5263-B233-82CAFCAFC4EF}"/>
                        </a:ext>
                      </a:extLst>
                    </p:cNvPr>
                    <p:cNvSpPr/>
                    <p:nvPr/>
                  </p:nvSpPr>
                  <p:spPr>
                    <a:xfrm rot="8883565">
                      <a:off x="4483699" y="1238359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7" name="Chord 8">
                      <a:extLst>
                        <a:ext uri="{FF2B5EF4-FFF2-40B4-BE49-F238E27FC236}">
                          <a16:creationId xmlns:a16="http://schemas.microsoft.com/office/drawing/2014/main" id="{7CFB915B-B30D-E58C-2A48-916C141D968E}"/>
                        </a:ext>
                      </a:extLst>
                    </p:cNvPr>
                    <p:cNvSpPr/>
                    <p:nvPr/>
                  </p:nvSpPr>
                  <p:spPr>
                    <a:xfrm rot="9952404">
                      <a:off x="4709144" y="1467622"/>
                      <a:ext cx="216778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8" name="Chord 8">
                      <a:extLst>
                        <a:ext uri="{FF2B5EF4-FFF2-40B4-BE49-F238E27FC236}">
                          <a16:creationId xmlns:a16="http://schemas.microsoft.com/office/drawing/2014/main" id="{DBBE2A10-815C-8ECE-A7AA-8D010FF5E346}"/>
                        </a:ext>
                      </a:extLst>
                    </p:cNvPr>
                    <p:cNvSpPr/>
                    <p:nvPr/>
                  </p:nvSpPr>
                  <p:spPr>
                    <a:xfrm rot="10967966">
                      <a:off x="4852792" y="1744562"/>
                      <a:ext cx="225759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575" name="Group 574">
                    <a:extLst>
                      <a:ext uri="{FF2B5EF4-FFF2-40B4-BE49-F238E27FC236}">
                        <a16:creationId xmlns:a16="http://schemas.microsoft.com/office/drawing/2014/main" id="{2CD6CF02-BB71-0491-E730-A84595E913E7}"/>
                      </a:ext>
                    </a:extLst>
                  </p:cNvPr>
                  <p:cNvGrpSpPr/>
                  <p:nvPr/>
                </p:nvGrpSpPr>
                <p:grpSpPr>
                  <a:xfrm rot="6216649">
                    <a:off x="3985707" y="2138034"/>
                    <a:ext cx="1265112" cy="1275229"/>
                    <a:chOff x="3875617" y="1042107"/>
                    <a:chExt cx="1265112" cy="1275229"/>
                  </a:xfrm>
                  <a:grpFill/>
                </p:grpSpPr>
                <p:sp>
                  <p:nvSpPr>
                    <p:cNvPr id="577" name="Chord 8">
                      <a:extLst>
                        <a:ext uri="{FF2B5EF4-FFF2-40B4-BE49-F238E27FC236}">
                          <a16:creationId xmlns:a16="http://schemas.microsoft.com/office/drawing/2014/main" id="{8568EA4B-CD51-9377-67C5-71FF20B463E9}"/>
                        </a:ext>
                      </a:extLst>
                    </p:cNvPr>
                    <p:cNvSpPr/>
                    <p:nvPr/>
                  </p:nvSpPr>
                  <p:spPr>
                    <a:xfrm rot="6829310">
                      <a:off x="3894435" y="1023289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78" name="Chord 8">
                      <a:extLst>
                        <a:ext uri="{FF2B5EF4-FFF2-40B4-BE49-F238E27FC236}">
                          <a16:creationId xmlns:a16="http://schemas.microsoft.com/office/drawing/2014/main" id="{FC5226E6-EB40-0496-C46D-9A24D4B3FDC5}"/>
                        </a:ext>
                      </a:extLst>
                    </p:cNvPr>
                    <p:cNvSpPr/>
                    <p:nvPr/>
                  </p:nvSpPr>
                  <p:spPr>
                    <a:xfrm rot="12054713">
                      <a:off x="4914971" y="2051582"/>
                      <a:ext cx="225758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79" name="Chord 8">
                      <a:extLst>
                        <a:ext uri="{FF2B5EF4-FFF2-40B4-BE49-F238E27FC236}">
                          <a16:creationId xmlns:a16="http://schemas.microsoft.com/office/drawing/2014/main" id="{3FDEACA1-C2FE-2DF8-1FEA-D77DC633C8F1}"/>
                        </a:ext>
                      </a:extLst>
                    </p:cNvPr>
                    <p:cNvSpPr/>
                    <p:nvPr/>
                  </p:nvSpPr>
                  <p:spPr>
                    <a:xfrm rot="7809369">
                      <a:off x="4199498" y="1092049"/>
                      <a:ext cx="226844" cy="264481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0" name="Chord 8">
                      <a:extLst>
                        <a:ext uri="{FF2B5EF4-FFF2-40B4-BE49-F238E27FC236}">
                          <a16:creationId xmlns:a16="http://schemas.microsoft.com/office/drawing/2014/main" id="{FB3A3E45-EDE9-6AE2-E828-AC91D4E341FA}"/>
                        </a:ext>
                      </a:extLst>
                    </p:cNvPr>
                    <p:cNvSpPr/>
                    <p:nvPr/>
                  </p:nvSpPr>
                  <p:spPr>
                    <a:xfrm rot="8883565">
                      <a:off x="4483699" y="1238359"/>
                      <a:ext cx="226845" cy="264482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1" name="Chord 8">
                      <a:extLst>
                        <a:ext uri="{FF2B5EF4-FFF2-40B4-BE49-F238E27FC236}">
                          <a16:creationId xmlns:a16="http://schemas.microsoft.com/office/drawing/2014/main" id="{B824B4BB-BA61-C6CE-2035-A1843A559EAA}"/>
                        </a:ext>
                      </a:extLst>
                    </p:cNvPr>
                    <p:cNvSpPr/>
                    <p:nvPr/>
                  </p:nvSpPr>
                  <p:spPr>
                    <a:xfrm rot="9952404">
                      <a:off x="4709008" y="1466526"/>
                      <a:ext cx="225759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82" name="Chord 8">
                      <a:extLst>
                        <a:ext uri="{FF2B5EF4-FFF2-40B4-BE49-F238E27FC236}">
                          <a16:creationId xmlns:a16="http://schemas.microsoft.com/office/drawing/2014/main" id="{D845B7BF-4FA6-A762-C4B7-A0A621316401}"/>
                        </a:ext>
                      </a:extLst>
                    </p:cNvPr>
                    <p:cNvSpPr/>
                    <p:nvPr/>
                  </p:nvSpPr>
                  <p:spPr>
                    <a:xfrm rot="10967966">
                      <a:off x="4852792" y="1744562"/>
                      <a:ext cx="225759" cy="265754"/>
                    </a:xfrm>
                    <a:custGeom>
                      <a:avLst/>
                      <a:gdLst>
                        <a:gd name="csX0" fmla="*/ 562434 w 658932"/>
                        <a:gd name="csY0" fmla="*/ 562434 h 658932"/>
                        <a:gd name="csX1" fmla="*/ 164733 w 658932"/>
                        <a:gd name="csY1" fmla="*/ 614792 h 658932"/>
                        <a:gd name="csX2" fmla="*/ 11226 w 658932"/>
                        <a:gd name="csY2" fmla="*/ 244194 h 658932"/>
                        <a:gd name="csX3" fmla="*/ 329466 w 658932"/>
                        <a:gd name="csY3" fmla="*/ 0 h 658932"/>
                        <a:gd name="csX4" fmla="*/ 562434 w 658932"/>
                        <a:gd name="csY4" fmla="*/ 562434 h 658932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  <a:gd name="csX0" fmla="*/ 562463 w 562463"/>
                        <a:gd name="csY0" fmla="*/ 562434 h 658939"/>
                        <a:gd name="csX1" fmla="*/ 164762 w 562463"/>
                        <a:gd name="csY1" fmla="*/ 614792 h 658939"/>
                        <a:gd name="csX2" fmla="*/ 11255 w 562463"/>
                        <a:gd name="csY2" fmla="*/ 244194 h 658939"/>
                        <a:gd name="csX3" fmla="*/ 329495 w 562463"/>
                        <a:gd name="csY3" fmla="*/ 0 h 658939"/>
                        <a:gd name="csX4" fmla="*/ 562463 w 562463"/>
                        <a:gd name="csY4" fmla="*/ 562434 h 658939"/>
                      </a:gdLst>
                      <a:ahLst/>
                      <a:cxnLst>
                        <a:cxn ang="0">
                          <a:pos x="csX0" y="csY0"/>
                        </a:cxn>
                        <a:cxn ang="0">
                          <a:pos x="csX1" y="csY1"/>
                        </a:cxn>
                        <a:cxn ang="0">
                          <a:pos x="csX2" y="csY2"/>
                        </a:cxn>
                        <a:cxn ang="0">
                          <a:pos x="csX3" y="csY3"/>
                        </a:cxn>
                        <a:cxn ang="0">
                          <a:pos x="csX4" y="csY4"/>
                        </a:cxn>
                      </a:cxnLst>
                      <a:rect l="l" t="t" r="r" b="b"/>
                      <a:pathLst>
                        <a:path w="562463" h="658939">
                          <a:moveTo>
                            <a:pt x="562463" y="562434"/>
                          </a:moveTo>
                          <a:cubicBezTo>
                            <a:pt x="457021" y="667876"/>
                            <a:pt x="293902" y="689351"/>
                            <a:pt x="164762" y="614792"/>
                          </a:cubicBezTo>
                          <a:cubicBezTo>
                            <a:pt x="35622" y="540233"/>
                            <a:pt x="-27339" y="388231"/>
                            <a:pt x="11255" y="244194"/>
                          </a:cubicBezTo>
                          <a:cubicBezTo>
                            <a:pt x="49850" y="100157"/>
                            <a:pt x="180377" y="0"/>
                            <a:pt x="329495" y="0"/>
                          </a:cubicBezTo>
                          <a:cubicBezTo>
                            <a:pt x="341793" y="206804"/>
                            <a:pt x="426696" y="418791"/>
                            <a:pt x="562463" y="562434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0">
                          <a:srgbClr val="953262">
                            <a:shade val="30000"/>
                            <a:satMod val="115000"/>
                          </a:srgbClr>
                        </a:gs>
                        <a:gs pos="50000">
                          <a:srgbClr val="953262">
                            <a:shade val="67500"/>
                            <a:satMod val="115000"/>
                          </a:srgbClr>
                        </a:gs>
                        <a:gs pos="100000">
                          <a:srgbClr val="953262">
                            <a:shade val="100000"/>
                            <a:satMod val="115000"/>
                          </a:srgbClr>
                        </a:gs>
                      </a:gsLst>
                      <a:path path="circle">
                        <a:fillToRect l="50000" t="50000" r="50000" b="50000"/>
                      </a:path>
                      <a:tileRect/>
                    </a:gradFill>
                    <a:ln w="3175">
                      <a:noFill/>
                    </a:ln>
                    <a:effectLst/>
                    <a:scene3d>
                      <a:camera prst="orthographicFront"/>
                      <a:lightRig rig="threePt" dir="t"/>
                    </a:scene3d>
                    <a:sp3d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76" name="Chord 8">
                    <a:extLst>
                      <a:ext uri="{FF2B5EF4-FFF2-40B4-BE49-F238E27FC236}">
                        <a16:creationId xmlns:a16="http://schemas.microsoft.com/office/drawing/2014/main" id="{82076D9A-83BA-A406-F203-D9AD5F7345FA}"/>
                      </a:ext>
                    </a:extLst>
                  </p:cNvPr>
                  <p:cNvSpPr/>
                  <p:nvPr/>
                </p:nvSpPr>
                <p:spPr>
                  <a:xfrm rot="5937933">
                    <a:off x="3869463" y="983360"/>
                    <a:ext cx="226844" cy="264481"/>
                  </a:xfrm>
                  <a:custGeom>
                    <a:avLst/>
                    <a:gdLst>
                      <a:gd name="csX0" fmla="*/ 562434 w 658932"/>
                      <a:gd name="csY0" fmla="*/ 562434 h 658932"/>
                      <a:gd name="csX1" fmla="*/ 164733 w 658932"/>
                      <a:gd name="csY1" fmla="*/ 614792 h 658932"/>
                      <a:gd name="csX2" fmla="*/ 11226 w 658932"/>
                      <a:gd name="csY2" fmla="*/ 244194 h 658932"/>
                      <a:gd name="csX3" fmla="*/ 329466 w 658932"/>
                      <a:gd name="csY3" fmla="*/ 0 h 658932"/>
                      <a:gd name="csX4" fmla="*/ 562434 w 658932"/>
                      <a:gd name="csY4" fmla="*/ 562434 h 658932"/>
                      <a:gd name="csX0" fmla="*/ 562463 w 562463"/>
                      <a:gd name="csY0" fmla="*/ 562434 h 658939"/>
                      <a:gd name="csX1" fmla="*/ 164762 w 562463"/>
                      <a:gd name="csY1" fmla="*/ 614792 h 658939"/>
                      <a:gd name="csX2" fmla="*/ 11255 w 562463"/>
                      <a:gd name="csY2" fmla="*/ 244194 h 658939"/>
                      <a:gd name="csX3" fmla="*/ 329495 w 562463"/>
                      <a:gd name="csY3" fmla="*/ 0 h 658939"/>
                      <a:gd name="csX4" fmla="*/ 562463 w 562463"/>
                      <a:gd name="csY4" fmla="*/ 562434 h 658939"/>
                      <a:gd name="csX0" fmla="*/ 562463 w 562463"/>
                      <a:gd name="csY0" fmla="*/ 562434 h 658939"/>
                      <a:gd name="csX1" fmla="*/ 164762 w 562463"/>
                      <a:gd name="csY1" fmla="*/ 614792 h 658939"/>
                      <a:gd name="csX2" fmla="*/ 11255 w 562463"/>
                      <a:gd name="csY2" fmla="*/ 244194 h 658939"/>
                      <a:gd name="csX3" fmla="*/ 329495 w 562463"/>
                      <a:gd name="csY3" fmla="*/ 0 h 658939"/>
                      <a:gd name="csX4" fmla="*/ 562463 w 562463"/>
                      <a:gd name="csY4" fmla="*/ 562434 h 658939"/>
                    </a:gdLst>
                    <a:ahLst/>
                    <a:cxnLst>
                      <a:cxn ang="0">
                        <a:pos x="csX0" y="csY0"/>
                      </a:cxn>
                      <a:cxn ang="0">
                        <a:pos x="csX1" y="csY1"/>
                      </a:cxn>
                      <a:cxn ang="0">
                        <a:pos x="csX2" y="csY2"/>
                      </a:cxn>
                      <a:cxn ang="0">
                        <a:pos x="csX3" y="csY3"/>
                      </a:cxn>
                      <a:cxn ang="0">
                        <a:pos x="csX4" y="csY4"/>
                      </a:cxn>
                    </a:cxnLst>
                    <a:rect l="l" t="t" r="r" b="b"/>
                    <a:pathLst>
                      <a:path w="562463" h="658939">
                        <a:moveTo>
                          <a:pt x="562463" y="562434"/>
                        </a:moveTo>
                        <a:cubicBezTo>
                          <a:pt x="457021" y="667876"/>
                          <a:pt x="293902" y="689351"/>
                          <a:pt x="164762" y="614792"/>
                        </a:cubicBezTo>
                        <a:cubicBezTo>
                          <a:pt x="35622" y="540233"/>
                          <a:pt x="-27339" y="388231"/>
                          <a:pt x="11255" y="244194"/>
                        </a:cubicBezTo>
                        <a:cubicBezTo>
                          <a:pt x="49850" y="100157"/>
                          <a:pt x="180377" y="0"/>
                          <a:pt x="329495" y="0"/>
                        </a:cubicBezTo>
                        <a:cubicBezTo>
                          <a:pt x="341793" y="206804"/>
                          <a:pt x="426696" y="418791"/>
                          <a:pt x="562463" y="562434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rgbClr val="953262">
                          <a:shade val="30000"/>
                          <a:satMod val="115000"/>
                        </a:srgbClr>
                      </a:gs>
                      <a:gs pos="50000">
                        <a:srgbClr val="953262">
                          <a:shade val="67500"/>
                          <a:satMod val="115000"/>
                        </a:srgbClr>
                      </a:gs>
                      <a:gs pos="100000">
                        <a:srgbClr val="953262">
                          <a:shade val="100000"/>
                          <a:satMod val="115000"/>
                        </a:srgbClr>
                      </a:gs>
                    </a:gsLst>
                    <a:path path="circle">
                      <a:fillToRect l="50000" t="50000" r="50000" b="50000"/>
                    </a:path>
                    <a:tileRect/>
                  </a:gradFill>
                  <a:ln w="3175">
                    <a:noFill/>
                  </a:ln>
                  <a:effectLst/>
                  <a:scene3d>
                    <a:camera prst="orthographicFront"/>
                    <a:lightRig rig="threePt" dir="t"/>
                  </a:scene3d>
                  <a:sp3d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cxnSp>
          <p:nvCxnSpPr>
            <p:cNvPr id="3209" name="Straight Arrow Connector 3208">
              <a:extLst>
                <a:ext uri="{FF2B5EF4-FFF2-40B4-BE49-F238E27FC236}">
                  <a16:creationId xmlns:a16="http://schemas.microsoft.com/office/drawing/2014/main" id="{59F04AB6-1B6F-9ED0-AC8E-481FD18C76D5}"/>
                </a:ext>
              </a:extLst>
            </p:cNvPr>
            <p:cNvCxnSpPr>
              <a:cxnSpLocks/>
              <a:endCxn id="3775" idx="1"/>
            </p:cNvCxnSpPr>
            <p:nvPr/>
          </p:nvCxnSpPr>
          <p:spPr>
            <a:xfrm>
              <a:off x="1051560" y="327896"/>
              <a:ext cx="829955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0" name="Straight Arrow Connector 3209">
              <a:extLst>
                <a:ext uri="{FF2B5EF4-FFF2-40B4-BE49-F238E27FC236}">
                  <a16:creationId xmlns:a16="http://schemas.microsoft.com/office/drawing/2014/main" id="{71904BB4-2D83-A6EB-DFA2-1CB366A5D55D}"/>
                </a:ext>
              </a:extLst>
            </p:cNvPr>
            <p:cNvCxnSpPr>
              <a:cxnSpLocks/>
              <a:endCxn id="3771" idx="0"/>
            </p:cNvCxnSpPr>
            <p:nvPr/>
          </p:nvCxnSpPr>
          <p:spPr>
            <a:xfrm>
              <a:off x="1051560" y="443989"/>
              <a:ext cx="83769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1" name="Straight Arrow Connector 3210">
              <a:extLst>
                <a:ext uri="{FF2B5EF4-FFF2-40B4-BE49-F238E27FC236}">
                  <a16:creationId xmlns:a16="http://schemas.microsoft.com/office/drawing/2014/main" id="{2F8FF9D9-4D7D-E9C9-C6A4-1BD03B653050}"/>
                </a:ext>
              </a:extLst>
            </p:cNvPr>
            <p:cNvCxnSpPr>
              <a:cxnSpLocks/>
              <a:endCxn id="3766" idx="0"/>
            </p:cNvCxnSpPr>
            <p:nvPr/>
          </p:nvCxnSpPr>
          <p:spPr>
            <a:xfrm>
              <a:off x="1045081" y="580080"/>
              <a:ext cx="647015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2" name="Straight Arrow Connector 3211">
              <a:extLst>
                <a:ext uri="{FF2B5EF4-FFF2-40B4-BE49-F238E27FC236}">
                  <a16:creationId xmlns:a16="http://schemas.microsoft.com/office/drawing/2014/main" id="{1342CFE5-6862-CB68-3D7E-C4295383AD51}"/>
                </a:ext>
              </a:extLst>
            </p:cNvPr>
            <p:cNvCxnSpPr>
              <a:cxnSpLocks/>
              <a:endCxn id="3661" idx="2"/>
            </p:cNvCxnSpPr>
            <p:nvPr/>
          </p:nvCxnSpPr>
          <p:spPr>
            <a:xfrm>
              <a:off x="1041842" y="690238"/>
              <a:ext cx="598019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3" name="Straight Arrow Connector 3212">
              <a:extLst>
                <a:ext uri="{FF2B5EF4-FFF2-40B4-BE49-F238E27FC236}">
                  <a16:creationId xmlns:a16="http://schemas.microsoft.com/office/drawing/2014/main" id="{D9880C80-4B28-C30D-0895-6FEB4E56B37D}"/>
                </a:ext>
              </a:extLst>
            </p:cNvPr>
            <p:cNvCxnSpPr>
              <a:cxnSpLocks/>
            </p:cNvCxnSpPr>
            <p:nvPr/>
          </p:nvCxnSpPr>
          <p:spPr>
            <a:xfrm>
              <a:off x="1041842" y="1190047"/>
              <a:ext cx="577003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4" name="Straight Arrow Connector 3213">
              <a:extLst>
                <a:ext uri="{FF2B5EF4-FFF2-40B4-BE49-F238E27FC236}">
                  <a16:creationId xmlns:a16="http://schemas.microsoft.com/office/drawing/2014/main" id="{89E23974-A265-B82C-B9AB-76916FB17ADA}"/>
                </a:ext>
              </a:extLst>
            </p:cNvPr>
            <p:cNvCxnSpPr>
              <a:cxnSpLocks/>
            </p:cNvCxnSpPr>
            <p:nvPr/>
          </p:nvCxnSpPr>
          <p:spPr>
            <a:xfrm>
              <a:off x="1041842" y="868680"/>
              <a:ext cx="764115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5" name="Straight Arrow Connector 3214">
              <a:extLst>
                <a:ext uri="{FF2B5EF4-FFF2-40B4-BE49-F238E27FC236}">
                  <a16:creationId xmlns:a16="http://schemas.microsoft.com/office/drawing/2014/main" id="{E86CB3ED-2B74-C624-B47C-2F53F681442B}"/>
                </a:ext>
              </a:extLst>
            </p:cNvPr>
            <p:cNvCxnSpPr>
              <a:cxnSpLocks/>
            </p:cNvCxnSpPr>
            <p:nvPr/>
          </p:nvCxnSpPr>
          <p:spPr>
            <a:xfrm>
              <a:off x="1041842" y="1314689"/>
              <a:ext cx="723769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16" name="Group 3215">
              <a:extLst>
                <a:ext uri="{FF2B5EF4-FFF2-40B4-BE49-F238E27FC236}">
                  <a16:creationId xmlns:a16="http://schemas.microsoft.com/office/drawing/2014/main" id="{5854715D-5B37-6BBE-6E57-2721214B2CC0}"/>
                </a:ext>
              </a:extLst>
            </p:cNvPr>
            <p:cNvGrpSpPr/>
            <p:nvPr/>
          </p:nvGrpSpPr>
          <p:grpSpPr>
            <a:xfrm>
              <a:off x="808881" y="257986"/>
              <a:ext cx="324539" cy="504235"/>
              <a:chOff x="720466" y="262601"/>
              <a:chExt cx="324539" cy="504235"/>
            </a:xfrm>
          </p:grpSpPr>
          <p:sp>
            <p:nvSpPr>
              <p:cNvPr id="3228" name="Rectangle 3227">
                <a:extLst>
                  <a:ext uri="{FF2B5EF4-FFF2-40B4-BE49-F238E27FC236}">
                    <a16:creationId xmlns:a16="http://schemas.microsoft.com/office/drawing/2014/main" id="{5FC39CB7-7FD9-48E4-CEC4-012F38BF882D}"/>
                  </a:ext>
                </a:extLst>
              </p:cNvPr>
              <p:cNvSpPr/>
              <p:nvPr/>
            </p:nvSpPr>
            <p:spPr>
              <a:xfrm>
                <a:off x="725749" y="262601"/>
                <a:ext cx="319255" cy="13995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l-GR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σ</a:t>
                </a:r>
                <a:r>
                  <a:rPr 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229" name="Rectangle 3228">
                <a:extLst>
                  <a:ext uri="{FF2B5EF4-FFF2-40B4-BE49-F238E27FC236}">
                    <a16:creationId xmlns:a16="http://schemas.microsoft.com/office/drawing/2014/main" id="{73AAA910-2EA1-2FD0-0236-675911D7E3C9}"/>
                  </a:ext>
                </a:extLst>
              </p:cNvPr>
              <p:cNvSpPr/>
              <p:nvPr/>
            </p:nvSpPr>
            <p:spPr>
              <a:xfrm>
                <a:off x="720466" y="525817"/>
                <a:ext cx="319255" cy="11775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l-GR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σ</a:t>
                </a:r>
                <a:r>
                  <a:rPr 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230" name="Rectangle 3229">
                <a:extLst>
                  <a:ext uri="{FF2B5EF4-FFF2-40B4-BE49-F238E27FC236}">
                    <a16:creationId xmlns:a16="http://schemas.microsoft.com/office/drawing/2014/main" id="{BF4F0EC3-ACB7-ED08-90D4-E3C47229F80E}"/>
                  </a:ext>
                </a:extLst>
              </p:cNvPr>
              <p:cNvSpPr/>
              <p:nvPr/>
            </p:nvSpPr>
            <p:spPr>
              <a:xfrm>
                <a:off x="725750" y="385865"/>
                <a:ext cx="319255" cy="12547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l-GR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λ</a:t>
                </a:r>
                <a:r>
                  <a:rPr 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231" name="Rectangle 3230">
                <a:extLst>
                  <a:ext uri="{FF2B5EF4-FFF2-40B4-BE49-F238E27FC236}">
                    <a16:creationId xmlns:a16="http://schemas.microsoft.com/office/drawing/2014/main" id="{F656E078-BADC-0D18-F412-017E8E4C56B9}"/>
                  </a:ext>
                </a:extLst>
              </p:cNvPr>
              <p:cNvSpPr/>
              <p:nvPr/>
            </p:nvSpPr>
            <p:spPr>
              <a:xfrm>
                <a:off x="725748" y="622872"/>
                <a:ext cx="319255" cy="14396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l-GR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μ</a:t>
                </a:r>
                <a:r>
                  <a:rPr 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Cambria" panose="02040503050406030204" pitchFamily="18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232" name="Left Bracket 3231">
                <a:extLst>
                  <a:ext uri="{FF2B5EF4-FFF2-40B4-BE49-F238E27FC236}">
                    <a16:creationId xmlns:a16="http://schemas.microsoft.com/office/drawing/2014/main" id="{93C37A8C-E61D-2A09-4F75-1E653B64914E}"/>
                  </a:ext>
                </a:extLst>
              </p:cNvPr>
              <p:cNvSpPr/>
              <p:nvPr/>
            </p:nvSpPr>
            <p:spPr>
              <a:xfrm>
                <a:off x="757532" y="336378"/>
                <a:ext cx="62476" cy="368957"/>
              </a:xfrm>
              <a:prstGeom prst="leftBracket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600" b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17" name="Rectangle 3216">
              <a:extLst>
                <a:ext uri="{FF2B5EF4-FFF2-40B4-BE49-F238E27FC236}">
                  <a16:creationId xmlns:a16="http://schemas.microsoft.com/office/drawing/2014/main" id="{EC2DFC2E-74DF-C2B2-4981-E1828BD36BC7}"/>
                </a:ext>
              </a:extLst>
            </p:cNvPr>
            <p:cNvSpPr/>
            <p:nvPr/>
          </p:nvSpPr>
          <p:spPr>
            <a:xfrm>
              <a:off x="806049" y="1154446"/>
              <a:ext cx="319255" cy="722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σ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218" name="Rectangle 3217">
              <a:extLst>
                <a:ext uri="{FF2B5EF4-FFF2-40B4-BE49-F238E27FC236}">
                  <a16:creationId xmlns:a16="http://schemas.microsoft.com/office/drawing/2014/main" id="{319A6AD6-70F0-0F61-C46E-EEBED78FFDB6}"/>
                </a:ext>
              </a:extLst>
            </p:cNvPr>
            <p:cNvSpPr/>
            <p:nvPr/>
          </p:nvSpPr>
          <p:spPr>
            <a:xfrm>
              <a:off x="805531" y="1275199"/>
              <a:ext cx="319255" cy="722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λ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219" name="Left Bracket 3218">
              <a:extLst>
                <a:ext uri="{FF2B5EF4-FFF2-40B4-BE49-F238E27FC236}">
                  <a16:creationId xmlns:a16="http://schemas.microsoft.com/office/drawing/2014/main" id="{7CA833C6-B26F-1AB2-7EE8-8F06798EAD83}"/>
                </a:ext>
              </a:extLst>
            </p:cNvPr>
            <p:cNvSpPr/>
            <p:nvPr/>
          </p:nvSpPr>
          <p:spPr>
            <a:xfrm>
              <a:off x="855431" y="1187479"/>
              <a:ext cx="45719" cy="125084"/>
            </a:xfrm>
            <a:prstGeom prst="leftBracket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220" name="Rectangle 3219">
              <a:extLst>
                <a:ext uri="{FF2B5EF4-FFF2-40B4-BE49-F238E27FC236}">
                  <a16:creationId xmlns:a16="http://schemas.microsoft.com/office/drawing/2014/main" id="{5A8242F4-42C7-CCF9-B77A-3A43A68C1B06}"/>
                </a:ext>
              </a:extLst>
            </p:cNvPr>
            <p:cNvSpPr/>
            <p:nvPr/>
          </p:nvSpPr>
          <p:spPr>
            <a:xfrm>
              <a:off x="808880" y="1027894"/>
              <a:ext cx="319255" cy="722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λ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221" name="Rectangle 3220">
              <a:extLst>
                <a:ext uri="{FF2B5EF4-FFF2-40B4-BE49-F238E27FC236}">
                  <a16:creationId xmlns:a16="http://schemas.microsoft.com/office/drawing/2014/main" id="{B5814AA9-D999-CECC-1B40-F4D800709C86}"/>
                </a:ext>
              </a:extLst>
            </p:cNvPr>
            <p:cNvSpPr/>
            <p:nvPr/>
          </p:nvSpPr>
          <p:spPr>
            <a:xfrm>
              <a:off x="808880" y="830509"/>
              <a:ext cx="319255" cy="722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μ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222" name="Rectangle 3221">
              <a:extLst>
                <a:ext uri="{FF2B5EF4-FFF2-40B4-BE49-F238E27FC236}">
                  <a16:creationId xmlns:a16="http://schemas.microsoft.com/office/drawing/2014/main" id="{C6D1F77B-EC58-F0B7-F14F-DDDDC204D218}"/>
                </a:ext>
              </a:extLst>
            </p:cNvPr>
            <p:cNvSpPr/>
            <p:nvPr/>
          </p:nvSpPr>
          <p:spPr>
            <a:xfrm>
              <a:off x="106578" y="1199910"/>
              <a:ext cx="781973" cy="1035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Inner capsid</a:t>
              </a:r>
            </a:p>
          </p:txBody>
        </p:sp>
        <p:sp>
          <p:nvSpPr>
            <p:cNvPr id="3223" name="Rectangle 3222">
              <a:extLst>
                <a:ext uri="{FF2B5EF4-FFF2-40B4-BE49-F238E27FC236}">
                  <a16:creationId xmlns:a16="http://schemas.microsoft.com/office/drawing/2014/main" id="{51AF4011-A489-4F06-2AFA-75DB8150D0BD}"/>
                </a:ext>
              </a:extLst>
            </p:cNvPr>
            <p:cNvSpPr/>
            <p:nvPr/>
          </p:nvSpPr>
          <p:spPr>
            <a:xfrm>
              <a:off x="120079" y="474807"/>
              <a:ext cx="781973" cy="1035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Outer capsid</a:t>
              </a:r>
            </a:p>
          </p:txBody>
        </p:sp>
        <p:sp>
          <p:nvSpPr>
            <p:cNvPr id="3224" name="Rectangle 3223">
              <a:extLst>
                <a:ext uri="{FF2B5EF4-FFF2-40B4-BE49-F238E27FC236}">
                  <a16:creationId xmlns:a16="http://schemas.microsoft.com/office/drawing/2014/main" id="{E07E5C70-CD21-3F4F-3367-950177952D85}"/>
                </a:ext>
              </a:extLst>
            </p:cNvPr>
            <p:cNvSpPr/>
            <p:nvPr/>
          </p:nvSpPr>
          <p:spPr>
            <a:xfrm>
              <a:off x="49876" y="832509"/>
              <a:ext cx="895135" cy="79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olymerase associated protein</a:t>
              </a:r>
            </a:p>
          </p:txBody>
        </p:sp>
        <p:sp>
          <p:nvSpPr>
            <p:cNvPr id="3225" name="Rectangle 3224">
              <a:extLst>
                <a:ext uri="{FF2B5EF4-FFF2-40B4-BE49-F238E27FC236}">
                  <a16:creationId xmlns:a16="http://schemas.microsoft.com/office/drawing/2014/main" id="{8E552522-7905-5ADB-81F3-1F2F9D5C8DDD}"/>
                </a:ext>
              </a:extLst>
            </p:cNvPr>
            <p:cNvSpPr/>
            <p:nvPr/>
          </p:nvSpPr>
          <p:spPr>
            <a:xfrm>
              <a:off x="147884" y="1012400"/>
              <a:ext cx="781973" cy="10355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olymerase</a:t>
              </a:r>
            </a:p>
          </p:txBody>
        </p:sp>
        <p:sp>
          <p:nvSpPr>
            <p:cNvPr id="3226" name="Rectangle 3225">
              <a:extLst>
                <a:ext uri="{FF2B5EF4-FFF2-40B4-BE49-F238E27FC236}">
                  <a16:creationId xmlns:a16="http://schemas.microsoft.com/office/drawing/2014/main" id="{547D1A4D-F2C6-0542-EFCD-4774ACD2A4AE}"/>
                </a:ext>
              </a:extLst>
            </p:cNvPr>
            <p:cNvSpPr/>
            <p:nvPr/>
          </p:nvSpPr>
          <p:spPr>
            <a:xfrm>
              <a:off x="-42814" y="1444649"/>
              <a:ext cx="1094374" cy="7846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μ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NS, </a:t>
              </a:r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μ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NSC, </a:t>
              </a:r>
              <a:r>
                <a:rPr lang="el-GR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σ</a:t>
              </a:r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NS </a:t>
              </a:r>
            </a:p>
            <a:p>
              <a:pPr algn="ctr"/>
              <a:r>
                <a:rPr 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(non structural protein)</a:t>
              </a:r>
              <a:endParaRPr lang="en-US" sz="600" b="1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3227" name="Straight Arrow Connector 3226">
              <a:extLst>
                <a:ext uri="{FF2B5EF4-FFF2-40B4-BE49-F238E27FC236}">
                  <a16:creationId xmlns:a16="http://schemas.microsoft.com/office/drawing/2014/main" id="{44FDC73F-FAB1-9F7C-7A29-A3BB9F0B08D9}"/>
                </a:ext>
              </a:extLst>
            </p:cNvPr>
            <p:cNvCxnSpPr>
              <a:cxnSpLocks/>
            </p:cNvCxnSpPr>
            <p:nvPr/>
          </p:nvCxnSpPr>
          <p:spPr>
            <a:xfrm>
              <a:off x="1041842" y="1063463"/>
              <a:ext cx="637919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62" name="Rectangle 3861">
            <a:extLst>
              <a:ext uri="{FF2B5EF4-FFF2-40B4-BE49-F238E27FC236}">
                <a16:creationId xmlns:a16="http://schemas.microsoft.com/office/drawing/2014/main" id="{B22CDED4-6D41-F190-86D0-D50638FA6566}"/>
              </a:ext>
            </a:extLst>
          </p:cNvPr>
          <p:cNvSpPr/>
          <p:nvPr/>
        </p:nvSpPr>
        <p:spPr>
          <a:xfrm>
            <a:off x="3489002" y="3561353"/>
            <a:ext cx="590295" cy="1737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wissADME</a:t>
            </a:r>
          </a:p>
        </p:txBody>
      </p:sp>
      <p:sp>
        <p:nvSpPr>
          <p:cNvPr id="3864" name="Rectangle 3863">
            <a:extLst>
              <a:ext uri="{FF2B5EF4-FFF2-40B4-BE49-F238E27FC236}">
                <a16:creationId xmlns:a16="http://schemas.microsoft.com/office/drawing/2014/main" id="{E3300CB8-03B4-215C-1ACE-12F154F5445B}"/>
              </a:ext>
            </a:extLst>
          </p:cNvPr>
          <p:cNvSpPr/>
          <p:nvPr/>
        </p:nvSpPr>
        <p:spPr>
          <a:xfrm>
            <a:off x="1850086" y="2978914"/>
            <a:ext cx="519909" cy="962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00" b="1" i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GROMACS</a:t>
            </a:r>
          </a:p>
        </p:txBody>
      </p:sp>
      <p:grpSp>
        <p:nvGrpSpPr>
          <p:cNvPr id="3871" name="Group 3870">
            <a:extLst>
              <a:ext uri="{FF2B5EF4-FFF2-40B4-BE49-F238E27FC236}">
                <a16:creationId xmlns:a16="http://schemas.microsoft.com/office/drawing/2014/main" id="{44A033A3-6537-8068-5263-1DD2BADF73F1}"/>
              </a:ext>
            </a:extLst>
          </p:cNvPr>
          <p:cNvGrpSpPr/>
          <p:nvPr/>
        </p:nvGrpSpPr>
        <p:grpSpPr>
          <a:xfrm>
            <a:off x="5571915" y="3539694"/>
            <a:ext cx="1208034" cy="1119213"/>
            <a:chOff x="4164839" y="1954524"/>
            <a:chExt cx="4323826" cy="4005912"/>
          </a:xfrm>
        </p:grpSpPr>
        <p:grpSp>
          <p:nvGrpSpPr>
            <p:cNvPr id="3873" name="Group 3872">
              <a:extLst>
                <a:ext uri="{FF2B5EF4-FFF2-40B4-BE49-F238E27FC236}">
                  <a16:creationId xmlns:a16="http://schemas.microsoft.com/office/drawing/2014/main" id="{686F2EE0-1AD0-ECE6-FC69-DB55B6B68ABA}"/>
                </a:ext>
              </a:extLst>
            </p:cNvPr>
            <p:cNvGrpSpPr/>
            <p:nvPr/>
          </p:nvGrpSpPr>
          <p:grpSpPr>
            <a:xfrm>
              <a:off x="4164839" y="1954524"/>
              <a:ext cx="4323826" cy="4005912"/>
              <a:chOff x="4164839" y="1954524"/>
              <a:chExt cx="4323826" cy="4005912"/>
            </a:xfrm>
          </p:grpSpPr>
          <p:grpSp>
            <p:nvGrpSpPr>
              <p:cNvPr id="3875" name="Group 3874">
                <a:extLst>
                  <a:ext uri="{FF2B5EF4-FFF2-40B4-BE49-F238E27FC236}">
                    <a16:creationId xmlns:a16="http://schemas.microsoft.com/office/drawing/2014/main" id="{C73878B8-FB7C-69CB-99F7-39C2C4A120FF}"/>
                  </a:ext>
                </a:extLst>
              </p:cNvPr>
              <p:cNvGrpSpPr/>
              <p:nvPr/>
            </p:nvGrpSpPr>
            <p:grpSpPr>
              <a:xfrm>
                <a:off x="4164839" y="1954524"/>
                <a:ext cx="4323826" cy="4005912"/>
                <a:chOff x="5827135" y="1954229"/>
                <a:chExt cx="2447932" cy="2267946"/>
              </a:xfrm>
            </p:grpSpPr>
            <p:sp>
              <p:nvSpPr>
                <p:cNvPr id="3880" name="Trapezoid 16">
                  <a:extLst>
                    <a:ext uri="{FF2B5EF4-FFF2-40B4-BE49-F238E27FC236}">
                      <a16:creationId xmlns:a16="http://schemas.microsoft.com/office/drawing/2014/main" id="{37416769-06B8-EA6C-4F15-8105601B79A6}"/>
                    </a:ext>
                  </a:extLst>
                </p:cNvPr>
                <p:cNvSpPr/>
                <p:nvPr/>
              </p:nvSpPr>
              <p:spPr>
                <a:xfrm rot="155691">
                  <a:off x="6295934" y="3732543"/>
                  <a:ext cx="1064310" cy="489632"/>
                </a:xfrm>
                <a:custGeom>
                  <a:avLst/>
                  <a:gdLst>
                    <a:gd name="csX0" fmla="*/ 0 w 745298"/>
                    <a:gd name="csY0" fmla="*/ 523875 h 523875"/>
                    <a:gd name="csX1" fmla="*/ 130969 w 745298"/>
                    <a:gd name="csY1" fmla="*/ 0 h 523875"/>
                    <a:gd name="csX2" fmla="*/ 614329 w 745298"/>
                    <a:gd name="csY2" fmla="*/ 0 h 523875"/>
                    <a:gd name="csX3" fmla="*/ 745298 w 745298"/>
                    <a:gd name="csY3" fmla="*/ 523875 h 523875"/>
                    <a:gd name="csX4" fmla="*/ 0 w 745298"/>
                    <a:gd name="csY4" fmla="*/ 523875 h 523875"/>
                    <a:gd name="csX0" fmla="*/ 0 w 1045957"/>
                    <a:gd name="csY0" fmla="*/ 369688 h 523875"/>
                    <a:gd name="csX1" fmla="*/ 431628 w 1045957"/>
                    <a:gd name="csY1" fmla="*/ 0 h 523875"/>
                    <a:gd name="csX2" fmla="*/ 914988 w 1045957"/>
                    <a:gd name="csY2" fmla="*/ 0 h 523875"/>
                    <a:gd name="csX3" fmla="*/ 1045957 w 1045957"/>
                    <a:gd name="csY3" fmla="*/ 523875 h 523875"/>
                    <a:gd name="csX4" fmla="*/ 0 w 1045957"/>
                    <a:gd name="csY4" fmla="*/ 369688 h 523875"/>
                    <a:gd name="csX0" fmla="*/ 0 w 968294"/>
                    <a:gd name="csY0" fmla="*/ 369688 h 409164"/>
                    <a:gd name="csX1" fmla="*/ 431628 w 968294"/>
                    <a:gd name="csY1" fmla="*/ 0 h 409164"/>
                    <a:gd name="csX2" fmla="*/ 914988 w 968294"/>
                    <a:gd name="csY2" fmla="*/ 0 h 409164"/>
                    <a:gd name="csX3" fmla="*/ 968294 w 968294"/>
                    <a:gd name="csY3" fmla="*/ 409164 h 409164"/>
                    <a:gd name="csX4" fmla="*/ 0 w 968294"/>
                    <a:gd name="csY4" fmla="*/ 369688 h 409164"/>
                    <a:gd name="csX0" fmla="*/ 0 w 914988"/>
                    <a:gd name="csY0" fmla="*/ 369688 h 437412"/>
                    <a:gd name="csX1" fmla="*/ 431628 w 914988"/>
                    <a:gd name="csY1" fmla="*/ 0 h 437412"/>
                    <a:gd name="csX2" fmla="*/ 914988 w 914988"/>
                    <a:gd name="csY2" fmla="*/ 0 h 437412"/>
                    <a:gd name="csX3" fmla="*/ 681624 w 914988"/>
                    <a:gd name="csY3" fmla="*/ 437412 h 437412"/>
                    <a:gd name="csX4" fmla="*/ 0 w 914988"/>
                    <a:gd name="csY4" fmla="*/ 369688 h 437412"/>
                    <a:gd name="csX0" fmla="*/ 0 w 914988"/>
                    <a:gd name="csY0" fmla="*/ 369688 h 437412"/>
                    <a:gd name="csX1" fmla="*/ 431628 w 914988"/>
                    <a:gd name="csY1" fmla="*/ 0 h 437412"/>
                    <a:gd name="csX2" fmla="*/ 914988 w 914988"/>
                    <a:gd name="csY2" fmla="*/ 0 h 437412"/>
                    <a:gd name="csX3" fmla="*/ 681624 w 914988"/>
                    <a:gd name="csY3" fmla="*/ 437412 h 437412"/>
                    <a:gd name="csX4" fmla="*/ 0 w 914988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66073"/>
                    <a:gd name="csY0" fmla="*/ 369688 h 437412"/>
                    <a:gd name="csX1" fmla="*/ 431628 w 966073"/>
                    <a:gd name="csY1" fmla="*/ 0 h 437412"/>
                    <a:gd name="csX2" fmla="*/ 914988 w 966073"/>
                    <a:gd name="csY2" fmla="*/ 0 h 437412"/>
                    <a:gd name="csX3" fmla="*/ 681624 w 966073"/>
                    <a:gd name="csY3" fmla="*/ 437412 h 437412"/>
                    <a:gd name="csX4" fmla="*/ 0 w 966073"/>
                    <a:gd name="csY4" fmla="*/ 369688 h 437412"/>
                    <a:gd name="csX0" fmla="*/ 6 w 966079"/>
                    <a:gd name="csY0" fmla="*/ 369688 h 437412"/>
                    <a:gd name="csX1" fmla="*/ 431634 w 966079"/>
                    <a:gd name="csY1" fmla="*/ 0 h 437412"/>
                    <a:gd name="csX2" fmla="*/ 914994 w 966079"/>
                    <a:gd name="csY2" fmla="*/ 0 h 437412"/>
                    <a:gd name="csX3" fmla="*/ 681630 w 966079"/>
                    <a:gd name="csY3" fmla="*/ 437412 h 437412"/>
                    <a:gd name="csX4" fmla="*/ 6 w 966079"/>
                    <a:gd name="csY4" fmla="*/ 369688 h 437412"/>
                    <a:gd name="csX0" fmla="*/ 6 w 966079"/>
                    <a:gd name="csY0" fmla="*/ 369688 h 437412"/>
                    <a:gd name="csX1" fmla="*/ 431634 w 966079"/>
                    <a:gd name="csY1" fmla="*/ 0 h 437412"/>
                    <a:gd name="csX2" fmla="*/ 914994 w 966079"/>
                    <a:gd name="csY2" fmla="*/ 0 h 437412"/>
                    <a:gd name="csX3" fmla="*/ 681630 w 966079"/>
                    <a:gd name="csY3" fmla="*/ 437412 h 437412"/>
                    <a:gd name="csX4" fmla="*/ 6 w 966079"/>
                    <a:gd name="csY4" fmla="*/ 369688 h 437412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966079" h="437412">
                      <a:moveTo>
                        <a:pt x="6" y="369688"/>
                      </a:moveTo>
                      <a:cubicBezTo>
                        <a:pt x="-2168" y="342310"/>
                        <a:pt x="651270" y="429420"/>
                        <a:pt x="431634" y="0"/>
                      </a:cubicBezTo>
                      <a:lnTo>
                        <a:pt x="914994" y="0"/>
                      </a:lnTo>
                      <a:cubicBezTo>
                        <a:pt x="1024280" y="360439"/>
                        <a:pt x="963475" y="291894"/>
                        <a:pt x="681630" y="437412"/>
                      </a:cubicBezTo>
                      <a:lnTo>
                        <a:pt x="6" y="369688"/>
                      </a:lnTo>
                      <a:close/>
                    </a:path>
                  </a:pathLst>
                </a:custGeom>
                <a:gradFill flip="none" rotWithShape="1">
                  <a:gsLst>
                    <a:gs pos="0">
                      <a:schemeClr val="bg2">
                        <a:lumMod val="50000"/>
                        <a:shade val="30000"/>
                        <a:satMod val="115000"/>
                      </a:schemeClr>
                    </a:gs>
                    <a:gs pos="50000">
                      <a:schemeClr val="bg2">
                        <a:lumMod val="50000"/>
                        <a:shade val="67500"/>
                        <a:satMod val="115000"/>
                      </a:schemeClr>
                    </a:gs>
                    <a:gs pos="100000">
                      <a:schemeClr val="bg2">
                        <a:lumMod val="50000"/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1" name="Rectangle: Rounded Corners 3880">
                  <a:extLst>
                    <a:ext uri="{FF2B5EF4-FFF2-40B4-BE49-F238E27FC236}">
                      <a16:creationId xmlns:a16="http://schemas.microsoft.com/office/drawing/2014/main" id="{FF100CB8-3CCD-7ED1-6E3F-9DB1D891EEF7}"/>
                    </a:ext>
                  </a:extLst>
                </p:cNvPr>
                <p:cNvSpPr/>
                <p:nvPr/>
              </p:nvSpPr>
              <p:spPr>
                <a:xfrm rot="245050">
                  <a:off x="8126879" y="1995485"/>
                  <a:ext cx="65088" cy="1810915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bg2">
                        <a:lumMod val="90000"/>
                        <a:shade val="30000"/>
                        <a:satMod val="115000"/>
                      </a:schemeClr>
                    </a:gs>
                    <a:gs pos="50000">
                      <a:schemeClr val="bg2">
                        <a:lumMod val="90000"/>
                        <a:shade val="67500"/>
                        <a:satMod val="115000"/>
                      </a:schemeClr>
                    </a:gs>
                    <a:gs pos="100000">
                      <a:schemeClr val="bg2">
                        <a:lumMod val="90000"/>
                        <a:shade val="100000"/>
                        <a:satMod val="115000"/>
                      </a:schemeClr>
                    </a:gs>
                  </a:gsLst>
                  <a:lin ang="54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2" name="Flowchart: Stored Data 3881">
                  <a:extLst>
                    <a:ext uri="{FF2B5EF4-FFF2-40B4-BE49-F238E27FC236}">
                      <a16:creationId xmlns:a16="http://schemas.microsoft.com/office/drawing/2014/main" id="{CD164B27-62C7-0ADD-9141-8A95E7D49AA2}"/>
                    </a:ext>
                  </a:extLst>
                </p:cNvPr>
                <p:cNvSpPr/>
                <p:nvPr/>
              </p:nvSpPr>
              <p:spPr>
                <a:xfrm rot="7215223">
                  <a:off x="8193205" y="1939706"/>
                  <a:ext cx="67340" cy="96385"/>
                </a:xfrm>
                <a:prstGeom prst="flowChartOnlineStorag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3" name="Flowchart: Stored Data 3882">
                  <a:extLst>
                    <a:ext uri="{FF2B5EF4-FFF2-40B4-BE49-F238E27FC236}">
                      <a16:creationId xmlns:a16="http://schemas.microsoft.com/office/drawing/2014/main" id="{EAA6A2C7-2B71-A174-A308-22E5057F2B08}"/>
                    </a:ext>
                  </a:extLst>
                </p:cNvPr>
                <p:cNvSpPr/>
                <p:nvPr/>
              </p:nvSpPr>
              <p:spPr>
                <a:xfrm rot="13557947">
                  <a:off x="8076115" y="3738468"/>
                  <a:ext cx="70712" cy="125916"/>
                </a:xfrm>
                <a:prstGeom prst="flowChartOnlineStorag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4" name="Flowchart: Manual Operation 3883">
                  <a:extLst>
                    <a:ext uri="{FF2B5EF4-FFF2-40B4-BE49-F238E27FC236}">
                      <a16:creationId xmlns:a16="http://schemas.microsoft.com/office/drawing/2014/main" id="{A1AC4112-E65D-7D60-4F47-0671489FC155}"/>
                    </a:ext>
                  </a:extLst>
                </p:cNvPr>
                <p:cNvSpPr/>
                <p:nvPr/>
              </p:nvSpPr>
              <p:spPr>
                <a:xfrm rot="21330547">
                  <a:off x="6806139" y="2101361"/>
                  <a:ext cx="469522" cy="65093"/>
                </a:xfrm>
                <a:prstGeom prst="flowChartManualOperation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5" name="Flowchart: Stored Data 3884">
                  <a:extLst>
                    <a:ext uri="{FF2B5EF4-FFF2-40B4-BE49-F238E27FC236}">
                      <a16:creationId xmlns:a16="http://schemas.microsoft.com/office/drawing/2014/main" id="{1AB62A8D-BF03-9AB6-7025-71C2FB83D1FE}"/>
                    </a:ext>
                  </a:extLst>
                </p:cNvPr>
                <p:cNvSpPr/>
                <p:nvPr/>
              </p:nvSpPr>
              <p:spPr>
                <a:xfrm rot="11300824">
                  <a:off x="6288960" y="4070203"/>
                  <a:ext cx="75843" cy="54621"/>
                </a:xfrm>
                <a:prstGeom prst="flowChartOnlineStorage">
                  <a:avLst/>
                </a:prstGeom>
                <a:solidFill>
                  <a:schemeClr val="bg2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6" name="Rectangle 24">
                  <a:extLst>
                    <a:ext uri="{FF2B5EF4-FFF2-40B4-BE49-F238E27FC236}">
                      <a16:creationId xmlns:a16="http://schemas.microsoft.com/office/drawing/2014/main" id="{548CE7D5-024D-8B04-D649-1BE923867548}"/>
                    </a:ext>
                  </a:extLst>
                </p:cNvPr>
                <p:cNvSpPr/>
                <p:nvPr/>
              </p:nvSpPr>
              <p:spPr>
                <a:xfrm rot="497238">
                  <a:off x="6326084" y="4114483"/>
                  <a:ext cx="711354" cy="67099"/>
                </a:xfrm>
                <a:custGeom>
                  <a:avLst/>
                  <a:gdLst>
                    <a:gd name="csX0" fmla="*/ 0 w 519372"/>
                    <a:gd name="csY0" fmla="*/ 0 h 49095"/>
                    <a:gd name="csX1" fmla="*/ 519372 w 519372"/>
                    <a:gd name="csY1" fmla="*/ 0 h 49095"/>
                    <a:gd name="csX2" fmla="*/ 519372 w 519372"/>
                    <a:gd name="csY2" fmla="*/ 49095 h 49095"/>
                    <a:gd name="csX3" fmla="*/ 0 w 519372"/>
                    <a:gd name="csY3" fmla="*/ 49095 h 49095"/>
                    <a:gd name="csX4" fmla="*/ 0 w 519372"/>
                    <a:gd name="csY4" fmla="*/ 0 h 49095"/>
                    <a:gd name="csX0" fmla="*/ 0 w 556562"/>
                    <a:gd name="csY0" fmla="*/ 0 h 53304"/>
                    <a:gd name="csX1" fmla="*/ 519372 w 556562"/>
                    <a:gd name="csY1" fmla="*/ 0 h 53304"/>
                    <a:gd name="csX2" fmla="*/ 556562 w 556562"/>
                    <a:gd name="csY2" fmla="*/ 53304 h 53304"/>
                    <a:gd name="csX3" fmla="*/ 0 w 556562"/>
                    <a:gd name="csY3" fmla="*/ 49095 h 53304"/>
                    <a:gd name="csX4" fmla="*/ 0 w 556562"/>
                    <a:gd name="csY4" fmla="*/ 0 h 53304"/>
                    <a:gd name="csX0" fmla="*/ 0 w 575962"/>
                    <a:gd name="csY0" fmla="*/ 0 h 54328"/>
                    <a:gd name="csX1" fmla="*/ 519372 w 575962"/>
                    <a:gd name="csY1" fmla="*/ 0 h 54328"/>
                    <a:gd name="csX2" fmla="*/ 575962 w 575962"/>
                    <a:gd name="csY2" fmla="*/ 54328 h 54328"/>
                    <a:gd name="csX3" fmla="*/ 0 w 575962"/>
                    <a:gd name="csY3" fmla="*/ 49095 h 54328"/>
                    <a:gd name="csX4" fmla="*/ 0 w 575962"/>
                    <a:gd name="csY4" fmla="*/ 0 h 54328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575962" h="54328">
                      <a:moveTo>
                        <a:pt x="0" y="0"/>
                      </a:moveTo>
                      <a:lnTo>
                        <a:pt x="519372" y="0"/>
                      </a:lnTo>
                      <a:lnTo>
                        <a:pt x="575962" y="54328"/>
                      </a:lnTo>
                      <a:lnTo>
                        <a:pt x="0" y="4909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2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7" name="Trapezoid 16">
                  <a:extLst>
                    <a:ext uri="{FF2B5EF4-FFF2-40B4-BE49-F238E27FC236}">
                      <a16:creationId xmlns:a16="http://schemas.microsoft.com/office/drawing/2014/main" id="{EC196713-527B-E080-B859-4D101963B01E}"/>
                    </a:ext>
                  </a:extLst>
                </p:cNvPr>
                <p:cNvSpPr/>
                <p:nvPr/>
              </p:nvSpPr>
              <p:spPr>
                <a:xfrm rot="155691">
                  <a:off x="6297837" y="3719837"/>
                  <a:ext cx="966073" cy="437412"/>
                </a:xfrm>
                <a:custGeom>
                  <a:avLst/>
                  <a:gdLst>
                    <a:gd name="csX0" fmla="*/ 0 w 745298"/>
                    <a:gd name="csY0" fmla="*/ 523875 h 523875"/>
                    <a:gd name="csX1" fmla="*/ 130969 w 745298"/>
                    <a:gd name="csY1" fmla="*/ 0 h 523875"/>
                    <a:gd name="csX2" fmla="*/ 614329 w 745298"/>
                    <a:gd name="csY2" fmla="*/ 0 h 523875"/>
                    <a:gd name="csX3" fmla="*/ 745298 w 745298"/>
                    <a:gd name="csY3" fmla="*/ 523875 h 523875"/>
                    <a:gd name="csX4" fmla="*/ 0 w 745298"/>
                    <a:gd name="csY4" fmla="*/ 523875 h 523875"/>
                    <a:gd name="csX0" fmla="*/ 0 w 1045957"/>
                    <a:gd name="csY0" fmla="*/ 369688 h 523875"/>
                    <a:gd name="csX1" fmla="*/ 431628 w 1045957"/>
                    <a:gd name="csY1" fmla="*/ 0 h 523875"/>
                    <a:gd name="csX2" fmla="*/ 914988 w 1045957"/>
                    <a:gd name="csY2" fmla="*/ 0 h 523875"/>
                    <a:gd name="csX3" fmla="*/ 1045957 w 1045957"/>
                    <a:gd name="csY3" fmla="*/ 523875 h 523875"/>
                    <a:gd name="csX4" fmla="*/ 0 w 1045957"/>
                    <a:gd name="csY4" fmla="*/ 369688 h 523875"/>
                    <a:gd name="csX0" fmla="*/ 0 w 968294"/>
                    <a:gd name="csY0" fmla="*/ 369688 h 409164"/>
                    <a:gd name="csX1" fmla="*/ 431628 w 968294"/>
                    <a:gd name="csY1" fmla="*/ 0 h 409164"/>
                    <a:gd name="csX2" fmla="*/ 914988 w 968294"/>
                    <a:gd name="csY2" fmla="*/ 0 h 409164"/>
                    <a:gd name="csX3" fmla="*/ 968294 w 968294"/>
                    <a:gd name="csY3" fmla="*/ 409164 h 409164"/>
                    <a:gd name="csX4" fmla="*/ 0 w 968294"/>
                    <a:gd name="csY4" fmla="*/ 369688 h 409164"/>
                    <a:gd name="csX0" fmla="*/ 0 w 914988"/>
                    <a:gd name="csY0" fmla="*/ 369688 h 437412"/>
                    <a:gd name="csX1" fmla="*/ 431628 w 914988"/>
                    <a:gd name="csY1" fmla="*/ 0 h 437412"/>
                    <a:gd name="csX2" fmla="*/ 914988 w 914988"/>
                    <a:gd name="csY2" fmla="*/ 0 h 437412"/>
                    <a:gd name="csX3" fmla="*/ 681624 w 914988"/>
                    <a:gd name="csY3" fmla="*/ 437412 h 437412"/>
                    <a:gd name="csX4" fmla="*/ 0 w 914988"/>
                    <a:gd name="csY4" fmla="*/ 369688 h 437412"/>
                    <a:gd name="csX0" fmla="*/ 0 w 914988"/>
                    <a:gd name="csY0" fmla="*/ 369688 h 437412"/>
                    <a:gd name="csX1" fmla="*/ 431628 w 914988"/>
                    <a:gd name="csY1" fmla="*/ 0 h 437412"/>
                    <a:gd name="csX2" fmla="*/ 914988 w 914988"/>
                    <a:gd name="csY2" fmla="*/ 0 h 437412"/>
                    <a:gd name="csX3" fmla="*/ 681624 w 914988"/>
                    <a:gd name="csY3" fmla="*/ 437412 h 437412"/>
                    <a:gd name="csX4" fmla="*/ 0 w 914988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72186"/>
                    <a:gd name="csY0" fmla="*/ 369688 h 437412"/>
                    <a:gd name="csX1" fmla="*/ 431628 w 972186"/>
                    <a:gd name="csY1" fmla="*/ 0 h 437412"/>
                    <a:gd name="csX2" fmla="*/ 914988 w 972186"/>
                    <a:gd name="csY2" fmla="*/ 0 h 437412"/>
                    <a:gd name="csX3" fmla="*/ 681624 w 972186"/>
                    <a:gd name="csY3" fmla="*/ 437412 h 437412"/>
                    <a:gd name="csX4" fmla="*/ 0 w 972186"/>
                    <a:gd name="csY4" fmla="*/ 369688 h 437412"/>
                    <a:gd name="csX0" fmla="*/ 0 w 966073"/>
                    <a:gd name="csY0" fmla="*/ 369688 h 437412"/>
                    <a:gd name="csX1" fmla="*/ 431628 w 966073"/>
                    <a:gd name="csY1" fmla="*/ 0 h 437412"/>
                    <a:gd name="csX2" fmla="*/ 914988 w 966073"/>
                    <a:gd name="csY2" fmla="*/ 0 h 437412"/>
                    <a:gd name="csX3" fmla="*/ 681624 w 966073"/>
                    <a:gd name="csY3" fmla="*/ 437412 h 437412"/>
                    <a:gd name="csX4" fmla="*/ 0 w 966073"/>
                    <a:gd name="csY4" fmla="*/ 369688 h 437412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966073" h="437412">
                      <a:moveTo>
                        <a:pt x="0" y="369688"/>
                      </a:moveTo>
                      <a:cubicBezTo>
                        <a:pt x="387898" y="244938"/>
                        <a:pt x="516348" y="328354"/>
                        <a:pt x="431628" y="0"/>
                      </a:cubicBezTo>
                      <a:lnTo>
                        <a:pt x="914988" y="0"/>
                      </a:lnTo>
                      <a:cubicBezTo>
                        <a:pt x="1024274" y="360439"/>
                        <a:pt x="963469" y="291894"/>
                        <a:pt x="681624" y="437412"/>
                      </a:cubicBezTo>
                      <a:lnTo>
                        <a:pt x="0" y="369688"/>
                      </a:lnTo>
                      <a:close/>
                    </a:path>
                  </a:pathLst>
                </a:custGeom>
                <a:gradFill flip="none" rotWithShape="1">
                  <a:gsLst>
                    <a:gs pos="0">
                      <a:schemeClr val="tx1">
                        <a:tint val="66000"/>
                        <a:satMod val="160000"/>
                      </a:schemeClr>
                    </a:gs>
                    <a:gs pos="50000">
                      <a:schemeClr val="tx1">
                        <a:tint val="44500"/>
                        <a:satMod val="160000"/>
                      </a:schemeClr>
                    </a:gs>
                    <a:gs pos="100000">
                      <a:schemeClr val="tx1">
                        <a:tint val="23500"/>
                        <a:satMod val="160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8" name="Rectangle 9">
                  <a:extLst>
                    <a:ext uri="{FF2B5EF4-FFF2-40B4-BE49-F238E27FC236}">
                      <a16:creationId xmlns:a16="http://schemas.microsoft.com/office/drawing/2014/main" id="{B4D6C000-78BC-23B7-214C-F847DA7D3C88}"/>
                    </a:ext>
                  </a:extLst>
                </p:cNvPr>
                <p:cNvSpPr/>
                <p:nvPr/>
              </p:nvSpPr>
              <p:spPr>
                <a:xfrm>
                  <a:off x="5827135" y="1997392"/>
                  <a:ext cx="2375535" cy="1804035"/>
                </a:xfrm>
                <a:custGeom>
                  <a:avLst/>
                  <a:gdLst>
                    <a:gd name="csX0" fmla="*/ 0 w 2076450"/>
                    <a:gd name="csY0" fmla="*/ 0 h 1634490"/>
                    <a:gd name="csX1" fmla="*/ 2076450 w 2076450"/>
                    <a:gd name="csY1" fmla="*/ 0 h 1634490"/>
                    <a:gd name="csX2" fmla="*/ 2076450 w 2076450"/>
                    <a:gd name="csY2" fmla="*/ 1634490 h 1634490"/>
                    <a:gd name="csX3" fmla="*/ 0 w 2076450"/>
                    <a:gd name="csY3" fmla="*/ 1634490 h 1634490"/>
                    <a:gd name="csX4" fmla="*/ 0 w 2076450"/>
                    <a:gd name="csY4" fmla="*/ 0 h 1634490"/>
                    <a:gd name="csX0" fmla="*/ 0 w 2196465"/>
                    <a:gd name="csY0" fmla="*/ 165735 h 1800225"/>
                    <a:gd name="csX1" fmla="*/ 2196465 w 2196465"/>
                    <a:gd name="csY1" fmla="*/ 0 h 1800225"/>
                    <a:gd name="csX2" fmla="*/ 2076450 w 2196465"/>
                    <a:gd name="csY2" fmla="*/ 1800225 h 1800225"/>
                    <a:gd name="csX3" fmla="*/ 0 w 2196465"/>
                    <a:gd name="csY3" fmla="*/ 1800225 h 1800225"/>
                    <a:gd name="csX4" fmla="*/ 0 w 2196465"/>
                    <a:gd name="csY4" fmla="*/ 165735 h 1800225"/>
                    <a:gd name="csX0" fmla="*/ 0 w 2196465"/>
                    <a:gd name="csY0" fmla="*/ 165735 h 1811655"/>
                    <a:gd name="csX1" fmla="*/ 2196465 w 2196465"/>
                    <a:gd name="csY1" fmla="*/ 0 h 1811655"/>
                    <a:gd name="csX2" fmla="*/ 2044065 w 2196465"/>
                    <a:gd name="csY2" fmla="*/ 1811655 h 1811655"/>
                    <a:gd name="csX3" fmla="*/ 0 w 2196465"/>
                    <a:gd name="csY3" fmla="*/ 1800225 h 1811655"/>
                    <a:gd name="csX4" fmla="*/ 0 w 2196465"/>
                    <a:gd name="csY4" fmla="*/ 165735 h 1811655"/>
                    <a:gd name="csX0" fmla="*/ 0 w 2196465"/>
                    <a:gd name="csY0" fmla="*/ 165735 h 1802130"/>
                    <a:gd name="csX1" fmla="*/ 2196465 w 2196465"/>
                    <a:gd name="csY1" fmla="*/ 0 h 1802130"/>
                    <a:gd name="csX2" fmla="*/ 2074545 w 2196465"/>
                    <a:gd name="csY2" fmla="*/ 1802130 h 1802130"/>
                    <a:gd name="csX3" fmla="*/ 0 w 2196465"/>
                    <a:gd name="csY3" fmla="*/ 1800225 h 1802130"/>
                    <a:gd name="csX4" fmla="*/ 0 w 2196465"/>
                    <a:gd name="csY4" fmla="*/ 165735 h 1802130"/>
                    <a:gd name="csX0" fmla="*/ 169545 w 2366010"/>
                    <a:gd name="csY0" fmla="*/ 165735 h 1802130"/>
                    <a:gd name="csX1" fmla="*/ 2366010 w 2366010"/>
                    <a:gd name="csY1" fmla="*/ 0 h 1802130"/>
                    <a:gd name="csX2" fmla="*/ 2244090 w 2366010"/>
                    <a:gd name="csY2" fmla="*/ 1802130 h 1802130"/>
                    <a:gd name="csX3" fmla="*/ 0 w 2366010"/>
                    <a:gd name="csY3" fmla="*/ 1676400 h 1802130"/>
                    <a:gd name="csX4" fmla="*/ 169545 w 2366010"/>
                    <a:gd name="csY4" fmla="*/ 165735 h 1802130"/>
                    <a:gd name="csX0" fmla="*/ 169545 w 2375535"/>
                    <a:gd name="csY0" fmla="*/ 167640 h 1804035"/>
                    <a:gd name="csX1" fmla="*/ 2375535 w 2375535"/>
                    <a:gd name="csY1" fmla="*/ 0 h 1804035"/>
                    <a:gd name="csX2" fmla="*/ 2244090 w 2375535"/>
                    <a:gd name="csY2" fmla="*/ 1804035 h 1804035"/>
                    <a:gd name="csX3" fmla="*/ 0 w 2375535"/>
                    <a:gd name="csY3" fmla="*/ 1678305 h 1804035"/>
                    <a:gd name="csX4" fmla="*/ 169545 w 2375535"/>
                    <a:gd name="csY4" fmla="*/ 167640 h 1804035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2375535" h="1804035">
                      <a:moveTo>
                        <a:pt x="169545" y="167640"/>
                      </a:moveTo>
                      <a:lnTo>
                        <a:pt x="2375535" y="0"/>
                      </a:lnTo>
                      <a:lnTo>
                        <a:pt x="2244090" y="1804035"/>
                      </a:lnTo>
                      <a:lnTo>
                        <a:pt x="0" y="1678305"/>
                      </a:lnTo>
                      <a:lnTo>
                        <a:pt x="169545" y="16764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9" name="Rectangle 9">
                  <a:extLst>
                    <a:ext uri="{FF2B5EF4-FFF2-40B4-BE49-F238E27FC236}">
                      <a16:creationId xmlns:a16="http://schemas.microsoft.com/office/drawing/2014/main" id="{36500D0A-7227-52C1-F43D-D156837DF0C2}"/>
                    </a:ext>
                  </a:extLst>
                </p:cNvPr>
                <p:cNvSpPr/>
                <p:nvPr/>
              </p:nvSpPr>
              <p:spPr>
                <a:xfrm>
                  <a:off x="5890977" y="2039806"/>
                  <a:ext cx="2257621" cy="1503723"/>
                </a:xfrm>
                <a:custGeom>
                  <a:avLst/>
                  <a:gdLst>
                    <a:gd name="csX0" fmla="*/ 0 w 2076450"/>
                    <a:gd name="csY0" fmla="*/ 0 h 1634490"/>
                    <a:gd name="csX1" fmla="*/ 2076450 w 2076450"/>
                    <a:gd name="csY1" fmla="*/ 0 h 1634490"/>
                    <a:gd name="csX2" fmla="*/ 2076450 w 2076450"/>
                    <a:gd name="csY2" fmla="*/ 1634490 h 1634490"/>
                    <a:gd name="csX3" fmla="*/ 0 w 2076450"/>
                    <a:gd name="csY3" fmla="*/ 1634490 h 1634490"/>
                    <a:gd name="csX4" fmla="*/ 0 w 2076450"/>
                    <a:gd name="csY4" fmla="*/ 0 h 1634490"/>
                    <a:gd name="csX0" fmla="*/ 0 w 2196465"/>
                    <a:gd name="csY0" fmla="*/ 165735 h 1800225"/>
                    <a:gd name="csX1" fmla="*/ 2196465 w 2196465"/>
                    <a:gd name="csY1" fmla="*/ 0 h 1800225"/>
                    <a:gd name="csX2" fmla="*/ 2076450 w 2196465"/>
                    <a:gd name="csY2" fmla="*/ 1800225 h 1800225"/>
                    <a:gd name="csX3" fmla="*/ 0 w 2196465"/>
                    <a:gd name="csY3" fmla="*/ 1800225 h 1800225"/>
                    <a:gd name="csX4" fmla="*/ 0 w 2196465"/>
                    <a:gd name="csY4" fmla="*/ 165735 h 1800225"/>
                    <a:gd name="csX0" fmla="*/ 0 w 2196465"/>
                    <a:gd name="csY0" fmla="*/ 165735 h 1811655"/>
                    <a:gd name="csX1" fmla="*/ 2196465 w 2196465"/>
                    <a:gd name="csY1" fmla="*/ 0 h 1811655"/>
                    <a:gd name="csX2" fmla="*/ 2044065 w 2196465"/>
                    <a:gd name="csY2" fmla="*/ 1811655 h 1811655"/>
                    <a:gd name="csX3" fmla="*/ 0 w 2196465"/>
                    <a:gd name="csY3" fmla="*/ 1800225 h 1811655"/>
                    <a:gd name="csX4" fmla="*/ 0 w 2196465"/>
                    <a:gd name="csY4" fmla="*/ 165735 h 1811655"/>
                    <a:gd name="csX0" fmla="*/ 0 w 2196465"/>
                    <a:gd name="csY0" fmla="*/ 165735 h 1802130"/>
                    <a:gd name="csX1" fmla="*/ 2196465 w 2196465"/>
                    <a:gd name="csY1" fmla="*/ 0 h 1802130"/>
                    <a:gd name="csX2" fmla="*/ 2074545 w 2196465"/>
                    <a:gd name="csY2" fmla="*/ 1802130 h 1802130"/>
                    <a:gd name="csX3" fmla="*/ 0 w 2196465"/>
                    <a:gd name="csY3" fmla="*/ 1800225 h 1802130"/>
                    <a:gd name="csX4" fmla="*/ 0 w 2196465"/>
                    <a:gd name="csY4" fmla="*/ 165735 h 1802130"/>
                    <a:gd name="csX0" fmla="*/ 169545 w 2366010"/>
                    <a:gd name="csY0" fmla="*/ 165735 h 1802130"/>
                    <a:gd name="csX1" fmla="*/ 2366010 w 2366010"/>
                    <a:gd name="csY1" fmla="*/ 0 h 1802130"/>
                    <a:gd name="csX2" fmla="*/ 2244090 w 2366010"/>
                    <a:gd name="csY2" fmla="*/ 1802130 h 1802130"/>
                    <a:gd name="csX3" fmla="*/ 0 w 2366010"/>
                    <a:gd name="csY3" fmla="*/ 1676400 h 1802130"/>
                    <a:gd name="csX4" fmla="*/ 169545 w 2366010"/>
                    <a:gd name="csY4" fmla="*/ 165735 h 1802130"/>
                    <a:gd name="csX0" fmla="*/ 169545 w 2375535"/>
                    <a:gd name="csY0" fmla="*/ 167640 h 1804035"/>
                    <a:gd name="csX1" fmla="*/ 2375535 w 2375535"/>
                    <a:gd name="csY1" fmla="*/ 0 h 1804035"/>
                    <a:gd name="csX2" fmla="*/ 2244090 w 2375535"/>
                    <a:gd name="csY2" fmla="*/ 1804035 h 1804035"/>
                    <a:gd name="csX3" fmla="*/ 0 w 2375535"/>
                    <a:gd name="csY3" fmla="*/ 1678305 h 1804035"/>
                    <a:gd name="csX4" fmla="*/ 169545 w 2375535"/>
                    <a:gd name="csY4" fmla="*/ 167640 h 1804035"/>
                    <a:gd name="csX0" fmla="*/ 169545 w 2367737"/>
                    <a:gd name="csY0" fmla="*/ 170231 h 1806626"/>
                    <a:gd name="csX1" fmla="*/ 2367737 w 2367737"/>
                    <a:gd name="csY1" fmla="*/ 0 h 1806626"/>
                    <a:gd name="csX2" fmla="*/ 2244090 w 2367737"/>
                    <a:gd name="csY2" fmla="*/ 1806626 h 1806626"/>
                    <a:gd name="csX3" fmla="*/ 0 w 2367737"/>
                    <a:gd name="csY3" fmla="*/ 1680896 h 1806626"/>
                    <a:gd name="csX4" fmla="*/ 169545 w 2367737"/>
                    <a:gd name="csY4" fmla="*/ 170231 h 1806626"/>
                    <a:gd name="csX0" fmla="*/ 169545 w 2382466"/>
                    <a:gd name="csY0" fmla="*/ 170231 h 1806626"/>
                    <a:gd name="csX1" fmla="*/ 2382466 w 2382466"/>
                    <a:gd name="csY1" fmla="*/ 0 h 1806626"/>
                    <a:gd name="csX2" fmla="*/ 2244090 w 2382466"/>
                    <a:gd name="csY2" fmla="*/ 1806626 h 1806626"/>
                    <a:gd name="csX3" fmla="*/ 0 w 2382466"/>
                    <a:gd name="csY3" fmla="*/ 1680896 h 1806626"/>
                    <a:gd name="csX4" fmla="*/ 169545 w 2382466"/>
                    <a:gd name="csY4" fmla="*/ 170231 h 1806626"/>
                    <a:gd name="csX0" fmla="*/ 169545 w 2377556"/>
                    <a:gd name="csY0" fmla="*/ 170231 h 1806626"/>
                    <a:gd name="csX1" fmla="*/ 2377556 w 2377556"/>
                    <a:gd name="csY1" fmla="*/ 0 h 1806626"/>
                    <a:gd name="csX2" fmla="*/ 2244090 w 2377556"/>
                    <a:gd name="csY2" fmla="*/ 1806626 h 1806626"/>
                    <a:gd name="csX3" fmla="*/ 0 w 2377556"/>
                    <a:gd name="csY3" fmla="*/ 1680896 h 1806626"/>
                    <a:gd name="csX4" fmla="*/ 169545 w 2377556"/>
                    <a:gd name="csY4" fmla="*/ 170231 h 1806626"/>
                    <a:gd name="csX0" fmla="*/ 149907 w 2357918"/>
                    <a:gd name="csY0" fmla="*/ 170231 h 1806626"/>
                    <a:gd name="csX1" fmla="*/ 2357918 w 2357918"/>
                    <a:gd name="csY1" fmla="*/ 0 h 1806626"/>
                    <a:gd name="csX2" fmla="*/ 2224452 w 2357918"/>
                    <a:gd name="csY2" fmla="*/ 1806626 h 1806626"/>
                    <a:gd name="csX3" fmla="*/ 0 w 2357918"/>
                    <a:gd name="csY3" fmla="*/ 1675286 h 1806626"/>
                    <a:gd name="csX4" fmla="*/ 149907 w 2357918"/>
                    <a:gd name="csY4" fmla="*/ 170231 h 1806626"/>
                    <a:gd name="csX0" fmla="*/ 147452 w 2355463"/>
                    <a:gd name="csY0" fmla="*/ 170231 h 1806626"/>
                    <a:gd name="csX1" fmla="*/ 2355463 w 2355463"/>
                    <a:gd name="csY1" fmla="*/ 0 h 1806626"/>
                    <a:gd name="csX2" fmla="*/ 2221997 w 2355463"/>
                    <a:gd name="csY2" fmla="*/ 1806626 h 1806626"/>
                    <a:gd name="csX3" fmla="*/ 0 w 2355463"/>
                    <a:gd name="csY3" fmla="*/ 1680895 h 1806626"/>
                    <a:gd name="csX4" fmla="*/ 147452 w 2355463"/>
                    <a:gd name="csY4" fmla="*/ 170231 h 1806626"/>
                    <a:gd name="csX0" fmla="*/ 147452 w 2355463"/>
                    <a:gd name="csY0" fmla="*/ 170231 h 1803821"/>
                    <a:gd name="csX1" fmla="*/ 2355463 w 2355463"/>
                    <a:gd name="csY1" fmla="*/ 0 h 1803821"/>
                    <a:gd name="csX2" fmla="*/ 2231816 w 2355463"/>
                    <a:gd name="csY2" fmla="*/ 1803821 h 1803821"/>
                    <a:gd name="csX3" fmla="*/ 0 w 2355463"/>
                    <a:gd name="csY3" fmla="*/ 1680895 h 1803821"/>
                    <a:gd name="csX4" fmla="*/ 147452 w 2355463"/>
                    <a:gd name="csY4" fmla="*/ 170231 h 1803821"/>
                    <a:gd name="csX0" fmla="*/ 147452 w 2355463"/>
                    <a:gd name="csY0" fmla="*/ 178645 h 1803821"/>
                    <a:gd name="csX1" fmla="*/ 2355463 w 2355463"/>
                    <a:gd name="csY1" fmla="*/ 0 h 1803821"/>
                    <a:gd name="csX2" fmla="*/ 2231816 w 2355463"/>
                    <a:gd name="csY2" fmla="*/ 1803821 h 1803821"/>
                    <a:gd name="csX3" fmla="*/ 0 w 2355463"/>
                    <a:gd name="csY3" fmla="*/ 1680895 h 1803821"/>
                    <a:gd name="csX4" fmla="*/ 147452 w 2355463"/>
                    <a:gd name="csY4" fmla="*/ 178645 h 1803821"/>
                    <a:gd name="csX0" fmla="*/ 147452 w 2355463"/>
                    <a:gd name="csY0" fmla="*/ 178645 h 1792602"/>
                    <a:gd name="csX1" fmla="*/ 2355463 w 2355463"/>
                    <a:gd name="csY1" fmla="*/ 0 h 1792602"/>
                    <a:gd name="csX2" fmla="*/ 2234270 w 2355463"/>
                    <a:gd name="csY2" fmla="*/ 1792602 h 1792602"/>
                    <a:gd name="csX3" fmla="*/ 0 w 2355463"/>
                    <a:gd name="csY3" fmla="*/ 1680895 h 1792602"/>
                    <a:gd name="csX4" fmla="*/ 147452 w 2355463"/>
                    <a:gd name="csY4" fmla="*/ 178645 h 1792602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2355463" h="1792602">
                      <a:moveTo>
                        <a:pt x="147452" y="178645"/>
                      </a:moveTo>
                      <a:lnTo>
                        <a:pt x="2355463" y="0"/>
                      </a:lnTo>
                      <a:lnTo>
                        <a:pt x="2234270" y="1792602"/>
                      </a:lnTo>
                      <a:lnTo>
                        <a:pt x="0" y="1680895"/>
                      </a:lnTo>
                      <a:lnTo>
                        <a:pt x="147452" y="178645"/>
                      </a:lnTo>
                      <a:close/>
                    </a:path>
                  </a:pathLst>
                </a:custGeom>
                <a:solidFill>
                  <a:srgbClr val="F7F7F7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90" name="Rectangle 19">
                  <a:extLst>
                    <a:ext uri="{FF2B5EF4-FFF2-40B4-BE49-F238E27FC236}">
                      <a16:creationId xmlns:a16="http://schemas.microsoft.com/office/drawing/2014/main" id="{8A0C0754-ED18-E95F-1C7D-5A472C9A4DC1}"/>
                    </a:ext>
                  </a:extLst>
                </p:cNvPr>
                <p:cNvSpPr/>
                <p:nvPr/>
              </p:nvSpPr>
              <p:spPr>
                <a:xfrm>
                  <a:off x="6561092" y="3740694"/>
                  <a:ext cx="476276" cy="380059"/>
                </a:xfrm>
                <a:custGeom>
                  <a:avLst/>
                  <a:gdLst>
                    <a:gd name="csX0" fmla="*/ 0 w 81280"/>
                    <a:gd name="csY0" fmla="*/ 0 h 429589"/>
                    <a:gd name="csX1" fmla="*/ 81280 w 81280"/>
                    <a:gd name="csY1" fmla="*/ 0 h 429589"/>
                    <a:gd name="csX2" fmla="*/ 81280 w 81280"/>
                    <a:gd name="csY2" fmla="*/ 429589 h 429589"/>
                    <a:gd name="csX3" fmla="*/ 0 w 81280"/>
                    <a:gd name="csY3" fmla="*/ 429589 h 429589"/>
                    <a:gd name="csX4" fmla="*/ 0 w 81280"/>
                    <a:gd name="csY4" fmla="*/ 0 h 429589"/>
                    <a:gd name="csX0" fmla="*/ 285750 w 367030"/>
                    <a:gd name="csY0" fmla="*/ 0 h 429589"/>
                    <a:gd name="csX1" fmla="*/ 367030 w 367030"/>
                    <a:gd name="csY1" fmla="*/ 0 h 429589"/>
                    <a:gd name="csX2" fmla="*/ 367030 w 367030"/>
                    <a:gd name="csY2" fmla="*/ 429589 h 429589"/>
                    <a:gd name="csX3" fmla="*/ 0 w 367030"/>
                    <a:gd name="csY3" fmla="*/ 383869 h 429589"/>
                    <a:gd name="csX4" fmla="*/ 285750 w 367030"/>
                    <a:gd name="csY4" fmla="*/ 0 h 429589"/>
                    <a:gd name="csX0" fmla="*/ 285750 w 367030"/>
                    <a:gd name="csY0" fmla="*/ 0 h 395299"/>
                    <a:gd name="csX1" fmla="*/ 367030 w 367030"/>
                    <a:gd name="csY1" fmla="*/ 0 h 395299"/>
                    <a:gd name="csX2" fmla="*/ 107950 w 367030"/>
                    <a:gd name="csY2" fmla="*/ 395299 h 395299"/>
                    <a:gd name="csX3" fmla="*/ 0 w 367030"/>
                    <a:gd name="csY3" fmla="*/ 383869 h 395299"/>
                    <a:gd name="csX4" fmla="*/ 285750 w 367030"/>
                    <a:gd name="csY4" fmla="*/ 0 h 395299"/>
                    <a:gd name="csX0" fmla="*/ 285750 w 450850"/>
                    <a:gd name="csY0" fmla="*/ 0 h 395299"/>
                    <a:gd name="csX1" fmla="*/ 450850 w 450850"/>
                    <a:gd name="csY1" fmla="*/ 20955 h 395299"/>
                    <a:gd name="csX2" fmla="*/ 107950 w 450850"/>
                    <a:gd name="csY2" fmla="*/ 395299 h 395299"/>
                    <a:gd name="csX3" fmla="*/ 0 w 450850"/>
                    <a:gd name="csY3" fmla="*/ 383869 h 395299"/>
                    <a:gd name="csX4" fmla="*/ 285750 w 450850"/>
                    <a:gd name="csY4" fmla="*/ 0 h 395299"/>
                    <a:gd name="csX0" fmla="*/ 377190 w 450850"/>
                    <a:gd name="csY0" fmla="*/ 0 h 376249"/>
                    <a:gd name="csX1" fmla="*/ 450850 w 450850"/>
                    <a:gd name="csY1" fmla="*/ 1905 h 376249"/>
                    <a:gd name="csX2" fmla="*/ 107950 w 450850"/>
                    <a:gd name="csY2" fmla="*/ 376249 h 376249"/>
                    <a:gd name="csX3" fmla="*/ 0 w 450850"/>
                    <a:gd name="csY3" fmla="*/ 364819 h 376249"/>
                    <a:gd name="csX4" fmla="*/ 377190 w 450850"/>
                    <a:gd name="csY4" fmla="*/ 0 h 376249"/>
                    <a:gd name="csX0" fmla="*/ 377190 w 494991"/>
                    <a:gd name="csY0" fmla="*/ 0 h 376249"/>
                    <a:gd name="csX1" fmla="*/ 450850 w 494991"/>
                    <a:gd name="csY1" fmla="*/ 1905 h 376249"/>
                    <a:gd name="csX2" fmla="*/ 107950 w 494991"/>
                    <a:gd name="csY2" fmla="*/ 376249 h 376249"/>
                    <a:gd name="csX3" fmla="*/ 0 w 494991"/>
                    <a:gd name="csY3" fmla="*/ 364819 h 376249"/>
                    <a:gd name="csX4" fmla="*/ 377190 w 494991"/>
                    <a:gd name="csY4" fmla="*/ 0 h 376249"/>
                    <a:gd name="csX0" fmla="*/ 377190 w 498545"/>
                    <a:gd name="csY0" fmla="*/ 0 h 376249"/>
                    <a:gd name="csX1" fmla="*/ 450850 w 498545"/>
                    <a:gd name="csY1" fmla="*/ 1905 h 376249"/>
                    <a:gd name="csX2" fmla="*/ 107950 w 498545"/>
                    <a:gd name="csY2" fmla="*/ 376249 h 376249"/>
                    <a:gd name="csX3" fmla="*/ 0 w 498545"/>
                    <a:gd name="csY3" fmla="*/ 364819 h 376249"/>
                    <a:gd name="csX4" fmla="*/ 377190 w 498545"/>
                    <a:gd name="csY4" fmla="*/ 0 h 376249"/>
                    <a:gd name="csX0" fmla="*/ 377190 w 505003"/>
                    <a:gd name="csY0" fmla="*/ 0 h 376249"/>
                    <a:gd name="csX1" fmla="*/ 450850 w 505003"/>
                    <a:gd name="csY1" fmla="*/ 1905 h 376249"/>
                    <a:gd name="csX2" fmla="*/ 107950 w 505003"/>
                    <a:gd name="csY2" fmla="*/ 376249 h 376249"/>
                    <a:gd name="csX3" fmla="*/ 0 w 505003"/>
                    <a:gd name="csY3" fmla="*/ 364819 h 376249"/>
                    <a:gd name="csX4" fmla="*/ 377190 w 505003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519545"/>
                    <a:gd name="csY0" fmla="*/ 0 h 376249"/>
                    <a:gd name="csX1" fmla="*/ 450850 w 519545"/>
                    <a:gd name="csY1" fmla="*/ 1905 h 376249"/>
                    <a:gd name="csX2" fmla="*/ 107950 w 519545"/>
                    <a:gd name="csY2" fmla="*/ 376249 h 376249"/>
                    <a:gd name="csX3" fmla="*/ 0 w 519545"/>
                    <a:gd name="csY3" fmla="*/ 364819 h 376249"/>
                    <a:gd name="csX4" fmla="*/ 377190 w 519545"/>
                    <a:gd name="csY4" fmla="*/ 0 h 376249"/>
                    <a:gd name="csX0" fmla="*/ 377190 w 479555"/>
                    <a:gd name="csY0" fmla="*/ 0 h 376249"/>
                    <a:gd name="csX1" fmla="*/ 450850 w 479555"/>
                    <a:gd name="csY1" fmla="*/ 1905 h 376249"/>
                    <a:gd name="csX2" fmla="*/ 107950 w 479555"/>
                    <a:gd name="csY2" fmla="*/ 376249 h 376249"/>
                    <a:gd name="csX3" fmla="*/ 0 w 479555"/>
                    <a:gd name="csY3" fmla="*/ 364819 h 376249"/>
                    <a:gd name="csX4" fmla="*/ 377190 w 479555"/>
                    <a:gd name="csY4" fmla="*/ 0 h 376249"/>
                    <a:gd name="csX0" fmla="*/ 377190 w 474258"/>
                    <a:gd name="csY0" fmla="*/ 0 h 376249"/>
                    <a:gd name="csX1" fmla="*/ 450850 w 474258"/>
                    <a:gd name="csY1" fmla="*/ 1905 h 376249"/>
                    <a:gd name="csX2" fmla="*/ 107950 w 474258"/>
                    <a:gd name="csY2" fmla="*/ 376249 h 376249"/>
                    <a:gd name="csX3" fmla="*/ 0 w 474258"/>
                    <a:gd name="csY3" fmla="*/ 364819 h 376249"/>
                    <a:gd name="csX4" fmla="*/ 377190 w 474258"/>
                    <a:gd name="csY4" fmla="*/ 0 h 376249"/>
                    <a:gd name="csX0" fmla="*/ 377190 w 472961"/>
                    <a:gd name="csY0" fmla="*/ 0 h 376249"/>
                    <a:gd name="csX1" fmla="*/ 450850 w 472961"/>
                    <a:gd name="csY1" fmla="*/ 1905 h 376249"/>
                    <a:gd name="csX2" fmla="*/ 107950 w 472961"/>
                    <a:gd name="csY2" fmla="*/ 376249 h 376249"/>
                    <a:gd name="csX3" fmla="*/ 0 w 472961"/>
                    <a:gd name="csY3" fmla="*/ 364819 h 376249"/>
                    <a:gd name="csX4" fmla="*/ 377190 w 472961"/>
                    <a:gd name="csY4" fmla="*/ 0 h 376249"/>
                    <a:gd name="csX0" fmla="*/ 377190 w 472961"/>
                    <a:gd name="csY0" fmla="*/ 0 h 376249"/>
                    <a:gd name="csX1" fmla="*/ 450850 w 472961"/>
                    <a:gd name="csY1" fmla="*/ 1905 h 376249"/>
                    <a:gd name="csX2" fmla="*/ 107950 w 472961"/>
                    <a:gd name="csY2" fmla="*/ 376249 h 376249"/>
                    <a:gd name="csX3" fmla="*/ 0 w 472961"/>
                    <a:gd name="csY3" fmla="*/ 364819 h 376249"/>
                    <a:gd name="csX4" fmla="*/ 377190 w 472961"/>
                    <a:gd name="csY4" fmla="*/ 0 h 376249"/>
                    <a:gd name="csX0" fmla="*/ 377190 w 473682"/>
                    <a:gd name="csY0" fmla="*/ 0 h 376249"/>
                    <a:gd name="csX1" fmla="*/ 450850 w 473682"/>
                    <a:gd name="csY1" fmla="*/ 1905 h 376249"/>
                    <a:gd name="csX2" fmla="*/ 121285 w 473682"/>
                    <a:gd name="csY2" fmla="*/ 376249 h 376249"/>
                    <a:gd name="csX3" fmla="*/ 0 w 473682"/>
                    <a:gd name="csY3" fmla="*/ 364819 h 376249"/>
                    <a:gd name="csX4" fmla="*/ 377190 w 473682"/>
                    <a:gd name="csY4" fmla="*/ 0 h 376249"/>
                    <a:gd name="csX0" fmla="*/ 377190 w 473789"/>
                    <a:gd name="csY0" fmla="*/ 0 h 378154"/>
                    <a:gd name="csX1" fmla="*/ 450850 w 473789"/>
                    <a:gd name="csY1" fmla="*/ 1905 h 378154"/>
                    <a:gd name="csX2" fmla="*/ 123190 w 473789"/>
                    <a:gd name="csY2" fmla="*/ 378154 h 378154"/>
                    <a:gd name="csX3" fmla="*/ 0 w 473789"/>
                    <a:gd name="csY3" fmla="*/ 364819 h 378154"/>
                    <a:gd name="csX4" fmla="*/ 377190 w 473789"/>
                    <a:gd name="csY4" fmla="*/ 0 h 378154"/>
                    <a:gd name="csX0" fmla="*/ 377190 w 474337"/>
                    <a:gd name="csY0" fmla="*/ 0 h 380059"/>
                    <a:gd name="csX1" fmla="*/ 450850 w 474337"/>
                    <a:gd name="csY1" fmla="*/ 1905 h 380059"/>
                    <a:gd name="csX2" fmla="*/ 132715 w 474337"/>
                    <a:gd name="csY2" fmla="*/ 380059 h 380059"/>
                    <a:gd name="csX3" fmla="*/ 0 w 474337"/>
                    <a:gd name="csY3" fmla="*/ 364819 h 380059"/>
                    <a:gd name="csX4" fmla="*/ 377190 w 474337"/>
                    <a:gd name="csY4" fmla="*/ 0 h 380059"/>
                    <a:gd name="csX0" fmla="*/ 377190 w 476276"/>
                    <a:gd name="csY0" fmla="*/ 0 h 380059"/>
                    <a:gd name="csX1" fmla="*/ 450850 w 476276"/>
                    <a:gd name="csY1" fmla="*/ 1905 h 380059"/>
                    <a:gd name="csX2" fmla="*/ 132715 w 476276"/>
                    <a:gd name="csY2" fmla="*/ 380059 h 380059"/>
                    <a:gd name="csX3" fmla="*/ 0 w 476276"/>
                    <a:gd name="csY3" fmla="*/ 364819 h 380059"/>
                    <a:gd name="csX4" fmla="*/ 377190 w 476276"/>
                    <a:gd name="csY4" fmla="*/ 0 h 380059"/>
                    <a:gd name="csX0" fmla="*/ 377190 w 476276"/>
                    <a:gd name="csY0" fmla="*/ 0 h 380059"/>
                    <a:gd name="csX1" fmla="*/ 450850 w 476276"/>
                    <a:gd name="csY1" fmla="*/ 1905 h 380059"/>
                    <a:gd name="csX2" fmla="*/ 132715 w 476276"/>
                    <a:gd name="csY2" fmla="*/ 380059 h 380059"/>
                    <a:gd name="csX3" fmla="*/ 0 w 476276"/>
                    <a:gd name="csY3" fmla="*/ 364819 h 380059"/>
                    <a:gd name="csX4" fmla="*/ 377190 w 476276"/>
                    <a:gd name="csY4" fmla="*/ 0 h 380059"/>
                  </a:gdLst>
                  <a:ahLst/>
                  <a:cxnLst>
                    <a:cxn ang="0">
                      <a:pos x="csX0" y="csY0"/>
                    </a:cxn>
                    <a:cxn ang="0">
                      <a:pos x="csX1" y="csY1"/>
                    </a:cxn>
                    <a:cxn ang="0">
                      <a:pos x="csX2" y="csY2"/>
                    </a:cxn>
                    <a:cxn ang="0">
                      <a:pos x="csX3" y="csY3"/>
                    </a:cxn>
                    <a:cxn ang="0">
                      <a:pos x="csX4" y="csY4"/>
                    </a:cxn>
                  </a:cxnLst>
                  <a:rect l="l" t="t" r="r" b="b"/>
                  <a:pathLst>
                    <a:path w="476276" h="380059">
                      <a:moveTo>
                        <a:pt x="377190" y="0"/>
                      </a:moveTo>
                      <a:lnTo>
                        <a:pt x="450850" y="1905"/>
                      </a:lnTo>
                      <a:cubicBezTo>
                        <a:pt x="561340" y="361001"/>
                        <a:pt x="285115" y="341003"/>
                        <a:pt x="132715" y="380059"/>
                      </a:cubicBezTo>
                      <a:lnTo>
                        <a:pt x="0" y="364819"/>
                      </a:lnTo>
                      <a:cubicBezTo>
                        <a:pt x="137160" y="317508"/>
                        <a:pt x="516255" y="367351"/>
                        <a:pt x="377190" y="0"/>
                      </a:cubicBezTo>
                      <a:close/>
                    </a:path>
                  </a:pathLst>
                </a:custGeom>
                <a:solidFill>
                  <a:schemeClr val="bg1">
                    <a:alpha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876" name="Oval 3875">
                <a:extLst>
                  <a:ext uri="{FF2B5EF4-FFF2-40B4-BE49-F238E27FC236}">
                    <a16:creationId xmlns:a16="http://schemas.microsoft.com/office/drawing/2014/main" id="{DE9AC3F5-6B9D-6E56-A818-D6DDCBF6881A}"/>
                  </a:ext>
                </a:extLst>
              </p:cNvPr>
              <p:cNvSpPr/>
              <p:nvPr/>
            </p:nvSpPr>
            <p:spPr>
              <a:xfrm>
                <a:off x="5890841" y="5159203"/>
                <a:ext cx="229213" cy="309322"/>
              </a:xfrm>
              <a:prstGeom prst="ellipse">
                <a:avLst/>
              </a:prstGeom>
              <a:solidFill>
                <a:schemeClr val="bg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77" name="Oval 3876">
                <a:extLst>
                  <a:ext uri="{FF2B5EF4-FFF2-40B4-BE49-F238E27FC236}">
                    <a16:creationId xmlns:a16="http://schemas.microsoft.com/office/drawing/2014/main" id="{9145052C-1D55-4D34-502E-38D046628B5F}"/>
                  </a:ext>
                </a:extLst>
              </p:cNvPr>
              <p:cNvSpPr/>
              <p:nvPr/>
            </p:nvSpPr>
            <p:spPr>
              <a:xfrm>
                <a:off x="6362310" y="5227108"/>
                <a:ext cx="229213" cy="309322"/>
              </a:xfrm>
              <a:prstGeom prst="ellipse">
                <a:avLst/>
              </a:prstGeom>
              <a:solidFill>
                <a:schemeClr val="bg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78" name="Oval 3877">
                <a:extLst>
                  <a:ext uri="{FF2B5EF4-FFF2-40B4-BE49-F238E27FC236}">
                    <a16:creationId xmlns:a16="http://schemas.microsoft.com/office/drawing/2014/main" id="{D88BB9C3-24A4-5C05-7F69-08E73588D9E7}"/>
                  </a:ext>
                </a:extLst>
              </p:cNvPr>
              <p:cNvSpPr/>
              <p:nvPr/>
            </p:nvSpPr>
            <p:spPr>
              <a:xfrm>
                <a:off x="5968281" y="5209446"/>
                <a:ext cx="151773" cy="204817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79" name="Oval 3878">
                <a:extLst>
                  <a:ext uri="{FF2B5EF4-FFF2-40B4-BE49-F238E27FC236}">
                    <a16:creationId xmlns:a16="http://schemas.microsoft.com/office/drawing/2014/main" id="{A4B5A2F1-CFF8-510E-63B0-38428A88EA7C}"/>
                  </a:ext>
                </a:extLst>
              </p:cNvPr>
              <p:cNvSpPr/>
              <p:nvPr/>
            </p:nvSpPr>
            <p:spPr>
              <a:xfrm>
                <a:off x="6439750" y="5277351"/>
                <a:ext cx="151773" cy="204817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874" name="Rectangle 84">
              <a:extLst>
                <a:ext uri="{FF2B5EF4-FFF2-40B4-BE49-F238E27FC236}">
                  <a16:creationId xmlns:a16="http://schemas.microsoft.com/office/drawing/2014/main" id="{B7356269-5CB7-72E0-4DF3-40D0CF5CACBD}"/>
                </a:ext>
              </a:extLst>
            </p:cNvPr>
            <p:cNvSpPr/>
            <p:nvPr/>
          </p:nvSpPr>
          <p:spPr>
            <a:xfrm rot="159426">
              <a:off x="4249968" y="4747726"/>
              <a:ext cx="3781908" cy="247647"/>
            </a:xfrm>
            <a:custGeom>
              <a:avLst/>
              <a:gdLst>
                <a:gd name="csX0" fmla="*/ 0 w 3835861"/>
                <a:gd name="csY0" fmla="*/ 0 h 352570"/>
                <a:gd name="csX1" fmla="*/ 3835861 w 3835861"/>
                <a:gd name="csY1" fmla="*/ 0 h 352570"/>
                <a:gd name="csX2" fmla="*/ 3835861 w 3835861"/>
                <a:gd name="csY2" fmla="*/ 352570 h 352570"/>
                <a:gd name="csX3" fmla="*/ 0 w 3835861"/>
                <a:gd name="csY3" fmla="*/ 352570 h 352570"/>
                <a:gd name="csX4" fmla="*/ 0 w 3835861"/>
                <a:gd name="csY4" fmla="*/ 0 h 352570"/>
                <a:gd name="csX0" fmla="*/ 17127 w 3835861"/>
                <a:gd name="csY0" fmla="*/ 0 h 353365"/>
                <a:gd name="csX1" fmla="*/ 3835861 w 3835861"/>
                <a:gd name="csY1" fmla="*/ 795 h 353365"/>
                <a:gd name="csX2" fmla="*/ 3835861 w 3835861"/>
                <a:gd name="csY2" fmla="*/ 353365 h 353365"/>
                <a:gd name="csX3" fmla="*/ 0 w 3835861"/>
                <a:gd name="csY3" fmla="*/ 353365 h 353365"/>
                <a:gd name="csX4" fmla="*/ 17127 w 3835861"/>
                <a:gd name="csY4" fmla="*/ 0 h 353365"/>
                <a:gd name="csX0" fmla="*/ 26730 w 3835861"/>
                <a:gd name="csY0" fmla="*/ 667 h 352570"/>
                <a:gd name="csX1" fmla="*/ 3835861 w 3835861"/>
                <a:gd name="csY1" fmla="*/ 0 h 352570"/>
                <a:gd name="csX2" fmla="*/ 3835861 w 3835861"/>
                <a:gd name="csY2" fmla="*/ 352570 h 352570"/>
                <a:gd name="csX3" fmla="*/ 0 w 3835861"/>
                <a:gd name="csY3" fmla="*/ 352570 h 352570"/>
                <a:gd name="csX4" fmla="*/ 26730 w 3835861"/>
                <a:gd name="csY4" fmla="*/ 667 h 352570"/>
                <a:gd name="csX0" fmla="*/ 26730 w 3835861"/>
                <a:gd name="csY0" fmla="*/ 21925 h 373828"/>
                <a:gd name="csX1" fmla="*/ 3835235 w 3835861"/>
                <a:gd name="csY1" fmla="*/ 0 h 373828"/>
                <a:gd name="csX2" fmla="*/ 3835861 w 3835861"/>
                <a:gd name="csY2" fmla="*/ 373828 h 373828"/>
                <a:gd name="csX3" fmla="*/ 0 w 3835861"/>
                <a:gd name="csY3" fmla="*/ 373828 h 373828"/>
                <a:gd name="csX4" fmla="*/ 26730 w 3835861"/>
                <a:gd name="csY4" fmla="*/ 21925 h 373828"/>
                <a:gd name="csX0" fmla="*/ 26730 w 3835261"/>
                <a:gd name="csY0" fmla="*/ 21925 h 395230"/>
                <a:gd name="csX1" fmla="*/ 3835235 w 3835261"/>
                <a:gd name="csY1" fmla="*/ 0 h 395230"/>
                <a:gd name="csX2" fmla="*/ 3834558 w 3835261"/>
                <a:gd name="csY2" fmla="*/ 395229 h 395230"/>
                <a:gd name="csX3" fmla="*/ 0 w 3835261"/>
                <a:gd name="csY3" fmla="*/ 373828 h 395230"/>
                <a:gd name="csX4" fmla="*/ 26730 w 3835261"/>
                <a:gd name="csY4" fmla="*/ 21925 h 395230"/>
              </a:gdLst>
              <a:ahLst/>
              <a:cxnLst>
                <a:cxn ang="0">
                  <a:pos x="csX0" y="csY0"/>
                </a:cxn>
                <a:cxn ang="0">
                  <a:pos x="csX1" y="csY1"/>
                </a:cxn>
                <a:cxn ang="0">
                  <a:pos x="csX2" y="csY2"/>
                </a:cxn>
                <a:cxn ang="0">
                  <a:pos x="csX3" y="csY3"/>
                </a:cxn>
                <a:cxn ang="0">
                  <a:pos x="csX4" y="csY4"/>
                </a:cxn>
              </a:cxnLst>
              <a:rect l="l" t="t" r="r" b="b"/>
              <a:pathLst>
                <a:path w="3835261" h="395230">
                  <a:moveTo>
                    <a:pt x="26730" y="21925"/>
                  </a:moveTo>
                  <a:lnTo>
                    <a:pt x="3835235" y="0"/>
                  </a:lnTo>
                  <a:cubicBezTo>
                    <a:pt x="3835444" y="124609"/>
                    <a:pt x="3834349" y="270620"/>
                    <a:pt x="3834558" y="395229"/>
                  </a:cubicBezTo>
                  <a:lnTo>
                    <a:pt x="0" y="373828"/>
                  </a:lnTo>
                  <a:lnTo>
                    <a:pt x="26730" y="21925"/>
                  </a:lnTo>
                  <a:close/>
                </a:path>
              </a:pathLst>
            </a:custGeom>
            <a:blipFill>
              <a:blip r:embed="rId2"/>
              <a:tile tx="0" ty="0" sx="100000" sy="100000" flip="none" algn="tl"/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01" name="Arrow: Down 3900">
            <a:extLst>
              <a:ext uri="{FF2B5EF4-FFF2-40B4-BE49-F238E27FC236}">
                <a16:creationId xmlns:a16="http://schemas.microsoft.com/office/drawing/2014/main" id="{95197B87-B834-8DDF-4115-96DE73BAC12C}"/>
              </a:ext>
            </a:extLst>
          </p:cNvPr>
          <p:cNvSpPr/>
          <p:nvPr/>
        </p:nvSpPr>
        <p:spPr>
          <a:xfrm flipH="1">
            <a:off x="6219231" y="1362210"/>
            <a:ext cx="45719" cy="96834"/>
          </a:xfrm>
          <a:prstGeom prst="downArrow">
            <a:avLst/>
          </a:prstGeom>
          <a:gradFill flip="none" rotWithShape="1">
            <a:gsLst>
              <a:gs pos="0">
                <a:schemeClr val="accent4">
                  <a:shade val="30000"/>
                  <a:satMod val="115000"/>
                </a:schemeClr>
              </a:gs>
              <a:gs pos="50000">
                <a:schemeClr val="accent4">
                  <a:shade val="67500"/>
                  <a:satMod val="115000"/>
                </a:schemeClr>
              </a:gs>
              <a:gs pos="100000">
                <a:schemeClr val="accent4">
                  <a:shade val="100000"/>
                  <a:satMod val="115000"/>
                </a:schemeClr>
              </a:gs>
            </a:gsLst>
            <a:lin ang="162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03" name="Picture 3902">
            <a:extLst>
              <a:ext uri="{FF2B5EF4-FFF2-40B4-BE49-F238E27FC236}">
                <a16:creationId xmlns:a16="http://schemas.microsoft.com/office/drawing/2014/main" id="{4E9B37D5-EBA7-98FC-B7B1-50D5360B03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9336826">
            <a:off x="2433655" y="3806801"/>
            <a:ext cx="751768" cy="444957"/>
          </a:xfrm>
          <a:prstGeom prst="rect">
            <a:avLst/>
          </a:prstGeom>
        </p:spPr>
      </p:pic>
      <p:pic>
        <p:nvPicPr>
          <p:cNvPr id="3905" name="Picture 3904">
            <a:extLst>
              <a:ext uri="{FF2B5EF4-FFF2-40B4-BE49-F238E27FC236}">
                <a16:creationId xmlns:a16="http://schemas.microsoft.com/office/drawing/2014/main" id="{02BA89A2-DC5B-C73D-6269-0A525C9971A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9532245">
            <a:off x="2553878" y="3404704"/>
            <a:ext cx="751768" cy="444957"/>
          </a:xfrm>
          <a:prstGeom prst="rect">
            <a:avLst/>
          </a:prstGeom>
        </p:spPr>
      </p:pic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id="{9954E750-34B8-3DA3-31D0-BE67260508BF}"/>
              </a:ext>
            </a:extLst>
          </p:cNvPr>
          <p:cNvCxnSpPr>
            <a:cxnSpLocks/>
            <a:endCxn id="1256" idx="0"/>
          </p:cNvCxnSpPr>
          <p:nvPr/>
        </p:nvCxnSpPr>
        <p:spPr>
          <a:xfrm>
            <a:off x="4048338" y="3553501"/>
            <a:ext cx="0" cy="272316"/>
          </a:xfrm>
          <a:prstGeom prst="straightConnector1">
            <a:avLst/>
          </a:prstGeom>
          <a:ln w="12700">
            <a:gradFill flip="none" rotWithShape="1">
              <a:gsLst>
                <a:gs pos="100000">
                  <a:schemeClr val="accent4"/>
                </a:gs>
                <a:gs pos="0">
                  <a:schemeClr val="accent4">
                    <a:lumMod val="60000"/>
                  </a:schemeClr>
                </a:gs>
              </a:gsLst>
              <a:path path="circle">
                <a:fillToRect l="50000" t="130000" r="50000" b="-30000"/>
              </a:path>
              <a:tileRect/>
            </a:gra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Rounded Rectangle 81">
            <a:extLst>
              <a:ext uri="{FF2B5EF4-FFF2-40B4-BE49-F238E27FC236}">
                <a16:creationId xmlns:a16="http://schemas.microsoft.com/office/drawing/2014/main" id="{1C884307-CA93-7676-8BC6-B2278E610087}"/>
              </a:ext>
            </a:extLst>
          </p:cNvPr>
          <p:cNvSpPr/>
          <p:nvPr/>
        </p:nvSpPr>
        <p:spPr>
          <a:xfrm>
            <a:off x="3496339" y="3342328"/>
            <a:ext cx="1157181" cy="211173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i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ADMET</a:t>
            </a:r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analysis of the selected phytochemicals</a:t>
            </a:r>
          </a:p>
        </p:txBody>
      </p:sp>
      <p:pic>
        <p:nvPicPr>
          <p:cNvPr id="3909" name="Picture 3908">
            <a:extLst>
              <a:ext uri="{FF2B5EF4-FFF2-40B4-BE49-F238E27FC236}">
                <a16:creationId xmlns:a16="http://schemas.microsoft.com/office/drawing/2014/main" id="{54091E69-30F5-1DA0-BD74-AEDA4692B47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7122" y="1121665"/>
            <a:ext cx="2985669" cy="1833384"/>
          </a:xfrm>
          <a:prstGeom prst="rect">
            <a:avLst/>
          </a:prstGeom>
        </p:spPr>
      </p:pic>
      <p:pic>
        <p:nvPicPr>
          <p:cNvPr id="3910" name="Picture 3909">
            <a:extLst>
              <a:ext uri="{FF2B5EF4-FFF2-40B4-BE49-F238E27FC236}">
                <a16:creationId xmlns:a16="http://schemas.microsoft.com/office/drawing/2014/main" id="{99F73966-6E9E-0A82-1676-CBC8F3CE5C7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8930" y="1074862"/>
            <a:ext cx="2985669" cy="183338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90F88D5-815E-1ED8-3674-FC4BAA6B880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2717" y="3722952"/>
            <a:ext cx="822453" cy="506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9484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15</TotalTime>
  <Words>213</Words>
  <Application>Microsoft Office PowerPoint</Application>
  <PresentationFormat>Custom</PresentationFormat>
  <Paragraphs>9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one</dc:creator>
  <cp:lastModifiedBy>Zone</cp:lastModifiedBy>
  <cp:revision>3</cp:revision>
  <dcterms:created xsi:type="dcterms:W3CDTF">2026-04-03T00:14:26Z</dcterms:created>
  <dcterms:modified xsi:type="dcterms:W3CDTF">2026-04-09T02:13:21Z</dcterms:modified>
</cp:coreProperties>
</file>